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8"/>
  </p:notesMasterIdLst>
  <p:sldIdLst>
    <p:sldId id="267" r:id="rId5"/>
    <p:sldId id="268" r:id="rId6"/>
    <p:sldId id="27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ortman, Guus" initials="KG" lastIdx="18" clrIdx="0">
    <p:extLst>
      <p:ext uri="{19B8F6BF-5375-455C-9EA6-DF929625EA0E}">
        <p15:presenceInfo xmlns:p15="http://schemas.microsoft.com/office/powerpoint/2012/main" userId="S::Guus.Kortman@nizo.com::41e95c6d-0420-46db-8343-bb7e712699d8" providerId="AD"/>
      </p:ext>
    </p:extLst>
  </p:cmAuthor>
  <p:cmAuthor id="2" name="Cercamondi,Colin Ivano,VEVEY,Clinical Research" initials="CR" lastIdx="3" clrIdx="1">
    <p:extLst>
      <p:ext uri="{19B8F6BF-5375-455C-9EA6-DF929625EA0E}">
        <p15:presenceInfo xmlns:p15="http://schemas.microsoft.com/office/powerpoint/2012/main" userId="S::colinivano.cercamondi@nestle.com::d25e694c-3ff8-4193-82fc-75dd469e9cee" providerId="AD"/>
      </p:ext>
    </p:extLst>
  </p:cmAuthor>
  <p:cmAuthor id="3" name="ccercam" initials="cc" lastIdx="34" clrIdx="2">
    <p:extLst>
      <p:ext uri="{19B8F6BF-5375-455C-9EA6-DF929625EA0E}">
        <p15:presenceInfo xmlns:p15="http://schemas.microsoft.com/office/powerpoint/2012/main" userId="ccercam" providerId="None"/>
      </p:ext>
    </p:extLst>
  </p:cmAuthor>
  <p:cmAuthor id="4" name="Berger,Bernard,CH-Lausanne" initials="B" lastIdx="3" clrIdx="3">
    <p:extLst>
      <p:ext uri="{19B8F6BF-5375-455C-9EA6-DF929625EA0E}">
        <p15:presenceInfo xmlns:p15="http://schemas.microsoft.com/office/powerpoint/2012/main" userId="S::bernard.berger@rdls.nestle.com::e82bb347-e851-4db7-bca8-21df8a20dbf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F07F29E-985D-4F0A-A6BD-79692FB1BAAB}" v="5" dt="2021-09-23T20:14:10.4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5" d="100"/>
          <a:sy n="55" d="100"/>
        </p:scale>
        <p:origin x="1004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commentAuthors" Target="commentAuthors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ercamondi,Colin Ivano,CH-Vevey" userId="d25e694c-3ff8-4193-82fc-75dd469e9cee" providerId="ADAL" clId="{A16F2C33-204C-4D20-A8B0-3F4160BF8763}"/>
    <pc:docChg chg="undo custSel addSld modSld">
      <pc:chgData name="Cercamondi,Colin Ivano,CH-Vevey" userId="d25e694c-3ff8-4193-82fc-75dd469e9cee" providerId="ADAL" clId="{A16F2C33-204C-4D20-A8B0-3F4160BF8763}" dt="2020-11-12T08:52:55.964" v="209" actId="1037"/>
      <pc:docMkLst>
        <pc:docMk/>
      </pc:docMkLst>
      <pc:sldChg chg="addSp modSp">
        <pc:chgData name="Cercamondi,Colin Ivano,CH-Vevey" userId="d25e694c-3ff8-4193-82fc-75dd469e9cee" providerId="ADAL" clId="{A16F2C33-204C-4D20-A8B0-3F4160BF8763}" dt="2020-10-29T10:16:59.901" v="116" actId="1036"/>
        <pc:sldMkLst>
          <pc:docMk/>
          <pc:sldMk cId="1299451647" sldId="257"/>
        </pc:sldMkLst>
        <pc:spChg chg="mod">
          <ac:chgData name="Cercamondi,Colin Ivano,CH-Vevey" userId="d25e694c-3ff8-4193-82fc-75dd469e9cee" providerId="ADAL" clId="{A16F2C33-204C-4D20-A8B0-3F4160BF8763}" dt="2020-10-18T20:14:45.144" v="78" actId="20577"/>
          <ac:spMkLst>
            <pc:docMk/>
            <pc:sldMk cId="1299451647" sldId="257"/>
            <ac:spMk id="3" creationId="{00000000-0000-0000-0000-000000000000}"/>
          </ac:spMkLst>
        </pc:spChg>
        <pc:spChg chg="add mod">
          <ac:chgData name="Cercamondi,Colin Ivano,CH-Vevey" userId="d25e694c-3ff8-4193-82fc-75dd469e9cee" providerId="ADAL" clId="{A16F2C33-204C-4D20-A8B0-3F4160BF8763}" dt="2020-10-29T10:16:36.547" v="108" actId="1076"/>
          <ac:spMkLst>
            <pc:docMk/>
            <pc:sldMk cId="1299451647" sldId="257"/>
            <ac:spMk id="6" creationId="{E2658BC6-E908-47F2-8D80-8075CE348F99}"/>
          </ac:spMkLst>
        </pc:spChg>
        <pc:spChg chg="add mod">
          <ac:chgData name="Cercamondi,Colin Ivano,CH-Vevey" userId="d25e694c-3ff8-4193-82fc-75dd469e9cee" providerId="ADAL" clId="{A16F2C33-204C-4D20-A8B0-3F4160BF8763}" dt="2020-10-29T10:16:59.901" v="116" actId="1036"/>
          <ac:spMkLst>
            <pc:docMk/>
            <pc:sldMk cId="1299451647" sldId="257"/>
            <ac:spMk id="7" creationId="{0C5D272F-2D94-4F8A-9994-F5CDA4B27394}"/>
          </ac:spMkLst>
        </pc:spChg>
        <pc:picChg chg="mod">
          <ac:chgData name="Cercamondi,Colin Ivano,CH-Vevey" userId="d25e694c-3ff8-4193-82fc-75dd469e9cee" providerId="ADAL" clId="{A16F2C33-204C-4D20-A8B0-3F4160BF8763}" dt="2020-10-29T09:44:37.926" v="97" actId="1076"/>
          <ac:picMkLst>
            <pc:docMk/>
            <pc:sldMk cId="1299451647" sldId="257"/>
            <ac:picMk id="4" creationId="{07B678AA-EBCA-45B1-9B14-268888E0BE28}"/>
          </ac:picMkLst>
        </pc:picChg>
        <pc:picChg chg="mod">
          <ac:chgData name="Cercamondi,Colin Ivano,CH-Vevey" userId="d25e694c-3ff8-4193-82fc-75dd469e9cee" providerId="ADAL" clId="{A16F2C33-204C-4D20-A8B0-3F4160BF8763}" dt="2020-10-29T09:44:27.147" v="95" actId="1035"/>
          <ac:picMkLst>
            <pc:docMk/>
            <pc:sldMk cId="1299451647" sldId="257"/>
            <ac:picMk id="5" creationId="{81702BDC-7DEB-448F-AFE4-8BF6F6171D74}"/>
          </ac:picMkLst>
        </pc:picChg>
      </pc:sldChg>
      <pc:sldChg chg="addCm modCm">
        <pc:chgData name="Cercamondi,Colin Ivano,CH-Vevey" userId="d25e694c-3ff8-4193-82fc-75dd469e9cee" providerId="ADAL" clId="{A16F2C33-204C-4D20-A8B0-3F4160BF8763}" dt="2020-10-29T16:03:04.331" v="129"/>
        <pc:sldMkLst>
          <pc:docMk/>
          <pc:sldMk cId="3481645440" sldId="259"/>
        </pc:sldMkLst>
      </pc:sldChg>
      <pc:sldChg chg="addSp modSp">
        <pc:chgData name="Cercamondi,Colin Ivano,CH-Vevey" userId="d25e694c-3ff8-4193-82fc-75dd469e9cee" providerId="ADAL" clId="{A16F2C33-204C-4D20-A8B0-3F4160BF8763}" dt="2020-10-29T10:17:22.047" v="123" actId="20577"/>
        <pc:sldMkLst>
          <pc:docMk/>
          <pc:sldMk cId="3261540884" sldId="260"/>
        </pc:sldMkLst>
        <pc:spChg chg="add mod">
          <ac:chgData name="Cercamondi,Colin Ivano,CH-Vevey" userId="d25e694c-3ff8-4193-82fc-75dd469e9cee" providerId="ADAL" clId="{A16F2C33-204C-4D20-A8B0-3F4160BF8763}" dt="2020-10-29T10:16:14.518" v="101" actId="1076"/>
          <ac:spMkLst>
            <pc:docMk/>
            <pc:sldMk cId="3261540884" sldId="260"/>
            <ac:spMk id="8" creationId="{DF3150E2-C615-4092-9C88-57EC909FFFD0}"/>
          </ac:spMkLst>
        </pc:spChg>
        <pc:spChg chg="add mod">
          <ac:chgData name="Cercamondi,Colin Ivano,CH-Vevey" userId="d25e694c-3ff8-4193-82fc-75dd469e9cee" providerId="ADAL" clId="{A16F2C33-204C-4D20-A8B0-3F4160BF8763}" dt="2020-10-29T10:16:22.300" v="104" actId="20577"/>
          <ac:spMkLst>
            <pc:docMk/>
            <pc:sldMk cId="3261540884" sldId="260"/>
            <ac:spMk id="11" creationId="{F00137AC-B220-4DB4-830B-378E9B5FAB31}"/>
          </ac:spMkLst>
        </pc:spChg>
        <pc:spChg chg="add mod">
          <ac:chgData name="Cercamondi,Colin Ivano,CH-Vevey" userId="d25e694c-3ff8-4193-82fc-75dd469e9cee" providerId="ADAL" clId="{A16F2C33-204C-4D20-A8B0-3F4160BF8763}" dt="2020-10-29T10:17:22.047" v="123" actId="20577"/>
          <ac:spMkLst>
            <pc:docMk/>
            <pc:sldMk cId="3261540884" sldId="260"/>
            <ac:spMk id="12" creationId="{A6B30807-652E-46D6-9349-DC424F5F6ED5}"/>
          </ac:spMkLst>
        </pc:spChg>
      </pc:sldChg>
      <pc:sldChg chg="addCm delCm modCm">
        <pc:chgData name="Cercamondi,Colin Ivano,CH-Vevey" userId="d25e694c-3ff8-4193-82fc-75dd469e9cee" providerId="ADAL" clId="{A16F2C33-204C-4D20-A8B0-3F4160BF8763}" dt="2020-10-29T16:02:20.731" v="127"/>
        <pc:sldMkLst>
          <pc:docMk/>
          <pc:sldMk cId="3249222257" sldId="263"/>
        </pc:sldMkLst>
      </pc:sldChg>
      <pc:sldChg chg="addSp delSp modSp delCm">
        <pc:chgData name="Cercamondi,Colin Ivano,CH-Vevey" userId="d25e694c-3ff8-4193-82fc-75dd469e9cee" providerId="ADAL" clId="{A16F2C33-204C-4D20-A8B0-3F4160BF8763}" dt="2020-11-12T08:52:55.964" v="209" actId="1037"/>
        <pc:sldMkLst>
          <pc:docMk/>
          <pc:sldMk cId="1210609011" sldId="264"/>
        </pc:sldMkLst>
        <pc:spChg chg="mod">
          <ac:chgData name="Cercamondi,Colin Ivano,CH-Vevey" userId="d25e694c-3ff8-4193-82fc-75dd469e9cee" providerId="ADAL" clId="{A16F2C33-204C-4D20-A8B0-3F4160BF8763}" dt="2020-11-12T08:50:58.857" v="159" actId="20577"/>
          <ac:spMkLst>
            <pc:docMk/>
            <pc:sldMk cId="1210609011" sldId="264"/>
            <ac:spMk id="3" creationId="{00000000-0000-0000-0000-000000000000}"/>
          </ac:spMkLst>
        </pc:spChg>
        <pc:picChg chg="del mod">
          <ac:chgData name="Cercamondi,Colin Ivano,CH-Vevey" userId="d25e694c-3ff8-4193-82fc-75dd469e9cee" providerId="ADAL" clId="{A16F2C33-204C-4D20-A8B0-3F4160BF8763}" dt="2020-11-12T08:52:46.561" v="163" actId="478"/>
          <ac:picMkLst>
            <pc:docMk/>
            <pc:sldMk cId="1210609011" sldId="264"/>
            <ac:picMk id="5" creationId="{DEE768B5-63F7-464E-BA6A-8C33631BDF39}"/>
          </ac:picMkLst>
        </pc:picChg>
        <pc:picChg chg="add mod">
          <ac:chgData name="Cercamondi,Colin Ivano,CH-Vevey" userId="d25e694c-3ff8-4193-82fc-75dd469e9cee" providerId="ADAL" clId="{A16F2C33-204C-4D20-A8B0-3F4160BF8763}" dt="2020-11-12T08:52:55.964" v="209" actId="1037"/>
          <ac:picMkLst>
            <pc:docMk/>
            <pc:sldMk cId="1210609011" sldId="264"/>
            <ac:picMk id="6" creationId="{18D5B6ED-40DC-43D6-A489-235DE3276AC4}"/>
          </ac:picMkLst>
        </pc:picChg>
      </pc:sldChg>
      <pc:sldChg chg="addSp delSp modSp add addCm modCm">
        <pc:chgData name="Cercamondi,Colin Ivano,CH-Vevey" userId="d25e694c-3ff8-4193-82fc-75dd469e9cee" providerId="ADAL" clId="{A16F2C33-204C-4D20-A8B0-3F4160BF8763}" dt="2020-10-29T16:17:40.486" v="136"/>
        <pc:sldMkLst>
          <pc:docMk/>
          <pc:sldMk cId="4229023287" sldId="268"/>
        </pc:sldMkLst>
        <pc:spChg chg="del">
          <ac:chgData name="Cercamondi,Colin Ivano,CH-Vevey" userId="d25e694c-3ff8-4193-82fc-75dd469e9cee" providerId="ADAL" clId="{A16F2C33-204C-4D20-A8B0-3F4160BF8763}" dt="2020-10-18T20:07:01.898" v="3" actId="478"/>
          <ac:spMkLst>
            <pc:docMk/>
            <pc:sldMk cId="4229023287" sldId="268"/>
            <ac:spMk id="2" creationId="{A3D08AA7-D03F-4E60-9863-BAE1EA2D2BFF}"/>
          </ac:spMkLst>
        </pc:spChg>
        <pc:spChg chg="del">
          <ac:chgData name="Cercamondi,Colin Ivano,CH-Vevey" userId="d25e694c-3ff8-4193-82fc-75dd469e9cee" providerId="ADAL" clId="{A16F2C33-204C-4D20-A8B0-3F4160BF8763}" dt="2020-10-18T20:07:04.411" v="4" actId="478"/>
          <ac:spMkLst>
            <pc:docMk/>
            <pc:sldMk cId="4229023287" sldId="268"/>
            <ac:spMk id="3" creationId="{DA6E557D-2C1C-45C0-8DA3-DCDD27970725}"/>
          </ac:spMkLst>
        </pc:spChg>
        <pc:spChg chg="add mod">
          <ac:chgData name="Cercamondi,Colin Ivano,CH-Vevey" userId="d25e694c-3ff8-4193-82fc-75dd469e9cee" providerId="ADAL" clId="{A16F2C33-204C-4D20-A8B0-3F4160BF8763}" dt="2020-10-18T20:06:57.431" v="2" actId="20577"/>
          <ac:spMkLst>
            <pc:docMk/>
            <pc:sldMk cId="4229023287" sldId="268"/>
            <ac:spMk id="4" creationId="{30C8E7F9-0CD8-4BEB-9390-DCE92E2A3A02}"/>
          </ac:spMkLst>
        </pc:spChg>
        <pc:spChg chg="add mod">
          <ac:chgData name="Cercamondi,Colin Ivano,CH-Vevey" userId="d25e694c-3ff8-4193-82fc-75dd469e9cee" providerId="ADAL" clId="{A16F2C33-204C-4D20-A8B0-3F4160BF8763}" dt="2020-10-18T20:11:47.506" v="46" actId="20577"/>
          <ac:spMkLst>
            <pc:docMk/>
            <pc:sldMk cId="4229023287" sldId="268"/>
            <ac:spMk id="6" creationId="{81FA4653-DC30-4403-B45C-5C347BD53527}"/>
          </ac:spMkLst>
        </pc:spChg>
        <pc:picChg chg="add mod">
          <ac:chgData name="Cercamondi,Colin Ivano,CH-Vevey" userId="d25e694c-3ff8-4193-82fc-75dd469e9cee" providerId="ADAL" clId="{A16F2C33-204C-4D20-A8B0-3F4160BF8763}" dt="2020-10-18T20:09:07.042" v="38" actId="1035"/>
          <ac:picMkLst>
            <pc:docMk/>
            <pc:sldMk cId="4229023287" sldId="268"/>
            <ac:picMk id="5" creationId="{EE389787-8913-4E60-B581-1F10EC39CEC0}"/>
          </ac:picMkLst>
        </pc:picChg>
      </pc:sldChg>
    </pc:docChg>
  </pc:docChgLst>
  <pc:docChgLst>
    <pc:chgData name="Kortman, Guus" userId="41e95c6d-0420-46db-8343-bb7e712699d8" providerId="ADAL" clId="{6323886D-AB16-4D89-9951-A349FA53F311}"/>
    <pc:docChg chg="custSel modSld">
      <pc:chgData name="Kortman, Guus" userId="41e95c6d-0420-46db-8343-bb7e712699d8" providerId="ADAL" clId="{6323886D-AB16-4D89-9951-A349FA53F311}" dt="2020-10-28T12:38:50.743" v="172" actId="14100"/>
      <pc:docMkLst>
        <pc:docMk/>
      </pc:docMkLst>
      <pc:sldChg chg="addCm delCm modCm">
        <pc:chgData name="Kortman, Guus" userId="41e95c6d-0420-46db-8343-bb7e712699d8" providerId="ADAL" clId="{6323886D-AB16-4D89-9951-A349FA53F311}" dt="2020-10-07T09:42:05.388" v="137" actId="1589"/>
        <pc:sldMkLst>
          <pc:docMk/>
          <pc:sldMk cId="1299451647" sldId="257"/>
        </pc:sldMkLst>
      </pc:sldChg>
      <pc:sldChg chg="delSp modSp">
        <pc:chgData name="Kortman, Guus" userId="41e95c6d-0420-46db-8343-bb7e712699d8" providerId="ADAL" clId="{6323886D-AB16-4D89-9951-A349FA53F311}" dt="2020-10-07T09:15:21.880" v="119" actId="14100"/>
        <pc:sldMkLst>
          <pc:docMk/>
          <pc:sldMk cId="3574380604" sldId="258"/>
        </pc:sldMkLst>
        <pc:spChg chg="mod">
          <ac:chgData name="Kortman, Guus" userId="41e95c6d-0420-46db-8343-bb7e712699d8" providerId="ADAL" clId="{6323886D-AB16-4D89-9951-A349FA53F311}" dt="2020-10-07T09:15:21.880" v="119" actId="14100"/>
          <ac:spMkLst>
            <pc:docMk/>
            <pc:sldMk cId="3574380604" sldId="258"/>
            <ac:spMk id="3" creationId="{00000000-0000-0000-0000-000000000000}"/>
          </ac:spMkLst>
        </pc:spChg>
        <pc:spChg chg="del">
          <ac:chgData name="Kortman, Guus" userId="41e95c6d-0420-46db-8343-bb7e712699d8" providerId="ADAL" clId="{6323886D-AB16-4D89-9951-A349FA53F311}" dt="2020-10-07T09:08:13.516" v="13" actId="478"/>
          <ac:spMkLst>
            <pc:docMk/>
            <pc:sldMk cId="3574380604" sldId="258"/>
            <ac:spMk id="7" creationId="{BB2BE229-9E6C-42FB-8A7D-FBE0D909AAB7}"/>
          </ac:spMkLst>
        </pc:spChg>
        <pc:graphicFrameChg chg="mod">
          <ac:chgData name="Kortman, Guus" userId="41e95c6d-0420-46db-8343-bb7e712699d8" providerId="ADAL" clId="{6323886D-AB16-4D89-9951-A349FA53F311}" dt="2020-10-07T09:13:43.439" v="19" actId="1076"/>
          <ac:graphicFrameMkLst>
            <pc:docMk/>
            <pc:sldMk cId="3574380604" sldId="258"/>
            <ac:graphicFrameMk id="8" creationId="{50BC301F-BEEC-40A2-B527-7BDBC23ED723}"/>
          </ac:graphicFrameMkLst>
        </pc:graphicFrameChg>
        <pc:graphicFrameChg chg="del">
          <ac:chgData name="Kortman, Guus" userId="41e95c6d-0420-46db-8343-bb7e712699d8" providerId="ADAL" clId="{6323886D-AB16-4D89-9951-A349FA53F311}" dt="2020-10-07T09:08:14.447" v="14" actId="478"/>
          <ac:graphicFrameMkLst>
            <pc:docMk/>
            <pc:sldMk cId="3574380604" sldId="258"/>
            <ac:graphicFrameMk id="9" creationId="{260CAD17-4D7C-4FBF-905F-F94EB3F0F74A}"/>
          </ac:graphicFrameMkLst>
        </pc:graphicFrameChg>
        <pc:inkChg chg="del">
          <ac:chgData name="Kortman, Guus" userId="41e95c6d-0420-46db-8343-bb7e712699d8" providerId="ADAL" clId="{6323886D-AB16-4D89-9951-A349FA53F311}" dt="2020-10-07T09:08:15.564" v="15" actId="478"/>
          <ac:inkMkLst>
            <pc:docMk/>
            <pc:sldMk cId="3574380604" sldId="258"/>
            <ac:inkMk id="4" creationId="{1E16DAD9-084D-44C5-9AB0-35EA4367BD8F}"/>
          </ac:inkMkLst>
        </pc:inkChg>
        <pc:inkChg chg="del">
          <ac:chgData name="Kortman, Guus" userId="41e95c6d-0420-46db-8343-bb7e712699d8" providerId="ADAL" clId="{6323886D-AB16-4D89-9951-A349FA53F311}" dt="2020-10-07T09:08:17.393" v="16" actId="478"/>
          <ac:inkMkLst>
            <pc:docMk/>
            <pc:sldMk cId="3574380604" sldId="258"/>
            <ac:inkMk id="6" creationId="{E6905A35-9F7A-42F2-8642-BA3DA6F1925E}"/>
          </ac:inkMkLst>
        </pc:inkChg>
      </pc:sldChg>
      <pc:sldChg chg="addSp delSp modSp addCm delCm modCm">
        <pc:chgData name="Kortman, Guus" userId="41e95c6d-0420-46db-8343-bb7e712699d8" providerId="ADAL" clId="{6323886D-AB16-4D89-9951-A349FA53F311}" dt="2020-10-28T12:16:53.722" v="143" actId="1076"/>
        <pc:sldMkLst>
          <pc:docMk/>
          <pc:sldMk cId="3481645440" sldId="259"/>
        </pc:sldMkLst>
        <pc:picChg chg="del">
          <ac:chgData name="Kortman, Guus" userId="41e95c6d-0420-46db-8343-bb7e712699d8" providerId="ADAL" clId="{6323886D-AB16-4D89-9951-A349FA53F311}" dt="2020-10-07T09:30:39.469" v="120" actId="478"/>
          <ac:picMkLst>
            <pc:docMk/>
            <pc:sldMk cId="3481645440" sldId="259"/>
            <ac:picMk id="5" creationId="{0878DFAD-2D83-4878-AFCE-DC3701920568}"/>
          </ac:picMkLst>
        </pc:picChg>
        <pc:picChg chg="add mod">
          <ac:chgData name="Kortman, Guus" userId="41e95c6d-0420-46db-8343-bb7e712699d8" providerId="ADAL" clId="{6323886D-AB16-4D89-9951-A349FA53F311}" dt="2020-10-28T12:16:53.722" v="143" actId="1076"/>
          <ac:picMkLst>
            <pc:docMk/>
            <pc:sldMk cId="3481645440" sldId="259"/>
            <ac:picMk id="5" creationId="{DE64BB77-7C35-4F18-8417-05617E8DD58B}"/>
          </ac:picMkLst>
        </pc:picChg>
        <pc:picChg chg="add del mod">
          <ac:chgData name="Kortman, Guus" userId="41e95c6d-0420-46db-8343-bb7e712699d8" providerId="ADAL" clId="{6323886D-AB16-4D89-9951-A349FA53F311}" dt="2020-10-28T12:16:47.729" v="141" actId="478"/>
          <ac:picMkLst>
            <pc:docMk/>
            <pc:sldMk cId="3481645440" sldId="259"/>
            <ac:picMk id="8" creationId="{CDFBAE04-20C6-472F-88A7-1BCE1F7F080C}"/>
          </ac:picMkLst>
        </pc:picChg>
      </pc:sldChg>
      <pc:sldChg chg="addCm delCm modCm">
        <pc:chgData name="Kortman, Guus" userId="41e95c6d-0420-46db-8343-bb7e712699d8" providerId="ADAL" clId="{6323886D-AB16-4D89-9951-A349FA53F311}" dt="2020-10-07T09:42:43.835" v="139" actId="1592"/>
        <pc:sldMkLst>
          <pc:docMk/>
          <pc:sldMk cId="3249222257" sldId="263"/>
        </pc:sldMkLst>
      </pc:sldChg>
      <pc:sldChg chg="delCm">
        <pc:chgData name="Kortman, Guus" userId="41e95c6d-0420-46db-8343-bb7e712699d8" providerId="ADAL" clId="{6323886D-AB16-4D89-9951-A349FA53F311}" dt="2020-10-07T09:42:58.373" v="140" actId="1592"/>
        <pc:sldMkLst>
          <pc:docMk/>
          <pc:sldMk cId="1210609011" sldId="264"/>
        </pc:sldMkLst>
      </pc:sldChg>
      <pc:sldChg chg="addSp delSp modSp">
        <pc:chgData name="Kortman, Guus" userId="41e95c6d-0420-46db-8343-bb7e712699d8" providerId="ADAL" clId="{6323886D-AB16-4D89-9951-A349FA53F311}" dt="2020-10-28T12:17:31.112" v="146" actId="1076"/>
        <pc:sldMkLst>
          <pc:docMk/>
          <pc:sldMk cId="1153482099" sldId="267"/>
        </pc:sldMkLst>
        <pc:spChg chg="mod">
          <ac:chgData name="Kortman, Guus" userId="41e95c6d-0420-46db-8343-bb7e712699d8" providerId="ADAL" clId="{6323886D-AB16-4D89-9951-A349FA53F311}" dt="2020-10-07T09:39:50.749" v="131" actId="207"/>
          <ac:spMkLst>
            <pc:docMk/>
            <pc:sldMk cId="1153482099" sldId="267"/>
            <ac:spMk id="3" creationId="{00000000-0000-0000-0000-000000000000}"/>
          </ac:spMkLst>
        </pc:spChg>
        <pc:picChg chg="add del mod">
          <ac:chgData name="Kortman, Guus" userId="41e95c6d-0420-46db-8343-bb7e712699d8" providerId="ADAL" clId="{6323886D-AB16-4D89-9951-A349FA53F311}" dt="2020-10-28T12:17:27.099" v="144" actId="478"/>
          <ac:picMkLst>
            <pc:docMk/>
            <pc:sldMk cId="1153482099" sldId="267"/>
            <ac:picMk id="5" creationId="{58E05BF9-A406-4CEF-B76C-061A5F7E9A00}"/>
          </ac:picMkLst>
        </pc:picChg>
        <pc:picChg chg="add mod">
          <ac:chgData name="Kortman, Guus" userId="41e95c6d-0420-46db-8343-bb7e712699d8" providerId="ADAL" clId="{6323886D-AB16-4D89-9951-A349FA53F311}" dt="2020-10-28T12:17:31.112" v="146" actId="1076"/>
          <ac:picMkLst>
            <pc:docMk/>
            <pc:sldMk cId="1153482099" sldId="267"/>
            <ac:picMk id="6" creationId="{767D1AEF-C759-401F-962D-6328A4D555A1}"/>
          </ac:picMkLst>
        </pc:picChg>
      </pc:sldChg>
      <pc:sldChg chg="addSp delSp modSp">
        <pc:chgData name="Kortman, Guus" userId="41e95c6d-0420-46db-8343-bb7e712699d8" providerId="ADAL" clId="{6323886D-AB16-4D89-9951-A349FA53F311}" dt="2020-10-28T12:38:50.743" v="172" actId="14100"/>
        <pc:sldMkLst>
          <pc:docMk/>
          <pc:sldMk cId="4229023287" sldId="268"/>
        </pc:sldMkLst>
        <pc:picChg chg="add del mod">
          <ac:chgData name="Kortman, Guus" userId="41e95c6d-0420-46db-8343-bb7e712699d8" providerId="ADAL" clId="{6323886D-AB16-4D89-9951-A349FA53F311}" dt="2020-10-28T12:30:43.566" v="151" actId="478"/>
          <ac:picMkLst>
            <pc:docMk/>
            <pc:sldMk cId="4229023287" sldId="268"/>
            <ac:picMk id="2" creationId="{357B8051-4CD1-4CE8-94A2-688F35B279F9}"/>
          </ac:picMkLst>
        </pc:picChg>
        <pc:picChg chg="add mod">
          <ac:chgData name="Kortman, Guus" userId="41e95c6d-0420-46db-8343-bb7e712699d8" providerId="ADAL" clId="{6323886D-AB16-4D89-9951-A349FA53F311}" dt="2020-10-28T12:30:50.564" v="154" actId="1076"/>
          <ac:picMkLst>
            <pc:docMk/>
            <pc:sldMk cId="4229023287" sldId="268"/>
            <ac:picMk id="3" creationId="{DFE11FC4-1C39-4E96-B121-EC348B77F58C}"/>
          </ac:picMkLst>
        </pc:picChg>
        <pc:picChg chg="del">
          <ac:chgData name="Kortman, Guus" userId="41e95c6d-0420-46db-8343-bb7e712699d8" providerId="ADAL" clId="{6323886D-AB16-4D89-9951-A349FA53F311}" dt="2020-10-28T12:25:40.749" v="147" actId="478"/>
          <ac:picMkLst>
            <pc:docMk/>
            <pc:sldMk cId="4229023287" sldId="268"/>
            <ac:picMk id="5" creationId="{EE389787-8913-4E60-B581-1F10EC39CEC0}"/>
          </ac:picMkLst>
        </pc:picChg>
        <pc:picChg chg="add mod">
          <ac:chgData name="Kortman, Guus" userId="41e95c6d-0420-46db-8343-bb7e712699d8" providerId="ADAL" clId="{6323886D-AB16-4D89-9951-A349FA53F311}" dt="2020-10-28T12:37:55.328" v="160" actId="1076"/>
          <ac:picMkLst>
            <pc:docMk/>
            <pc:sldMk cId="4229023287" sldId="268"/>
            <ac:picMk id="7" creationId="{5D74F200-EC70-455D-A7C2-2CD098E4195F}"/>
          </ac:picMkLst>
        </pc:picChg>
        <pc:picChg chg="add mod">
          <ac:chgData name="Kortman, Guus" userId="41e95c6d-0420-46db-8343-bb7e712699d8" providerId="ADAL" clId="{6323886D-AB16-4D89-9951-A349FA53F311}" dt="2020-10-28T12:38:23.957" v="167" actId="1076"/>
          <ac:picMkLst>
            <pc:docMk/>
            <pc:sldMk cId="4229023287" sldId="268"/>
            <ac:picMk id="8" creationId="{DC024299-3823-4DE1-90E9-C98CC54F08E1}"/>
          </ac:picMkLst>
        </pc:picChg>
        <pc:picChg chg="add mod">
          <ac:chgData name="Kortman, Guus" userId="41e95c6d-0420-46db-8343-bb7e712699d8" providerId="ADAL" clId="{6323886D-AB16-4D89-9951-A349FA53F311}" dt="2020-10-28T12:38:50.743" v="172" actId="14100"/>
          <ac:picMkLst>
            <pc:docMk/>
            <pc:sldMk cId="4229023287" sldId="268"/>
            <ac:picMk id="9" creationId="{1CA31809-C731-4381-A145-A7CD21CA43C3}"/>
          </ac:picMkLst>
        </pc:picChg>
      </pc:sldChg>
    </pc:docChg>
  </pc:docChgLst>
  <pc:docChgLst>
    <pc:chgData name="Berger,Bernard,CH-Lausanne" userId="S::bernard.berger@rdls.nestle.com::e82bb347-e851-4db7-bca8-21df8a20dbf3" providerId="AD" clId="Web-{EE26EF87-F617-59BF-4540-35A4C634D31C}"/>
    <pc:docChg chg="modSld">
      <pc:chgData name="Berger,Bernard,CH-Lausanne" userId="S::bernard.berger@rdls.nestle.com::e82bb347-e851-4db7-bca8-21df8a20dbf3" providerId="AD" clId="Web-{EE26EF87-F617-59BF-4540-35A4C634D31C}" dt="2020-10-07T07:50:23.397" v="7"/>
      <pc:docMkLst>
        <pc:docMk/>
      </pc:docMkLst>
      <pc:sldChg chg="addSp">
        <pc:chgData name="Berger,Bernard,CH-Lausanne" userId="S::bernard.berger@rdls.nestle.com::e82bb347-e851-4db7-bca8-21df8a20dbf3" providerId="AD" clId="Web-{EE26EF87-F617-59BF-4540-35A4C634D31C}" dt="2020-10-07T07:07:15.579" v="1"/>
        <pc:sldMkLst>
          <pc:docMk/>
          <pc:sldMk cId="3574380604" sldId="258"/>
        </pc:sldMkLst>
        <pc:inkChg chg="add">
          <ac:chgData name="Berger,Bernard,CH-Lausanne" userId="S::bernard.berger@rdls.nestle.com::e82bb347-e851-4db7-bca8-21df8a20dbf3" providerId="AD" clId="Web-{EE26EF87-F617-59BF-4540-35A4C634D31C}" dt="2020-10-07T07:06:05.609" v="0"/>
          <ac:inkMkLst>
            <pc:docMk/>
            <pc:sldMk cId="3574380604" sldId="258"/>
            <ac:inkMk id="4" creationId="{1E16DAD9-084D-44C5-9AB0-35EA4367BD8F}"/>
          </ac:inkMkLst>
        </pc:inkChg>
        <pc:inkChg chg="add">
          <ac:chgData name="Berger,Bernard,CH-Lausanne" userId="S::bernard.berger@rdls.nestle.com::e82bb347-e851-4db7-bca8-21df8a20dbf3" providerId="AD" clId="Web-{EE26EF87-F617-59BF-4540-35A4C634D31C}" dt="2020-10-07T07:07:15.579" v="1"/>
          <ac:inkMkLst>
            <pc:docMk/>
            <pc:sldMk cId="3574380604" sldId="258"/>
            <ac:inkMk id="6" creationId="{E6905A35-9F7A-42F2-8642-BA3DA6F1925E}"/>
          </ac:inkMkLst>
        </pc:inkChg>
      </pc:sldChg>
      <pc:sldChg chg="addSp">
        <pc:chgData name="Berger,Bernard,CH-Lausanne" userId="S::bernard.berger@rdls.nestle.com::e82bb347-e851-4db7-bca8-21df8a20dbf3" providerId="AD" clId="Web-{EE26EF87-F617-59BF-4540-35A4C634D31C}" dt="2020-10-07T07:19:21.295" v="4"/>
        <pc:sldMkLst>
          <pc:docMk/>
          <pc:sldMk cId="3481645440" sldId="259"/>
        </pc:sldMkLst>
        <pc:inkChg chg="add">
          <ac:chgData name="Berger,Bernard,CH-Lausanne" userId="S::bernard.berger@rdls.nestle.com::e82bb347-e851-4db7-bca8-21df8a20dbf3" providerId="AD" clId="Web-{EE26EF87-F617-59BF-4540-35A4C634D31C}" dt="2020-10-07T07:17:05.980" v="3"/>
          <ac:inkMkLst>
            <pc:docMk/>
            <pc:sldMk cId="3481645440" sldId="259"/>
            <ac:inkMk id="6" creationId="{48BC38D3-DD2D-4D85-9233-6C72D387CF43}"/>
          </ac:inkMkLst>
        </pc:inkChg>
        <pc:inkChg chg="add">
          <ac:chgData name="Berger,Bernard,CH-Lausanne" userId="S::bernard.berger@rdls.nestle.com::e82bb347-e851-4db7-bca8-21df8a20dbf3" providerId="AD" clId="Web-{EE26EF87-F617-59BF-4540-35A4C634D31C}" dt="2020-10-07T07:19:21.295" v="4"/>
          <ac:inkMkLst>
            <pc:docMk/>
            <pc:sldMk cId="3481645440" sldId="259"/>
            <ac:inkMk id="7" creationId="{A144B03C-C196-4DB4-AFED-A1F5876DC8D1}"/>
          </ac:inkMkLst>
        </pc:inkChg>
      </pc:sldChg>
      <pc:sldChg chg="addSp delSp">
        <pc:chgData name="Berger,Bernard,CH-Lausanne" userId="S::bernard.berger@rdls.nestle.com::e82bb347-e851-4db7-bca8-21df8a20dbf3" providerId="AD" clId="Web-{EE26EF87-F617-59BF-4540-35A4C634D31C}" dt="2020-10-07T07:50:23.397" v="7"/>
        <pc:sldMkLst>
          <pc:docMk/>
          <pc:sldMk cId="3261540884" sldId="260"/>
        </pc:sldMkLst>
        <pc:inkChg chg="add">
          <ac:chgData name="Berger,Bernard,CH-Lausanne" userId="S::bernard.berger@rdls.nestle.com::e82bb347-e851-4db7-bca8-21df8a20dbf3" providerId="AD" clId="Web-{EE26EF87-F617-59BF-4540-35A4C634D31C}" dt="2020-10-07T07:50:13.288" v="5"/>
          <ac:inkMkLst>
            <pc:docMk/>
            <pc:sldMk cId="3261540884" sldId="260"/>
            <ac:inkMk id="4" creationId="{12648172-ABCC-4246-8600-67E77C19D8F8}"/>
          </ac:inkMkLst>
        </pc:inkChg>
        <pc:inkChg chg="add del">
          <ac:chgData name="Berger,Bernard,CH-Lausanne" userId="S::bernard.berger@rdls.nestle.com::e82bb347-e851-4db7-bca8-21df8a20dbf3" providerId="AD" clId="Web-{EE26EF87-F617-59BF-4540-35A4C634D31C}" dt="2020-10-07T07:50:23.397" v="7"/>
          <ac:inkMkLst>
            <pc:docMk/>
            <pc:sldMk cId="3261540884" sldId="260"/>
            <ac:inkMk id="5" creationId="{D223D890-D8FC-49CB-A6B8-15CE52AEFB07}"/>
          </ac:inkMkLst>
        </pc:inkChg>
      </pc:sldChg>
      <pc:sldChg chg="addSp">
        <pc:chgData name="Berger,Bernard,CH-Lausanne" userId="S::bernard.berger@rdls.nestle.com::e82bb347-e851-4db7-bca8-21df8a20dbf3" providerId="AD" clId="Web-{EE26EF87-F617-59BF-4540-35A4C634D31C}" dt="2020-10-07T07:09:15.144" v="2"/>
        <pc:sldMkLst>
          <pc:docMk/>
          <pc:sldMk cId="1915425" sldId="265"/>
        </pc:sldMkLst>
        <pc:inkChg chg="add">
          <ac:chgData name="Berger,Bernard,CH-Lausanne" userId="S::bernard.berger@rdls.nestle.com::e82bb347-e851-4db7-bca8-21df8a20dbf3" providerId="AD" clId="Web-{EE26EF87-F617-59BF-4540-35A4C634D31C}" dt="2020-10-07T07:09:15.144" v="2"/>
          <ac:inkMkLst>
            <pc:docMk/>
            <pc:sldMk cId="1915425" sldId="265"/>
            <ac:inkMk id="6" creationId="{7D7A02F9-DB45-4919-986B-F7147132B7F8}"/>
          </ac:inkMkLst>
        </pc:inkChg>
      </pc:sldChg>
    </pc:docChg>
  </pc:docChgLst>
  <pc:docChgLst>
    <pc:chgData name="Cercamondi,Colin Ivano,CH-Vevey" userId="d25e694c-3ff8-4193-82fc-75dd469e9cee" providerId="ADAL" clId="{C7E5EE27-21D3-41A1-AF7C-1292D5D7928D}"/>
    <pc:docChg chg="undo custSel addSld delSld modSld sldOrd modMainMaster">
      <pc:chgData name="Cercamondi,Colin Ivano,CH-Vevey" userId="d25e694c-3ff8-4193-82fc-75dd469e9cee" providerId="ADAL" clId="{C7E5EE27-21D3-41A1-AF7C-1292D5D7928D}" dt="2021-01-19T14:00:30.392" v="1296"/>
      <pc:docMkLst>
        <pc:docMk/>
      </pc:docMkLst>
      <pc:sldChg chg="addSp delSp modSp delCm">
        <pc:chgData name="Cercamondi,Colin Ivano,CH-Vevey" userId="d25e694c-3ff8-4193-82fc-75dd469e9cee" providerId="ADAL" clId="{C7E5EE27-21D3-41A1-AF7C-1292D5D7928D}" dt="2021-01-19T12:37:39.318" v="1284" actId="20577"/>
        <pc:sldMkLst>
          <pc:docMk/>
          <pc:sldMk cId="109857222" sldId="256"/>
        </pc:sldMkLst>
        <pc:spChg chg="mod">
          <ac:chgData name="Cercamondi,Colin Ivano,CH-Vevey" userId="d25e694c-3ff8-4193-82fc-75dd469e9cee" providerId="ADAL" clId="{C7E5EE27-21D3-41A1-AF7C-1292D5D7928D}" dt="2021-01-18T20:24:43.261" v="755" actId="1076"/>
          <ac:spMkLst>
            <pc:docMk/>
            <pc:sldMk cId="109857222" sldId="256"/>
            <ac:spMk id="2" creationId="{00000000-0000-0000-0000-000000000000}"/>
          </ac:spMkLst>
        </pc:spChg>
        <pc:spChg chg="del">
          <ac:chgData name="Cercamondi,Colin Ivano,CH-Vevey" userId="d25e694c-3ff8-4193-82fc-75dd469e9cee" providerId="ADAL" clId="{C7E5EE27-21D3-41A1-AF7C-1292D5D7928D}" dt="2021-01-18T20:24:37.048" v="754" actId="478"/>
          <ac:spMkLst>
            <pc:docMk/>
            <pc:sldMk cId="109857222" sldId="256"/>
            <ac:spMk id="3" creationId="{C3823737-F235-485E-AB7F-55083DAACE50}"/>
          </ac:spMkLst>
        </pc:spChg>
        <pc:spChg chg="del mod">
          <ac:chgData name="Cercamondi,Colin Ivano,CH-Vevey" userId="d25e694c-3ff8-4193-82fc-75dd469e9cee" providerId="ADAL" clId="{C7E5EE27-21D3-41A1-AF7C-1292D5D7928D}" dt="2021-01-18T20:40:33.874" v="767" actId="478"/>
          <ac:spMkLst>
            <pc:docMk/>
            <pc:sldMk cId="109857222" sldId="256"/>
            <ac:spMk id="5" creationId="{9A249F47-1ED4-4170-BDAD-750E309A02F2}"/>
          </ac:spMkLst>
        </pc:spChg>
        <pc:spChg chg="del">
          <ac:chgData name="Cercamondi,Colin Ivano,CH-Vevey" userId="d25e694c-3ff8-4193-82fc-75dd469e9cee" providerId="ADAL" clId="{C7E5EE27-21D3-41A1-AF7C-1292D5D7928D}" dt="2021-01-18T20:24:37.048" v="754" actId="478"/>
          <ac:spMkLst>
            <pc:docMk/>
            <pc:sldMk cId="109857222" sldId="256"/>
            <ac:spMk id="7" creationId="{BA57869A-C8D7-4F9D-80D1-458D020127F8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109857222" sldId="256"/>
            <ac:spMk id="8" creationId="{B42FEAC0-0A9F-49F0-B139-A90BB146A5F6}"/>
          </ac:spMkLst>
        </pc:spChg>
        <pc:spChg chg="del">
          <ac:chgData name="Cercamondi,Colin Ivano,CH-Vevey" userId="d25e694c-3ff8-4193-82fc-75dd469e9cee" providerId="ADAL" clId="{C7E5EE27-21D3-41A1-AF7C-1292D5D7928D}" dt="2021-01-18T20:24:37.048" v="754" actId="478"/>
          <ac:spMkLst>
            <pc:docMk/>
            <pc:sldMk cId="109857222" sldId="256"/>
            <ac:spMk id="10" creationId="{1BCDD75C-0B64-4B21-94D6-07C81321A4D8}"/>
          </ac:spMkLst>
        </pc:spChg>
        <pc:spChg chg="del">
          <ac:chgData name="Cercamondi,Colin Ivano,CH-Vevey" userId="d25e694c-3ff8-4193-82fc-75dd469e9cee" providerId="ADAL" clId="{C7E5EE27-21D3-41A1-AF7C-1292D5D7928D}" dt="2021-01-18T20:24:37.048" v="754" actId="478"/>
          <ac:spMkLst>
            <pc:docMk/>
            <pc:sldMk cId="109857222" sldId="256"/>
            <ac:spMk id="12" creationId="{45A87E81-B498-4EFE-B2F4-B6604AC2F798}"/>
          </ac:spMkLst>
        </pc:spChg>
        <pc:spChg chg="del">
          <ac:chgData name="Cercamondi,Colin Ivano,CH-Vevey" userId="d25e694c-3ff8-4193-82fc-75dd469e9cee" providerId="ADAL" clId="{C7E5EE27-21D3-41A1-AF7C-1292D5D7928D}" dt="2021-01-18T20:24:37.048" v="754" actId="478"/>
          <ac:spMkLst>
            <pc:docMk/>
            <pc:sldMk cId="109857222" sldId="256"/>
            <ac:spMk id="14" creationId="{34DDCB74-77C2-4CA2-9E94-A2A93233688C}"/>
          </ac:spMkLst>
        </pc:spChg>
        <pc:spChg chg="add">
          <ac:chgData name="Cercamondi,Colin Ivano,CH-Vevey" userId="d25e694c-3ff8-4193-82fc-75dd469e9cee" providerId="ADAL" clId="{C7E5EE27-21D3-41A1-AF7C-1292D5D7928D}" dt="2021-01-18T20:27:45.813" v="756"/>
          <ac:spMkLst>
            <pc:docMk/>
            <pc:sldMk cId="109857222" sldId="256"/>
            <ac:spMk id="15" creationId="{025E058F-9E81-48D8-A83C-404FD6EFCA7F}"/>
          </ac:spMkLst>
        </pc:spChg>
        <pc:spChg chg="add">
          <ac:chgData name="Cercamondi,Colin Ivano,CH-Vevey" userId="d25e694c-3ff8-4193-82fc-75dd469e9cee" providerId="ADAL" clId="{C7E5EE27-21D3-41A1-AF7C-1292D5D7928D}" dt="2021-01-18T20:27:45.813" v="756"/>
          <ac:spMkLst>
            <pc:docMk/>
            <pc:sldMk cId="109857222" sldId="256"/>
            <ac:spMk id="16" creationId="{90F3694A-BD7F-44FD-8637-E03F3674001F}"/>
          </ac:spMkLst>
        </pc:spChg>
        <pc:spChg chg="add">
          <ac:chgData name="Cercamondi,Colin Ivano,CH-Vevey" userId="d25e694c-3ff8-4193-82fc-75dd469e9cee" providerId="ADAL" clId="{C7E5EE27-21D3-41A1-AF7C-1292D5D7928D}" dt="2021-01-18T20:27:45.813" v="756"/>
          <ac:spMkLst>
            <pc:docMk/>
            <pc:sldMk cId="109857222" sldId="256"/>
            <ac:spMk id="17" creationId="{ACC496A6-4C19-4153-BBA1-312FDD6B716E}"/>
          </ac:spMkLst>
        </pc:spChg>
        <pc:spChg chg="add mod">
          <ac:chgData name="Cercamondi,Colin Ivano,CH-Vevey" userId="d25e694c-3ff8-4193-82fc-75dd469e9cee" providerId="ADAL" clId="{C7E5EE27-21D3-41A1-AF7C-1292D5D7928D}" dt="2021-01-19T12:36:05.043" v="1237" actId="20577"/>
          <ac:spMkLst>
            <pc:docMk/>
            <pc:sldMk cId="109857222" sldId="256"/>
            <ac:spMk id="18" creationId="{49F47FF3-31EA-4757-95D9-B525345F9127}"/>
          </ac:spMkLst>
        </pc:spChg>
        <pc:spChg chg="add mod">
          <ac:chgData name="Cercamondi,Colin Ivano,CH-Vevey" userId="d25e694c-3ff8-4193-82fc-75dd469e9cee" providerId="ADAL" clId="{C7E5EE27-21D3-41A1-AF7C-1292D5D7928D}" dt="2021-01-19T12:33:45.102" v="1096" actId="14100"/>
          <ac:spMkLst>
            <pc:docMk/>
            <pc:sldMk cId="109857222" sldId="256"/>
            <ac:spMk id="19" creationId="{2FC1F329-7DF3-447F-9AC5-3849D388919C}"/>
          </ac:spMkLst>
        </pc:spChg>
        <pc:spChg chg="add mod">
          <ac:chgData name="Cercamondi,Colin Ivano,CH-Vevey" userId="d25e694c-3ff8-4193-82fc-75dd469e9cee" providerId="ADAL" clId="{C7E5EE27-21D3-41A1-AF7C-1292D5D7928D}" dt="2021-01-19T12:35:48.415" v="1232" actId="20577"/>
          <ac:spMkLst>
            <pc:docMk/>
            <pc:sldMk cId="109857222" sldId="256"/>
            <ac:spMk id="20" creationId="{9A30711F-CCC2-49DC-B7C9-1DE4364A4993}"/>
          </ac:spMkLst>
        </pc:spChg>
        <pc:spChg chg="add">
          <ac:chgData name="Cercamondi,Colin Ivano,CH-Vevey" userId="d25e694c-3ff8-4193-82fc-75dd469e9cee" providerId="ADAL" clId="{C7E5EE27-21D3-41A1-AF7C-1292D5D7928D}" dt="2021-01-18T20:27:45.813" v="756"/>
          <ac:spMkLst>
            <pc:docMk/>
            <pc:sldMk cId="109857222" sldId="256"/>
            <ac:spMk id="21" creationId="{9DD15496-2CEB-4B4D-BEB3-520A3ADD6940}"/>
          </ac:spMkLst>
        </pc:spChg>
        <pc:spChg chg="add mod">
          <ac:chgData name="Cercamondi,Colin Ivano,CH-Vevey" userId="d25e694c-3ff8-4193-82fc-75dd469e9cee" providerId="ADAL" clId="{C7E5EE27-21D3-41A1-AF7C-1292D5D7928D}" dt="2021-01-19T12:35:52.524" v="1234" actId="20577"/>
          <ac:spMkLst>
            <pc:docMk/>
            <pc:sldMk cId="109857222" sldId="256"/>
            <ac:spMk id="22" creationId="{389D65FA-6926-4B6A-89F2-32FF6AFA8193}"/>
          </ac:spMkLst>
        </pc:spChg>
        <pc:spChg chg="add">
          <ac:chgData name="Cercamondi,Colin Ivano,CH-Vevey" userId="d25e694c-3ff8-4193-82fc-75dd469e9cee" providerId="ADAL" clId="{C7E5EE27-21D3-41A1-AF7C-1292D5D7928D}" dt="2021-01-18T20:27:45.813" v="756"/>
          <ac:spMkLst>
            <pc:docMk/>
            <pc:sldMk cId="109857222" sldId="256"/>
            <ac:spMk id="23" creationId="{D736D421-07E9-443F-8881-CFEC06F599E6}"/>
          </ac:spMkLst>
        </pc:spChg>
        <pc:spChg chg="add">
          <ac:chgData name="Cercamondi,Colin Ivano,CH-Vevey" userId="d25e694c-3ff8-4193-82fc-75dd469e9cee" providerId="ADAL" clId="{C7E5EE27-21D3-41A1-AF7C-1292D5D7928D}" dt="2021-01-18T20:27:45.813" v="756"/>
          <ac:spMkLst>
            <pc:docMk/>
            <pc:sldMk cId="109857222" sldId="256"/>
            <ac:spMk id="24" creationId="{B31B1D76-421D-413A-A6CB-06E788EDF4A8}"/>
          </ac:spMkLst>
        </pc:spChg>
        <pc:spChg chg="add mod">
          <ac:chgData name="Cercamondi,Colin Ivano,CH-Vevey" userId="d25e694c-3ff8-4193-82fc-75dd469e9cee" providerId="ADAL" clId="{C7E5EE27-21D3-41A1-AF7C-1292D5D7928D}" dt="2021-01-19T12:33:24.458" v="1094" actId="1076"/>
          <ac:spMkLst>
            <pc:docMk/>
            <pc:sldMk cId="109857222" sldId="256"/>
            <ac:spMk id="25" creationId="{ACDF26AB-968A-409C-9131-65FCC0898D59}"/>
          </ac:spMkLst>
        </pc:spChg>
        <pc:spChg chg="add mod">
          <ac:chgData name="Cercamondi,Colin Ivano,CH-Vevey" userId="d25e694c-3ff8-4193-82fc-75dd469e9cee" providerId="ADAL" clId="{C7E5EE27-21D3-41A1-AF7C-1292D5D7928D}" dt="2021-01-19T12:33:08.425" v="1092" actId="14100"/>
          <ac:spMkLst>
            <pc:docMk/>
            <pc:sldMk cId="109857222" sldId="256"/>
            <ac:spMk id="26" creationId="{58174D21-BBA6-4400-90EB-C87BFCB51832}"/>
          </ac:spMkLst>
        </pc:spChg>
        <pc:spChg chg="add mod">
          <ac:chgData name="Cercamondi,Colin Ivano,CH-Vevey" userId="d25e694c-3ff8-4193-82fc-75dd469e9cee" providerId="ADAL" clId="{C7E5EE27-21D3-41A1-AF7C-1292D5D7928D}" dt="2021-01-19T12:35:55.908" v="1236" actId="20577"/>
          <ac:spMkLst>
            <pc:docMk/>
            <pc:sldMk cId="109857222" sldId="256"/>
            <ac:spMk id="27" creationId="{041C7B99-7A98-4E78-9804-1596F065576E}"/>
          </ac:spMkLst>
        </pc:spChg>
        <pc:spChg chg="add">
          <ac:chgData name="Cercamondi,Colin Ivano,CH-Vevey" userId="d25e694c-3ff8-4193-82fc-75dd469e9cee" providerId="ADAL" clId="{C7E5EE27-21D3-41A1-AF7C-1292D5D7928D}" dt="2021-01-18T20:27:45.813" v="756"/>
          <ac:spMkLst>
            <pc:docMk/>
            <pc:sldMk cId="109857222" sldId="256"/>
            <ac:spMk id="28" creationId="{F6AA7AC3-1174-4474-BD16-2993020C1C9F}"/>
          </ac:spMkLst>
        </pc:spChg>
        <pc:spChg chg="add">
          <ac:chgData name="Cercamondi,Colin Ivano,CH-Vevey" userId="d25e694c-3ff8-4193-82fc-75dd469e9cee" providerId="ADAL" clId="{C7E5EE27-21D3-41A1-AF7C-1292D5D7928D}" dt="2021-01-18T20:27:45.813" v="756"/>
          <ac:spMkLst>
            <pc:docMk/>
            <pc:sldMk cId="109857222" sldId="256"/>
            <ac:spMk id="30" creationId="{41505651-91C4-47BD-AC4F-9F83C54936BE}"/>
          </ac:spMkLst>
        </pc:spChg>
        <pc:spChg chg="add">
          <ac:chgData name="Cercamondi,Colin Ivano,CH-Vevey" userId="d25e694c-3ff8-4193-82fc-75dd469e9cee" providerId="ADAL" clId="{C7E5EE27-21D3-41A1-AF7C-1292D5D7928D}" dt="2021-01-18T20:27:45.813" v="756"/>
          <ac:spMkLst>
            <pc:docMk/>
            <pc:sldMk cId="109857222" sldId="256"/>
            <ac:spMk id="31" creationId="{AFDA443B-7AC5-42FD-B3AE-6D008E937FC0}"/>
          </ac:spMkLst>
        </pc:spChg>
        <pc:spChg chg="add mod">
          <ac:chgData name="Cercamondi,Colin Ivano,CH-Vevey" userId="d25e694c-3ff8-4193-82fc-75dd469e9cee" providerId="ADAL" clId="{C7E5EE27-21D3-41A1-AF7C-1292D5D7928D}" dt="2021-01-19T12:37:39.318" v="1284" actId="20577"/>
          <ac:spMkLst>
            <pc:docMk/>
            <pc:sldMk cId="109857222" sldId="256"/>
            <ac:spMk id="32" creationId="{BADCC188-C84E-4C45-9C26-4E35DD1F97E5}"/>
          </ac:spMkLst>
        </pc:spChg>
        <pc:spChg chg="add">
          <ac:chgData name="Cercamondi,Colin Ivano,CH-Vevey" userId="d25e694c-3ff8-4193-82fc-75dd469e9cee" providerId="ADAL" clId="{C7E5EE27-21D3-41A1-AF7C-1292D5D7928D}" dt="2021-01-18T20:27:45.813" v="756"/>
          <ac:spMkLst>
            <pc:docMk/>
            <pc:sldMk cId="109857222" sldId="256"/>
            <ac:spMk id="38" creationId="{79FC7981-7CF4-44BD-A412-845821CC04A9}"/>
          </ac:spMkLst>
        </pc:spChg>
        <pc:spChg chg="add mod">
          <ac:chgData name="Cercamondi,Colin Ivano,CH-Vevey" userId="d25e694c-3ff8-4193-82fc-75dd469e9cee" providerId="ADAL" clId="{C7E5EE27-21D3-41A1-AF7C-1292D5D7928D}" dt="2021-01-19T12:34:03.102" v="1110" actId="20577"/>
          <ac:spMkLst>
            <pc:docMk/>
            <pc:sldMk cId="109857222" sldId="256"/>
            <ac:spMk id="42" creationId="{C5676B0E-A4A1-4F7A-9920-E8621EA713CB}"/>
          </ac:spMkLst>
        </pc:spChg>
        <pc:picChg chg="del mod">
          <ac:chgData name="Cercamondi,Colin Ivano,CH-Vevey" userId="d25e694c-3ff8-4193-82fc-75dd469e9cee" providerId="ADAL" clId="{C7E5EE27-21D3-41A1-AF7C-1292D5D7928D}" dt="2021-01-18T20:24:30.828" v="752" actId="478"/>
          <ac:picMkLst>
            <pc:docMk/>
            <pc:sldMk cId="109857222" sldId="256"/>
            <ac:picMk id="4" creationId="{2601AFFB-1F80-49E9-B2D8-1AC9C9938783}"/>
          </ac:picMkLst>
        </pc:picChg>
        <pc:cxnChg chg="del">
          <ac:chgData name="Cercamondi,Colin Ivano,CH-Vevey" userId="d25e694c-3ff8-4193-82fc-75dd469e9cee" providerId="ADAL" clId="{C7E5EE27-21D3-41A1-AF7C-1292D5D7928D}" dt="2021-01-18T20:24:37.048" v="754" actId="478"/>
          <ac:cxnSpMkLst>
            <pc:docMk/>
            <pc:sldMk cId="109857222" sldId="256"/>
            <ac:cxnSpMk id="6" creationId="{59A35516-239A-42DD-B9AD-46DF1AC7EC72}"/>
          </ac:cxnSpMkLst>
        </pc:cxnChg>
        <pc:cxnChg chg="del">
          <ac:chgData name="Cercamondi,Colin Ivano,CH-Vevey" userId="d25e694c-3ff8-4193-82fc-75dd469e9cee" providerId="ADAL" clId="{C7E5EE27-21D3-41A1-AF7C-1292D5D7928D}" dt="2021-01-18T20:24:37.048" v="754" actId="478"/>
          <ac:cxnSpMkLst>
            <pc:docMk/>
            <pc:sldMk cId="109857222" sldId="256"/>
            <ac:cxnSpMk id="9" creationId="{7B5044C7-236A-4E7D-9644-CF2BA4790F70}"/>
          </ac:cxnSpMkLst>
        </pc:cxnChg>
        <pc:cxnChg chg="del">
          <ac:chgData name="Cercamondi,Colin Ivano,CH-Vevey" userId="d25e694c-3ff8-4193-82fc-75dd469e9cee" providerId="ADAL" clId="{C7E5EE27-21D3-41A1-AF7C-1292D5D7928D}" dt="2021-01-18T20:24:37.048" v="754" actId="478"/>
          <ac:cxnSpMkLst>
            <pc:docMk/>
            <pc:sldMk cId="109857222" sldId="256"/>
            <ac:cxnSpMk id="11" creationId="{A26C34F2-94E1-424F-972F-2F9E6649003F}"/>
          </ac:cxnSpMkLst>
        </pc:cxnChg>
        <pc:cxnChg chg="add">
          <ac:chgData name="Cercamondi,Colin Ivano,CH-Vevey" userId="d25e694c-3ff8-4193-82fc-75dd469e9cee" providerId="ADAL" clId="{C7E5EE27-21D3-41A1-AF7C-1292D5D7928D}" dt="2021-01-18T20:27:45.813" v="756"/>
          <ac:cxnSpMkLst>
            <pc:docMk/>
            <pc:sldMk cId="109857222" sldId="256"/>
            <ac:cxnSpMk id="29" creationId="{1DAE31F0-9FB7-474C-A0BE-6BDF4AEB198A}"/>
          </ac:cxnSpMkLst>
        </pc:cxnChg>
        <pc:cxnChg chg="add">
          <ac:chgData name="Cercamondi,Colin Ivano,CH-Vevey" userId="d25e694c-3ff8-4193-82fc-75dd469e9cee" providerId="ADAL" clId="{C7E5EE27-21D3-41A1-AF7C-1292D5D7928D}" dt="2021-01-18T20:27:45.813" v="756"/>
          <ac:cxnSpMkLst>
            <pc:docMk/>
            <pc:sldMk cId="109857222" sldId="256"/>
            <ac:cxnSpMk id="33" creationId="{30A8671B-4C69-4DD3-9BD5-48B60FC1477F}"/>
          </ac:cxnSpMkLst>
        </pc:cxnChg>
        <pc:cxnChg chg="add">
          <ac:chgData name="Cercamondi,Colin Ivano,CH-Vevey" userId="d25e694c-3ff8-4193-82fc-75dd469e9cee" providerId="ADAL" clId="{C7E5EE27-21D3-41A1-AF7C-1292D5D7928D}" dt="2021-01-18T20:27:45.813" v="756"/>
          <ac:cxnSpMkLst>
            <pc:docMk/>
            <pc:sldMk cId="109857222" sldId="256"/>
            <ac:cxnSpMk id="34" creationId="{5EAD1E3A-FC0B-4161-BAA0-A191910B0A0C}"/>
          </ac:cxnSpMkLst>
        </pc:cxnChg>
        <pc:cxnChg chg="add">
          <ac:chgData name="Cercamondi,Colin Ivano,CH-Vevey" userId="d25e694c-3ff8-4193-82fc-75dd469e9cee" providerId="ADAL" clId="{C7E5EE27-21D3-41A1-AF7C-1292D5D7928D}" dt="2021-01-18T20:27:45.813" v="756"/>
          <ac:cxnSpMkLst>
            <pc:docMk/>
            <pc:sldMk cId="109857222" sldId="256"/>
            <ac:cxnSpMk id="35" creationId="{4BFFF0C5-CCAD-45AA-90FB-79250B8B0F8E}"/>
          </ac:cxnSpMkLst>
        </pc:cxnChg>
        <pc:cxnChg chg="add">
          <ac:chgData name="Cercamondi,Colin Ivano,CH-Vevey" userId="d25e694c-3ff8-4193-82fc-75dd469e9cee" providerId="ADAL" clId="{C7E5EE27-21D3-41A1-AF7C-1292D5D7928D}" dt="2021-01-18T20:27:45.813" v="756"/>
          <ac:cxnSpMkLst>
            <pc:docMk/>
            <pc:sldMk cId="109857222" sldId="256"/>
            <ac:cxnSpMk id="36" creationId="{D92EFD5D-C68D-43EB-8E3E-4D1AF43D3C6F}"/>
          </ac:cxnSpMkLst>
        </pc:cxnChg>
        <pc:cxnChg chg="add">
          <ac:chgData name="Cercamondi,Colin Ivano,CH-Vevey" userId="d25e694c-3ff8-4193-82fc-75dd469e9cee" providerId="ADAL" clId="{C7E5EE27-21D3-41A1-AF7C-1292D5D7928D}" dt="2021-01-18T20:27:45.813" v="756"/>
          <ac:cxnSpMkLst>
            <pc:docMk/>
            <pc:sldMk cId="109857222" sldId="256"/>
            <ac:cxnSpMk id="37" creationId="{8A5B0DA6-8C1A-4A06-BAD7-4667B03238DD}"/>
          </ac:cxnSpMkLst>
        </pc:cxnChg>
        <pc:cxnChg chg="add">
          <ac:chgData name="Cercamondi,Colin Ivano,CH-Vevey" userId="d25e694c-3ff8-4193-82fc-75dd469e9cee" providerId="ADAL" clId="{C7E5EE27-21D3-41A1-AF7C-1292D5D7928D}" dt="2021-01-18T20:27:45.813" v="756"/>
          <ac:cxnSpMkLst>
            <pc:docMk/>
            <pc:sldMk cId="109857222" sldId="256"/>
            <ac:cxnSpMk id="39" creationId="{D928827F-200F-4274-AEF0-A70262A261F8}"/>
          </ac:cxnSpMkLst>
        </pc:cxnChg>
        <pc:cxnChg chg="add mod">
          <ac:chgData name="Cercamondi,Colin Ivano,CH-Vevey" userId="d25e694c-3ff8-4193-82fc-75dd469e9cee" providerId="ADAL" clId="{C7E5EE27-21D3-41A1-AF7C-1292D5D7928D}" dt="2021-01-19T12:33:24.458" v="1094" actId="1076"/>
          <ac:cxnSpMkLst>
            <pc:docMk/>
            <pc:sldMk cId="109857222" sldId="256"/>
            <ac:cxnSpMk id="40" creationId="{3E2290E4-41D5-43F5-A1E9-67BC7BBD0636}"/>
          </ac:cxnSpMkLst>
        </pc:cxnChg>
        <pc:cxnChg chg="add mod">
          <ac:chgData name="Cercamondi,Colin Ivano,CH-Vevey" userId="d25e694c-3ff8-4193-82fc-75dd469e9cee" providerId="ADAL" clId="{C7E5EE27-21D3-41A1-AF7C-1292D5D7928D}" dt="2021-01-19T12:33:08.425" v="1092" actId="14100"/>
          <ac:cxnSpMkLst>
            <pc:docMk/>
            <pc:sldMk cId="109857222" sldId="256"/>
            <ac:cxnSpMk id="41" creationId="{6D559383-CAE1-447D-82D9-5C72C6D8EE57}"/>
          </ac:cxnSpMkLst>
        </pc:cxnChg>
      </pc:sldChg>
      <pc:sldChg chg="addSp modSp addCm delCm modCm">
        <pc:chgData name="Cercamondi,Colin Ivano,CH-Vevey" userId="d25e694c-3ff8-4193-82fc-75dd469e9cee" providerId="ADAL" clId="{C7E5EE27-21D3-41A1-AF7C-1292D5D7928D}" dt="2021-01-12T15:03:09.994" v="704" actId="1592"/>
        <pc:sldMkLst>
          <pc:docMk/>
          <pc:sldMk cId="1299451647" sldId="257"/>
        </pc:sldMkLst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1299451647" sldId="257"/>
            <ac:spMk id="2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12T14:51:31.378" v="701" actId="207"/>
          <ac:spMkLst>
            <pc:docMk/>
            <pc:sldMk cId="1299451647" sldId="257"/>
            <ac:spMk id="3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12T14:22:16.552" v="617" actId="1037"/>
          <ac:spMkLst>
            <pc:docMk/>
            <pc:sldMk cId="1299451647" sldId="257"/>
            <ac:spMk id="6" creationId="{E2658BC6-E908-47F2-8D80-8075CE348F99}"/>
          </ac:spMkLst>
        </pc:spChg>
        <pc:spChg chg="mod">
          <ac:chgData name="Cercamondi,Colin Ivano,CH-Vevey" userId="d25e694c-3ff8-4193-82fc-75dd469e9cee" providerId="ADAL" clId="{C7E5EE27-21D3-41A1-AF7C-1292D5D7928D}" dt="2021-01-12T14:33:03.982" v="680" actId="1076"/>
          <ac:spMkLst>
            <pc:docMk/>
            <pc:sldMk cId="1299451647" sldId="257"/>
            <ac:spMk id="7" creationId="{0C5D272F-2D94-4F8A-9994-F5CDA4B27394}"/>
          </ac:spMkLst>
        </pc:spChg>
        <pc:spChg chg="add mod">
          <ac:chgData name="Cercamondi,Colin Ivano,CH-Vevey" userId="d25e694c-3ff8-4193-82fc-75dd469e9cee" providerId="ADAL" clId="{C7E5EE27-21D3-41A1-AF7C-1292D5D7928D}" dt="2021-01-12T14:32:55.681" v="679" actId="20577"/>
          <ac:spMkLst>
            <pc:docMk/>
            <pc:sldMk cId="1299451647" sldId="257"/>
            <ac:spMk id="9" creationId="{27F0784C-44C8-447C-BD40-F972986CC706}"/>
          </ac:spMkLst>
        </pc:spChg>
        <pc:picChg chg="mod ord">
          <ac:chgData name="Cercamondi,Colin Ivano,CH-Vevey" userId="d25e694c-3ff8-4193-82fc-75dd469e9cee" providerId="ADAL" clId="{C7E5EE27-21D3-41A1-AF7C-1292D5D7928D}" dt="2021-01-12T14:31:21.872" v="676" actId="167"/>
          <ac:picMkLst>
            <pc:docMk/>
            <pc:sldMk cId="1299451647" sldId="257"/>
            <ac:picMk id="4" creationId="{07B678AA-EBCA-45B1-9B14-268888E0BE28}"/>
          </ac:picMkLst>
        </pc:picChg>
        <pc:picChg chg="mod ord">
          <ac:chgData name="Cercamondi,Colin Ivano,CH-Vevey" userId="d25e694c-3ff8-4193-82fc-75dd469e9cee" providerId="ADAL" clId="{C7E5EE27-21D3-41A1-AF7C-1292D5D7928D}" dt="2021-01-12T14:30:19.347" v="674" actId="167"/>
          <ac:picMkLst>
            <pc:docMk/>
            <pc:sldMk cId="1299451647" sldId="257"/>
            <ac:picMk id="5" creationId="{81702BDC-7DEB-448F-AFE4-8BF6F6171D74}"/>
          </ac:picMkLst>
        </pc:picChg>
        <pc:picChg chg="add mod ord">
          <ac:chgData name="Cercamondi,Colin Ivano,CH-Vevey" userId="d25e694c-3ff8-4193-82fc-75dd469e9cee" providerId="ADAL" clId="{C7E5EE27-21D3-41A1-AF7C-1292D5D7928D}" dt="2021-01-12T14:30:15.566" v="673" actId="167"/>
          <ac:picMkLst>
            <pc:docMk/>
            <pc:sldMk cId="1299451647" sldId="257"/>
            <ac:picMk id="8" creationId="{0853C466-3925-4261-BE29-A30A1DAC2CC3}"/>
          </ac:picMkLst>
        </pc:picChg>
      </pc:sldChg>
      <pc:sldChg chg="addSp modSp del addCm modCm">
        <pc:chgData name="Cercamondi,Colin Ivano,CH-Vevey" userId="d25e694c-3ff8-4193-82fc-75dd469e9cee" providerId="ADAL" clId="{C7E5EE27-21D3-41A1-AF7C-1292D5D7928D}" dt="2021-01-18T20:55:56.833" v="846" actId="2696"/>
        <pc:sldMkLst>
          <pc:docMk/>
          <pc:sldMk cId="3574380604" sldId="258"/>
        </pc:sldMkLst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3574380604" sldId="258"/>
            <ac:spMk id="2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3574380604" sldId="258"/>
            <ac:spMk id="3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3574380604" sldId="258"/>
            <ac:spMk id="5" creationId="{0E1AE68E-2216-43E5-8448-74BA71496703}"/>
          </ac:spMkLst>
        </pc:spChg>
        <pc:spChg chg="add 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3574380604" sldId="258"/>
            <ac:spMk id="7" creationId="{0E3C0B81-52E8-4941-BC7C-65F8E5190525}"/>
          </ac:spMkLst>
        </pc:spChg>
        <pc:graphicFrameChg chg="mod">
          <ac:chgData name="Cercamondi,Colin Ivano,CH-Vevey" userId="d25e694c-3ff8-4193-82fc-75dd469e9cee" providerId="ADAL" clId="{C7E5EE27-21D3-41A1-AF7C-1292D5D7928D}" dt="2021-01-12T14:22:04.017" v="583" actId="1076"/>
          <ac:graphicFrameMkLst>
            <pc:docMk/>
            <pc:sldMk cId="3574380604" sldId="258"/>
            <ac:graphicFrameMk id="8" creationId="{50BC301F-BEEC-40A2-B527-7BDBC23ED723}"/>
          </ac:graphicFrameMkLst>
        </pc:graphicFrameChg>
        <pc:picChg chg="add mod">
          <ac:chgData name="Cercamondi,Colin Ivano,CH-Vevey" userId="d25e694c-3ff8-4193-82fc-75dd469e9cee" providerId="ADAL" clId="{C7E5EE27-21D3-41A1-AF7C-1292D5D7928D}" dt="2021-01-12T14:22:01.325" v="582" actId="1076"/>
          <ac:picMkLst>
            <pc:docMk/>
            <pc:sldMk cId="3574380604" sldId="258"/>
            <ac:picMk id="6" creationId="{CEFB7FE0-FA58-4E6C-BA7B-34B3853C42F2}"/>
          </ac:picMkLst>
        </pc:picChg>
      </pc:sldChg>
      <pc:sldChg chg="addSp delSp modSp addCm delCm modCm">
        <pc:chgData name="Cercamondi,Colin Ivano,CH-Vevey" userId="d25e694c-3ff8-4193-82fc-75dd469e9cee" providerId="ADAL" clId="{C7E5EE27-21D3-41A1-AF7C-1292D5D7928D}" dt="2021-01-18T20:58:02.803" v="869" actId="1076"/>
        <pc:sldMkLst>
          <pc:docMk/>
          <pc:sldMk cId="3481645440" sldId="259"/>
        </pc:sldMkLst>
        <pc:spChg chg="mod">
          <ac:chgData name="Cercamondi,Colin Ivano,CH-Vevey" userId="d25e694c-3ff8-4193-82fc-75dd469e9cee" providerId="ADAL" clId="{C7E5EE27-21D3-41A1-AF7C-1292D5D7928D}" dt="2021-01-18T20:57:05.264" v="849" actId="20577"/>
          <ac:spMkLst>
            <pc:docMk/>
            <pc:sldMk cId="3481645440" sldId="259"/>
            <ac:spMk id="2" creationId="{00000000-0000-0000-0000-000000000000}"/>
          </ac:spMkLst>
        </pc:spChg>
        <pc:spChg chg="del mod">
          <ac:chgData name="Cercamondi,Colin Ivano,CH-Vevey" userId="d25e694c-3ff8-4193-82fc-75dd469e9cee" providerId="ADAL" clId="{C7E5EE27-21D3-41A1-AF7C-1292D5D7928D}" dt="2021-01-18T20:57:39.837" v="850" actId="478"/>
          <ac:spMkLst>
            <pc:docMk/>
            <pc:sldMk cId="3481645440" sldId="259"/>
            <ac:spMk id="3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3481645440" sldId="259"/>
            <ac:spMk id="4" creationId="{65485C5E-5332-4EF8-90D3-2CFAFB1BA38F}"/>
          </ac:spMkLst>
        </pc:spChg>
        <pc:spChg chg="add del mod">
          <ac:chgData name="Cercamondi,Colin Ivano,CH-Vevey" userId="d25e694c-3ff8-4193-82fc-75dd469e9cee" providerId="ADAL" clId="{C7E5EE27-21D3-41A1-AF7C-1292D5D7928D}" dt="2021-01-18T20:57:41.682" v="851" actId="478"/>
          <ac:spMkLst>
            <pc:docMk/>
            <pc:sldMk cId="3481645440" sldId="259"/>
            <ac:spMk id="9" creationId="{CF87DBB7-5FA6-4F63-B7DE-D5CF73FD8DC6}"/>
          </ac:spMkLst>
        </pc:spChg>
        <pc:picChg chg="mod">
          <ac:chgData name="Cercamondi,Colin Ivano,CH-Vevey" userId="d25e694c-3ff8-4193-82fc-75dd469e9cee" providerId="ADAL" clId="{C7E5EE27-21D3-41A1-AF7C-1292D5D7928D}" dt="2021-01-18T20:58:02.803" v="869" actId="1076"/>
          <ac:picMkLst>
            <pc:docMk/>
            <pc:sldMk cId="3481645440" sldId="259"/>
            <ac:picMk id="5" creationId="{DE64BB77-7C35-4F18-8417-05617E8DD58B}"/>
          </ac:picMkLst>
        </pc:picChg>
        <pc:inkChg chg="mod">
          <ac:chgData name="Cercamondi,Colin Ivano,CH-Vevey" userId="d25e694c-3ff8-4193-82fc-75dd469e9cee" providerId="ADAL" clId="{C7E5EE27-21D3-41A1-AF7C-1292D5D7928D}" dt="2021-01-05T09:52:46.406" v="278"/>
          <ac:inkMkLst>
            <pc:docMk/>
            <pc:sldMk cId="3481645440" sldId="259"/>
            <ac:inkMk id="6" creationId="{48BC38D3-DD2D-4D85-9233-6C72D387CF43}"/>
          </ac:inkMkLst>
        </pc:inkChg>
        <pc:inkChg chg="mod">
          <ac:chgData name="Cercamondi,Colin Ivano,CH-Vevey" userId="d25e694c-3ff8-4193-82fc-75dd469e9cee" providerId="ADAL" clId="{C7E5EE27-21D3-41A1-AF7C-1292D5D7928D}" dt="2021-01-05T09:52:46.406" v="278"/>
          <ac:inkMkLst>
            <pc:docMk/>
            <pc:sldMk cId="3481645440" sldId="259"/>
            <ac:inkMk id="7" creationId="{A144B03C-C196-4DB4-AFED-A1F5876DC8D1}"/>
          </ac:inkMkLst>
        </pc:inkChg>
      </pc:sldChg>
      <pc:sldChg chg="modSp del addCm modCm">
        <pc:chgData name="Cercamondi,Colin Ivano,CH-Vevey" userId="d25e694c-3ff8-4193-82fc-75dd469e9cee" providerId="ADAL" clId="{C7E5EE27-21D3-41A1-AF7C-1292D5D7928D}" dt="2021-01-18T21:14:04.931" v="969" actId="2696"/>
        <pc:sldMkLst>
          <pc:docMk/>
          <pc:sldMk cId="3261540884" sldId="260"/>
        </pc:sldMkLst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3261540884" sldId="260"/>
            <ac:spMk id="2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3261540884" sldId="260"/>
            <ac:spMk id="3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3261540884" sldId="260"/>
            <ac:spMk id="8" creationId="{DF3150E2-C615-4092-9C88-57EC909FFFD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3261540884" sldId="260"/>
            <ac:spMk id="11" creationId="{F00137AC-B220-4DB4-830B-378E9B5FAB31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3261540884" sldId="260"/>
            <ac:spMk id="12" creationId="{A6B30807-652E-46D6-9349-DC424F5F6ED5}"/>
          </ac:spMkLst>
        </pc:spChg>
        <pc:picChg chg="mod">
          <ac:chgData name="Cercamondi,Colin Ivano,CH-Vevey" userId="d25e694c-3ff8-4193-82fc-75dd469e9cee" providerId="ADAL" clId="{C7E5EE27-21D3-41A1-AF7C-1292D5D7928D}" dt="2021-01-05T09:52:46.406" v="278"/>
          <ac:picMkLst>
            <pc:docMk/>
            <pc:sldMk cId="3261540884" sldId="260"/>
            <ac:picMk id="7" creationId="{6FD4A128-53D0-44D5-8022-E6D66A8603CF}"/>
          </ac:picMkLst>
        </pc:picChg>
        <pc:picChg chg="mod">
          <ac:chgData name="Cercamondi,Colin Ivano,CH-Vevey" userId="d25e694c-3ff8-4193-82fc-75dd469e9cee" providerId="ADAL" clId="{C7E5EE27-21D3-41A1-AF7C-1292D5D7928D}" dt="2021-01-05T09:52:46.406" v="278"/>
          <ac:picMkLst>
            <pc:docMk/>
            <pc:sldMk cId="3261540884" sldId="260"/>
            <ac:picMk id="9" creationId="{752EDCCB-31CC-406D-B7A2-D86F31DD013B}"/>
          </ac:picMkLst>
        </pc:picChg>
        <pc:picChg chg="mod">
          <ac:chgData name="Cercamondi,Colin Ivano,CH-Vevey" userId="d25e694c-3ff8-4193-82fc-75dd469e9cee" providerId="ADAL" clId="{C7E5EE27-21D3-41A1-AF7C-1292D5D7928D}" dt="2021-01-05T09:52:46.406" v="278"/>
          <ac:picMkLst>
            <pc:docMk/>
            <pc:sldMk cId="3261540884" sldId="260"/>
            <ac:picMk id="10" creationId="{E1E211D5-9EA0-40CF-B930-E1D82F07F433}"/>
          </ac:picMkLst>
        </pc:picChg>
        <pc:inkChg chg="mod">
          <ac:chgData name="Cercamondi,Colin Ivano,CH-Vevey" userId="d25e694c-3ff8-4193-82fc-75dd469e9cee" providerId="ADAL" clId="{C7E5EE27-21D3-41A1-AF7C-1292D5D7928D}" dt="2021-01-05T09:52:46.406" v="278"/>
          <ac:inkMkLst>
            <pc:docMk/>
            <pc:sldMk cId="3261540884" sldId="260"/>
            <ac:inkMk id="4" creationId="{12648172-ABCC-4246-8600-67E77C19D8F8}"/>
          </ac:inkMkLst>
        </pc:inkChg>
      </pc:sldChg>
      <pc:sldChg chg="addSp delSp modSp del">
        <pc:chgData name="Cercamondi,Colin Ivano,CH-Vevey" userId="d25e694c-3ff8-4193-82fc-75dd469e9cee" providerId="ADAL" clId="{C7E5EE27-21D3-41A1-AF7C-1292D5D7928D}" dt="2020-12-21T12:40:19.098" v="42" actId="2696"/>
        <pc:sldMkLst>
          <pc:docMk/>
          <pc:sldMk cId="1876531822" sldId="261"/>
        </pc:sldMkLst>
        <pc:spChg chg="del mod">
          <ac:chgData name="Cercamondi,Colin Ivano,CH-Vevey" userId="d25e694c-3ff8-4193-82fc-75dd469e9cee" providerId="ADAL" clId="{C7E5EE27-21D3-41A1-AF7C-1292D5D7928D}" dt="2020-12-21T12:39:47.404" v="10"/>
          <ac:spMkLst>
            <pc:docMk/>
            <pc:sldMk cId="1876531822" sldId="261"/>
            <ac:spMk id="3" creationId="{00000000-0000-0000-0000-000000000000}"/>
          </ac:spMkLst>
        </pc:spChg>
        <pc:spChg chg="add mod">
          <ac:chgData name="Cercamondi,Colin Ivano,CH-Vevey" userId="d25e694c-3ff8-4193-82fc-75dd469e9cee" providerId="ADAL" clId="{C7E5EE27-21D3-41A1-AF7C-1292D5D7928D}" dt="2020-12-21T12:39:47.404" v="10"/>
          <ac:spMkLst>
            <pc:docMk/>
            <pc:sldMk cId="1876531822" sldId="261"/>
            <ac:spMk id="5" creationId="{618C72A0-A0DA-42CF-B873-B6064919CD2C}"/>
          </ac:spMkLst>
        </pc:spChg>
        <pc:picChg chg="del">
          <ac:chgData name="Cercamondi,Colin Ivano,CH-Vevey" userId="d25e694c-3ff8-4193-82fc-75dd469e9cee" providerId="ADAL" clId="{C7E5EE27-21D3-41A1-AF7C-1292D5D7928D}" dt="2020-12-21T12:39:20.757" v="4"/>
          <ac:picMkLst>
            <pc:docMk/>
            <pc:sldMk cId="1876531822" sldId="261"/>
            <ac:picMk id="4" creationId="{2AD37E68-2D9D-42C5-8ACC-500496F39856}"/>
          </ac:picMkLst>
        </pc:picChg>
      </pc:sldChg>
      <pc:sldChg chg="modSp del addCm modCm">
        <pc:chgData name="Cercamondi,Colin Ivano,CH-Vevey" userId="d25e694c-3ff8-4193-82fc-75dd469e9cee" providerId="ADAL" clId="{C7E5EE27-21D3-41A1-AF7C-1292D5D7928D}" dt="2021-01-18T21:02:57.761" v="874" actId="2696"/>
        <pc:sldMkLst>
          <pc:docMk/>
          <pc:sldMk cId="907894339" sldId="262"/>
        </pc:sldMkLst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907894339" sldId="262"/>
            <ac:spMk id="2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907894339" sldId="262"/>
            <ac:spMk id="3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907894339" sldId="262"/>
            <ac:spMk id="6" creationId="{92CAFDC8-999F-4800-B85F-F60D7E98E0E1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907894339" sldId="262"/>
            <ac:spMk id="7" creationId="{353B68AC-5DB7-4784-9867-3FDC9D74DE6E}"/>
          </ac:spMkLst>
        </pc:spChg>
        <pc:picChg chg="mod">
          <ac:chgData name="Cercamondi,Colin Ivano,CH-Vevey" userId="d25e694c-3ff8-4193-82fc-75dd469e9cee" providerId="ADAL" clId="{C7E5EE27-21D3-41A1-AF7C-1292D5D7928D}" dt="2021-01-05T09:52:46.406" v="278"/>
          <ac:picMkLst>
            <pc:docMk/>
            <pc:sldMk cId="907894339" sldId="262"/>
            <ac:picMk id="4" creationId="{54DA59D2-506D-4A60-B0C2-BD0B056E9695}"/>
          </ac:picMkLst>
        </pc:picChg>
        <pc:picChg chg="mod">
          <ac:chgData name="Cercamondi,Colin Ivano,CH-Vevey" userId="d25e694c-3ff8-4193-82fc-75dd469e9cee" providerId="ADAL" clId="{C7E5EE27-21D3-41A1-AF7C-1292D5D7928D}" dt="2021-01-05T09:52:46.406" v="278"/>
          <ac:picMkLst>
            <pc:docMk/>
            <pc:sldMk cId="907894339" sldId="262"/>
            <ac:picMk id="5" creationId="{07526367-45CF-498E-BCB5-826D54DE1044}"/>
          </ac:picMkLst>
        </pc:picChg>
      </pc:sldChg>
      <pc:sldChg chg="modSp del">
        <pc:chgData name="Cercamondi,Colin Ivano,CH-Vevey" userId="d25e694c-3ff8-4193-82fc-75dd469e9cee" providerId="ADAL" clId="{C7E5EE27-21D3-41A1-AF7C-1292D5D7928D}" dt="2021-01-18T21:01:52.646" v="870" actId="2696"/>
        <pc:sldMkLst>
          <pc:docMk/>
          <pc:sldMk cId="3249222257" sldId="263"/>
        </pc:sldMkLst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3249222257" sldId="263"/>
            <ac:spMk id="2" creationId="{88105DD8-232D-46AA-98B2-E5ADEF8FA725}"/>
          </ac:spMkLst>
        </pc:spChg>
        <pc:picChg chg="mod">
          <ac:chgData name="Cercamondi,Colin Ivano,CH-Vevey" userId="d25e694c-3ff8-4193-82fc-75dd469e9cee" providerId="ADAL" clId="{C7E5EE27-21D3-41A1-AF7C-1292D5D7928D}" dt="2021-01-05T09:52:46.406" v="278"/>
          <ac:picMkLst>
            <pc:docMk/>
            <pc:sldMk cId="3249222257" sldId="263"/>
            <ac:picMk id="7" creationId="{C64A515D-1D66-492A-A1DA-404148D7A318}"/>
          </ac:picMkLst>
        </pc:picChg>
        <pc:picChg chg="mod">
          <ac:chgData name="Cercamondi,Colin Ivano,CH-Vevey" userId="d25e694c-3ff8-4193-82fc-75dd469e9cee" providerId="ADAL" clId="{C7E5EE27-21D3-41A1-AF7C-1292D5D7928D}" dt="2021-01-05T09:52:46.406" v="278"/>
          <ac:picMkLst>
            <pc:docMk/>
            <pc:sldMk cId="3249222257" sldId="263"/>
            <ac:picMk id="8" creationId="{803CDCC6-F59D-40A3-ACF3-65C8C2F8A0D8}"/>
          </ac:picMkLst>
        </pc:picChg>
      </pc:sldChg>
      <pc:sldChg chg="addSp delSp modSp addCm delCm modCm">
        <pc:chgData name="Cercamondi,Colin Ivano,CH-Vevey" userId="d25e694c-3ff8-4193-82fc-75dd469e9cee" providerId="ADAL" clId="{C7E5EE27-21D3-41A1-AF7C-1292D5D7928D}" dt="2021-01-19T14:00:30.392" v="1296"/>
        <pc:sldMkLst>
          <pc:docMk/>
          <pc:sldMk cId="1210609011" sldId="264"/>
        </pc:sldMkLst>
        <pc:spChg chg="mod">
          <ac:chgData name="Cercamondi,Colin Ivano,CH-Vevey" userId="d25e694c-3ff8-4193-82fc-75dd469e9cee" providerId="ADAL" clId="{C7E5EE27-21D3-41A1-AF7C-1292D5D7928D}" dt="2021-01-18T21:38:38.799" v="1071" actId="20577"/>
          <ac:spMkLst>
            <pc:docMk/>
            <pc:sldMk cId="1210609011" sldId="264"/>
            <ac:spMk id="2" creationId="{00000000-0000-0000-0000-000000000000}"/>
          </ac:spMkLst>
        </pc:spChg>
        <pc:spChg chg="del mod">
          <ac:chgData name="Cercamondi,Colin Ivano,CH-Vevey" userId="d25e694c-3ff8-4193-82fc-75dd469e9cee" providerId="ADAL" clId="{C7E5EE27-21D3-41A1-AF7C-1292D5D7928D}" dt="2021-01-18T21:17:36.406" v="976" actId="478"/>
          <ac:spMkLst>
            <pc:docMk/>
            <pc:sldMk cId="1210609011" sldId="264"/>
            <ac:spMk id="3" creationId="{00000000-0000-0000-0000-000000000000}"/>
          </ac:spMkLst>
        </pc:spChg>
        <pc:spChg chg="add del mod">
          <ac:chgData name="Cercamondi,Colin Ivano,CH-Vevey" userId="d25e694c-3ff8-4193-82fc-75dd469e9cee" providerId="ADAL" clId="{C7E5EE27-21D3-41A1-AF7C-1292D5D7928D}" dt="2021-01-18T21:17:38.502" v="977" actId="478"/>
          <ac:spMkLst>
            <pc:docMk/>
            <pc:sldMk cId="1210609011" sldId="264"/>
            <ac:spMk id="6" creationId="{EB8C2CDD-54C7-478F-BEDB-FA6AE9AEDE0F}"/>
          </ac:spMkLst>
        </pc:spChg>
        <pc:picChg chg="add mod">
          <ac:chgData name="Cercamondi,Colin Ivano,CH-Vevey" userId="d25e694c-3ff8-4193-82fc-75dd469e9cee" providerId="ADAL" clId="{C7E5EE27-21D3-41A1-AF7C-1292D5D7928D}" dt="2021-01-05T09:58:05.606" v="287" actId="1076"/>
          <ac:picMkLst>
            <pc:docMk/>
            <pc:sldMk cId="1210609011" sldId="264"/>
            <ac:picMk id="5" creationId="{F17739DB-1853-4405-8DEA-20047D0726DE}"/>
          </ac:picMkLst>
        </pc:picChg>
        <pc:picChg chg="del mod">
          <ac:chgData name="Cercamondi,Colin Ivano,CH-Vevey" userId="d25e694c-3ff8-4193-82fc-75dd469e9cee" providerId="ADAL" clId="{C7E5EE27-21D3-41A1-AF7C-1292D5D7928D}" dt="2021-01-05T09:53:12.838" v="279" actId="478"/>
          <ac:picMkLst>
            <pc:docMk/>
            <pc:sldMk cId="1210609011" sldId="264"/>
            <ac:picMk id="6" creationId="{18D5B6ED-40DC-43D6-A489-235DE3276AC4}"/>
          </ac:picMkLst>
        </pc:picChg>
      </pc:sldChg>
      <pc:sldChg chg="modSp del">
        <pc:chgData name="Cercamondi,Colin Ivano,CH-Vevey" userId="d25e694c-3ff8-4193-82fc-75dd469e9cee" providerId="ADAL" clId="{C7E5EE27-21D3-41A1-AF7C-1292D5D7928D}" dt="2021-01-18T21:03:05.198" v="875" actId="2696"/>
        <pc:sldMkLst>
          <pc:docMk/>
          <pc:sldMk cId="1915425" sldId="265"/>
        </pc:sldMkLst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1915425" sldId="265"/>
            <ac:spMk id="2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1915425" sldId="265"/>
            <ac:spMk id="3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1915425" sldId="265"/>
            <ac:spMk id="4" creationId="{2C7295EC-FEE4-42D6-976E-0B19C0C83971}"/>
          </ac:spMkLst>
        </pc:spChg>
        <pc:graphicFrameChg chg="mod">
          <ac:chgData name="Cercamondi,Colin Ivano,CH-Vevey" userId="d25e694c-3ff8-4193-82fc-75dd469e9cee" providerId="ADAL" clId="{C7E5EE27-21D3-41A1-AF7C-1292D5D7928D}" dt="2021-01-13T12:15:05.408" v="737" actId="1076"/>
          <ac:graphicFrameMkLst>
            <pc:docMk/>
            <pc:sldMk cId="1915425" sldId="265"/>
            <ac:graphicFrameMk id="5" creationId="{0A7BE4EC-0AF0-41F5-81F2-EDC8962D0A27}"/>
          </ac:graphicFrameMkLst>
        </pc:graphicFrameChg>
        <pc:inkChg chg="mod">
          <ac:chgData name="Cercamondi,Colin Ivano,CH-Vevey" userId="d25e694c-3ff8-4193-82fc-75dd469e9cee" providerId="ADAL" clId="{C7E5EE27-21D3-41A1-AF7C-1292D5D7928D}" dt="2021-01-05T09:52:46.406" v="278"/>
          <ac:inkMkLst>
            <pc:docMk/>
            <pc:sldMk cId="1915425" sldId="265"/>
            <ac:inkMk id="6" creationId="{7D7A02F9-DB45-4919-986B-F7147132B7F8}"/>
          </ac:inkMkLst>
        </pc:inkChg>
      </pc:sldChg>
      <pc:sldChg chg="delSp modSp del">
        <pc:chgData name="Cercamondi,Colin Ivano,CH-Vevey" userId="d25e694c-3ff8-4193-82fc-75dd469e9cee" providerId="ADAL" clId="{C7E5EE27-21D3-41A1-AF7C-1292D5D7928D}" dt="2021-01-15T12:23:05.865" v="751" actId="2696"/>
        <pc:sldMkLst>
          <pc:docMk/>
          <pc:sldMk cId="1790202609" sldId="266"/>
        </pc:sldMkLst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1790202609" sldId="266"/>
            <ac:spMk id="2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12T14:49:25.507" v="693"/>
          <ac:spMkLst>
            <pc:docMk/>
            <pc:sldMk cId="1790202609" sldId="266"/>
            <ac:spMk id="3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1790202609" sldId="266"/>
            <ac:spMk id="4" creationId="{2C7295EC-FEE4-42D6-976E-0B19C0C83971}"/>
          </ac:spMkLst>
        </pc:spChg>
        <pc:picChg chg="del mod">
          <ac:chgData name="Cercamondi,Colin Ivano,CH-Vevey" userId="d25e694c-3ff8-4193-82fc-75dd469e9cee" providerId="ADAL" clId="{C7E5EE27-21D3-41A1-AF7C-1292D5D7928D}" dt="2021-01-12T14:29:38.741" v="650"/>
          <ac:picMkLst>
            <pc:docMk/>
            <pc:sldMk cId="1790202609" sldId="266"/>
            <ac:picMk id="6" creationId="{6FED7408-CDED-4F4C-932A-DA0B386B3F4E}"/>
          </ac:picMkLst>
        </pc:picChg>
      </pc:sldChg>
      <pc:sldChg chg="modSp">
        <pc:chgData name="Cercamondi,Colin Ivano,CH-Vevey" userId="d25e694c-3ff8-4193-82fc-75dd469e9cee" providerId="ADAL" clId="{C7E5EE27-21D3-41A1-AF7C-1292D5D7928D}" dt="2021-01-19T13:04:32.164" v="1292" actId="122"/>
        <pc:sldMkLst>
          <pc:docMk/>
          <pc:sldMk cId="1153482099" sldId="267"/>
        </pc:sldMkLst>
        <pc:spChg chg="mod">
          <ac:chgData name="Cercamondi,Colin Ivano,CH-Vevey" userId="d25e694c-3ff8-4193-82fc-75dd469e9cee" providerId="ADAL" clId="{C7E5EE27-21D3-41A1-AF7C-1292D5D7928D}" dt="2021-01-19T13:04:32.164" v="1292" actId="122"/>
          <ac:spMkLst>
            <pc:docMk/>
            <pc:sldMk cId="1153482099" sldId="267"/>
            <ac:spMk id="2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18T21:21:54.537" v="1068" actId="1076"/>
          <ac:spMkLst>
            <pc:docMk/>
            <pc:sldMk cId="1153482099" sldId="267"/>
            <ac:spMk id="3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k cId="1153482099" sldId="267"/>
            <ac:spMk id="4" creationId="{2C7295EC-FEE4-42D6-976E-0B19C0C83971}"/>
          </ac:spMkLst>
        </pc:spChg>
        <pc:picChg chg="mod">
          <ac:chgData name="Cercamondi,Colin Ivano,CH-Vevey" userId="d25e694c-3ff8-4193-82fc-75dd469e9cee" providerId="ADAL" clId="{C7E5EE27-21D3-41A1-AF7C-1292D5D7928D}" dt="2021-01-18T21:21:56.545" v="1069" actId="1076"/>
          <ac:picMkLst>
            <pc:docMk/>
            <pc:sldMk cId="1153482099" sldId="267"/>
            <ac:picMk id="6" creationId="{767D1AEF-C759-401F-962D-6328A4D555A1}"/>
          </ac:picMkLst>
        </pc:picChg>
      </pc:sldChg>
      <pc:sldChg chg="addSp delSp modSp">
        <pc:chgData name="Cercamondi,Colin Ivano,CH-Vevey" userId="d25e694c-3ff8-4193-82fc-75dd469e9cee" providerId="ADAL" clId="{C7E5EE27-21D3-41A1-AF7C-1292D5D7928D}" dt="2021-01-19T13:33:07.653" v="1295" actId="20577"/>
        <pc:sldMkLst>
          <pc:docMk/>
          <pc:sldMk cId="4229023287" sldId="268"/>
        </pc:sldMkLst>
        <pc:spChg chg="del mod">
          <ac:chgData name="Cercamondi,Colin Ivano,CH-Vevey" userId="d25e694c-3ff8-4193-82fc-75dd469e9cee" providerId="ADAL" clId="{C7E5EE27-21D3-41A1-AF7C-1292D5D7928D}" dt="2021-01-19T13:04:09.848" v="1286" actId="478"/>
          <ac:spMkLst>
            <pc:docMk/>
            <pc:sldMk cId="4229023287" sldId="268"/>
            <ac:spMk id="4" creationId="{30C8E7F9-0CD8-4BEB-9390-DCE92E2A3A02}"/>
          </ac:spMkLst>
        </pc:spChg>
        <pc:spChg chg="add mod">
          <ac:chgData name="Cercamondi,Colin Ivano,CH-Vevey" userId="d25e694c-3ff8-4193-82fc-75dd469e9cee" providerId="ADAL" clId="{C7E5EE27-21D3-41A1-AF7C-1292D5D7928D}" dt="2021-01-19T13:04:28.529" v="1291" actId="122"/>
          <ac:spMkLst>
            <pc:docMk/>
            <pc:sldMk cId="4229023287" sldId="268"/>
            <ac:spMk id="5" creationId="{E2ED84B5-882E-45CA-B8DA-5101548D0972}"/>
          </ac:spMkLst>
        </pc:spChg>
        <pc:spChg chg="mod">
          <ac:chgData name="Cercamondi,Colin Ivano,CH-Vevey" userId="d25e694c-3ff8-4193-82fc-75dd469e9cee" providerId="ADAL" clId="{C7E5EE27-21D3-41A1-AF7C-1292D5D7928D}" dt="2021-01-19T13:33:07.653" v="1295" actId="20577"/>
          <ac:spMkLst>
            <pc:docMk/>
            <pc:sldMk cId="4229023287" sldId="268"/>
            <ac:spMk id="6" creationId="{81FA4653-DC30-4403-B45C-5C347BD53527}"/>
          </ac:spMkLst>
        </pc:spChg>
        <pc:picChg chg="mod">
          <ac:chgData name="Cercamondi,Colin Ivano,CH-Vevey" userId="d25e694c-3ff8-4193-82fc-75dd469e9cee" providerId="ADAL" clId="{C7E5EE27-21D3-41A1-AF7C-1292D5D7928D}" dt="2021-01-18T21:21:45.865" v="1066" actId="1076"/>
          <ac:picMkLst>
            <pc:docMk/>
            <pc:sldMk cId="4229023287" sldId="268"/>
            <ac:picMk id="3" creationId="{F84E23B7-6BF6-463A-8023-3BD3D4E43BCB}"/>
          </ac:picMkLst>
        </pc:picChg>
        <pc:picChg chg="del mod">
          <ac:chgData name="Cercamondi,Colin Ivano,CH-Vevey" userId="d25e694c-3ff8-4193-82fc-75dd469e9cee" providerId="ADAL" clId="{C7E5EE27-21D3-41A1-AF7C-1292D5D7928D}" dt="2021-01-18T21:21:25.869" v="1063" actId="478"/>
          <ac:picMkLst>
            <pc:docMk/>
            <pc:sldMk cId="4229023287" sldId="268"/>
            <ac:picMk id="7" creationId="{5D74F200-EC70-455D-A7C2-2CD098E4195F}"/>
          </ac:picMkLst>
        </pc:picChg>
        <pc:picChg chg="del mod">
          <ac:chgData name="Cercamondi,Colin Ivano,CH-Vevey" userId="d25e694c-3ff8-4193-82fc-75dd469e9cee" providerId="ADAL" clId="{C7E5EE27-21D3-41A1-AF7C-1292D5D7928D}" dt="2021-01-18T21:21:27.385" v="1064" actId="478"/>
          <ac:picMkLst>
            <pc:docMk/>
            <pc:sldMk cId="4229023287" sldId="268"/>
            <ac:picMk id="8" creationId="{DC024299-3823-4DE1-90E9-C98CC54F08E1}"/>
          </ac:picMkLst>
        </pc:picChg>
        <pc:picChg chg="del mod">
          <ac:chgData name="Cercamondi,Colin Ivano,CH-Vevey" userId="d25e694c-3ff8-4193-82fc-75dd469e9cee" providerId="ADAL" clId="{C7E5EE27-21D3-41A1-AF7C-1292D5D7928D}" dt="2021-01-18T21:21:30.290" v="1065" actId="478"/>
          <ac:picMkLst>
            <pc:docMk/>
            <pc:sldMk cId="4229023287" sldId="268"/>
            <ac:picMk id="9" creationId="{1CA31809-C731-4381-A145-A7CD21CA43C3}"/>
          </ac:picMkLst>
        </pc:picChg>
      </pc:sldChg>
      <pc:sldChg chg="addSp delSp modSp add ord">
        <pc:chgData name="Cercamondi,Colin Ivano,CH-Vevey" userId="d25e694c-3ff8-4193-82fc-75dd469e9cee" providerId="ADAL" clId="{C7E5EE27-21D3-41A1-AF7C-1292D5D7928D}" dt="2021-01-18T21:38:42.240" v="1072" actId="20577"/>
        <pc:sldMkLst>
          <pc:docMk/>
          <pc:sldMk cId="4065762664" sldId="269"/>
        </pc:sldMkLst>
        <pc:spChg chg="del">
          <ac:chgData name="Cercamondi,Colin Ivano,CH-Vevey" userId="d25e694c-3ff8-4193-82fc-75dd469e9cee" providerId="ADAL" clId="{C7E5EE27-21D3-41A1-AF7C-1292D5D7928D}" dt="2020-12-21T20:55:10.061" v="47" actId="478"/>
          <ac:spMkLst>
            <pc:docMk/>
            <pc:sldMk cId="4065762664" sldId="269"/>
            <ac:spMk id="2" creationId="{04411A6F-ED73-4F23-90B7-31ADE799FFEA}"/>
          </ac:spMkLst>
        </pc:spChg>
        <pc:spChg chg="del">
          <ac:chgData name="Cercamondi,Colin Ivano,CH-Vevey" userId="d25e694c-3ff8-4193-82fc-75dd469e9cee" providerId="ADAL" clId="{C7E5EE27-21D3-41A1-AF7C-1292D5D7928D}" dt="2020-12-21T20:54:55.155" v="44"/>
          <ac:spMkLst>
            <pc:docMk/>
            <pc:sldMk cId="4065762664" sldId="269"/>
            <ac:spMk id="3" creationId="{612E3CA4-B242-4BCA-842F-CF1586BC830C}"/>
          </ac:spMkLst>
        </pc:spChg>
        <pc:spChg chg="add del mod">
          <ac:chgData name="Cercamondi,Colin Ivano,CH-Vevey" userId="d25e694c-3ff8-4193-82fc-75dd469e9cee" providerId="ADAL" clId="{C7E5EE27-21D3-41A1-AF7C-1292D5D7928D}" dt="2021-01-18T21:16:29.951" v="972" actId="478"/>
          <ac:spMkLst>
            <pc:docMk/>
            <pc:sldMk cId="4065762664" sldId="269"/>
            <ac:spMk id="6" creationId="{FE24FDEF-8B1D-4075-9372-E9B65C6E18AA}"/>
          </ac:spMkLst>
        </pc:spChg>
        <pc:spChg chg="add mod">
          <ac:chgData name="Cercamondi,Colin Ivano,CH-Vevey" userId="d25e694c-3ff8-4193-82fc-75dd469e9cee" providerId="ADAL" clId="{C7E5EE27-21D3-41A1-AF7C-1292D5D7928D}" dt="2021-01-18T21:38:42.240" v="1072" actId="20577"/>
          <ac:spMkLst>
            <pc:docMk/>
            <pc:sldMk cId="4065762664" sldId="269"/>
            <ac:spMk id="7" creationId="{9623A356-FF2C-45D5-A615-ADDEB83EEED6}"/>
          </ac:spMkLst>
        </pc:spChg>
        <pc:spChg chg="add del mod">
          <ac:chgData name="Cercamondi,Colin Ivano,CH-Vevey" userId="d25e694c-3ff8-4193-82fc-75dd469e9cee" providerId="ADAL" clId="{C7E5EE27-21D3-41A1-AF7C-1292D5D7928D}" dt="2020-12-21T21:00:51.296" v="153"/>
          <ac:spMkLst>
            <pc:docMk/>
            <pc:sldMk cId="4065762664" sldId="269"/>
            <ac:spMk id="9" creationId="{F2DC1977-635C-44E6-9E7B-77BF8506ECFC}"/>
          </ac:spMkLst>
        </pc:spChg>
        <pc:picChg chg="add del mod">
          <ac:chgData name="Cercamondi,Colin Ivano,CH-Vevey" userId="d25e694c-3ff8-4193-82fc-75dd469e9cee" providerId="ADAL" clId="{C7E5EE27-21D3-41A1-AF7C-1292D5D7928D}" dt="2020-12-21T21:00:49.647" v="152" actId="478"/>
          <ac:picMkLst>
            <pc:docMk/>
            <pc:sldMk cId="4065762664" sldId="269"/>
            <ac:picMk id="5" creationId="{5CD036E0-7791-427B-B957-B3EB7D5F57F4}"/>
          </ac:picMkLst>
        </pc:picChg>
        <pc:picChg chg="add mod ord">
          <ac:chgData name="Cercamondi,Colin Ivano,CH-Vevey" userId="d25e694c-3ff8-4193-82fc-75dd469e9cee" providerId="ADAL" clId="{C7E5EE27-21D3-41A1-AF7C-1292D5D7928D}" dt="2021-01-18T21:16:36.365" v="973" actId="1076"/>
          <ac:picMkLst>
            <pc:docMk/>
            <pc:sldMk cId="4065762664" sldId="269"/>
            <ac:picMk id="11" creationId="{75FAD200-E95A-4A3D-A380-23ADA77412D1}"/>
          </ac:picMkLst>
        </pc:picChg>
      </pc:sldChg>
      <pc:sldChg chg="addSp delSp modSp add del addCm modCm">
        <pc:chgData name="Cercamondi,Colin Ivano,CH-Vevey" userId="d25e694c-3ff8-4193-82fc-75dd469e9cee" providerId="ADAL" clId="{C7E5EE27-21D3-41A1-AF7C-1292D5D7928D}" dt="2021-01-18T21:03:38.680" v="880" actId="2696"/>
        <pc:sldMkLst>
          <pc:docMk/>
          <pc:sldMk cId="3063682696" sldId="270"/>
        </pc:sldMkLst>
        <pc:spChg chg="mod">
          <ac:chgData name="Cercamondi,Colin Ivano,CH-Vevey" userId="d25e694c-3ff8-4193-82fc-75dd469e9cee" providerId="ADAL" clId="{C7E5EE27-21D3-41A1-AF7C-1292D5D7928D}" dt="2021-01-07T07:56:37.829" v="416" actId="20577"/>
          <ac:spMkLst>
            <pc:docMk/>
            <pc:sldMk cId="3063682696" sldId="270"/>
            <ac:spMk id="2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7T08:00:59.650" v="579" actId="20577"/>
          <ac:spMkLst>
            <pc:docMk/>
            <pc:sldMk cId="3063682696" sldId="270"/>
            <ac:spMk id="3" creationId="{00000000-0000-0000-0000-000000000000}"/>
          </ac:spMkLst>
        </pc:spChg>
        <pc:picChg chg="del">
          <ac:chgData name="Cercamondi,Colin Ivano,CH-Vevey" userId="d25e694c-3ff8-4193-82fc-75dd469e9cee" providerId="ADAL" clId="{C7E5EE27-21D3-41A1-AF7C-1292D5D7928D}" dt="2021-01-05T10:06:54.560" v="326" actId="478"/>
          <ac:picMkLst>
            <pc:docMk/>
            <pc:sldMk cId="3063682696" sldId="270"/>
            <ac:picMk id="5" creationId="{F17739DB-1853-4405-8DEA-20047D0726DE}"/>
          </ac:picMkLst>
        </pc:picChg>
        <pc:picChg chg="add mod">
          <ac:chgData name="Cercamondi,Colin Ivano,CH-Vevey" userId="d25e694c-3ff8-4193-82fc-75dd469e9cee" providerId="ADAL" clId="{C7E5EE27-21D3-41A1-AF7C-1292D5D7928D}" dt="2021-01-05T10:07:16.390" v="332" actId="14100"/>
          <ac:picMkLst>
            <pc:docMk/>
            <pc:sldMk cId="3063682696" sldId="270"/>
            <ac:picMk id="6" creationId="{7FC038B3-B771-47EB-941A-0AF79580BAE3}"/>
          </ac:picMkLst>
        </pc:picChg>
      </pc:sldChg>
      <pc:sldChg chg="addSp delSp modSp add del addCm modCm">
        <pc:chgData name="Cercamondi,Colin Ivano,CH-Vevey" userId="d25e694c-3ff8-4193-82fc-75dd469e9cee" providerId="ADAL" clId="{C7E5EE27-21D3-41A1-AF7C-1292D5D7928D}" dt="2021-01-18T21:03:41.600" v="881" actId="2696"/>
        <pc:sldMkLst>
          <pc:docMk/>
          <pc:sldMk cId="2425756050" sldId="271"/>
        </pc:sldMkLst>
        <pc:spChg chg="mod">
          <ac:chgData name="Cercamondi,Colin Ivano,CH-Vevey" userId="d25e694c-3ff8-4193-82fc-75dd469e9cee" providerId="ADAL" clId="{C7E5EE27-21D3-41A1-AF7C-1292D5D7928D}" dt="2021-01-07T07:56:34.335" v="414" actId="20577"/>
          <ac:spMkLst>
            <pc:docMk/>
            <pc:sldMk cId="2425756050" sldId="271"/>
            <ac:spMk id="2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7T08:00:52.673" v="578" actId="27636"/>
          <ac:spMkLst>
            <pc:docMk/>
            <pc:sldMk cId="2425756050" sldId="271"/>
            <ac:spMk id="3" creationId="{00000000-0000-0000-0000-000000000000}"/>
          </ac:spMkLst>
        </pc:spChg>
        <pc:picChg chg="del">
          <ac:chgData name="Cercamondi,Colin Ivano,CH-Vevey" userId="d25e694c-3ff8-4193-82fc-75dd469e9cee" providerId="ADAL" clId="{C7E5EE27-21D3-41A1-AF7C-1292D5D7928D}" dt="2021-01-07T07:58:44.157" v="478" actId="478"/>
          <ac:picMkLst>
            <pc:docMk/>
            <pc:sldMk cId="2425756050" sldId="271"/>
            <ac:picMk id="5" creationId="{F17739DB-1853-4405-8DEA-20047D0726DE}"/>
          </ac:picMkLst>
        </pc:picChg>
        <pc:picChg chg="add mod">
          <ac:chgData name="Cercamondi,Colin Ivano,CH-Vevey" userId="d25e694c-3ff8-4193-82fc-75dd469e9cee" providerId="ADAL" clId="{C7E5EE27-21D3-41A1-AF7C-1292D5D7928D}" dt="2021-01-07T07:59:02.506" v="527" actId="1038"/>
          <ac:picMkLst>
            <pc:docMk/>
            <pc:sldMk cId="2425756050" sldId="271"/>
            <ac:picMk id="6" creationId="{9FF11B40-D4EE-4CCF-AEE0-DEF6742E7290}"/>
          </ac:picMkLst>
        </pc:picChg>
      </pc:sldChg>
      <pc:sldChg chg="del addCm">
        <pc:chgData name="Cercamondi,Colin Ivano,CH-Vevey" userId="d25e694c-3ff8-4193-82fc-75dd469e9cee" providerId="ADAL" clId="{C7E5EE27-21D3-41A1-AF7C-1292D5D7928D}" dt="2021-01-18T20:55:31.263" v="844" actId="2696"/>
        <pc:sldMkLst>
          <pc:docMk/>
          <pc:sldMk cId="4186082910" sldId="272"/>
        </pc:sldMkLst>
      </pc:sldChg>
      <pc:sldChg chg="delSp">
        <pc:chgData name="Cercamondi,Colin Ivano,CH-Vevey" userId="d25e694c-3ff8-4193-82fc-75dd469e9cee" providerId="ADAL" clId="{C7E5EE27-21D3-41A1-AF7C-1292D5D7928D}" dt="2021-01-18T21:18:27.381" v="984" actId="478"/>
        <pc:sldMkLst>
          <pc:docMk/>
          <pc:sldMk cId="2408093355" sldId="273"/>
        </pc:sldMkLst>
        <pc:spChg chg="del">
          <ac:chgData name="Cercamondi,Colin Ivano,CH-Vevey" userId="d25e694c-3ff8-4193-82fc-75dd469e9cee" providerId="ADAL" clId="{C7E5EE27-21D3-41A1-AF7C-1292D5D7928D}" dt="2021-01-18T21:18:27.381" v="984" actId="478"/>
          <ac:spMkLst>
            <pc:docMk/>
            <pc:sldMk cId="2408093355" sldId="273"/>
            <ac:spMk id="3" creationId="{BB64D2FC-199D-4C0B-B0D0-D3246E1C00FF}"/>
          </ac:spMkLst>
        </pc:spChg>
      </pc:sldChg>
      <pc:sldChg chg="addSp delSp modSp delCm modCm">
        <pc:chgData name="Cercamondi,Colin Ivano,CH-Vevey" userId="d25e694c-3ff8-4193-82fc-75dd469e9cee" providerId="ADAL" clId="{C7E5EE27-21D3-41A1-AF7C-1292D5D7928D}" dt="2021-01-18T20:55:28.294" v="843"/>
        <pc:sldMkLst>
          <pc:docMk/>
          <pc:sldMk cId="4181099377" sldId="274"/>
        </pc:sldMkLst>
        <pc:spChg chg="mod">
          <ac:chgData name="Cercamondi,Colin Ivano,CH-Vevey" userId="d25e694c-3ff8-4193-82fc-75dd469e9cee" providerId="ADAL" clId="{C7E5EE27-21D3-41A1-AF7C-1292D5D7928D}" dt="2021-01-18T20:28:28.824" v="758" actId="1076"/>
          <ac:spMkLst>
            <pc:docMk/>
            <pc:sldMk cId="4181099377" sldId="274"/>
            <ac:spMk id="2" creationId="{00000000-0000-0000-0000-000000000000}"/>
          </ac:spMkLst>
        </pc:spChg>
        <pc:spChg chg="del">
          <ac:chgData name="Cercamondi,Colin Ivano,CH-Vevey" userId="d25e694c-3ff8-4193-82fc-75dd469e9cee" providerId="ADAL" clId="{C7E5EE27-21D3-41A1-AF7C-1292D5D7928D}" dt="2021-01-18T20:50:39.505" v="771" actId="478"/>
          <ac:spMkLst>
            <pc:docMk/>
            <pc:sldMk cId="4181099377" sldId="274"/>
            <ac:spMk id="3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18T20:52:19.267" v="818" actId="164"/>
          <ac:spMkLst>
            <pc:docMk/>
            <pc:sldMk cId="4181099377" sldId="274"/>
            <ac:spMk id="6" creationId="{E2658BC6-E908-47F2-8D80-8075CE348F99}"/>
          </ac:spMkLst>
        </pc:spChg>
        <pc:spChg chg="mod">
          <ac:chgData name="Cercamondi,Colin Ivano,CH-Vevey" userId="d25e694c-3ff8-4193-82fc-75dd469e9cee" providerId="ADAL" clId="{C7E5EE27-21D3-41A1-AF7C-1292D5D7928D}" dt="2021-01-18T20:51:48.915" v="816" actId="164"/>
          <ac:spMkLst>
            <pc:docMk/>
            <pc:sldMk cId="4181099377" sldId="274"/>
            <ac:spMk id="7" creationId="{0C5D272F-2D94-4F8A-9994-F5CDA4B27394}"/>
          </ac:spMkLst>
        </pc:spChg>
        <pc:spChg chg="mod">
          <ac:chgData name="Cercamondi,Colin Ivano,CH-Vevey" userId="d25e694c-3ff8-4193-82fc-75dd469e9cee" providerId="ADAL" clId="{C7E5EE27-21D3-41A1-AF7C-1292D5D7928D}" dt="2021-01-18T20:51:19.564" v="796" actId="164"/>
          <ac:spMkLst>
            <pc:docMk/>
            <pc:sldMk cId="4181099377" sldId="274"/>
            <ac:spMk id="9" creationId="{27F0784C-44C8-447C-BD40-F972986CC706}"/>
          </ac:spMkLst>
        </pc:spChg>
        <pc:spChg chg="del">
          <ac:chgData name="Cercamondi,Colin Ivano,CH-Vevey" userId="d25e694c-3ff8-4193-82fc-75dd469e9cee" providerId="ADAL" clId="{C7E5EE27-21D3-41A1-AF7C-1292D5D7928D}" dt="2021-01-18T20:28:24.704" v="757" actId="478"/>
          <ac:spMkLst>
            <pc:docMk/>
            <pc:sldMk cId="4181099377" sldId="274"/>
            <ac:spMk id="10" creationId="{5FA22EB1-AB3C-420E-B24A-0C5100EC0B9F}"/>
          </ac:spMkLst>
        </pc:spChg>
        <pc:spChg chg="del mod">
          <ac:chgData name="Cercamondi,Colin Ivano,CH-Vevey" userId="d25e694c-3ff8-4193-82fc-75dd469e9cee" providerId="ADAL" clId="{C7E5EE27-21D3-41A1-AF7C-1292D5D7928D}" dt="2021-01-18T20:50:37.555" v="770" actId="478"/>
          <ac:spMkLst>
            <pc:docMk/>
            <pc:sldMk cId="4181099377" sldId="274"/>
            <ac:spMk id="13" creationId="{DC69C8CB-CB16-4A67-BD7F-0C6E879F7314}"/>
          </ac:spMkLst>
        </pc:spChg>
        <pc:spChg chg="del">
          <ac:chgData name="Cercamondi,Colin Ivano,CH-Vevey" userId="d25e694c-3ff8-4193-82fc-75dd469e9cee" providerId="ADAL" clId="{C7E5EE27-21D3-41A1-AF7C-1292D5D7928D}" dt="2021-01-18T20:50:36.262" v="769" actId="478"/>
          <ac:spMkLst>
            <pc:docMk/>
            <pc:sldMk cId="4181099377" sldId="274"/>
            <ac:spMk id="14" creationId="{BD8AF208-385D-4602-B5CB-51C6F5785B55}"/>
          </ac:spMkLst>
        </pc:spChg>
        <pc:spChg chg="mod">
          <ac:chgData name="Cercamondi,Colin Ivano,CH-Vevey" userId="d25e694c-3ff8-4193-82fc-75dd469e9cee" providerId="ADAL" clId="{C7E5EE27-21D3-41A1-AF7C-1292D5D7928D}" dt="2021-01-18T20:52:39.980" v="832" actId="1076"/>
          <ac:spMkLst>
            <pc:docMk/>
            <pc:sldMk cId="4181099377" sldId="274"/>
            <ac:spMk id="15" creationId="{A4FFF726-C6C5-407E-962B-9404C108370F}"/>
          </ac:spMkLst>
        </pc:spChg>
        <pc:spChg chg="add del mod">
          <ac:chgData name="Cercamondi,Colin Ivano,CH-Vevey" userId="d25e694c-3ff8-4193-82fc-75dd469e9cee" providerId="ADAL" clId="{C7E5EE27-21D3-41A1-AF7C-1292D5D7928D}" dt="2021-01-18T20:50:41.721" v="772" actId="478"/>
          <ac:spMkLst>
            <pc:docMk/>
            <pc:sldMk cId="4181099377" sldId="274"/>
            <ac:spMk id="17" creationId="{DE99D9B4-6D8A-4822-9C43-59F5E4167E55}"/>
          </ac:spMkLst>
        </pc:spChg>
        <pc:spChg chg="add mod">
          <ac:chgData name="Cercamondi,Colin Ivano,CH-Vevey" userId="d25e694c-3ff8-4193-82fc-75dd469e9cee" providerId="ADAL" clId="{C7E5EE27-21D3-41A1-AF7C-1292D5D7928D}" dt="2021-01-18T20:52:54.905" v="835" actId="20577"/>
          <ac:spMkLst>
            <pc:docMk/>
            <pc:sldMk cId="4181099377" sldId="274"/>
            <ac:spMk id="21" creationId="{CC1BB4E4-6483-444B-A376-8EA489BF8CC6}"/>
          </ac:spMkLst>
        </pc:spChg>
        <pc:spChg chg="add mod">
          <ac:chgData name="Cercamondi,Colin Ivano,CH-Vevey" userId="d25e694c-3ff8-4193-82fc-75dd469e9cee" providerId="ADAL" clId="{C7E5EE27-21D3-41A1-AF7C-1292D5D7928D}" dt="2021-01-18T20:53:04.709" v="838" actId="20577"/>
          <ac:spMkLst>
            <pc:docMk/>
            <pc:sldMk cId="4181099377" sldId="274"/>
            <ac:spMk id="22" creationId="{BF15CBAC-169D-416D-87CB-96F58772D621}"/>
          </ac:spMkLst>
        </pc:spChg>
        <pc:grpChg chg="add mod">
          <ac:chgData name="Cercamondi,Colin Ivano,CH-Vevey" userId="d25e694c-3ff8-4193-82fc-75dd469e9cee" providerId="ADAL" clId="{C7E5EE27-21D3-41A1-AF7C-1292D5D7928D}" dt="2021-01-18T20:51:39.787" v="815" actId="1076"/>
          <ac:grpSpMkLst>
            <pc:docMk/>
            <pc:sldMk cId="4181099377" sldId="274"/>
            <ac:grpSpMk id="18" creationId="{5D43A207-A002-4D06-B994-3797D03C2AC6}"/>
          </ac:grpSpMkLst>
        </pc:grpChg>
        <pc:grpChg chg="add mod">
          <ac:chgData name="Cercamondi,Colin Ivano,CH-Vevey" userId="d25e694c-3ff8-4193-82fc-75dd469e9cee" providerId="ADAL" clId="{C7E5EE27-21D3-41A1-AF7C-1292D5D7928D}" dt="2021-01-18T20:51:57.978" v="817" actId="1076"/>
          <ac:grpSpMkLst>
            <pc:docMk/>
            <pc:sldMk cId="4181099377" sldId="274"/>
            <ac:grpSpMk id="19" creationId="{F5260A26-6679-4507-8FB5-5DB28904881A}"/>
          </ac:grpSpMkLst>
        </pc:grpChg>
        <pc:grpChg chg="add mod">
          <ac:chgData name="Cercamondi,Colin Ivano,CH-Vevey" userId="d25e694c-3ff8-4193-82fc-75dd469e9cee" providerId="ADAL" clId="{C7E5EE27-21D3-41A1-AF7C-1292D5D7928D}" dt="2021-01-18T20:52:24.692" v="819" actId="1076"/>
          <ac:grpSpMkLst>
            <pc:docMk/>
            <pc:sldMk cId="4181099377" sldId="274"/>
            <ac:grpSpMk id="20" creationId="{BC10A1FE-16E9-44BD-AA43-252628278ABF}"/>
          </ac:grpSpMkLst>
        </pc:grpChg>
        <pc:graphicFrameChg chg="mod">
          <ac:chgData name="Cercamondi,Colin Ivano,CH-Vevey" userId="d25e694c-3ff8-4193-82fc-75dd469e9cee" providerId="ADAL" clId="{C7E5EE27-21D3-41A1-AF7C-1292D5D7928D}" dt="2021-01-18T20:51:12.874" v="795" actId="1076"/>
          <ac:graphicFrameMkLst>
            <pc:docMk/>
            <pc:sldMk cId="4181099377" sldId="274"/>
            <ac:graphicFrameMk id="11" creationId="{7A88A2FE-4192-4027-9541-32C9B32F6C74}"/>
          </ac:graphicFrameMkLst>
        </pc:graphicFrameChg>
        <pc:graphicFrameChg chg="mod">
          <ac:chgData name="Cercamondi,Colin Ivano,CH-Vevey" userId="d25e694c-3ff8-4193-82fc-75dd469e9cee" providerId="ADAL" clId="{C7E5EE27-21D3-41A1-AF7C-1292D5D7928D}" dt="2021-01-18T20:51:34.163" v="814" actId="1076"/>
          <ac:graphicFrameMkLst>
            <pc:docMk/>
            <pc:sldMk cId="4181099377" sldId="274"/>
            <ac:graphicFrameMk id="12" creationId="{24264916-EED1-4E0B-995F-D76D5EA2BAB6}"/>
          </ac:graphicFrameMkLst>
        </pc:graphicFrameChg>
        <pc:picChg chg="mod">
          <ac:chgData name="Cercamondi,Colin Ivano,CH-Vevey" userId="d25e694c-3ff8-4193-82fc-75dd469e9cee" providerId="ADAL" clId="{C7E5EE27-21D3-41A1-AF7C-1292D5D7928D}" dt="2021-01-18T20:52:19.267" v="818" actId="164"/>
          <ac:picMkLst>
            <pc:docMk/>
            <pc:sldMk cId="4181099377" sldId="274"/>
            <ac:picMk id="4" creationId="{07B678AA-EBCA-45B1-9B14-268888E0BE28}"/>
          </ac:picMkLst>
        </pc:picChg>
        <pc:picChg chg="mod">
          <ac:chgData name="Cercamondi,Colin Ivano,CH-Vevey" userId="d25e694c-3ff8-4193-82fc-75dd469e9cee" providerId="ADAL" clId="{C7E5EE27-21D3-41A1-AF7C-1292D5D7928D}" dt="2021-01-18T20:51:19.564" v="796" actId="164"/>
          <ac:picMkLst>
            <pc:docMk/>
            <pc:sldMk cId="4181099377" sldId="274"/>
            <ac:picMk id="5" creationId="{81702BDC-7DEB-448F-AFE4-8BF6F6171D74}"/>
          </ac:picMkLst>
        </pc:picChg>
        <pc:picChg chg="mod">
          <ac:chgData name="Cercamondi,Colin Ivano,CH-Vevey" userId="d25e694c-3ff8-4193-82fc-75dd469e9cee" providerId="ADAL" clId="{C7E5EE27-21D3-41A1-AF7C-1292D5D7928D}" dt="2021-01-18T20:51:48.915" v="816" actId="164"/>
          <ac:picMkLst>
            <pc:docMk/>
            <pc:sldMk cId="4181099377" sldId="274"/>
            <ac:picMk id="8" creationId="{0853C466-3925-4261-BE29-A30A1DAC2CC3}"/>
          </ac:picMkLst>
        </pc:picChg>
      </pc:sldChg>
      <pc:sldChg chg="addSp delSp modSp addCm modCm">
        <pc:chgData name="Cercamondi,Colin Ivano,CH-Vevey" userId="d25e694c-3ff8-4193-82fc-75dd469e9cee" providerId="ADAL" clId="{C7E5EE27-21D3-41A1-AF7C-1292D5D7928D}" dt="2021-01-18T21:13:56.166" v="968"/>
        <pc:sldMkLst>
          <pc:docMk/>
          <pc:sldMk cId="562436449" sldId="275"/>
        </pc:sldMkLst>
        <pc:spChg chg="mod">
          <ac:chgData name="Cercamondi,Colin Ivano,CH-Vevey" userId="d25e694c-3ff8-4193-82fc-75dd469e9cee" providerId="ADAL" clId="{C7E5EE27-21D3-41A1-AF7C-1292D5D7928D}" dt="2021-01-18T21:02:28.254" v="873" actId="20577"/>
          <ac:spMkLst>
            <pc:docMk/>
            <pc:sldMk cId="562436449" sldId="275"/>
            <ac:spMk id="2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18T21:05:32.244" v="957" actId="1076"/>
          <ac:spMkLst>
            <pc:docMk/>
            <pc:sldMk cId="562436449" sldId="275"/>
            <ac:spMk id="8" creationId="{DF3150E2-C615-4092-9C88-57EC909FFFD0}"/>
          </ac:spMkLst>
        </pc:spChg>
        <pc:spChg chg="mod">
          <ac:chgData name="Cercamondi,Colin Ivano,CH-Vevey" userId="d25e694c-3ff8-4193-82fc-75dd469e9cee" providerId="ADAL" clId="{C7E5EE27-21D3-41A1-AF7C-1292D5D7928D}" dt="2021-01-18T21:05:36.964" v="958" actId="1076"/>
          <ac:spMkLst>
            <pc:docMk/>
            <pc:sldMk cId="562436449" sldId="275"/>
            <ac:spMk id="11" creationId="{F00137AC-B220-4DB4-830B-378E9B5FAB31}"/>
          </ac:spMkLst>
        </pc:spChg>
        <pc:spChg chg="mod">
          <ac:chgData name="Cercamondi,Colin Ivano,CH-Vevey" userId="d25e694c-3ff8-4193-82fc-75dd469e9cee" providerId="ADAL" clId="{C7E5EE27-21D3-41A1-AF7C-1292D5D7928D}" dt="2021-01-18T21:05:40.452" v="959" actId="1076"/>
          <ac:spMkLst>
            <pc:docMk/>
            <pc:sldMk cId="562436449" sldId="275"/>
            <ac:spMk id="12" creationId="{A6B30807-652E-46D6-9349-DC424F5F6ED5}"/>
          </ac:spMkLst>
        </pc:spChg>
        <pc:spChg chg="add del">
          <ac:chgData name="Cercamondi,Colin Ivano,CH-Vevey" userId="d25e694c-3ff8-4193-82fc-75dd469e9cee" providerId="ADAL" clId="{C7E5EE27-21D3-41A1-AF7C-1292D5D7928D}" dt="2021-01-18T21:13:26.676" v="962" actId="478"/>
          <ac:spMkLst>
            <pc:docMk/>
            <pc:sldMk cId="562436449" sldId="275"/>
            <ac:spMk id="14" creationId="{CDBF670F-68B2-4559-BA94-FE8784BEF7A2}"/>
          </ac:spMkLst>
        </pc:spChg>
        <pc:spChg chg="del">
          <ac:chgData name="Cercamondi,Colin Ivano,CH-Vevey" userId="d25e694c-3ff8-4193-82fc-75dd469e9cee" providerId="ADAL" clId="{C7E5EE27-21D3-41A1-AF7C-1292D5D7928D}" dt="2021-01-18T21:02:20.276" v="871" actId="478"/>
          <ac:spMkLst>
            <pc:docMk/>
            <pc:sldMk cId="562436449" sldId="275"/>
            <ac:spMk id="15" creationId="{B276FD76-44D4-48DF-A52F-066CF3CDB601}"/>
          </ac:spMkLst>
        </pc:spChg>
        <pc:spChg chg="del">
          <ac:chgData name="Cercamondi,Colin Ivano,CH-Vevey" userId="d25e694c-3ff8-4193-82fc-75dd469e9cee" providerId="ADAL" clId="{C7E5EE27-21D3-41A1-AF7C-1292D5D7928D}" dt="2021-01-18T21:13:29.054" v="963" actId="478"/>
          <ac:spMkLst>
            <pc:docMk/>
            <pc:sldMk cId="562436449" sldId="275"/>
            <ac:spMk id="16" creationId="{FD99EC64-4D30-40BF-840B-F14700F2E217}"/>
          </ac:spMkLst>
        </pc:spChg>
        <pc:picChg chg="mod">
          <ac:chgData name="Cercamondi,Colin Ivano,CH-Vevey" userId="d25e694c-3ff8-4193-82fc-75dd469e9cee" providerId="ADAL" clId="{C7E5EE27-21D3-41A1-AF7C-1292D5D7928D}" dt="2021-01-18T21:05:13.345" v="950" actId="14100"/>
          <ac:picMkLst>
            <pc:docMk/>
            <pc:sldMk cId="562436449" sldId="275"/>
            <ac:picMk id="7" creationId="{6FD4A128-53D0-44D5-8022-E6D66A8603CF}"/>
          </ac:picMkLst>
        </pc:picChg>
        <pc:picChg chg="mod">
          <ac:chgData name="Cercamondi,Colin Ivano,CH-Vevey" userId="d25e694c-3ff8-4193-82fc-75dd469e9cee" providerId="ADAL" clId="{C7E5EE27-21D3-41A1-AF7C-1292D5D7928D}" dt="2021-01-18T21:05:17.323" v="951" actId="1076"/>
          <ac:picMkLst>
            <pc:docMk/>
            <pc:sldMk cId="562436449" sldId="275"/>
            <ac:picMk id="9" creationId="{752EDCCB-31CC-406D-B7A2-D86F31DD013B}"/>
          </ac:picMkLst>
        </pc:picChg>
        <pc:picChg chg="mod">
          <ac:chgData name="Cercamondi,Colin Ivano,CH-Vevey" userId="d25e694c-3ff8-4193-82fc-75dd469e9cee" providerId="ADAL" clId="{C7E5EE27-21D3-41A1-AF7C-1292D5D7928D}" dt="2021-01-18T21:05:23.799" v="956" actId="14100"/>
          <ac:picMkLst>
            <pc:docMk/>
            <pc:sldMk cId="562436449" sldId="275"/>
            <ac:picMk id="10" creationId="{E1E211D5-9EA0-40CF-B930-E1D82F07F433}"/>
          </ac:picMkLst>
        </pc:picChg>
        <pc:picChg chg="mod">
          <ac:chgData name="Cercamondi,Colin Ivano,CH-Vevey" userId="d25e694c-3ff8-4193-82fc-75dd469e9cee" providerId="ADAL" clId="{C7E5EE27-21D3-41A1-AF7C-1292D5D7928D}" dt="2021-01-18T21:13:32.875" v="964" actId="1076"/>
          <ac:picMkLst>
            <pc:docMk/>
            <pc:sldMk cId="562436449" sldId="275"/>
            <ac:picMk id="13" creationId="{CF00B211-672D-494F-AD26-1949025262BA}"/>
          </ac:picMkLst>
        </pc:picChg>
      </pc:sldChg>
      <pc:sldMasterChg chg="modSp modSldLayout">
        <pc:chgData name="Cercamondi,Colin Ivano,CH-Vevey" userId="d25e694c-3ff8-4193-82fc-75dd469e9cee" providerId="ADAL" clId="{C7E5EE27-21D3-41A1-AF7C-1292D5D7928D}" dt="2021-01-05T09:52:46.406" v="278"/>
        <pc:sldMasterMkLst>
          <pc:docMk/>
          <pc:sldMasterMk cId="2460954070" sldId="2147483660"/>
        </pc:sldMasterMkLst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asterMk cId="2460954070" sldId="2147483660"/>
            <ac:spMk id="2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asterMk cId="2460954070" sldId="2147483660"/>
            <ac:spMk id="3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asterMk cId="2460954070" sldId="2147483660"/>
            <ac:spMk id="4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asterMk cId="2460954070" sldId="2147483660"/>
            <ac:spMk id="5" creationId="{00000000-0000-0000-0000-000000000000}"/>
          </ac:spMkLst>
        </pc:spChg>
        <pc:spChg chg="mod">
          <ac:chgData name="Cercamondi,Colin Ivano,CH-Vevey" userId="d25e694c-3ff8-4193-82fc-75dd469e9cee" providerId="ADAL" clId="{C7E5EE27-21D3-41A1-AF7C-1292D5D7928D}" dt="2021-01-05T09:52:46.406" v="278"/>
          <ac:spMkLst>
            <pc:docMk/>
            <pc:sldMasterMk cId="2460954070" sldId="2147483660"/>
            <ac:spMk id="6" creationId="{00000000-0000-0000-0000-000000000000}"/>
          </ac:spMkLst>
        </pc:spChg>
        <pc:sldLayoutChg chg="modSp">
          <pc:chgData name="Cercamondi,Colin Ivano,CH-Vevey" userId="d25e694c-3ff8-4193-82fc-75dd469e9cee" providerId="ADAL" clId="{C7E5EE27-21D3-41A1-AF7C-1292D5D7928D}" dt="2021-01-05T09:52:46.406" v="278"/>
          <pc:sldLayoutMkLst>
            <pc:docMk/>
            <pc:sldMasterMk cId="2460954070" sldId="2147483660"/>
            <pc:sldLayoutMk cId="2385387890" sldId="2147483661"/>
          </pc:sldLayoutMkLst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2385387890" sldId="2147483661"/>
              <ac:spMk id="2" creationId="{00000000-0000-0000-0000-000000000000}"/>
            </ac:spMkLst>
          </pc:spChg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2385387890" sldId="2147483661"/>
              <ac:spMk id="3" creationId="{00000000-0000-0000-0000-000000000000}"/>
            </ac:spMkLst>
          </pc:spChg>
        </pc:sldLayoutChg>
        <pc:sldLayoutChg chg="modSp">
          <pc:chgData name="Cercamondi,Colin Ivano,CH-Vevey" userId="d25e694c-3ff8-4193-82fc-75dd469e9cee" providerId="ADAL" clId="{C7E5EE27-21D3-41A1-AF7C-1292D5D7928D}" dt="2021-01-05T09:52:46.406" v="278"/>
          <pc:sldLayoutMkLst>
            <pc:docMk/>
            <pc:sldMasterMk cId="2460954070" sldId="2147483660"/>
            <pc:sldLayoutMk cId="2591524520" sldId="2147483663"/>
          </pc:sldLayoutMkLst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2591524520" sldId="2147483663"/>
              <ac:spMk id="2" creationId="{00000000-0000-0000-0000-000000000000}"/>
            </ac:spMkLst>
          </pc:spChg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2591524520" sldId="2147483663"/>
              <ac:spMk id="3" creationId="{00000000-0000-0000-0000-000000000000}"/>
            </ac:spMkLst>
          </pc:spChg>
        </pc:sldLayoutChg>
        <pc:sldLayoutChg chg="modSp">
          <pc:chgData name="Cercamondi,Colin Ivano,CH-Vevey" userId="d25e694c-3ff8-4193-82fc-75dd469e9cee" providerId="ADAL" clId="{C7E5EE27-21D3-41A1-AF7C-1292D5D7928D}" dt="2021-01-05T09:52:46.406" v="278"/>
          <pc:sldLayoutMkLst>
            <pc:docMk/>
            <pc:sldMasterMk cId="2460954070" sldId="2147483660"/>
            <pc:sldLayoutMk cId="1203092039" sldId="2147483664"/>
          </pc:sldLayoutMkLst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1203092039" sldId="2147483664"/>
              <ac:spMk id="3" creationId="{00000000-0000-0000-0000-000000000000}"/>
            </ac:spMkLst>
          </pc:spChg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1203092039" sldId="2147483664"/>
              <ac:spMk id="4" creationId="{00000000-0000-0000-0000-000000000000}"/>
            </ac:spMkLst>
          </pc:spChg>
        </pc:sldLayoutChg>
        <pc:sldLayoutChg chg="modSp">
          <pc:chgData name="Cercamondi,Colin Ivano,CH-Vevey" userId="d25e694c-3ff8-4193-82fc-75dd469e9cee" providerId="ADAL" clId="{C7E5EE27-21D3-41A1-AF7C-1292D5D7928D}" dt="2021-01-05T09:52:46.406" v="278"/>
          <pc:sldLayoutMkLst>
            <pc:docMk/>
            <pc:sldMasterMk cId="2460954070" sldId="2147483660"/>
            <pc:sldLayoutMk cId="3733172339" sldId="2147483665"/>
          </pc:sldLayoutMkLst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3733172339" sldId="2147483665"/>
              <ac:spMk id="2" creationId="{00000000-0000-0000-0000-000000000000}"/>
            </ac:spMkLst>
          </pc:spChg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3733172339" sldId="2147483665"/>
              <ac:spMk id="3" creationId="{00000000-0000-0000-0000-000000000000}"/>
            </ac:spMkLst>
          </pc:spChg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3733172339" sldId="2147483665"/>
              <ac:spMk id="4" creationId="{00000000-0000-0000-0000-000000000000}"/>
            </ac:spMkLst>
          </pc:spChg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3733172339" sldId="2147483665"/>
              <ac:spMk id="5" creationId="{00000000-0000-0000-0000-000000000000}"/>
            </ac:spMkLst>
          </pc:spChg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3733172339" sldId="2147483665"/>
              <ac:spMk id="6" creationId="{00000000-0000-0000-0000-000000000000}"/>
            </ac:spMkLst>
          </pc:spChg>
        </pc:sldLayoutChg>
        <pc:sldLayoutChg chg="modSp">
          <pc:chgData name="Cercamondi,Colin Ivano,CH-Vevey" userId="d25e694c-3ff8-4193-82fc-75dd469e9cee" providerId="ADAL" clId="{C7E5EE27-21D3-41A1-AF7C-1292D5D7928D}" dt="2021-01-05T09:52:46.406" v="278"/>
          <pc:sldLayoutMkLst>
            <pc:docMk/>
            <pc:sldMasterMk cId="2460954070" sldId="2147483660"/>
            <pc:sldLayoutMk cId="3171841454" sldId="2147483668"/>
          </pc:sldLayoutMkLst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3171841454" sldId="2147483668"/>
              <ac:spMk id="2" creationId="{00000000-0000-0000-0000-000000000000}"/>
            </ac:spMkLst>
          </pc:spChg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3171841454" sldId="2147483668"/>
              <ac:spMk id="3" creationId="{00000000-0000-0000-0000-000000000000}"/>
            </ac:spMkLst>
          </pc:spChg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3171841454" sldId="2147483668"/>
              <ac:spMk id="4" creationId="{00000000-0000-0000-0000-000000000000}"/>
            </ac:spMkLst>
          </pc:spChg>
        </pc:sldLayoutChg>
        <pc:sldLayoutChg chg="modSp">
          <pc:chgData name="Cercamondi,Colin Ivano,CH-Vevey" userId="d25e694c-3ff8-4193-82fc-75dd469e9cee" providerId="ADAL" clId="{C7E5EE27-21D3-41A1-AF7C-1292D5D7928D}" dt="2021-01-05T09:52:46.406" v="278"/>
          <pc:sldLayoutMkLst>
            <pc:docMk/>
            <pc:sldMasterMk cId="2460954070" sldId="2147483660"/>
            <pc:sldLayoutMk cId="1718958274" sldId="2147483669"/>
          </pc:sldLayoutMkLst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1718958274" sldId="2147483669"/>
              <ac:spMk id="2" creationId="{00000000-0000-0000-0000-000000000000}"/>
            </ac:spMkLst>
          </pc:spChg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1718958274" sldId="2147483669"/>
              <ac:spMk id="3" creationId="{00000000-0000-0000-0000-000000000000}"/>
            </ac:spMkLst>
          </pc:spChg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1718958274" sldId="2147483669"/>
              <ac:spMk id="4" creationId="{00000000-0000-0000-0000-000000000000}"/>
            </ac:spMkLst>
          </pc:spChg>
        </pc:sldLayoutChg>
        <pc:sldLayoutChg chg="modSp">
          <pc:chgData name="Cercamondi,Colin Ivano,CH-Vevey" userId="d25e694c-3ff8-4193-82fc-75dd469e9cee" providerId="ADAL" clId="{C7E5EE27-21D3-41A1-AF7C-1292D5D7928D}" dt="2021-01-05T09:52:46.406" v="278"/>
          <pc:sldLayoutMkLst>
            <pc:docMk/>
            <pc:sldMasterMk cId="2460954070" sldId="2147483660"/>
            <pc:sldLayoutMk cId="3479445657" sldId="2147483671"/>
          </pc:sldLayoutMkLst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3479445657" sldId="2147483671"/>
              <ac:spMk id="2" creationId="{00000000-0000-0000-0000-000000000000}"/>
            </ac:spMkLst>
          </pc:spChg>
          <pc:spChg chg="mod">
            <ac:chgData name="Cercamondi,Colin Ivano,CH-Vevey" userId="d25e694c-3ff8-4193-82fc-75dd469e9cee" providerId="ADAL" clId="{C7E5EE27-21D3-41A1-AF7C-1292D5D7928D}" dt="2021-01-05T09:52:46.406" v="278"/>
            <ac:spMkLst>
              <pc:docMk/>
              <pc:sldMasterMk cId="2460954070" sldId="2147483660"/>
              <pc:sldLayoutMk cId="3479445657" sldId="2147483671"/>
              <ac:spMk id="3" creationId="{00000000-0000-0000-0000-000000000000}"/>
            </ac:spMkLst>
          </pc:spChg>
        </pc:sldLayoutChg>
      </pc:sldMasterChg>
    </pc:docChg>
  </pc:docChgLst>
  <pc:docChgLst>
    <pc:chgData name="Cercamondi,Colin Ivano,CH-Vevey" userId="d25e694c-3ff8-4193-82fc-75dd469e9cee" providerId="ADAL" clId="{04C91DDA-D881-481C-92C7-ED75F21FE670}"/>
    <pc:docChg chg="delSld modSld">
      <pc:chgData name="Cercamondi,Colin Ivano,CH-Vevey" userId="d25e694c-3ff8-4193-82fc-75dd469e9cee" providerId="ADAL" clId="{04C91DDA-D881-481C-92C7-ED75F21FE670}" dt="2021-04-16T14:15:24.159" v="55" actId="20577"/>
      <pc:docMkLst>
        <pc:docMk/>
      </pc:docMkLst>
      <pc:sldChg chg="del">
        <pc:chgData name="Cercamondi,Colin Ivano,CH-Vevey" userId="d25e694c-3ff8-4193-82fc-75dd469e9cee" providerId="ADAL" clId="{04C91DDA-D881-481C-92C7-ED75F21FE670}" dt="2021-04-16T14:14:38.183" v="0" actId="2696"/>
        <pc:sldMkLst>
          <pc:docMk/>
          <pc:sldMk cId="109857222" sldId="256"/>
        </pc:sldMkLst>
      </pc:sldChg>
      <pc:sldChg chg="del">
        <pc:chgData name="Cercamondi,Colin Ivano,CH-Vevey" userId="d25e694c-3ff8-4193-82fc-75dd469e9cee" providerId="ADAL" clId="{04C91DDA-D881-481C-92C7-ED75F21FE670}" dt="2021-04-16T14:14:39.431" v="2" actId="2696"/>
        <pc:sldMkLst>
          <pc:docMk/>
          <pc:sldMk cId="3481645440" sldId="259"/>
        </pc:sldMkLst>
      </pc:sldChg>
      <pc:sldChg chg="del">
        <pc:chgData name="Cercamondi,Colin Ivano,CH-Vevey" userId="d25e694c-3ff8-4193-82fc-75dd469e9cee" providerId="ADAL" clId="{04C91DDA-D881-481C-92C7-ED75F21FE670}" dt="2021-04-16T14:14:40.577" v="4" actId="2696"/>
        <pc:sldMkLst>
          <pc:docMk/>
          <pc:sldMk cId="1210609011" sldId="264"/>
        </pc:sldMkLst>
      </pc:sldChg>
      <pc:sldChg chg="modSp">
        <pc:chgData name="Cercamondi,Colin Ivano,CH-Vevey" userId="d25e694c-3ff8-4193-82fc-75dd469e9cee" providerId="ADAL" clId="{04C91DDA-D881-481C-92C7-ED75F21FE670}" dt="2021-04-16T14:15:06.564" v="51" actId="20577"/>
        <pc:sldMkLst>
          <pc:docMk/>
          <pc:sldMk cId="1153482099" sldId="267"/>
        </pc:sldMkLst>
        <pc:spChg chg="mod">
          <ac:chgData name="Cercamondi,Colin Ivano,CH-Vevey" userId="d25e694c-3ff8-4193-82fc-75dd469e9cee" providerId="ADAL" clId="{04C91DDA-D881-481C-92C7-ED75F21FE670}" dt="2021-04-16T14:15:06.564" v="51" actId="20577"/>
          <ac:spMkLst>
            <pc:docMk/>
            <pc:sldMk cId="1153482099" sldId="267"/>
            <ac:spMk id="3" creationId="{00000000-0000-0000-0000-000000000000}"/>
          </ac:spMkLst>
        </pc:spChg>
      </pc:sldChg>
      <pc:sldChg chg="modSp">
        <pc:chgData name="Cercamondi,Colin Ivano,CH-Vevey" userId="d25e694c-3ff8-4193-82fc-75dd469e9cee" providerId="ADAL" clId="{04C91DDA-D881-481C-92C7-ED75F21FE670}" dt="2021-04-16T14:15:24.159" v="55" actId="20577"/>
        <pc:sldMkLst>
          <pc:docMk/>
          <pc:sldMk cId="4229023287" sldId="268"/>
        </pc:sldMkLst>
        <pc:spChg chg="mod">
          <ac:chgData name="Cercamondi,Colin Ivano,CH-Vevey" userId="d25e694c-3ff8-4193-82fc-75dd469e9cee" providerId="ADAL" clId="{04C91DDA-D881-481C-92C7-ED75F21FE670}" dt="2021-04-16T14:15:24.159" v="55" actId="20577"/>
          <ac:spMkLst>
            <pc:docMk/>
            <pc:sldMk cId="4229023287" sldId="268"/>
            <ac:spMk id="6" creationId="{81FA4653-DC30-4403-B45C-5C347BD53527}"/>
          </ac:spMkLst>
        </pc:spChg>
      </pc:sldChg>
      <pc:sldChg chg="del">
        <pc:chgData name="Cercamondi,Colin Ivano,CH-Vevey" userId="d25e694c-3ff8-4193-82fc-75dd469e9cee" providerId="ADAL" clId="{04C91DDA-D881-481C-92C7-ED75F21FE670}" dt="2021-04-16T14:14:41.376" v="5" actId="2696"/>
        <pc:sldMkLst>
          <pc:docMk/>
          <pc:sldMk cId="4065762664" sldId="269"/>
        </pc:sldMkLst>
      </pc:sldChg>
      <pc:sldChg chg="del">
        <pc:chgData name="Cercamondi,Colin Ivano,CH-Vevey" userId="d25e694c-3ff8-4193-82fc-75dd469e9cee" providerId="ADAL" clId="{04C91DDA-D881-481C-92C7-ED75F21FE670}" dt="2021-04-16T14:14:42.927" v="6" actId="2696"/>
        <pc:sldMkLst>
          <pc:docMk/>
          <pc:sldMk cId="2408093355" sldId="273"/>
        </pc:sldMkLst>
      </pc:sldChg>
      <pc:sldChg chg="del">
        <pc:chgData name="Cercamondi,Colin Ivano,CH-Vevey" userId="d25e694c-3ff8-4193-82fc-75dd469e9cee" providerId="ADAL" clId="{04C91DDA-D881-481C-92C7-ED75F21FE670}" dt="2021-04-16T14:14:38.798" v="1" actId="2696"/>
        <pc:sldMkLst>
          <pc:docMk/>
          <pc:sldMk cId="4181099377" sldId="274"/>
        </pc:sldMkLst>
      </pc:sldChg>
      <pc:sldChg chg="del">
        <pc:chgData name="Cercamondi,Colin Ivano,CH-Vevey" userId="d25e694c-3ff8-4193-82fc-75dd469e9cee" providerId="ADAL" clId="{04C91DDA-D881-481C-92C7-ED75F21FE670}" dt="2021-04-16T14:14:39.988" v="3" actId="2696"/>
        <pc:sldMkLst>
          <pc:docMk/>
          <pc:sldMk cId="562436449" sldId="275"/>
        </pc:sldMkLst>
      </pc:sldChg>
    </pc:docChg>
  </pc:docChgLst>
  <pc:docChgLst>
    <pc:chgData name="Cercamondi,Colin Ivano,CH-Vevey" userId="d25e694c-3ff8-4193-82fc-75dd469e9cee" providerId="ADAL" clId="{6F0D7A41-2275-4718-AE9C-536B6BEB548A}"/>
    <pc:docChg chg="custSel modSld">
      <pc:chgData name="Cercamondi,Colin Ivano,CH-Vevey" userId="d25e694c-3ff8-4193-82fc-75dd469e9cee" providerId="ADAL" clId="{6F0D7A41-2275-4718-AE9C-536B6BEB548A}" dt="2021-01-19T15:45:48.373" v="6" actId="20577"/>
      <pc:docMkLst>
        <pc:docMk/>
      </pc:docMkLst>
      <pc:sldChg chg="delCm">
        <pc:chgData name="Cercamondi,Colin Ivano,CH-Vevey" userId="d25e694c-3ff8-4193-82fc-75dd469e9cee" providerId="ADAL" clId="{6F0D7A41-2275-4718-AE9C-536B6BEB548A}" dt="2021-01-19T15:43:28.294" v="0" actId="1592"/>
        <pc:sldMkLst>
          <pc:docMk/>
          <pc:sldMk cId="3481645440" sldId="259"/>
        </pc:sldMkLst>
      </pc:sldChg>
      <pc:sldChg chg="addSp delSp modSp delCm">
        <pc:chgData name="Cercamondi,Colin Ivano,CH-Vevey" userId="d25e694c-3ff8-4193-82fc-75dd469e9cee" providerId="ADAL" clId="{6F0D7A41-2275-4718-AE9C-536B6BEB548A}" dt="2021-01-19T15:45:48.373" v="6" actId="20577"/>
        <pc:sldMkLst>
          <pc:docMk/>
          <pc:sldMk cId="4181099377" sldId="274"/>
        </pc:sldMkLst>
        <pc:spChg chg="del">
          <ac:chgData name="Cercamondi,Colin Ivano,CH-Vevey" userId="d25e694c-3ff8-4193-82fc-75dd469e9cee" providerId="ADAL" clId="{6F0D7A41-2275-4718-AE9C-536B6BEB548A}" dt="2021-01-19T15:45:12.956" v="2" actId="478"/>
          <ac:spMkLst>
            <pc:docMk/>
            <pc:sldMk cId="4181099377" sldId="274"/>
            <ac:spMk id="15" creationId="{A4FFF726-C6C5-407E-962B-9404C108370F}"/>
          </ac:spMkLst>
        </pc:spChg>
        <pc:spChg chg="add mod">
          <ac:chgData name="Cercamondi,Colin Ivano,CH-Vevey" userId="d25e694c-3ff8-4193-82fc-75dd469e9cee" providerId="ADAL" clId="{6F0D7A41-2275-4718-AE9C-536B6BEB548A}" dt="2021-01-19T15:45:48.373" v="6" actId="20577"/>
          <ac:spMkLst>
            <pc:docMk/>
            <pc:sldMk cId="4181099377" sldId="274"/>
            <ac:spMk id="23" creationId="{0B0AB68F-B58F-46FD-BC4F-C573E240C9D0}"/>
          </ac:spMkLst>
        </pc:spChg>
      </pc:sldChg>
      <pc:sldChg chg="delCm">
        <pc:chgData name="Cercamondi,Colin Ivano,CH-Vevey" userId="d25e694c-3ff8-4193-82fc-75dd469e9cee" providerId="ADAL" clId="{6F0D7A41-2275-4718-AE9C-536B6BEB548A}" dt="2021-01-19T15:45:05.448" v="1" actId="1592"/>
        <pc:sldMkLst>
          <pc:docMk/>
          <pc:sldMk cId="562436449" sldId="275"/>
        </pc:sldMkLst>
      </pc:sldChg>
    </pc:docChg>
  </pc:docChgLst>
  <pc:docChgLst>
    <pc:chgData name="Cercamondi,Colin Ivano,CH-Vevey" userId="d25e694c-3ff8-4193-82fc-75dd469e9cee" providerId="ADAL" clId="{0F07F29E-985D-4F0A-A6BD-79692FB1BAAB}"/>
    <pc:docChg chg="addSld delSld modSld">
      <pc:chgData name="Cercamondi,Colin Ivano,CH-Vevey" userId="d25e694c-3ff8-4193-82fc-75dd469e9cee" providerId="ADAL" clId="{0F07F29E-985D-4F0A-A6BD-79692FB1BAAB}" dt="2021-09-23T20:14:13.051" v="7" actId="47"/>
      <pc:docMkLst>
        <pc:docMk/>
      </pc:docMkLst>
      <pc:sldChg chg="add">
        <pc:chgData name="Cercamondi,Colin Ivano,CH-Vevey" userId="d25e694c-3ff8-4193-82fc-75dd469e9cee" providerId="ADAL" clId="{0F07F29E-985D-4F0A-A6BD-79692FB1BAAB}" dt="2021-09-23T20:07:34.460" v="0"/>
        <pc:sldMkLst>
          <pc:docMk/>
          <pc:sldMk cId="930360236" sldId="268"/>
        </pc:sldMkLst>
      </pc:sldChg>
      <pc:sldChg chg="add del">
        <pc:chgData name="Cercamondi,Colin Ivano,CH-Vevey" userId="d25e694c-3ff8-4193-82fc-75dd469e9cee" providerId="ADAL" clId="{0F07F29E-985D-4F0A-A6BD-79692FB1BAAB}" dt="2021-09-23T20:08:18.980" v="2" actId="47"/>
        <pc:sldMkLst>
          <pc:docMk/>
          <pc:sldMk cId="302831193" sldId="269"/>
        </pc:sldMkLst>
      </pc:sldChg>
      <pc:sldChg chg="add del">
        <pc:chgData name="Cercamondi,Colin Ivano,CH-Vevey" userId="d25e694c-3ff8-4193-82fc-75dd469e9cee" providerId="ADAL" clId="{0F07F29E-985D-4F0A-A6BD-79692FB1BAAB}" dt="2021-09-23T20:14:12.508" v="6" actId="47"/>
        <pc:sldMkLst>
          <pc:docMk/>
          <pc:sldMk cId="1316131140" sldId="269"/>
        </pc:sldMkLst>
      </pc:sldChg>
      <pc:sldChg chg="add del">
        <pc:chgData name="Cercamondi,Colin Ivano,CH-Vevey" userId="d25e694c-3ff8-4193-82fc-75dd469e9cee" providerId="ADAL" clId="{0F07F29E-985D-4F0A-A6BD-79692FB1BAAB}" dt="2021-09-23T20:14:13.051" v="7" actId="47"/>
        <pc:sldMkLst>
          <pc:docMk/>
          <pc:sldMk cId="3464295420" sldId="270"/>
        </pc:sldMkLst>
      </pc:sldChg>
      <pc:sldChg chg="add">
        <pc:chgData name="Cercamondi,Colin Ivano,CH-Vevey" userId="d25e694c-3ff8-4193-82fc-75dd469e9cee" providerId="ADAL" clId="{0F07F29E-985D-4F0A-A6BD-79692FB1BAAB}" dt="2021-09-23T20:14:10.401" v="5"/>
        <pc:sldMkLst>
          <pc:docMk/>
          <pc:sldMk cId="4229023287" sldId="271"/>
        </pc:sldMkLst>
      </pc:sldChg>
    </pc:docChg>
  </pc:docChgLst>
  <pc:docChgLst>
    <pc:chgData name="Berger,Bernard,LAUSANNE,Host-Microbe Interaction" userId="e82bb347-e851-4db7-bca8-21df8a20dbf3" providerId="ADAL" clId="{FC9DACE4-EF10-4BB6-954C-5EEAA1F54334}"/>
    <pc:docChg chg="modSld">
      <pc:chgData name="Berger,Bernard,LAUSANNE,Host-Microbe Interaction" userId="e82bb347-e851-4db7-bca8-21df8a20dbf3" providerId="ADAL" clId="{FC9DACE4-EF10-4BB6-954C-5EEAA1F54334}" dt="2020-09-29T13:45:01.065" v="0"/>
      <pc:docMkLst>
        <pc:docMk/>
      </pc:docMkLst>
      <pc:sldChg chg="modCm">
        <pc:chgData name="Berger,Bernard,LAUSANNE,Host-Microbe Interaction" userId="e82bb347-e851-4db7-bca8-21df8a20dbf3" providerId="ADAL" clId="{FC9DACE4-EF10-4BB6-954C-5EEAA1F54334}" dt="2020-09-29T13:45:01.065" v="0"/>
        <pc:sldMkLst>
          <pc:docMk/>
          <pc:sldMk cId="1299451647" sldId="257"/>
        </pc:sldMkLst>
      </pc:sldChg>
    </pc:docChg>
  </pc:docChgLst>
  <pc:docChgLst>
    <pc:chgData name="Kortman, Guus" userId="41e95c6d-0420-46db-8343-bb7e712699d8" providerId="ADAL" clId="{EDEE4854-D4D8-4D8C-8914-9E9D4ACDA13A}"/>
    <pc:docChg chg="custSel modSld">
      <pc:chgData name="Kortman, Guus" userId="41e95c6d-0420-46db-8343-bb7e712699d8" providerId="ADAL" clId="{EDEE4854-D4D8-4D8C-8914-9E9D4ACDA13A}" dt="2020-11-20T16:32:32.824" v="20"/>
      <pc:docMkLst>
        <pc:docMk/>
      </pc:docMkLst>
      <pc:sldChg chg="modSp">
        <pc:chgData name="Kortman, Guus" userId="41e95c6d-0420-46db-8343-bb7e712699d8" providerId="ADAL" clId="{EDEE4854-D4D8-4D8C-8914-9E9D4ACDA13A}" dt="2020-11-20T16:15:29.907" v="15" actId="20577"/>
        <pc:sldMkLst>
          <pc:docMk/>
          <pc:sldMk cId="3574380604" sldId="258"/>
        </pc:sldMkLst>
        <pc:spChg chg="mod">
          <ac:chgData name="Kortman, Guus" userId="41e95c6d-0420-46db-8343-bb7e712699d8" providerId="ADAL" clId="{EDEE4854-D4D8-4D8C-8914-9E9D4ACDA13A}" dt="2020-11-20T16:15:29.907" v="15" actId="20577"/>
          <ac:spMkLst>
            <pc:docMk/>
            <pc:sldMk cId="3574380604" sldId="258"/>
            <ac:spMk id="3" creationId="{00000000-0000-0000-0000-000000000000}"/>
          </ac:spMkLst>
        </pc:spChg>
      </pc:sldChg>
      <pc:sldChg chg="addCm">
        <pc:chgData name="Kortman, Guus" userId="41e95c6d-0420-46db-8343-bb7e712699d8" providerId="ADAL" clId="{EDEE4854-D4D8-4D8C-8914-9E9D4ACDA13A}" dt="2020-11-20T16:26:56.231" v="16" actId="1589"/>
        <pc:sldMkLst>
          <pc:docMk/>
          <pc:sldMk cId="3481645440" sldId="259"/>
        </pc:sldMkLst>
      </pc:sldChg>
      <pc:sldChg chg="addCm modCm">
        <pc:chgData name="Kortman, Guus" userId="41e95c6d-0420-46db-8343-bb7e712699d8" providerId="ADAL" clId="{EDEE4854-D4D8-4D8C-8914-9E9D4ACDA13A}" dt="2020-11-20T16:32:32.824" v="20"/>
        <pc:sldMkLst>
          <pc:docMk/>
          <pc:sldMk cId="4229023287" sldId="268"/>
        </pc:sldMkLst>
      </pc:sldChg>
    </pc:docChg>
  </pc:docChgLst>
  <pc:docChgLst>
    <pc:chgData name="Kortman, Guus" userId="41e95c6d-0420-46db-8343-bb7e712699d8" providerId="ADAL" clId="{3AA44D66-D68A-46E9-A735-AD362713FB55}"/>
    <pc:docChg chg="custSel addSld delSld modSld">
      <pc:chgData name="Kortman, Guus" userId="41e95c6d-0420-46db-8343-bb7e712699d8" providerId="ADAL" clId="{3AA44D66-D68A-46E9-A735-AD362713FB55}" dt="2020-09-23T14:53:40.102" v="480" actId="1076"/>
      <pc:docMkLst>
        <pc:docMk/>
      </pc:docMkLst>
      <pc:sldChg chg="addSp modSp">
        <pc:chgData name="Kortman, Guus" userId="41e95c6d-0420-46db-8343-bb7e712699d8" providerId="ADAL" clId="{3AA44D66-D68A-46E9-A735-AD362713FB55}" dt="2020-09-23T13:20:03.891" v="22" actId="20577"/>
        <pc:sldMkLst>
          <pc:docMk/>
          <pc:sldMk cId="109857222" sldId="256"/>
        </pc:sldMkLst>
        <pc:spChg chg="mod">
          <ac:chgData name="Kortman, Guus" userId="41e95c6d-0420-46db-8343-bb7e712699d8" providerId="ADAL" clId="{3AA44D66-D68A-46E9-A735-AD362713FB55}" dt="2020-09-23T13:20:03.891" v="22" actId="20577"/>
          <ac:spMkLst>
            <pc:docMk/>
            <pc:sldMk cId="109857222" sldId="256"/>
            <ac:spMk id="3" creationId="{00000000-0000-0000-0000-000000000000}"/>
          </ac:spMkLst>
        </pc:spChg>
        <pc:picChg chg="add mod">
          <ac:chgData name="Kortman, Guus" userId="41e95c6d-0420-46db-8343-bb7e712699d8" providerId="ADAL" clId="{3AA44D66-D68A-46E9-A735-AD362713FB55}" dt="2020-09-23T13:19:50.767" v="4" actId="1076"/>
          <ac:picMkLst>
            <pc:docMk/>
            <pc:sldMk cId="109857222" sldId="256"/>
            <ac:picMk id="4" creationId="{2601AFFB-1F80-49E9-B2D8-1AC9C9938783}"/>
          </ac:picMkLst>
        </pc:picChg>
      </pc:sldChg>
      <pc:sldChg chg="addSp modSp">
        <pc:chgData name="Kortman, Guus" userId="41e95c6d-0420-46db-8343-bb7e712699d8" providerId="ADAL" clId="{3AA44D66-D68A-46E9-A735-AD362713FB55}" dt="2020-09-23T14:53:17.514" v="478" actId="1076"/>
        <pc:sldMkLst>
          <pc:docMk/>
          <pc:sldMk cId="1299451647" sldId="257"/>
        </pc:sldMkLst>
        <pc:spChg chg="mod">
          <ac:chgData name="Kortman, Guus" userId="41e95c6d-0420-46db-8343-bb7e712699d8" providerId="ADAL" clId="{3AA44D66-D68A-46E9-A735-AD362713FB55}" dt="2020-09-23T13:22:38.409" v="57" actId="20577"/>
          <ac:spMkLst>
            <pc:docMk/>
            <pc:sldMk cId="1299451647" sldId="257"/>
            <ac:spMk id="3" creationId="{00000000-0000-0000-0000-000000000000}"/>
          </ac:spMkLst>
        </pc:spChg>
        <pc:picChg chg="add mod">
          <ac:chgData name="Kortman, Guus" userId="41e95c6d-0420-46db-8343-bb7e712699d8" providerId="ADAL" clId="{3AA44D66-D68A-46E9-A735-AD362713FB55}" dt="2020-09-23T14:53:17.514" v="478" actId="1076"/>
          <ac:picMkLst>
            <pc:docMk/>
            <pc:sldMk cId="1299451647" sldId="257"/>
            <ac:picMk id="4" creationId="{D16E0238-7CCD-4037-92F9-C584AD562906}"/>
          </ac:picMkLst>
        </pc:picChg>
        <pc:picChg chg="add mod">
          <ac:chgData name="Kortman, Guus" userId="41e95c6d-0420-46db-8343-bb7e712699d8" providerId="ADAL" clId="{3AA44D66-D68A-46E9-A735-AD362713FB55}" dt="2020-09-23T14:53:17.514" v="478" actId="1076"/>
          <ac:picMkLst>
            <pc:docMk/>
            <pc:sldMk cId="1299451647" sldId="257"/>
            <ac:picMk id="5" creationId="{F275F451-16F7-4A31-AEB5-47A6FEF1D6D1}"/>
          </ac:picMkLst>
        </pc:picChg>
      </pc:sldChg>
      <pc:sldChg chg="addSp delSp modSp">
        <pc:chgData name="Kortman, Guus" userId="41e95c6d-0420-46db-8343-bb7e712699d8" providerId="ADAL" clId="{3AA44D66-D68A-46E9-A735-AD362713FB55}" dt="2020-09-23T14:04:56.868" v="468" actId="1076"/>
        <pc:sldMkLst>
          <pc:docMk/>
          <pc:sldMk cId="3574380604" sldId="258"/>
        </pc:sldMkLst>
        <pc:spChg chg="mod">
          <ac:chgData name="Kortman, Guus" userId="41e95c6d-0420-46db-8343-bb7e712699d8" providerId="ADAL" clId="{3AA44D66-D68A-46E9-A735-AD362713FB55}" dt="2020-09-23T13:27:12.595" v="163" actId="404"/>
          <ac:spMkLst>
            <pc:docMk/>
            <pc:sldMk cId="3574380604" sldId="258"/>
            <ac:spMk id="3" creationId="{00000000-0000-0000-0000-000000000000}"/>
          </ac:spMkLst>
        </pc:spChg>
        <pc:spChg chg="add mod">
          <ac:chgData name="Kortman, Guus" userId="41e95c6d-0420-46db-8343-bb7e712699d8" providerId="ADAL" clId="{3AA44D66-D68A-46E9-A735-AD362713FB55}" dt="2020-09-23T13:25:10.730" v="61" actId="1076"/>
          <ac:spMkLst>
            <pc:docMk/>
            <pc:sldMk cId="3574380604" sldId="258"/>
            <ac:spMk id="5" creationId="{0E1AE68E-2216-43E5-8448-74BA71496703}"/>
          </ac:spMkLst>
        </pc:spChg>
        <pc:spChg chg="add mod">
          <ac:chgData name="Kortman, Guus" userId="41e95c6d-0420-46db-8343-bb7e712699d8" providerId="ADAL" clId="{3AA44D66-D68A-46E9-A735-AD362713FB55}" dt="2020-09-23T13:25:55.951" v="94" actId="207"/>
          <ac:spMkLst>
            <pc:docMk/>
            <pc:sldMk cId="3574380604" sldId="258"/>
            <ac:spMk id="7" creationId="{BB2BE229-9E6C-42FB-8A7D-FBE0D909AAB7}"/>
          </ac:spMkLst>
        </pc:spChg>
        <pc:graphicFrameChg chg="add del mod">
          <ac:chgData name="Kortman, Guus" userId="41e95c6d-0420-46db-8343-bb7e712699d8" providerId="ADAL" clId="{3AA44D66-D68A-46E9-A735-AD362713FB55}" dt="2020-09-23T14:04:32.932" v="464" actId="478"/>
          <ac:graphicFrameMkLst>
            <pc:docMk/>
            <pc:sldMk cId="3574380604" sldId="258"/>
            <ac:graphicFrameMk id="4" creationId="{50A2B077-2CF7-4766-A301-590DABB63416}"/>
          </ac:graphicFrameMkLst>
        </pc:graphicFrameChg>
        <pc:graphicFrameChg chg="add del mod">
          <ac:chgData name="Kortman, Guus" userId="41e95c6d-0420-46db-8343-bb7e712699d8" providerId="ADAL" clId="{3AA44D66-D68A-46E9-A735-AD362713FB55}" dt="2020-09-23T14:04:32.370" v="463" actId="478"/>
          <ac:graphicFrameMkLst>
            <pc:docMk/>
            <pc:sldMk cId="3574380604" sldId="258"/>
            <ac:graphicFrameMk id="6" creationId="{6EDB30D3-5515-46C1-9B6D-0FA59BD58F7D}"/>
          </ac:graphicFrameMkLst>
        </pc:graphicFrameChg>
        <pc:graphicFrameChg chg="add mod">
          <ac:chgData name="Kortman, Guus" userId="41e95c6d-0420-46db-8343-bb7e712699d8" providerId="ADAL" clId="{3AA44D66-D68A-46E9-A735-AD362713FB55}" dt="2020-09-23T14:04:40.283" v="466" actId="1076"/>
          <ac:graphicFrameMkLst>
            <pc:docMk/>
            <pc:sldMk cId="3574380604" sldId="258"/>
            <ac:graphicFrameMk id="8" creationId="{50BC301F-BEEC-40A2-B527-7BDBC23ED723}"/>
          </ac:graphicFrameMkLst>
        </pc:graphicFrameChg>
        <pc:graphicFrameChg chg="add mod">
          <ac:chgData name="Kortman, Guus" userId="41e95c6d-0420-46db-8343-bb7e712699d8" providerId="ADAL" clId="{3AA44D66-D68A-46E9-A735-AD362713FB55}" dt="2020-09-23T14:04:56.868" v="468" actId="1076"/>
          <ac:graphicFrameMkLst>
            <pc:docMk/>
            <pc:sldMk cId="3574380604" sldId="258"/>
            <ac:graphicFrameMk id="9" creationId="{260CAD17-4D7C-4FBF-905F-F94EB3F0F74A}"/>
          </ac:graphicFrameMkLst>
        </pc:graphicFrameChg>
      </pc:sldChg>
      <pc:sldChg chg="addSp delSp modSp">
        <pc:chgData name="Kortman, Guus" userId="41e95c6d-0420-46db-8343-bb7e712699d8" providerId="ADAL" clId="{3AA44D66-D68A-46E9-A735-AD362713FB55}" dt="2020-09-23T14:49:03.639" v="476" actId="1076"/>
        <pc:sldMkLst>
          <pc:docMk/>
          <pc:sldMk cId="3481645440" sldId="259"/>
        </pc:sldMkLst>
        <pc:spChg chg="mod">
          <ac:chgData name="Kortman, Guus" userId="41e95c6d-0420-46db-8343-bb7e712699d8" providerId="ADAL" clId="{3AA44D66-D68A-46E9-A735-AD362713FB55}" dt="2020-09-23T13:28:34.645" v="179" actId="404"/>
          <ac:spMkLst>
            <pc:docMk/>
            <pc:sldMk cId="3481645440" sldId="259"/>
            <ac:spMk id="3" creationId="{00000000-0000-0000-0000-000000000000}"/>
          </ac:spMkLst>
        </pc:spChg>
        <pc:spChg chg="add mod">
          <ac:chgData name="Kortman, Guus" userId="41e95c6d-0420-46db-8343-bb7e712699d8" providerId="ADAL" clId="{3AA44D66-D68A-46E9-A735-AD362713FB55}" dt="2020-09-23T13:27:38.662" v="165" actId="1076"/>
          <ac:spMkLst>
            <pc:docMk/>
            <pc:sldMk cId="3481645440" sldId="259"/>
            <ac:spMk id="4" creationId="{65485C5E-5332-4EF8-90D3-2CFAFB1BA38F}"/>
          </ac:spMkLst>
        </pc:spChg>
        <pc:graphicFrameChg chg="add del mod">
          <ac:chgData name="Kortman, Guus" userId="41e95c6d-0420-46db-8343-bb7e712699d8" providerId="ADAL" clId="{3AA44D66-D68A-46E9-A735-AD362713FB55}" dt="2020-09-23T14:48:46.217" v="469" actId="478"/>
          <ac:graphicFrameMkLst>
            <pc:docMk/>
            <pc:sldMk cId="3481645440" sldId="259"/>
            <ac:graphicFrameMk id="5" creationId="{799A30AF-D896-4A95-8F37-1EB0C03350CD}"/>
          </ac:graphicFrameMkLst>
        </pc:graphicFrameChg>
        <pc:picChg chg="add mod">
          <ac:chgData name="Kortman, Guus" userId="41e95c6d-0420-46db-8343-bb7e712699d8" providerId="ADAL" clId="{3AA44D66-D68A-46E9-A735-AD362713FB55}" dt="2020-09-23T14:49:03.639" v="476" actId="1076"/>
          <ac:picMkLst>
            <pc:docMk/>
            <pc:sldMk cId="3481645440" sldId="259"/>
            <ac:picMk id="6" creationId="{0819C97F-1F32-4E7A-A0F4-519AFDA91A7F}"/>
          </ac:picMkLst>
        </pc:picChg>
      </pc:sldChg>
      <pc:sldChg chg="addSp modSp">
        <pc:chgData name="Kortman, Guus" userId="41e95c6d-0420-46db-8343-bb7e712699d8" providerId="ADAL" clId="{3AA44D66-D68A-46E9-A735-AD362713FB55}" dt="2020-09-23T13:31:25.526" v="236" actId="20577"/>
        <pc:sldMkLst>
          <pc:docMk/>
          <pc:sldMk cId="3261540884" sldId="260"/>
        </pc:sldMkLst>
        <pc:spChg chg="mod">
          <ac:chgData name="Kortman, Guus" userId="41e95c6d-0420-46db-8343-bb7e712699d8" providerId="ADAL" clId="{3AA44D66-D68A-46E9-A735-AD362713FB55}" dt="2020-09-23T13:31:25.526" v="236" actId="20577"/>
          <ac:spMkLst>
            <pc:docMk/>
            <pc:sldMk cId="3261540884" sldId="260"/>
            <ac:spMk id="2" creationId="{00000000-0000-0000-0000-000000000000}"/>
          </ac:spMkLst>
        </pc:spChg>
        <pc:picChg chg="add mod">
          <ac:chgData name="Kortman, Guus" userId="41e95c6d-0420-46db-8343-bb7e712699d8" providerId="ADAL" clId="{3AA44D66-D68A-46E9-A735-AD362713FB55}" dt="2020-09-23T13:30:20.816" v="222" actId="14100"/>
          <ac:picMkLst>
            <pc:docMk/>
            <pc:sldMk cId="3261540884" sldId="260"/>
            <ac:picMk id="4" creationId="{68D51F3A-36FD-4657-9FC1-A2437CBEE3E3}"/>
          </ac:picMkLst>
        </pc:picChg>
        <pc:picChg chg="add mod">
          <ac:chgData name="Kortman, Guus" userId="41e95c6d-0420-46db-8343-bb7e712699d8" providerId="ADAL" clId="{3AA44D66-D68A-46E9-A735-AD362713FB55}" dt="2020-09-23T13:30:27.278" v="224" actId="1076"/>
          <ac:picMkLst>
            <pc:docMk/>
            <pc:sldMk cId="3261540884" sldId="260"/>
            <ac:picMk id="5" creationId="{633892B0-5E85-492C-8A6C-5C66B7776321}"/>
          </ac:picMkLst>
        </pc:picChg>
        <pc:picChg chg="add mod">
          <ac:chgData name="Kortman, Guus" userId="41e95c6d-0420-46db-8343-bb7e712699d8" providerId="ADAL" clId="{3AA44D66-D68A-46E9-A735-AD362713FB55}" dt="2020-09-23T13:30:30.815" v="225" actId="1076"/>
          <ac:picMkLst>
            <pc:docMk/>
            <pc:sldMk cId="3261540884" sldId="260"/>
            <ac:picMk id="6" creationId="{C7B81B08-93DA-4687-B79C-B13BDB3059CE}"/>
          </ac:picMkLst>
        </pc:picChg>
      </pc:sldChg>
      <pc:sldChg chg="addSp modSp">
        <pc:chgData name="Kortman, Guus" userId="41e95c6d-0420-46db-8343-bb7e712699d8" providerId="ADAL" clId="{3AA44D66-D68A-46E9-A735-AD362713FB55}" dt="2020-09-23T13:31:31.305" v="238" actId="20577"/>
        <pc:sldMkLst>
          <pc:docMk/>
          <pc:sldMk cId="1876531822" sldId="261"/>
        </pc:sldMkLst>
        <pc:spChg chg="mod">
          <ac:chgData name="Kortman, Guus" userId="41e95c6d-0420-46db-8343-bb7e712699d8" providerId="ADAL" clId="{3AA44D66-D68A-46E9-A735-AD362713FB55}" dt="2020-09-23T13:31:31.305" v="238" actId="20577"/>
          <ac:spMkLst>
            <pc:docMk/>
            <pc:sldMk cId="1876531822" sldId="261"/>
            <ac:spMk id="2" creationId="{00000000-0000-0000-0000-000000000000}"/>
          </ac:spMkLst>
        </pc:spChg>
        <pc:spChg chg="mod">
          <ac:chgData name="Kortman, Guus" userId="41e95c6d-0420-46db-8343-bb7e712699d8" providerId="ADAL" clId="{3AA44D66-D68A-46E9-A735-AD362713FB55}" dt="2020-09-23T13:30:59.930" v="230" actId="404"/>
          <ac:spMkLst>
            <pc:docMk/>
            <pc:sldMk cId="1876531822" sldId="261"/>
            <ac:spMk id="3" creationId="{00000000-0000-0000-0000-000000000000}"/>
          </ac:spMkLst>
        </pc:spChg>
        <pc:picChg chg="add mod">
          <ac:chgData name="Kortman, Guus" userId="41e95c6d-0420-46db-8343-bb7e712699d8" providerId="ADAL" clId="{3AA44D66-D68A-46E9-A735-AD362713FB55}" dt="2020-09-23T13:30:43.246" v="227" actId="1076"/>
          <ac:picMkLst>
            <pc:docMk/>
            <pc:sldMk cId="1876531822" sldId="261"/>
            <ac:picMk id="4" creationId="{2AD37E68-2D9D-42C5-8ACC-500496F39856}"/>
          </ac:picMkLst>
        </pc:picChg>
      </pc:sldChg>
      <pc:sldChg chg="modSp">
        <pc:chgData name="Kortman, Guus" userId="41e95c6d-0420-46db-8343-bb7e712699d8" providerId="ADAL" clId="{3AA44D66-D68A-46E9-A735-AD362713FB55}" dt="2020-09-23T13:33:02.915" v="276" actId="20577"/>
        <pc:sldMkLst>
          <pc:docMk/>
          <pc:sldMk cId="907894339" sldId="262"/>
        </pc:sldMkLst>
        <pc:spChg chg="mod">
          <ac:chgData name="Kortman, Guus" userId="41e95c6d-0420-46db-8343-bb7e712699d8" providerId="ADAL" clId="{3AA44D66-D68A-46E9-A735-AD362713FB55}" dt="2020-09-23T13:32:48.942" v="261" actId="20577"/>
          <ac:spMkLst>
            <pc:docMk/>
            <pc:sldMk cId="907894339" sldId="262"/>
            <ac:spMk id="2" creationId="{00000000-0000-0000-0000-000000000000}"/>
          </ac:spMkLst>
        </pc:spChg>
        <pc:spChg chg="mod">
          <ac:chgData name="Kortman, Guus" userId="41e95c6d-0420-46db-8343-bb7e712699d8" providerId="ADAL" clId="{3AA44D66-D68A-46E9-A735-AD362713FB55}" dt="2020-09-23T13:33:02.915" v="276" actId="20577"/>
          <ac:spMkLst>
            <pc:docMk/>
            <pc:sldMk cId="907894339" sldId="262"/>
            <ac:spMk id="3" creationId="{00000000-0000-0000-0000-000000000000}"/>
          </ac:spMkLst>
        </pc:spChg>
      </pc:sldChg>
      <pc:sldChg chg="addSp delSp modSp add">
        <pc:chgData name="Kortman, Guus" userId="41e95c6d-0420-46db-8343-bb7e712699d8" providerId="ADAL" clId="{3AA44D66-D68A-46E9-A735-AD362713FB55}" dt="2020-09-23T13:29:34.462" v="214" actId="1076"/>
        <pc:sldMkLst>
          <pc:docMk/>
          <pc:sldMk cId="3249222257" sldId="263"/>
        </pc:sldMkLst>
        <pc:spChg chg="mod">
          <ac:chgData name="Kortman, Guus" userId="41e95c6d-0420-46db-8343-bb7e712699d8" providerId="ADAL" clId="{3AA44D66-D68A-46E9-A735-AD362713FB55}" dt="2020-09-23T13:29:18.792" v="208" actId="14100"/>
          <ac:spMkLst>
            <pc:docMk/>
            <pc:sldMk cId="3249222257" sldId="263"/>
            <ac:spMk id="2" creationId="{88105DD8-232D-46AA-98B2-E5ADEF8FA725}"/>
          </ac:spMkLst>
        </pc:spChg>
        <pc:spChg chg="del">
          <ac:chgData name="Kortman, Guus" userId="41e95c6d-0420-46db-8343-bb7e712699d8" providerId="ADAL" clId="{3AA44D66-D68A-46E9-A735-AD362713FB55}" dt="2020-09-23T13:28:58.854" v="182" actId="478"/>
          <ac:spMkLst>
            <pc:docMk/>
            <pc:sldMk cId="3249222257" sldId="263"/>
            <ac:spMk id="3" creationId="{8A99487D-3093-4377-B133-4CBD265036C1}"/>
          </ac:spMkLst>
        </pc:spChg>
        <pc:picChg chg="add mod">
          <ac:chgData name="Kortman, Guus" userId="41e95c6d-0420-46db-8343-bb7e712699d8" providerId="ADAL" clId="{3AA44D66-D68A-46E9-A735-AD362713FB55}" dt="2020-09-23T13:29:25.527" v="211" actId="1076"/>
          <ac:picMkLst>
            <pc:docMk/>
            <pc:sldMk cId="3249222257" sldId="263"/>
            <ac:picMk id="4" creationId="{6B65013A-E1CE-424F-8F27-D492B616BC05}"/>
          </ac:picMkLst>
        </pc:picChg>
        <pc:picChg chg="add mod">
          <ac:chgData name="Kortman, Guus" userId="41e95c6d-0420-46db-8343-bb7e712699d8" providerId="ADAL" clId="{3AA44D66-D68A-46E9-A735-AD362713FB55}" dt="2020-09-23T13:29:34.462" v="214" actId="1076"/>
          <ac:picMkLst>
            <pc:docMk/>
            <pc:sldMk cId="3249222257" sldId="263"/>
            <ac:picMk id="5" creationId="{D4CDA747-8074-448C-98A7-87E3E693A247}"/>
          </ac:picMkLst>
        </pc:picChg>
      </pc:sldChg>
      <pc:sldChg chg="addSp delSp modSp add">
        <pc:chgData name="Kortman, Guus" userId="41e95c6d-0420-46db-8343-bb7e712699d8" providerId="ADAL" clId="{3AA44D66-D68A-46E9-A735-AD362713FB55}" dt="2020-09-23T13:32:21.946" v="251" actId="404"/>
        <pc:sldMkLst>
          <pc:docMk/>
          <pc:sldMk cId="1210609011" sldId="264"/>
        </pc:sldMkLst>
        <pc:spChg chg="mod">
          <ac:chgData name="Kortman, Guus" userId="41e95c6d-0420-46db-8343-bb7e712699d8" providerId="ADAL" clId="{3AA44D66-D68A-46E9-A735-AD362713FB55}" dt="2020-09-23T13:32:21.946" v="251" actId="404"/>
          <ac:spMkLst>
            <pc:docMk/>
            <pc:sldMk cId="1210609011" sldId="264"/>
            <ac:spMk id="3" creationId="{00000000-0000-0000-0000-000000000000}"/>
          </ac:spMkLst>
        </pc:spChg>
        <pc:picChg chg="del">
          <ac:chgData name="Kortman, Guus" userId="41e95c6d-0420-46db-8343-bb7e712699d8" providerId="ADAL" clId="{3AA44D66-D68A-46E9-A735-AD362713FB55}" dt="2020-09-23T13:31:18.744" v="232" actId="478"/>
          <ac:picMkLst>
            <pc:docMk/>
            <pc:sldMk cId="1210609011" sldId="264"/>
            <ac:picMk id="4" creationId="{68D51F3A-36FD-4657-9FC1-A2437CBEE3E3}"/>
          </ac:picMkLst>
        </pc:picChg>
        <pc:picChg chg="del">
          <ac:chgData name="Kortman, Guus" userId="41e95c6d-0420-46db-8343-bb7e712699d8" providerId="ADAL" clId="{3AA44D66-D68A-46E9-A735-AD362713FB55}" dt="2020-09-23T13:31:19.303" v="233" actId="478"/>
          <ac:picMkLst>
            <pc:docMk/>
            <pc:sldMk cId="1210609011" sldId="264"/>
            <ac:picMk id="5" creationId="{633892B0-5E85-492C-8A6C-5C66B7776321}"/>
          </ac:picMkLst>
        </pc:picChg>
        <pc:picChg chg="del">
          <ac:chgData name="Kortman, Guus" userId="41e95c6d-0420-46db-8343-bb7e712699d8" providerId="ADAL" clId="{3AA44D66-D68A-46E9-A735-AD362713FB55}" dt="2020-09-23T13:31:19.992" v="234" actId="478"/>
          <ac:picMkLst>
            <pc:docMk/>
            <pc:sldMk cId="1210609011" sldId="264"/>
            <ac:picMk id="6" creationId="{C7B81B08-93DA-4687-B79C-B13BDB3059CE}"/>
          </ac:picMkLst>
        </pc:picChg>
        <pc:picChg chg="add mod">
          <ac:chgData name="Kortman, Guus" userId="41e95c6d-0420-46db-8343-bb7e712699d8" providerId="ADAL" clId="{3AA44D66-D68A-46E9-A735-AD362713FB55}" dt="2020-09-23T13:31:50.927" v="245" actId="14100"/>
          <ac:picMkLst>
            <pc:docMk/>
            <pc:sldMk cId="1210609011" sldId="264"/>
            <ac:picMk id="7" creationId="{CB93249C-BB2C-499A-9B9A-BB8614064997}"/>
          </ac:picMkLst>
        </pc:picChg>
      </pc:sldChg>
      <pc:sldChg chg="addSp delSp modSp add">
        <pc:chgData name="Kortman, Guus" userId="41e95c6d-0420-46db-8343-bb7e712699d8" providerId="ADAL" clId="{3AA44D66-D68A-46E9-A735-AD362713FB55}" dt="2020-09-23T13:53:18.535" v="462" actId="20577"/>
        <pc:sldMkLst>
          <pc:docMk/>
          <pc:sldMk cId="1915425" sldId="265"/>
        </pc:sldMkLst>
        <pc:spChg chg="mod">
          <ac:chgData name="Kortman, Guus" userId="41e95c6d-0420-46db-8343-bb7e712699d8" providerId="ADAL" clId="{3AA44D66-D68A-46E9-A735-AD362713FB55}" dt="2020-09-23T13:33:17.568" v="281" actId="6549"/>
          <ac:spMkLst>
            <pc:docMk/>
            <pc:sldMk cId="1915425" sldId="265"/>
            <ac:spMk id="2" creationId="{00000000-0000-0000-0000-000000000000}"/>
          </ac:spMkLst>
        </pc:spChg>
        <pc:spChg chg="mod">
          <ac:chgData name="Kortman, Guus" userId="41e95c6d-0420-46db-8343-bb7e712699d8" providerId="ADAL" clId="{3AA44D66-D68A-46E9-A735-AD362713FB55}" dt="2020-09-23T13:53:18.535" v="462" actId="20577"/>
          <ac:spMkLst>
            <pc:docMk/>
            <pc:sldMk cId="1915425" sldId="265"/>
            <ac:spMk id="3" creationId="{00000000-0000-0000-0000-000000000000}"/>
          </ac:spMkLst>
        </pc:spChg>
        <pc:spChg chg="add mod">
          <ac:chgData name="Kortman, Guus" userId="41e95c6d-0420-46db-8343-bb7e712699d8" providerId="ADAL" clId="{3AA44D66-D68A-46E9-A735-AD362713FB55}" dt="2020-09-23T13:33:43.711" v="283" actId="1076"/>
          <ac:spMkLst>
            <pc:docMk/>
            <pc:sldMk cId="1915425" sldId="265"/>
            <ac:spMk id="4" creationId="{2C7295EC-FEE4-42D6-976E-0B19C0C83971}"/>
          </ac:spMkLst>
        </pc:spChg>
        <pc:graphicFrameChg chg="add del mod">
          <ac:chgData name="Kortman, Guus" userId="41e95c6d-0420-46db-8343-bb7e712699d8" providerId="ADAL" clId="{3AA44D66-D68A-46E9-A735-AD362713FB55}" dt="2020-09-23T13:47:22.953" v="285" actId="478"/>
          <ac:graphicFrameMkLst>
            <pc:docMk/>
            <pc:sldMk cId="1915425" sldId="265"/>
            <ac:graphicFrameMk id="5" creationId="{1197E329-D7CD-4248-8566-99BB0A7FAB38}"/>
          </ac:graphicFrameMkLst>
        </pc:graphicFrameChg>
        <pc:graphicFrameChg chg="add mod">
          <ac:chgData name="Kortman, Guus" userId="41e95c6d-0420-46db-8343-bb7e712699d8" providerId="ADAL" clId="{3AA44D66-D68A-46E9-A735-AD362713FB55}" dt="2020-09-23T13:47:40.214" v="287" actId="1076"/>
          <ac:graphicFrameMkLst>
            <pc:docMk/>
            <pc:sldMk cId="1915425" sldId="265"/>
            <ac:graphicFrameMk id="6" creationId="{327C24CF-8A97-4264-8AA8-8A8BE5230C3D}"/>
          </ac:graphicFrameMkLst>
        </pc:graphicFrameChg>
      </pc:sldChg>
      <pc:sldChg chg="add del">
        <pc:chgData name="Kortman, Guus" userId="41e95c6d-0420-46db-8343-bb7e712699d8" providerId="ADAL" clId="{3AA44D66-D68A-46E9-A735-AD362713FB55}" dt="2020-09-23T13:33:10.337" v="278"/>
        <pc:sldMkLst>
          <pc:docMk/>
          <pc:sldMk cId="2598013401" sldId="265"/>
        </pc:sldMkLst>
      </pc:sldChg>
      <pc:sldChg chg="add del">
        <pc:chgData name="Kortman, Guus" userId="41e95c6d-0420-46db-8343-bb7e712699d8" providerId="ADAL" clId="{3AA44D66-D68A-46E9-A735-AD362713FB55}" dt="2020-09-23T13:49:07.767" v="416" actId="2696"/>
        <pc:sldMkLst>
          <pc:docMk/>
          <pc:sldMk cId="1441196648" sldId="266"/>
        </pc:sldMkLst>
      </pc:sldChg>
      <pc:sldChg chg="addSp delSp modSp add">
        <pc:chgData name="Kortman, Guus" userId="41e95c6d-0420-46db-8343-bb7e712699d8" providerId="ADAL" clId="{3AA44D66-D68A-46E9-A735-AD362713FB55}" dt="2020-09-23T14:53:40.102" v="480" actId="1076"/>
        <pc:sldMkLst>
          <pc:docMk/>
          <pc:sldMk cId="1790202609" sldId="266"/>
        </pc:sldMkLst>
        <pc:spChg chg="mod">
          <ac:chgData name="Kortman, Guus" userId="41e95c6d-0420-46db-8343-bb7e712699d8" providerId="ADAL" clId="{3AA44D66-D68A-46E9-A735-AD362713FB55}" dt="2020-09-23T13:49:13.174" v="419" actId="20577"/>
          <ac:spMkLst>
            <pc:docMk/>
            <pc:sldMk cId="1790202609" sldId="266"/>
            <ac:spMk id="2" creationId="{00000000-0000-0000-0000-000000000000}"/>
          </ac:spMkLst>
        </pc:spChg>
        <pc:spChg chg="mod">
          <ac:chgData name="Kortman, Guus" userId="41e95c6d-0420-46db-8343-bb7e712699d8" providerId="ADAL" clId="{3AA44D66-D68A-46E9-A735-AD362713FB55}" dt="2020-09-23T13:49:57.046" v="449" actId="20577"/>
          <ac:spMkLst>
            <pc:docMk/>
            <pc:sldMk cId="1790202609" sldId="266"/>
            <ac:spMk id="3" creationId="{00000000-0000-0000-0000-000000000000}"/>
          </ac:spMkLst>
        </pc:spChg>
        <pc:graphicFrameChg chg="del">
          <ac:chgData name="Kortman, Guus" userId="41e95c6d-0420-46db-8343-bb7e712699d8" providerId="ADAL" clId="{3AA44D66-D68A-46E9-A735-AD362713FB55}" dt="2020-09-23T13:49:14.479" v="420" actId="478"/>
          <ac:graphicFrameMkLst>
            <pc:docMk/>
            <pc:sldMk cId="1790202609" sldId="266"/>
            <ac:graphicFrameMk id="6" creationId="{327C24CF-8A97-4264-8AA8-8A8BE5230C3D}"/>
          </ac:graphicFrameMkLst>
        </pc:graphicFrameChg>
        <pc:picChg chg="add mod">
          <ac:chgData name="Kortman, Guus" userId="41e95c6d-0420-46db-8343-bb7e712699d8" providerId="ADAL" clId="{3AA44D66-D68A-46E9-A735-AD362713FB55}" dt="2020-09-23T14:53:40.102" v="480" actId="1076"/>
          <ac:picMkLst>
            <pc:docMk/>
            <pc:sldMk cId="1790202609" sldId="266"/>
            <ac:picMk id="7" creationId="{97CA63F0-CA31-4BD5-AA14-0F3D5766EE4A}"/>
          </ac:picMkLst>
        </pc:picChg>
      </pc:sldChg>
    </pc:docChg>
  </pc:docChgLst>
  <pc:docChgLst>
    <pc:chgData name="Kortman, Guus" userId="41e95c6d-0420-46db-8343-bb7e712699d8" providerId="ADAL" clId="{DF052B54-2678-4881-B71B-FB99E8A66118}"/>
    <pc:docChg chg="undo custSel modSld">
      <pc:chgData name="Kortman, Guus" userId="41e95c6d-0420-46db-8343-bb7e712699d8" providerId="ADAL" clId="{DF052B54-2678-4881-B71B-FB99E8A66118}" dt="2021-02-15T17:05:41.333" v="57" actId="1035"/>
      <pc:docMkLst>
        <pc:docMk/>
      </pc:docMkLst>
      <pc:sldChg chg="addSp delSp modSp mod addCm modCm">
        <pc:chgData name="Kortman, Guus" userId="41e95c6d-0420-46db-8343-bb7e712699d8" providerId="ADAL" clId="{DF052B54-2678-4881-B71B-FB99E8A66118}" dt="2021-02-15T16:54:56.281" v="28" actId="14100"/>
        <pc:sldMkLst>
          <pc:docMk/>
          <pc:sldMk cId="4181099377" sldId="274"/>
        </pc:sldMkLst>
        <pc:spChg chg="mod">
          <ac:chgData name="Kortman, Guus" userId="41e95c6d-0420-46db-8343-bb7e712699d8" providerId="ADAL" clId="{DF052B54-2678-4881-B71B-FB99E8A66118}" dt="2021-02-15T16:54:41.875" v="25" actId="1076"/>
          <ac:spMkLst>
            <pc:docMk/>
            <pc:sldMk cId="4181099377" sldId="274"/>
            <ac:spMk id="2" creationId="{00000000-0000-0000-0000-000000000000}"/>
          </ac:spMkLst>
        </pc:spChg>
        <pc:spChg chg="mod ord topLvl">
          <ac:chgData name="Kortman, Guus" userId="41e95c6d-0420-46db-8343-bb7e712699d8" providerId="ADAL" clId="{DF052B54-2678-4881-B71B-FB99E8A66118}" dt="2021-02-15T16:54:49.025" v="27" actId="1076"/>
          <ac:spMkLst>
            <pc:docMk/>
            <pc:sldMk cId="4181099377" sldId="274"/>
            <ac:spMk id="6" creationId="{E2658BC6-E908-47F2-8D80-8075CE348F99}"/>
          </ac:spMkLst>
        </pc:spChg>
        <pc:spChg chg="mod ord topLvl">
          <ac:chgData name="Kortman, Guus" userId="41e95c6d-0420-46db-8343-bb7e712699d8" providerId="ADAL" clId="{DF052B54-2678-4881-B71B-FB99E8A66118}" dt="2021-02-15T16:54:06.986" v="18" actId="1076"/>
          <ac:spMkLst>
            <pc:docMk/>
            <pc:sldMk cId="4181099377" sldId="274"/>
            <ac:spMk id="7" creationId="{0C5D272F-2D94-4F8A-9994-F5CDA4B27394}"/>
          </ac:spMkLst>
        </pc:spChg>
        <pc:grpChg chg="add del">
          <ac:chgData name="Kortman, Guus" userId="41e95c6d-0420-46db-8343-bb7e712699d8" providerId="ADAL" clId="{DF052B54-2678-4881-B71B-FB99E8A66118}" dt="2021-02-15T16:53:42.387" v="10" actId="478"/>
          <ac:grpSpMkLst>
            <pc:docMk/>
            <pc:sldMk cId="4181099377" sldId="274"/>
            <ac:grpSpMk id="19" creationId="{F5260A26-6679-4507-8FB5-5DB28904881A}"/>
          </ac:grpSpMkLst>
        </pc:grpChg>
        <pc:grpChg chg="del">
          <ac:chgData name="Kortman, Guus" userId="41e95c6d-0420-46db-8343-bb7e712699d8" providerId="ADAL" clId="{DF052B54-2678-4881-B71B-FB99E8A66118}" dt="2021-02-15T16:54:12.587" v="20" actId="478"/>
          <ac:grpSpMkLst>
            <pc:docMk/>
            <pc:sldMk cId="4181099377" sldId="274"/>
            <ac:grpSpMk id="20" creationId="{BC10A1FE-16E9-44BD-AA43-252628278ABF}"/>
          </ac:grpSpMkLst>
        </pc:grpChg>
        <pc:graphicFrameChg chg="del">
          <ac:chgData name="Kortman, Guus" userId="41e95c6d-0420-46db-8343-bb7e712699d8" providerId="ADAL" clId="{DF052B54-2678-4881-B71B-FB99E8A66118}" dt="2021-02-15T16:20:20.648" v="0" actId="478"/>
          <ac:graphicFrameMkLst>
            <pc:docMk/>
            <pc:sldMk cId="4181099377" sldId="274"/>
            <ac:graphicFrameMk id="12" creationId="{24264916-EED1-4E0B-995F-D76D5EA2BAB6}"/>
          </ac:graphicFrameMkLst>
        </pc:graphicFrameChg>
        <pc:picChg chg="del topLvl">
          <ac:chgData name="Kortman, Guus" userId="41e95c6d-0420-46db-8343-bb7e712699d8" providerId="ADAL" clId="{DF052B54-2678-4881-B71B-FB99E8A66118}" dt="2021-02-15T16:54:12.587" v="20" actId="478"/>
          <ac:picMkLst>
            <pc:docMk/>
            <pc:sldMk cId="4181099377" sldId="274"/>
            <ac:picMk id="4" creationId="{07B678AA-EBCA-45B1-9B14-268888E0BE28}"/>
          </ac:picMkLst>
        </pc:picChg>
        <pc:picChg chg="del topLvl">
          <ac:chgData name="Kortman, Guus" userId="41e95c6d-0420-46db-8343-bb7e712699d8" providerId="ADAL" clId="{DF052B54-2678-4881-B71B-FB99E8A66118}" dt="2021-02-15T16:53:42.387" v="10" actId="478"/>
          <ac:picMkLst>
            <pc:docMk/>
            <pc:sldMk cId="4181099377" sldId="274"/>
            <ac:picMk id="8" creationId="{0853C466-3925-4261-BE29-A30A1DAC2CC3}"/>
          </ac:picMkLst>
        </pc:picChg>
        <pc:picChg chg="add mod">
          <ac:chgData name="Kortman, Guus" userId="41e95c6d-0420-46db-8343-bb7e712699d8" providerId="ADAL" clId="{DF052B54-2678-4881-B71B-FB99E8A66118}" dt="2021-02-15T16:20:29.758" v="4" actId="1076"/>
          <ac:picMkLst>
            <pc:docMk/>
            <pc:sldMk cId="4181099377" sldId="274"/>
            <ac:picMk id="11" creationId="{F23CF51B-5055-423B-8992-7596E0E01F6D}"/>
          </ac:picMkLst>
        </pc:picChg>
        <pc:picChg chg="add mod">
          <ac:chgData name="Kortman, Guus" userId="41e95c6d-0420-46db-8343-bb7e712699d8" providerId="ADAL" clId="{DF052B54-2678-4881-B71B-FB99E8A66118}" dt="2021-02-15T16:53:55.722" v="15" actId="1076"/>
          <ac:picMkLst>
            <pc:docMk/>
            <pc:sldMk cId="4181099377" sldId="274"/>
            <ac:picMk id="15" creationId="{4FF3116F-1BC4-4388-9A29-8FB094FF9190}"/>
          </ac:picMkLst>
        </pc:picChg>
        <pc:picChg chg="add mod">
          <ac:chgData name="Kortman, Guus" userId="41e95c6d-0420-46db-8343-bb7e712699d8" providerId="ADAL" clId="{DF052B54-2678-4881-B71B-FB99E8A66118}" dt="2021-02-15T16:54:56.281" v="28" actId="14100"/>
          <ac:picMkLst>
            <pc:docMk/>
            <pc:sldMk cId="4181099377" sldId="274"/>
            <ac:picMk id="17" creationId="{D9FC6D36-B80C-484B-B711-BEF27278D0F0}"/>
          </ac:picMkLst>
        </pc:picChg>
      </pc:sldChg>
      <pc:sldChg chg="addSp delSp modSp mod">
        <pc:chgData name="Kortman, Guus" userId="41e95c6d-0420-46db-8343-bb7e712699d8" providerId="ADAL" clId="{DF052B54-2678-4881-B71B-FB99E8A66118}" dt="2021-02-15T17:05:41.333" v="57" actId="1035"/>
        <pc:sldMkLst>
          <pc:docMk/>
          <pc:sldMk cId="562436449" sldId="275"/>
        </pc:sldMkLst>
        <pc:spChg chg="mod ord">
          <ac:chgData name="Kortman, Guus" userId="41e95c6d-0420-46db-8343-bb7e712699d8" providerId="ADAL" clId="{DF052B54-2678-4881-B71B-FB99E8A66118}" dt="2021-02-15T17:05:41.333" v="57" actId="1035"/>
          <ac:spMkLst>
            <pc:docMk/>
            <pc:sldMk cId="562436449" sldId="275"/>
            <ac:spMk id="12" creationId="{A6B30807-652E-46D6-9349-DC424F5F6ED5}"/>
          </ac:spMkLst>
        </pc:spChg>
        <pc:picChg chg="add mod">
          <ac:chgData name="Kortman, Guus" userId="41e95c6d-0420-46db-8343-bb7e712699d8" providerId="ADAL" clId="{DF052B54-2678-4881-B71B-FB99E8A66118}" dt="2021-02-15T17:05:32.662" v="46" actId="1036"/>
          <ac:picMkLst>
            <pc:docMk/>
            <pc:sldMk cId="562436449" sldId="275"/>
            <ac:picMk id="5" creationId="{54C9BE2D-738D-41DF-BBEE-9FF5F1C40DAA}"/>
          </ac:picMkLst>
        </pc:picChg>
        <pc:picChg chg="del">
          <ac:chgData name="Kortman, Guus" userId="41e95c6d-0420-46db-8343-bb7e712699d8" providerId="ADAL" clId="{DF052B54-2678-4881-B71B-FB99E8A66118}" dt="2021-02-15T17:05:16.693" v="30" actId="478"/>
          <ac:picMkLst>
            <pc:docMk/>
            <pc:sldMk cId="562436449" sldId="275"/>
            <ac:picMk id="10" creationId="{E1E211D5-9EA0-40CF-B930-E1D82F07F433}"/>
          </ac:picMkLst>
        </pc:picChg>
      </pc:sldChg>
    </pc:docChg>
  </pc:docChgLst>
  <pc:docChgLst>
    <pc:chgData name="Kortman, Guus" userId="41e95c6d-0420-46db-8343-bb7e712699d8" providerId="ADAL" clId="{AA9A3CAF-325C-45B1-9252-06C4E8F6BB38}"/>
    <pc:docChg chg="custSel modSld">
      <pc:chgData name="Kortman, Guus" userId="41e95c6d-0420-46db-8343-bb7e712699d8" providerId="ADAL" clId="{AA9A3CAF-325C-45B1-9252-06C4E8F6BB38}" dt="2020-10-29T16:05:05.648" v="686" actId="1076"/>
      <pc:docMkLst>
        <pc:docMk/>
      </pc:docMkLst>
      <pc:sldChg chg="modSp delCm">
        <pc:chgData name="Kortman, Guus" userId="41e95c6d-0420-46db-8343-bb7e712699d8" providerId="ADAL" clId="{AA9A3CAF-325C-45B1-9252-06C4E8F6BB38}" dt="2020-10-29T11:04:30.516" v="306" actId="1592"/>
        <pc:sldMkLst>
          <pc:docMk/>
          <pc:sldMk cId="1299451647" sldId="257"/>
        </pc:sldMkLst>
        <pc:spChg chg="mod">
          <ac:chgData name="Kortman, Guus" userId="41e95c6d-0420-46db-8343-bb7e712699d8" providerId="ADAL" clId="{AA9A3CAF-325C-45B1-9252-06C4E8F6BB38}" dt="2020-10-29T11:04:14.317" v="305" actId="27636"/>
          <ac:spMkLst>
            <pc:docMk/>
            <pc:sldMk cId="1299451647" sldId="257"/>
            <ac:spMk id="3" creationId="{00000000-0000-0000-0000-000000000000}"/>
          </ac:spMkLst>
        </pc:spChg>
      </pc:sldChg>
      <pc:sldChg chg="modSp">
        <pc:chgData name="Kortman, Guus" userId="41e95c6d-0420-46db-8343-bb7e712699d8" providerId="ADAL" clId="{AA9A3CAF-325C-45B1-9252-06C4E8F6BB38}" dt="2020-10-29T15:46:56.369" v="660" actId="27636"/>
        <pc:sldMkLst>
          <pc:docMk/>
          <pc:sldMk cId="3261540884" sldId="260"/>
        </pc:sldMkLst>
        <pc:spChg chg="mod">
          <ac:chgData name="Kortman, Guus" userId="41e95c6d-0420-46db-8343-bb7e712699d8" providerId="ADAL" clId="{AA9A3CAF-325C-45B1-9252-06C4E8F6BB38}" dt="2020-10-29T15:46:56.369" v="660" actId="27636"/>
          <ac:spMkLst>
            <pc:docMk/>
            <pc:sldMk cId="3261540884" sldId="260"/>
            <ac:spMk id="3" creationId="{00000000-0000-0000-0000-000000000000}"/>
          </ac:spMkLst>
        </pc:spChg>
      </pc:sldChg>
      <pc:sldChg chg="addSp delSp modSp delCm modCm">
        <pc:chgData name="Kortman, Guus" userId="41e95c6d-0420-46db-8343-bb7e712699d8" providerId="ADAL" clId="{AA9A3CAF-325C-45B1-9252-06C4E8F6BB38}" dt="2020-10-29T16:00:59.650" v="679" actId="5900"/>
        <pc:sldMkLst>
          <pc:docMk/>
          <pc:sldMk cId="3249222257" sldId="263"/>
        </pc:sldMkLst>
        <pc:picChg chg="del mod">
          <ac:chgData name="Kortman, Guus" userId="41e95c6d-0420-46db-8343-bb7e712699d8" providerId="ADAL" clId="{AA9A3CAF-325C-45B1-9252-06C4E8F6BB38}" dt="2020-10-29T16:00:31.343" v="674" actId="478"/>
          <ac:picMkLst>
            <pc:docMk/>
            <pc:sldMk cId="3249222257" sldId="263"/>
            <ac:picMk id="3" creationId="{63572A93-E725-4C75-BF31-6E8A7DC4E859}"/>
          </ac:picMkLst>
        </pc:picChg>
        <pc:picChg chg="add del mod">
          <ac:chgData name="Kortman, Guus" userId="41e95c6d-0420-46db-8343-bb7e712699d8" providerId="ADAL" clId="{AA9A3CAF-325C-45B1-9252-06C4E8F6BB38}" dt="2020-10-29T15:56:45.210" v="666" actId="478"/>
          <ac:picMkLst>
            <pc:docMk/>
            <pc:sldMk cId="3249222257" sldId="263"/>
            <ac:picMk id="4" creationId="{644E38A6-8C64-4315-9E03-96D92AFED1CA}"/>
          </ac:picMkLst>
        </pc:picChg>
        <pc:picChg chg="del">
          <ac:chgData name="Kortman, Guus" userId="41e95c6d-0420-46db-8343-bb7e712699d8" providerId="ADAL" clId="{AA9A3CAF-325C-45B1-9252-06C4E8F6BB38}" dt="2020-10-29T15:55:18.451" v="661" actId="478"/>
          <ac:picMkLst>
            <pc:docMk/>
            <pc:sldMk cId="3249222257" sldId="263"/>
            <ac:picMk id="5" creationId="{20D52804-70B5-48CB-BF98-BFAFF586588D}"/>
          </ac:picMkLst>
        </pc:picChg>
        <pc:picChg chg="add del mod">
          <ac:chgData name="Kortman, Guus" userId="41e95c6d-0420-46db-8343-bb7e712699d8" providerId="ADAL" clId="{AA9A3CAF-325C-45B1-9252-06C4E8F6BB38}" dt="2020-10-29T16:00:15.191" v="670" actId="478"/>
          <ac:picMkLst>
            <pc:docMk/>
            <pc:sldMk cId="3249222257" sldId="263"/>
            <ac:picMk id="6" creationId="{F2F4C000-B0D6-42FD-86DC-0C419B1988CB}"/>
          </ac:picMkLst>
        </pc:picChg>
        <pc:picChg chg="add mod">
          <ac:chgData name="Kortman, Guus" userId="41e95c6d-0420-46db-8343-bb7e712699d8" providerId="ADAL" clId="{AA9A3CAF-325C-45B1-9252-06C4E8F6BB38}" dt="2020-10-29T16:00:55.550" v="678" actId="1076"/>
          <ac:picMkLst>
            <pc:docMk/>
            <pc:sldMk cId="3249222257" sldId="263"/>
            <ac:picMk id="7" creationId="{C64A515D-1D66-492A-A1DA-404148D7A318}"/>
          </ac:picMkLst>
        </pc:picChg>
        <pc:picChg chg="add mod">
          <ac:chgData name="Kortman, Guus" userId="41e95c6d-0420-46db-8343-bb7e712699d8" providerId="ADAL" clId="{AA9A3CAF-325C-45B1-9252-06C4E8F6BB38}" dt="2020-10-29T16:00:53.376" v="677" actId="1076"/>
          <ac:picMkLst>
            <pc:docMk/>
            <pc:sldMk cId="3249222257" sldId="263"/>
            <ac:picMk id="8" creationId="{803CDCC6-F59D-40A3-ACF3-65C8C2F8A0D8}"/>
          </ac:picMkLst>
        </pc:picChg>
      </pc:sldChg>
      <pc:sldChg chg="modSp">
        <pc:chgData name="Kortman, Guus" userId="41e95c6d-0420-46db-8343-bb7e712699d8" providerId="ADAL" clId="{AA9A3CAF-325C-45B1-9252-06C4E8F6BB38}" dt="2020-10-29T10:53:13.500" v="6" actId="1076"/>
        <pc:sldMkLst>
          <pc:docMk/>
          <pc:sldMk cId="1915425" sldId="265"/>
        </pc:sldMkLst>
        <pc:spChg chg="mod">
          <ac:chgData name="Kortman, Guus" userId="41e95c6d-0420-46db-8343-bb7e712699d8" providerId="ADAL" clId="{AA9A3CAF-325C-45B1-9252-06C4E8F6BB38}" dt="2020-10-29T10:53:13.500" v="6" actId="1076"/>
          <ac:spMkLst>
            <pc:docMk/>
            <pc:sldMk cId="1915425" sldId="265"/>
            <ac:spMk id="3" creationId="{00000000-0000-0000-0000-000000000000}"/>
          </ac:spMkLst>
        </pc:spChg>
      </pc:sldChg>
      <pc:sldChg chg="modSp">
        <pc:chgData name="Kortman, Guus" userId="41e95c6d-0420-46db-8343-bb7e712699d8" providerId="ADAL" clId="{AA9A3CAF-325C-45B1-9252-06C4E8F6BB38}" dt="2020-10-29T16:02:09.378" v="682"/>
        <pc:sldMkLst>
          <pc:docMk/>
          <pc:sldMk cId="1790202609" sldId="266"/>
        </pc:sldMkLst>
        <pc:spChg chg="mod">
          <ac:chgData name="Kortman, Guus" userId="41e95c6d-0420-46db-8343-bb7e712699d8" providerId="ADAL" clId="{AA9A3CAF-325C-45B1-9252-06C4E8F6BB38}" dt="2020-10-29T16:02:09.378" v="682"/>
          <ac:spMkLst>
            <pc:docMk/>
            <pc:sldMk cId="1790202609" sldId="266"/>
            <ac:spMk id="3" creationId="{00000000-0000-0000-0000-000000000000}"/>
          </ac:spMkLst>
        </pc:spChg>
      </pc:sldChg>
      <pc:sldChg chg="addSp delSp modSp addCm modCm">
        <pc:chgData name="Kortman, Guus" userId="41e95c6d-0420-46db-8343-bb7e712699d8" providerId="ADAL" clId="{AA9A3CAF-325C-45B1-9252-06C4E8F6BB38}" dt="2020-10-29T16:05:05.648" v="686" actId="1076"/>
        <pc:sldMkLst>
          <pc:docMk/>
          <pc:sldMk cId="4229023287" sldId="268"/>
        </pc:sldMkLst>
        <pc:spChg chg="mod">
          <ac:chgData name="Kortman, Guus" userId="41e95c6d-0420-46db-8343-bb7e712699d8" providerId="ADAL" clId="{AA9A3CAF-325C-45B1-9252-06C4E8F6BB38}" dt="2020-10-29T10:55:51.639" v="24" actId="20577"/>
          <ac:spMkLst>
            <pc:docMk/>
            <pc:sldMk cId="4229023287" sldId="268"/>
            <ac:spMk id="6" creationId="{81FA4653-DC30-4403-B45C-5C347BD53527}"/>
          </ac:spMkLst>
        </pc:spChg>
        <pc:picChg chg="add del mod">
          <ac:chgData name="Kortman, Guus" userId="41e95c6d-0420-46db-8343-bb7e712699d8" providerId="ADAL" clId="{AA9A3CAF-325C-45B1-9252-06C4E8F6BB38}" dt="2020-10-29T16:05:00.944" v="683" actId="478"/>
          <ac:picMkLst>
            <pc:docMk/>
            <pc:sldMk cId="4229023287" sldId="268"/>
            <ac:picMk id="2" creationId="{B6B600AB-550F-4E00-AC3B-BEED8931E0F6}"/>
          </ac:picMkLst>
        </pc:picChg>
        <pc:picChg chg="del">
          <ac:chgData name="Kortman, Guus" userId="41e95c6d-0420-46db-8343-bb7e712699d8" providerId="ADAL" clId="{AA9A3CAF-325C-45B1-9252-06C4E8F6BB38}" dt="2020-10-29T10:52:38.502" v="0" actId="478"/>
          <ac:picMkLst>
            <pc:docMk/>
            <pc:sldMk cId="4229023287" sldId="268"/>
            <ac:picMk id="3" creationId="{DFE11FC4-1C39-4E96-B121-EC348B77F58C}"/>
          </ac:picMkLst>
        </pc:picChg>
        <pc:picChg chg="add mod">
          <ac:chgData name="Kortman, Guus" userId="41e95c6d-0420-46db-8343-bb7e712699d8" providerId="ADAL" clId="{AA9A3CAF-325C-45B1-9252-06C4E8F6BB38}" dt="2020-10-29T16:05:05.648" v="686" actId="1076"/>
          <ac:picMkLst>
            <pc:docMk/>
            <pc:sldMk cId="4229023287" sldId="268"/>
            <ac:picMk id="5" creationId="{0E815035-DAC1-4452-8DBB-5D99398D357A}"/>
          </ac:picMkLst>
        </pc:picChg>
      </pc:sldChg>
    </pc:docChg>
  </pc:docChgLst>
  <pc:docChgLst>
    <pc:chgData name="Cercamondi,Colin Ivano,VEVEY,Clinical Research" userId="d25e694c-3ff8-4193-82fc-75dd469e9cee" providerId="ADAL" clId="{A16F2C33-204C-4D20-A8B0-3F4160BF8763}"/>
    <pc:docChg chg="undo custSel addSld delSld modSld sldOrd modMainMaster">
      <pc:chgData name="Cercamondi,Colin Ivano,VEVEY,Clinical Research" userId="d25e694c-3ff8-4193-82fc-75dd469e9cee" providerId="ADAL" clId="{A16F2C33-204C-4D20-A8B0-3F4160BF8763}" dt="2020-10-07T08:43:03.584" v="309" actId="6549"/>
      <pc:docMkLst>
        <pc:docMk/>
      </pc:docMkLst>
      <pc:sldChg chg="addSp delSp modSp">
        <pc:chgData name="Cercamondi,Colin Ivano,VEVEY,Clinical Research" userId="d25e694c-3ff8-4193-82fc-75dd469e9cee" providerId="ADAL" clId="{A16F2C33-204C-4D20-A8B0-3F4160BF8763}" dt="2020-10-05T16:03:36.186" v="255" actId="20577"/>
        <pc:sldMkLst>
          <pc:docMk/>
          <pc:sldMk cId="109857222" sldId="256"/>
        </pc:sldMkLst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109857222" sldId="256"/>
            <ac:spMk id="2" creationId="{00000000-0000-0000-0000-000000000000}"/>
          </ac:spMkLst>
        </pc:spChg>
        <pc:spChg chg="del mod">
          <ac:chgData name="Cercamondi,Colin Ivano,VEVEY,Clinical Research" userId="d25e694c-3ff8-4193-82fc-75dd469e9cee" providerId="ADAL" clId="{A16F2C33-204C-4D20-A8B0-3F4160BF8763}" dt="2020-10-05T15:59:07.944" v="220" actId="478"/>
          <ac:spMkLst>
            <pc:docMk/>
            <pc:sldMk cId="109857222" sldId="256"/>
            <ac:spMk id="3" creationId="{00000000-0000-0000-0000-000000000000}"/>
          </ac:spMkLst>
        </pc:spChg>
        <pc:spChg chg="add mod">
          <ac:chgData name="Cercamondi,Colin Ivano,VEVEY,Clinical Research" userId="d25e694c-3ff8-4193-82fc-75dd469e9cee" providerId="ADAL" clId="{A16F2C33-204C-4D20-A8B0-3F4160BF8763}" dt="2020-10-05T16:03:36.186" v="255" actId="20577"/>
          <ac:spMkLst>
            <pc:docMk/>
            <pc:sldMk cId="109857222" sldId="256"/>
            <ac:spMk id="5" creationId="{9A249F47-1ED4-4170-BDAD-750E309A02F2}"/>
          </ac:spMkLst>
        </pc:spChg>
        <pc:spChg chg="add del mod">
          <ac:chgData name="Cercamondi,Colin Ivano,VEVEY,Clinical Research" userId="d25e694c-3ff8-4193-82fc-75dd469e9cee" providerId="ADAL" clId="{A16F2C33-204C-4D20-A8B0-3F4160BF8763}" dt="2020-10-05T16:00:10.895" v="237" actId="478"/>
          <ac:spMkLst>
            <pc:docMk/>
            <pc:sldMk cId="109857222" sldId="256"/>
            <ac:spMk id="7" creationId="{39AB0560-0E13-447D-B229-0AB1DEC493D5}"/>
          </ac:spMkLst>
        </pc:spChg>
        <pc:spChg chg="add mod">
          <ac:chgData name="Cercamondi,Colin Ivano,VEVEY,Clinical Research" userId="d25e694c-3ff8-4193-82fc-75dd469e9cee" providerId="ADAL" clId="{A16F2C33-204C-4D20-A8B0-3F4160BF8763}" dt="2020-10-05T16:00:08.240" v="236" actId="2085"/>
          <ac:spMkLst>
            <pc:docMk/>
            <pc:sldMk cId="109857222" sldId="256"/>
            <ac:spMk id="8" creationId="{B42FEAC0-0A9F-49F0-B139-A90BB146A5F6}"/>
          </ac:spMkLst>
        </pc:spChg>
        <pc:picChg chg="add del mod">
          <ac:chgData name="Cercamondi,Colin Ivano,VEVEY,Clinical Research" userId="d25e694c-3ff8-4193-82fc-75dd469e9cee" providerId="ADAL" clId="{A16F2C33-204C-4D20-A8B0-3F4160BF8763}" dt="2020-10-05T15:59:22.013" v="223" actId="478"/>
          <ac:picMkLst>
            <pc:docMk/>
            <pc:sldMk cId="109857222" sldId="256"/>
            <ac:picMk id="4" creationId="{2601AFFB-1F80-49E9-B2D8-1AC9C9938783}"/>
          </ac:picMkLst>
        </pc:picChg>
      </pc:sldChg>
      <pc:sldChg chg="modSp">
        <pc:chgData name="Cercamondi,Colin Ivano,VEVEY,Clinical Research" userId="d25e694c-3ff8-4193-82fc-75dd469e9cee" providerId="ADAL" clId="{A16F2C33-204C-4D20-A8B0-3F4160BF8763}" dt="2020-10-05T15:37:44.020" v="166" actId="27636"/>
        <pc:sldMkLst>
          <pc:docMk/>
          <pc:sldMk cId="1299451647" sldId="257"/>
        </pc:sldMkLst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1299451647" sldId="257"/>
            <ac:spMk id="2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37:44.020" v="166" actId="27636"/>
          <ac:spMkLst>
            <pc:docMk/>
            <pc:sldMk cId="1299451647" sldId="257"/>
            <ac:spMk id="3" creationId="{00000000-0000-0000-0000-000000000000}"/>
          </ac:spMkLst>
        </pc:spChg>
        <pc:picChg chg="mod">
          <ac:chgData name="Cercamondi,Colin Ivano,VEVEY,Clinical Research" userId="d25e694c-3ff8-4193-82fc-75dd469e9cee" providerId="ADAL" clId="{A16F2C33-204C-4D20-A8B0-3F4160BF8763}" dt="2020-10-05T15:32:22.337" v="17"/>
          <ac:picMkLst>
            <pc:docMk/>
            <pc:sldMk cId="1299451647" sldId="257"/>
            <ac:picMk id="4" creationId="{07B678AA-EBCA-45B1-9B14-268888E0BE28}"/>
          </ac:picMkLst>
        </pc:picChg>
        <pc:picChg chg="mod">
          <ac:chgData name="Cercamondi,Colin Ivano,VEVEY,Clinical Research" userId="d25e694c-3ff8-4193-82fc-75dd469e9cee" providerId="ADAL" clId="{A16F2C33-204C-4D20-A8B0-3F4160BF8763}" dt="2020-10-05T15:32:22.337" v="17"/>
          <ac:picMkLst>
            <pc:docMk/>
            <pc:sldMk cId="1299451647" sldId="257"/>
            <ac:picMk id="5" creationId="{81702BDC-7DEB-448F-AFE4-8BF6F6171D74}"/>
          </ac:picMkLst>
        </pc:picChg>
      </pc:sldChg>
      <pc:sldChg chg="modSp">
        <pc:chgData name="Cercamondi,Colin Ivano,VEVEY,Clinical Research" userId="d25e694c-3ff8-4193-82fc-75dd469e9cee" providerId="ADAL" clId="{A16F2C33-204C-4D20-A8B0-3F4160BF8763}" dt="2020-10-05T15:37:57.814" v="170"/>
        <pc:sldMkLst>
          <pc:docMk/>
          <pc:sldMk cId="3574380604" sldId="258"/>
        </pc:sldMkLst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3574380604" sldId="258"/>
            <ac:spMk id="2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37:57.814" v="170"/>
          <ac:spMkLst>
            <pc:docMk/>
            <pc:sldMk cId="3574380604" sldId="258"/>
            <ac:spMk id="3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3574380604" sldId="258"/>
            <ac:spMk id="5" creationId="{0E1AE68E-2216-43E5-8448-74BA71496703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3574380604" sldId="258"/>
            <ac:spMk id="7" creationId="{BB2BE229-9E6C-42FB-8A7D-FBE0D909AAB7}"/>
          </ac:spMkLst>
        </pc:spChg>
        <pc:graphicFrameChg chg="mod">
          <ac:chgData name="Cercamondi,Colin Ivano,VEVEY,Clinical Research" userId="d25e694c-3ff8-4193-82fc-75dd469e9cee" providerId="ADAL" clId="{A16F2C33-204C-4D20-A8B0-3F4160BF8763}" dt="2020-10-05T15:32:22.337" v="17"/>
          <ac:graphicFrameMkLst>
            <pc:docMk/>
            <pc:sldMk cId="3574380604" sldId="258"/>
            <ac:graphicFrameMk id="8" creationId="{50BC301F-BEEC-40A2-B527-7BDBC23ED723}"/>
          </ac:graphicFrameMkLst>
        </pc:graphicFrameChg>
        <pc:graphicFrameChg chg="mod">
          <ac:chgData name="Cercamondi,Colin Ivano,VEVEY,Clinical Research" userId="d25e694c-3ff8-4193-82fc-75dd469e9cee" providerId="ADAL" clId="{A16F2C33-204C-4D20-A8B0-3F4160BF8763}" dt="2020-10-05T15:32:22.337" v="17"/>
          <ac:graphicFrameMkLst>
            <pc:docMk/>
            <pc:sldMk cId="3574380604" sldId="258"/>
            <ac:graphicFrameMk id="9" creationId="{260CAD17-4D7C-4FBF-905F-F94EB3F0F74A}"/>
          </ac:graphicFrameMkLst>
        </pc:graphicFrameChg>
      </pc:sldChg>
      <pc:sldChg chg="modSp addCm delCm modCm">
        <pc:chgData name="Cercamondi,Colin Ivano,VEVEY,Clinical Research" userId="d25e694c-3ff8-4193-82fc-75dd469e9cee" providerId="ADAL" clId="{A16F2C33-204C-4D20-A8B0-3F4160BF8763}" dt="2020-10-07T08:23:30.048" v="267" actId="1592"/>
        <pc:sldMkLst>
          <pc:docMk/>
          <pc:sldMk cId="3481645440" sldId="259"/>
        </pc:sldMkLst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3481645440" sldId="259"/>
            <ac:spMk id="2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38:07.816" v="176" actId="27636"/>
          <ac:spMkLst>
            <pc:docMk/>
            <pc:sldMk cId="3481645440" sldId="259"/>
            <ac:spMk id="3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3481645440" sldId="259"/>
            <ac:spMk id="4" creationId="{65485C5E-5332-4EF8-90D3-2CFAFB1BA38F}"/>
          </ac:spMkLst>
        </pc:spChg>
        <pc:picChg chg="mod">
          <ac:chgData name="Cercamondi,Colin Ivano,VEVEY,Clinical Research" userId="d25e694c-3ff8-4193-82fc-75dd469e9cee" providerId="ADAL" clId="{A16F2C33-204C-4D20-A8B0-3F4160BF8763}" dt="2020-10-05T15:32:22.337" v="17"/>
          <ac:picMkLst>
            <pc:docMk/>
            <pc:sldMk cId="3481645440" sldId="259"/>
            <ac:picMk id="6" creationId="{0819C97F-1F32-4E7A-A0F4-519AFDA91A7F}"/>
          </ac:picMkLst>
        </pc:picChg>
      </pc:sldChg>
      <pc:sldChg chg="modSp ord">
        <pc:chgData name="Cercamondi,Colin Ivano,VEVEY,Clinical Research" userId="d25e694c-3ff8-4193-82fc-75dd469e9cee" providerId="ADAL" clId="{A16F2C33-204C-4D20-A8B0-3F4160BF8763}" dt="2020-10-07T08:39:05.561" v="276" actId="20577"/>
        <pc:sldMkLst>
          <pc:docMk/>
          <pc:sldMk cId="3261540884" sldId="260"/>
        </pc:sldMkLst>
        <pc:spChg chg="mod">
          <ac:chgData name="Cercamondi,Colin Ivano,VEVEY,Clinical Research" userId="d25e694c-3ff8-4193-82fc-75dd469e9cee" providerId="ADAL" clId="{A16F2C33-204C-4D20-A8B0-3F4160BF8763}" dt="2020-10-07T08:39:05.561" v="276" actId="20577"/>
          <ac:spMkLst>
            <pc:docMk/>
            <pc:sldMk cId="3261540884" sldId="260"/>
            <ac:spMk id="2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41:31.886" v="184" actId="27636"/>
          <ac:spMkLst>
            <pc:docMk/>
            <pc:sldMk cId="3261540884" sldId="260"/>
            <ac:spMk id="3" creationId="{00000000-0000-0000-0000-000000000000}"/>
          </ac:spMkLst>
        </pc:spChg>
        <pc:picChg chg="mod">
          <ac:chgData name="Cercamondi,Colin Ivano,VEVEY,Clinical Research" userId="d25e694c-3ff8-4193-82fc-75dd469e9cee" providerId="ADAL" clId="{A16F2C33-204C-4D20-A8B0-3F4160BF8763}" dt="2020-10-05T15:32:22.337" v="17"/>
          <ac:picMkLst>
            <pc:docMk/>
            <pc:sldMk cId="3261540884" sldId="260"/>
            <ac:picMk id="7" creationId="{6FD4A128-53D0-44D5-8022-E6D66A8603CF}"/>
          </ac:picMkLst>
        </pc:picChg>
        <pc:picChg chg="mod">
          <ac:chgData name="Cercamondi,Colin Ivano,VEVEY,Clinical Research" userId="d25e694c-3ff8-4193-82fc-75dd469e9cee" providerId="ADAL" clId="{A16F2C33-204C-4D20-A8B0-3F4160BF8763}" dt="2020-10-05T15:32:22.337" v="17"/>
          <ac:picMkLst>
            <pc:docMk/>
            <pc:sldMk cId="3261540884" sldId="260"/>
            <ac:picMk id="9" creationId="{752EDCCB-31CC-406D-B7A2-D86F31DD013B}"/>
          </ac:picMkLst>
        </pc:picChg>
        <pc:picChg chg="mod">
          <ac:chgData name="Cercamondi,Colin Ivano,VEVEY,Clinical Research" userId="d25e694c-3ff8-4193-82fc-75dd469e9cee" providerId="ADAL" clId="{A16F2C33-204C-4D20-A8B0-3F4160BF8763}" dt="2020-10-05T15:32:22.337" v="17"/>
          <ac:picMkLst>
            <pc:docMk/>
            <pc:sldMk cId="3261540884" sldId="260"/>
            <ac:picMk id="10" creationId="{E1E211D5-9EA0-40CF-B930-E1D82F07F433}"/>
          </ac:picMkLst>
        </pc:picChg>
      </pc:sldChg>
      <pc:sldChg chg="modSp ord">
        <pc:chgData name="Cercamondi,Colin Ivano,VEVEY,Clinical Research" userId="d25e694c-3ff8-4193-82fc-75dd469e9cee" providerId="ADAL" clId="{A16F2C33-204C-4D20-A8B0-3F4160BF8763}" dt="2020-10-07T08:39:09.938" v="278" actId="20577"/>
        <pc:sldMkLst>
          <pc:docMk/>
          <pc:sldMk cId="1876531822" sldId="261"/>
        </pc:sldMkLst>
        <pc:spChg chg="mod">
          <ac:chgData name="Cercamondi,Colin Ivano,VEVEY,Clinical Research" userId="d25e694c-3ff8-4193-82fc-75dd469e9cee" providerId="ADAL" clId="{A16F2C33-204C-4D20-A8B0-3F4160BF8763}" dt="2020-10-07T08:39:09.938" v="278" actId="20577"/>
          <ac:spMkLst>
            <pc:docMk/>
            <pc:sldMk cId="1876531822" sldId="261"/>
            <ac:spMk id="2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41:44.060" v="189"/>
          <ac:spMkLst>
            <pc:docMk/>
            <pc:sldMk cId="1876531822" sldId="261"/>
            <ac:spMk id="3" creationId="{00000000-0000-0000-0000-000000000000}"/>
          </ac:spMkLst>
        </pc:spChg>
        <pc:picChg chg="mod">
          <ac:chgData name="Cercamondi,Colin Ivano,VEVEY,Clinical Research" userId="d25e694c-3ff8-4193-82fc-75dd469e9cee" providerId="ADAL" clId="{A16F2C33-204C-4D20-A8B0-3F4160BF8763}" dt="2020-10-05T15:32:22.337" v="17"/>
          <ac:picMkLst>
            <pc:docMk/>
            <pc:sldMk cId="1876531822" sldId="261"/>
            <ac:picMk id="4" creationId="{2AD37E68-2D9D-42C5-8ACC-500496F39856}"/>
          </ac:picMkLst>
        </pc:picChg>
      </pc:sldChg>
      <pc:sldChg chg="modSp">
        <pc:chgData name="Cercamondi,Colin Ivano,VEVEY,Clinical Research" userId="d25e694c-3ff8-4193-82fc-75dd469e9cee" providerId="ADAL" clId="{A16F2C33-204C-4D20-A8B0-3F4160BF8763}" dt="2020-10-05T15:42:17.645" v="206" actId="20577"/>
        <pc:sldMkLst>
          <pc:docMk/>
          <pc:sldMk cId="907894339" sldId="262"/>
        </pc:sldMkLst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907894339" sldId="262"/>
            <ac:spMk id="2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42:17.645" v="206" actId="20577"/>
          <ac:spMkLst>
            <pc:docMk/>
            <pc:sldMk cId="907894339" sldId="262"/>
            <ac:spMk id="3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907894339" sldId="262"/>
            <ac:spMk id="6" creationId="{92CAFDC8-999F-4800-B85F-F60D7E98E0E1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907894339" sldId="262"/>
            <ac:spMk id="7" creationId="{353B68AC-5DB7-4784-9867-3FDC9D74DE6E}"/>
          </ac:spMkLst>
        </pc:spChg>
        <pc:picChg chg="mod">
          <ac:chgData name="Cercamondi,Colin Ivano,VEVEY,Clinical Research" userId="d25e694c-3ff8-4193-82fc-75dd469e9cee" providerId="ADAL" clId="{A16F2C33-204C-4D20-A8B0-3F4160BF8763}" dt="2020-10-05T15:32:22.337" v="17"/>
          <ac:picMkLst>
            <pc:docMk/>
            <pc:sldMk cId="907894339" sldId="262"/>
            <ac:picMk id="4" creationId="{54DA59D2-506D-4A60-B0C2-BD0B056E9695}"/>
          </ac:picMkLst>
        </pc:picChg>
        <pc:picChg chg="mod">
          <ac:chgData name="Cercamondi,Colin Ivano,VEVEY,Clinical Research" userId="d25e694c-3ff8-4193-82fc-75dd469e9cee" providerId="ADAL" clId="{A16F2C33-204C-4D20-A8B0-3F4160BF8763}" dt="2020-10-05T15:32:22.337" v="17"/>
          <ac:picMkLst>
            <pc:docMk/>
            <pc:sldMk cId="907894339" sldId="262"/>
            <ac:picMk id="5" creationId="{07526367-45CF-498E-BCB5-826D54DE1044}"/>
          </ac:picMkLst>
        </pc:picChg>
      </pc:sldChg>
      <pc:sldChg chg="modSp addCm modCm">
        <pc:chgData name="Cercamondi,Colin Ivano,VEVEY,Clinical Research" userId="d25e694c-3ff8-4193-82fc-75dd469e9cee" providerId="ADAL" clId="{A16F2C33-204C-4D20-A8B0-3F4160BF8763}" dt="2020-10-07T08:32:52.687" v="272"/>
        <pc:sldMkLst>
          <pc:docMk/>
          <pc:sldMk cId="3249222257" sldId="263"/>
        </pc:sldMkLst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3249222257" sldId="263"/>
            <ac:spMk id="2" creationId="{88105DD8-232D-46AA-98B2-E5ADEF8FA725}"/>
          </ac:spMkLst>
        </pc:spChg>
        <pc:picChg chg="mod">
          <ac:chgData name="Cercamondi,Colin Ivano,VEVEY,Clinical Research" userId="d25e694c-3ff8-4193-82fc-75dd469e9cee" providerId="ADAL" clId="{A16F2C33-204C-4D20-A8B0-3F4160BF8763}" dt="2020-10-05T15:32:22.337" v="17"/>
          <ac:picMkLst>
            <pc:docMk/>
            <pc:sldMk cId="3249222257" sldId="263"/>
            <ac:picMk id="3" creationId="{63572A93-E725-4C75-BF31-6E8A7DC4E859}"/>
          </ac:picMkLst>
        </pc:picChg>
        <pc:picChg chg="mod">
          <ac:chgData name="Cercamondi,Colin Ivano,VEVEY,Clinical Research" userId="d25e694c-3ff8-4193-82fc-75dd469e9cee" providerId="ADAL" clId="{A16F2C33-204C-4D20-A8B0-3F4160BF8763}" dt="2020-10-05T15:32:22.337" v="17"/>
          <ac:picMkLst>
            <pc:docMk/>
            <pc:sldMk cId="3249222257" sldId="263"/>
            <ac:picMk id="4" creationId="{6B65013A-E1CE-424F-8F27-D492B616BC05}"/>
          </ac:picMkLst>
        </pc:picChg>
      </pc:sldChg>
      <pc:sldChg chg="addSp delSp modSp addCm delCm modCm">
        <pc:chgData name="Cercamondi,Colin Ivano,VEVEY,Clinical Research" userId="d25e694c-3ff8-4193-82fc-75dd469e9cee" providerId="ADAL" clId="{A16F2C33-204C-4D20-A8B0-3F4160BF8763}" dt="2020-10-07T08:39:13.885" v="280" actId="20577"/>
        <pc:sldMkLst>
          <pc:docMk/>
          <pc:sldMk cId="1210609011" sldId="264"/>
        </pc:sldMkLst>
        <pc:spChg chg="mod">
          <ac:chgData name="Cercamondi,Colin Ivano,VEVEY,Clinical Research" userId="d25e694c-3ff8-4193-82fc-75dd469e9cee" providerId="ADAL" clId="{A16F2C33-204C-4D20-A8B0-3F4160BF8763}" dt="2020-10-07T08:39:13.885" v="280" actId="20577"/>
          <ac:spMkLst>
            <pc:docMk/>
            <pc:sldMk cId="1210609011" sldId="264"/>
            <ac:spMk id="2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6:03:46.860" v="265" actId="20577"/>
          <ac:spMkLst>
            <pc:docMk/>
            <pc:sldMk cId="1210609011" sldId="264"/>
            <ac:spMk id="3" creationId="{00000000-0000-0000-0000-000000000000}"/>
          </ac:spMkLst>
        </pc:spChg>
        <pc:picChg chg="add mod">
          <ac:chgData name="Cercamondi,Colin Ivano,VEVEY,Clinical Research" userId="d25e694c-3ff8-4193-82fc-75dd469e9cee" providerId="ADAL" clId="{A16F2C33-204C-4D20-A8B0-3F4160BF8763}" dt="2020-10-05T15:43:27.109" v="215" actId="1076"/>
          <ac:picMkLst>
            <pc:docMk/>
            <pc:sldMk cId="1210609011" sldId="264"/>
            <ac:picMk id="5" creationId="{DEE768B5-63F7-464E-BA6A-8C33631BDF39}"/>
          </ac:picMkLst>
        </pc:picChg>
        <pc:picChg chg="del mod">
          <ac:chgData name="Cercamondi,Colin Ivano,VEVEY,Clinical Research" userId="d25e694c-3ff8-4193-82fc-75dd469e9cee" providerId="ADAL" clId="{A16F2C33-204C-4D20-A8B0-3F4160BF8763}" dt="2020-10-05T15:42:53.470" v="211" actId="478"/>
          <ac:picMkLst>
            <pc:docMk/>
            <pc:sldMk cId="1210609011" sldId="264"/>
            <ac:picMk id="7" creationId="{CB93249C-BB2C-499A-9B9A-BB8614064997}"/>
          </ac:picMkLst>
        </pc:picChg>
      </pc:sldChg>
      <pc:sldChg chg="modSp addCm modCm">
        <pc:chgData name="Cercamondi,Colin Ivano,VEVEY,Clinical Research" userId="d25e694c-3ff8-4193-82fc-75dd469e9cee" providerId="ADAL" clId="{A16F2C33-204C-4D20-A8B0-3F4160BF8763}" dt="2020-10-05T15:42:30.391" v="209" actId="120"/>
        <pc:sldMkLst>
          <pc:docMk/>
          <pc:sldMk cId="1915425" sldId="265"/>
        </pc:sldMkLst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1915425" sldId="265"/>
            <ac:spMk id="2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42:30.391" v="209" actId="120"/>
          <ac:spMkLst>
            <pc:docMk/>
            <pc:sldMk cId="1915425" sldId="265"/>
            <ac:spMk id="3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1915425" sldId="265"/>
            <ac:spMk id="4" creationId="{2C7295EC-FEE4-42D6-976E-0B19C0C83971}"/>
          </ac:spMkLst>
        </pc:spChg>
        <pc:graphicFrameChg chg="mod">
          <ac:chgData name="Cercamondi,Colin Ivano,VEVEY,Clinical Research" userId="d25e694c-3ff8-4193-82fc-75dd469e9cee" providerId="ADAL" clId="{A16F2C33-204C-4D20-A8B0-3F4160BF8763}" dt="2020-10-05T15:32:22.337" v="17"/>
          <ac:graphicFrameMkLst>
            <pc:docMk/>
            <pc:sldMk cId="1915425" sldId="265"/>
            <ac:graphicFrameMk id="5" creationId="{0A7BE4EC-0AF0-41F5-81F2-EDC8962D0A27}"/>
          </ac:graphicFrameMkLst>
        </pc:graphicFrameChg>
      </pc:sldChg>
      <pc:sldChg chg="modSp">
        <pc:chgData name="Cercamondi,Colin Ivano,VEVEY,Clinical Research" userId="d25e694c-3ff8-4193-82fc-75dd469e9cee" providerId="ADAL" clId="{A16F2C33-204C-4D20-A8B0-3F4160BF8763}" dt="2020-10-05T15:42:40.903" v="210"/>
        <pc:sldMkLst>
          <pc:docMk/>
          <pc:sldMk cId="1790202609" sldId="266"/>
        </pc:sldMkLst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1790202609" sldId="266"/>
            <ac:spMk id="2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42:40.903" v="210"/>
          <ac:spMkLst>
            <pc:docMk/>
            <pc:sldMk cId="1790202609" sldId="266"/>
            <ac:spMk id="3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k cId="1790202609" sldId="266"/>
            <ac:spMk id="4" creationId="{2C7295EC-FEE4-42D6-976E-0B19C0C83971}"/>
          </ac:spMkLst>
        </pc:spChg>
        <pc:picChg chg="mod">
          <ac:chgData name="Cercamondi,Colin Ivano,VEVEY,Clinical Research" userId="d25e694c-3ff8-4193-82fc-75dd469e9cee" providerId="ADAL" clId="{A16F2C33-204C-4D20-A8B0-3F4160BF8763}" dt="2020-10-05T15:32:22.337" v="17"/>
          <ac:picMkLst>
            <pc:docMk/>
            <pc:sldMk cId="1790202609" sldId="266"/>
            <ac:picMk id="6" creationId="{6FED7408-CDED-4F4C-932A-DA0B386B3F4E}"/>
          </ac:picMkLst>
        </pc:picChg>
      </pc:sldChg>
      <pc:sldChg chg="add del">
        <pc:chgData name="Cercamondi,Colin Ivano,VEVEY,Clinical Research" userId="d25e694c-3ff8-4193-82fc-75dd469e9cee" providerId="ADAL" clId="{A16F2C33-204C-4D20-A8B0-3F4160BF8763}" dt="2020-10-07T08:41:49.777" v="282"/>
        <pc:sldMkLst>
          <pc:docMk/>
          <pc:sldMk cId="434781279" sldId="267"/>
        </pc:sldMkLst>
      </pc:sldChg>
      <pc:sldChg chg="delSp modSp add">
        <pc:chgData name="Cercamondi,Colin Ivano,VEVEY,Clinical Research" userId="d25e694c-3ff8-4193-82fc-75dd469e9cee" providerId="ADAL" clId="{A16F2C33-204C-4D20-A8B0-3F4160BF8763}" dt="2020-10-07T08:43:03.584" v="309" actId="6549"/>
        <pc:sldMkLst>
          <pc:docMk/>
          <pc:sldMk cId="1153482099" sldId="267"/>
        </pc:sldMkLst>
        <pc:spChg chg="mod">
          <ac:chgData name="Cercamondi,Colin Ivano,VEVEY,Clinical Research" userId="d25e694c-3ff8-4193-82fc-75dd469e9cee" providerId="ADAL" clId="{A16F2C33-204C-4D20-A8B0-3F4160BF8763}" dt="2020-10-07T08:42:42.825" v="308" actId="20577"/>
          <ac:spMkLst>
            <pc:docMk/>
            <pc:sldMk cId="1153482099" sldId="267"/>
            <ac:spMk id="2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7T08:43:03.584" v="309" actId="6549"/>
          <ac:spMkLst>
            <pc:docMk/>
            <pc:sldMk cId="1153482099" sldId="267"/>
            <ac:spMk id="3" creationId="{00000000-0000-0000-0000-000000000000}"/>
          </ac:spMkLst>
        </pc:spChg>
        <pc:picChg chg="del">
          <ac:chgData name="Cercamondi,Colin Ivano,VEVEY,Clinical Research" userId="d25e694c-3ff8-4193-82fc-75dd469e9cee" providerId="ADAL" clId="{A16F2C33-204C-4D20-A8B0-3F4160BF8763}" dt="2020-10-07T08:41:56.066" v="284" actId="478"/>
          <ac:picMkLst>
            <pc:docMk/>
            <pc:sldMk cId="1153482099" sldId="267"/>
            <ac:picMk id="6" creationId="{6FED7408-CDED-4F4C-932A-DA0B386B3F4E}"/>
          </ac:picMkLst>
        </pc:picChg>
      </pc:sldChg>
      <pc:sldMasterChg chg="modSp modSldLayout">
        <pc:chgData name="Cercamondi,Colin Ivano,VEVEY,Clinical Research" userId="d25e694c-3ff8-4193-82fc-75dd469e9cee" providerId="ADAL" clId="{A16F2C33-204C-4D20-A8B0-3F4160BF8763}" dt="2020-10-05T15:32:22.337" v="17"/>
        <pc:sldMasterMkLst>
          <pc:docMk/>
          <pc:sldMasterMk cId="2460954070" sldId="2147483660"/>
        </pc:sldMasterMkLst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asterMk cId="2460954070" sldId="2147483660"/>
            <ac:spMk id="2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asterMk cId="2460954070" sldId="2147483660"/>
            <ac:spMk id="3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asterMk cId="2460954070" sldId="2147483660"/>
            <ac:spMk id="4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asterMk cId="2460954070" sldId="2147483660"/>
            <ac:spMk id="5" creationId="{00000000-0000-0000-0000-000000000000}"/>
          </ac:spMkLst>
        </pc:spChg>
        <pc:spChg chg="mod">
          <ac:chgData name="Cercamondi,Colin Ivano,VEVEY,Clinical Research" userId="d25e694c-3ff8-4193-82fc-75dd469e9cee" providerId="ADAL" clId="{A16F2C33-204C-4D20-A8B0-3F4160BF8763}" dt="2020-10-05T15:32:22.337" v="17"/>
          <ac:spMkLst>
            <pc:docMk/>
            <pc:sldMasterMk cId="2460954070" sldId="2147483660"/>
            <ac:spMk id="6" creationId="{00000000-0000-0000-0000-000000000000}"/>
          </ac:spMkLst>
        </pc:spChg>
        <pc:sldLayoutChg chg="modSp">
          <pc:chgData name="Cercamondi,Colin Ivano,VEVEY,Clinical Research" userId="d25e694c-3ff8-4193-82fc-75dd469e9cee" providerId="ADAL" clId="{A16F2C33-204C-4D20-A8B0-3F4160BF8763}" dt="2020-10-05T15:32:22.337" v="17"/>
          <pc:sldLayoutMkLst>
            <pc:docMk/>
            <pc:sldMasterMk cId="2460954070" sldId="2147483660"/>
            <pc:sldLayoutMk cId="2385387890" sldId="2147483661"/>
          </pc:sldLayoutMkLst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2385387890" sldId="2147483661"/>
              <ac:spMk id="2" creationId="{00000000-0000-0000-0000-000000000000}"/>
            </ac:spMkLst>
          </pc:spChg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2385387890" sldId="2147483661"/>
              <ac:spMk id="3" creationId="{00000000-0000-0000-0000-000000000000}"/>
            </ac:spMkLst>
          </pc:spChg>
        </pc:sldLayoutChg>
        <pc:sldLayoutChg chg="modSp">
          <pc:chgData name="Cercamondi,Colin Ivano,VEVEY,Clinical Research" userId="d25e694c-3ff8-4193-82fc-75dd469e9cee" providerId="ADAL" clId="{A16F2C33-204C-4D20-A8B0-3F4160BF8763}" dt="2020-10-05T15:32:22.337" v="17"/>
          <pc:sldLayoutMkLst>
            <pc:docMk/>
            <pc:sldMasterMk cId="2460954070" sldId="2147483660"/>
            <pc:sldLayoutMk cId="2591524520" sldId="2147483663"/>
          </pc:sldLayoutMkLst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2591524520" sldId="2147483663"/>
              <ac:spMk id="2" creationId="{00000000-0000-0000-0000-000000000000}"/>
            </ac:spMkLst>
          </pc:spChg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2591524520" sldId="2147483663"/>
              <ac:spMk id="3" creationId="{00000000-0000-0000-0000-000000000000}"/>
            </ac:spMkLst>
          </pc:spChg>
        </pc:sldLayoutChg>
        <pc:sldLayoutChg chg="modSp">
          <pc:chgData name="Cercamondi,Colin Ivano,VEVEY,Clinical Research" userId="d25e694c-3ff8-4193-82fc-75dd469e9cee" providerId="ADAL" clId="{A16F2C33-204C-4D20-A8B0-3F4160BF8763}" dt="2020-10-05T15:32:22.337" v="17"/>
          <pc:sldLayoutMkLst>
            <pc:docMk/>
            <pc:sldMasterMk cId="2460954070" sldId="2147483660"/>
            <pc:sldLayoutMk cId="1203092039" sldId="2147483664"/>
          </pc:sldLayoutMkLst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1203092039" sldId="2147483664"/>
              <ac:spMk id="3" creationId="{00000000-0000-0000-0000-000000000000}"/>
            </ac:spMkLst>
          </pc:spChg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1203092039" sldId="2147483664"/>
              <ac:spMk id="4" creationId="{00000000-0000-0000-0000-000000000000}"/>
            </ac:spMkLst>
          </pc:spChg>
        </pc:sldLayoutChg>
        <pc:sldLayoutChg chg="modSp">
          <pc:chgData name="Cercamondi,Colin Ivano,VEVEY,Clinical Research" userId="d25e694c-3ff8-4193-82fc-75dd469e9cee" providerId="ADAL" clId="{A16F2C33-204C-4D20-A8B0-3F4160BF8763}" dt="2020-10-05T15:32:22.337" v="17"/>
          <pc:sldLayoutMkLst>
            <pc:docMk/>
            <pc:sldMasterMk cId="2460954070" sldId="2147483660"/>
            <pc:sldLayoutMk cId="3733172339" sldId="2147483665"/>
          </pc:sldLayoutMkLst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3733172339" sldId="2147483665"/>
              <ac:spMk id="2" creationId="{00000000-0000-0000-0000-000000000000}"/>
            </ac:spMkLst>
          </pc:spChg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3733172339" sldId="2147483665"/>
              <ac:spMk id="3" creationId="{00000000-0000-0000-0000-000000000000}"/>
            </ac:spMkLst>
          </pc:spChg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3733172339" sldId="2147483665"/>
              <ac:spMk id="4" creationId="{00000000-0000-0000-0000-000000000000}"/>
            </ac:spMkLst>
          </pc:spChg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3733172339" sldId="2147483665"/>
              <ac:spMk id="5" creationId="{00000000-0000-0000-0000-000000000000}"/>
            </ac:spMkLst>
          </pc:spChg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3733172339" sldId="2147483665"/>
              <ac:spMk id="6" creationId="{00000000-0000-0000-0000-000000000000}"/>
            </ac:spMkLst>
          </pc:spChg>
        </pc:sldLayoutChg>
        <pc:sldLayoutChg chg="modSp">
          <pc:chgData name="Cercamondi,Colin Ivano,VEVEY,Clinical Research" userId="d25e694c-3ff8-4193-82fc-75dd469e9cee" providerId="ADAL" clId="{A16F2C33-204C-4D20-A8B0-3F4160BF8763}" dt="2020-10-05T15:32:22.337" v="17"/>
          <pc:sldLayoutMkLst>
            <pc:docMk/>
            <pc:sldMasterMk cId="2460954070" sldId="2147483660"/>
            <pc:sldLayoutMk cId="3171841454" sldId="2147483668"/>
          </pc:sldLayoutMkLst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3171841454" sldId="2147483668"/>
              <ac:spMk id="2" creationId="{00000000-0000-0000-0000-000000000000}"/>
            </ac:spMkLst>
          </pc:spChg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3171841454" sldId="2147483668"/>
              <ac:spMk id="3" creationId="{00000000-0000-0000-0000-000000000000}"/>
            </ac:spMkLst>
          </pc:spChg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3171841454" sldId="2147483668"/>
              <ac:spMk id="4" creationId="{00000000-0000-0000-0000-000000000000}"/>
            </ac:spMkLst>
          </pc:spChg>
        </pc:sldLayoutChg>
        <pc:sldLayoutChg chg="modSp">
          <pc:chgData name="Cercamondi,Colin Ivano,VEVEY,Clinical Research" userId="d25e694c-3ff8-4193-82fc-75dd469e9cee" providerId="ADAL" clId="{A16F2C33-204C-4D20-A8B0-3F4160BF8763}" dt="2020-10-05T15:32:22.337" v="17"/>
          <pc:sldLayoutMkLst>
            <pc:docMk/>
            <pc:sldMasterMk cId="2460954070" sldId="2147483660"/>
            <pc:sldLayoutMk cId="1718958274" sldId="2147483669"/>
          </pc:sldLayoutMkLst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1718958274" sldId="2147483669"/>
              <ac:spMk id="2" creationId="{00000000-0000-0000-0000-000000000000}"/>
            </ac:spMkLst>
          </pc:spChg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1718958274" sldId="2147483669"/>
              <ac:spMk id="3" creationId="{00000000-0000-0000-0000-000000000000}"/>
            </ac:spMkLst>
          </pc:spChg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1718958274" sldId="2147483669"/>
              <ac:spMk id="4" creationId="{00000000-0000-0000-0000-000000000000}"/>
            </ac:spMkLst>
          </pc:spChg>
        </pc:sldLayoutChg>
        <pc:sldLayoutChg chg="modSp">
          <pc:chgData name="Cercamondi,Colin Ivano,VEVEY,Clinical Research" userId="d25e694c-3ff8-4193-82fc-75dd469e9cee" providerId="ADAL" clId="{A16F2C33-204C-4D20-A8B0-3F4160BF8763}" dt="2020-10-05T15:32:22.337" v="17"/>
          <pc:sldLayoutMkLst>
            <pc:docMk/>
            <pc:sldMasterMk cId="2460954070" sldId="2147483660"/>
            <pc:sldLayoutMk cId="3479445657" sldId="2147483671"/>
          </pc:sldLayoutMkLst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3479445657" sldId="2147483671"/>
              <ac:spMk id="2" creationId="{00000000-0000-0000-0000-000000000000}"/>
            </ac:spMkLst>
          </pc:spChg>
          <pc:spChg chg="mod">
            <ac:chgData name="Cercamondi,Colin Ivano,VEVEY,Clinical Research" userId="d25e694c-3ff8-4193-82fc-75dd469e9cee" providerId="ADAL" clId="{A16F2C33-204C-4D20-A8B0-3F4160BF8763}" dt="2020-10-05T15:32:22.337" v="17"/>
            <ac:spMkLst>
              <pc:docMk/>
              <pc:sldMasterMk cId="2460954070" sldId="2147483660"/>
              <pc:sldLayoutMk cId="3479445657" sldId="2147483671"/>
              <ac:spMk id="3" creationId="{00000000-0000-0000-0000-000000000000}"/>
            </ac:spMkLst>
          </pc:spChg>
        </pc:sldLayoutChg>
      </pc:sldMasterChg>
    </pc:docChg>
  </pc:docChgLst>
  <pc:docChgLst>
    <pc:chgData name="Kortman, Guus" userId="41e95c6d-0420-46db-8343-bb7e712699d8" providerId="ADAL" clId="{8B7D5FE7-02A9-4FD7-93E1-EB2A7DC62581}"/>
    <pc:docChg chg="custSel modSld">
      <pc:chgData name="Kortman, Guus" userId="41e95c6d-0420-46db-8343-bb7e712699d8" providerId="ADAL" clId="{8B7D5FE7-02A9-4FD7-93E1-EB2A7DC62581}" dt="2020-11-24T14:21:55.981" v="24" actId="1589"/>
      <pc:docMkLst>
        <pc:docMk/>
      </pc:docMkLst>
      <pc:sldChg chg="addCm">
        <pc:chgData name="Kortman, Guus" userId="41e95c6d-0420-46db-8343-bb7e712699d8" providerId="ADAL" clId="{8B7D5FE7-02A9-4FD7-93E1-EB2A7DC62581}" dt="2020-11-24T14:21:55.981" v="24" actId="1589"/>
        <pc:sldMkLst>
          <pc:docMk/>
          <pc:sldMk cId="3249222257" sldId="263"/>
        </pc:sldMkLst>
      </pc:sldChg>
      <pc:sldChg chg="addSp delSp modSp delCm modCm">
        <pc:chgData name="Kortman, Guus" userId="41e95c6d-0420-46db-8343-bb7e712699d8" providerId="ADAL" clId="{8B7D5FE7-02A9-4FD7-93E1-EB2A7DC62581}" dt="2020-11-24T14:20:55.906" v="23" actId="1592"/>
        <pc:sldMkLst>
          <pc:docMk/>
          <pc:sldMk cId="4229023287" sldId="268"/>
        </pc:sldMkLst>
        <pc:spChg chg="mod">
          <ac:chgData name="Kortman, Guus" userId="41e95c6d-0420-46db-8343-bb7e712699d8" providerId="ADAL" clId="{8B7D5FE7-02A9-4FD7-93E1-EB2A7DC62581}" dt="2020-11-24T14:20:49.571" v="21" actId="20577"/>
          <ac:spMkLst>
            <pc:docMk/>
            <pc:sldMk cId="4229023287" sldId="268"/>
            <ac:spMk id="6" creationId="{81FA4653-DC30-4403-B45C-5C347BD53527}"/>
          </ac:spMkLst>
        </pc:spChg>
        <pc:picChg chg="add del mod">
          <ac:chgData name="Kortman, Guus" userId="41e95c6d-0420-46db-8343-bb7e712699d8" providerId="ADAL" clId="{8B7D5FE7-02A9-4FD7-93E1-EB2A7DC62581}" dt="2020-11-24T14:19:42.202" v="6" actId="478"/>
          <ac:picMkLst>
            <pc:docMk/>
            <pc:sldMk cId="4229023287" sldId="268"/>
            <ac:picMk id="2" creationId="{5398B16C-0F4E-4AA4-9116-5CBCD9A69451}"/>
          </ac:picMkLst>
        </pc:picChg>
        <pc:picChg chg="add mod">
          <ac:chgData name="Kortman, Guus" userId="41e95c6d-0420-46db-8343-bb7e712699d8" providerId="ADAL" clId="{8B7D5FE7-02A9-4FD7-93E1-EB2A7DC62581}" dt="2020-11-24T14:19:52.126" v="10" actId="1076"/>
          <ac:picMkLst>
            <pc:docMk/>
            <pc:sldMk cId="4229023287" sldId="268"/>
            <ac:picMk id="3" creationId="{F84E23B7-6BF6-463A-8023-3BD3D4E43BCB}"/>
          </ac:picMkLst>
        </pc:picChg>
        <pc:picChg chg="del">
          <ac:chgData name="Kortman, Guus" userId="41e95c6d-0420-46db-8343-bb7e712699d8" providerId="ADAL" clId="{8B7D5FE7-02A9-4FD7-93E1-EB2A7DC62581}" dt="2020-11-24T14:17:16.908" v="0" actId="478"/>
          <ac:picMkLst>
            <pc:docMk/>
            <pc:sldMk cId="4229023287" sldId="268"/>
            <ac:picMk id="5" creationId="{0E815035-DAC1-4452-8DBB-5D99398D357A}"/>
          </ac:picMkLst>
        </pc:picChg>
      </pc:sldChg>
    </pc:docChg>
  </pc:docChgLst>
  <pc:docChgLst>
    <pc:chgData name="Berger,Bernard,CH-Lausanne" userId="e82bb347-e851-4db7-bca8-21df8a20dbf3" providerId="ADAL" clId="{06724261-09FD-48FC-BCB4-C9FBF772096A}"/>
    <pc:docChg chg="custSel addSld delSld modSld sldOrd">
      <pc:chgData name="Berger,Bernard,CH-Lausanne" userId="e82bb347-e851-4db7-bca8-21df8a20dbf3" providerId="ADAL" clId="{06724261-09FD-48FC-BCB4-C9FBF772096A}" dt="2021-01-18T15:58:25.120" v="369" actId="207"/>
      <pc:docMkLst>
        <pc:docMk/>
      </pc:docMkLst>
      <pc:sldChg chg="addSp modSp addCm modCm">
        <pc:chgData name="Berger,Bernard,CH-Lausanne" userId="e82bb347-e851-4db7-bca8-21df8a20dbf3" providerId="ADAL" clId="{06724261-09FD-48FC-BCB4-C9FBF772096A}" dt="2021-01-17T23:30:07.733" v="149"/>
        <pc:sldMkLst>
          <pc:docMk/>
          <pc:sldMk cId="109857222" sldId="256"/>
        </pc:sldMkLst>
        <pc:spChg chg="add mod">
          <ac:chgData name="Berger,Bernard,CH-Lausanne" userId="e82bb347-e851-4db7-bca8-21df8a20dbf3" providerId="ADAL" clId="{06724261-09FD-48FC-BCB4-C9FBF772096A}" dt="2021-01-17T23:28:58.113" v="147" actId="208"/>
          <ac:spMkLst>
            <pc:docMk/>
            <pc:sldMk cId="109857222" sldId="256"/>
            <ac:spMk id="3" creationId="{C3823737-F235-485E-AB7F-55083DAACE50}"/>
          </ac:spMkLst>
        </pc:spChg>
        <pc:spChg chg="add mod">
          <ac:chgData name="Berger,Bernard,CH-Lausanne" userId="e82bb347-e851-4db7-bca8-21df8a20dbf3" providerId="ADAL" clId="{06724261-09FD-48FC-BCB4-C9FBF772096A}" dt="2021-01-13T10:16:43.191" v="5" actId="208"/>
          <ac:spMkLst>
            <pc:docMk/>
            <pc:sldMk cId="109857222" sldId="256"/>
            <ac:spMk id="7" creationId="{BA57869A-C8D7-4F9D-80D1-458D020127F8}"/>
          </ac:spMkLst>
        </pc:spChg>
        <pc:spChg chg="add mod">
          <ac:chgData name="Berger,Bernard,CH-Lausanne" userId="e82bb347-e851-4db7-bca8-21df8a20dbf3" providerId="ADAL" clId="{06724261-09FD-48FC-BCB4-C9FBF772096A}" dt="2021-01-13T10:16:58.065" v="8" actId="1076"/>
          <ac:spMkLst>
            <pc:docMk/>
            <pc:sldMk cId="109857222" sldId="256"/>
            <ac:spMk id="10" creationId="{1BCDD75C-0B64-4B21-94D6-07C81321A4D8}"/>
          </ac:spMkLst>
        </pc:spChg>
        <pc:spChg chg="add mod">
          <ac:chgData name="Berger,Bernard,CH-Lausanne" userId="e82bb347-e851-4db7-bca8-21df8a20dbf3" providerId="ADAL" clId="{06724261-09FD-48FC-BCB4-C9FBF772096A}" dt="2021-01-13T10:17:05.802" v="10" actId="1076"/>
          <ac:spMkLst>
            <pc:docMk/>
            <pc:sldMk cId="109857222" sldId="256"/>
            <ac:spMk id="12" creationId="{45A87E81-B498-4EFE-B2F4-B6604AC2F798}"/>
          </ac:spMkLst>
        </pc:spChg>
        <pc:spChg chg="add mod">
          <ac:chgData name="Berger,Bernard,CH-Lausanne" userId="e82bb347-e851-4db7-bca8-21df8a20dbf3" providerId="ADAL" clId="{06724261-09FD-48FC-BCB4-C9FBF772096A}" dt="2021-01-17T23:30:07.733" v="149"/>
          <ac:spMkLst>
            <pc:docMk/>
            <pc:sldMk cId="109857222" sldId="256"/>
            <ac:spMk id="14" creationId="{34DDCB74-77C2-4CA2-9E94-A2A93233688C}"/>
          </ac:spMkLst>
        </pc:spChg>
        <pc:cxnChg chg="add mod">
          <ac:chgData name="Berger,Bernard,CH-Lausanne" userId="e82bb347-e851-4db7-bca8-21df8a20dbf3" providerId="ADAL" clId="{06724261-09FD-48FC-BCB4-C9FBF772096A}" dt="2021-01-13T10:16:46.500" v="6" actId="208"/>
          <ac:cxnSpMkLst>
            <pc:docMk/>
            <pc:sldMk cId="109857222" sldId="256"/>
            <ac:cxnSpMk id="6" creationId="{59A35516-239A-42DD-B9AD-46DF1AC7EC72}"/>
          </ac:cxnSpMkLst>
        </pc:cxnChg>
        <pc:cxnChg chg="add mod">
          <ac:chgData name="Berger,Bernard,CH-Lausanne" userId="e82bb347-e851-4db7-bca8-21df8a20dbf3" providerId="ADAL" clId="{06724261-09FD-48FC-BCB4-C9FBF772096A}" dt="2021-01-13T10:16:58.065" v="8" actId="1076"/>
          <ac:cxnSpMkLst>
            <pc:docMk/>
            <pc:sldMk cId="109857222" sldId="256"/>
            <ac:cxnSpMk id="9" creationId="{7B5044C7-236A-4E7D-9644-CF2BA4790F70}"/>
          </ac:cxnSpMkLst>
        </pc:cxnChg>
        <pc:cxnChg chg="add mod">
          <ac:chgData name="Berger,Bernard,CH-Lausanne" userId="e82bb347-e851-4db7-bca8-21df8a20dbf3" providerId="ADAL" clId="{06724261-09FD-48FC-BCB4-C9FBF772096A}" dt="2021-01-17T23:25:50.661" v="77" actId="14100"/>
          <ac:cxnSpMkLst>
            <pc:docMk/>
            <pc:sldMk cId="109857222" sldId="256"/>
            <ac:cxnSpMk id="11" creationId="{A26C34F2-94E1-424F-972F-2F9E6649003F}"/>
          </ac:cxnSpMkLst>
        </pc:cxnChg>
      </pc:sldChg>
      <pc:sldChg chg="addSp modSp del">
        <pc:chgData name="Berger,Bernard,CH-Lausanne" userId="e82bb347-e851-4db7-bca8-21df8a20dbf3" providerId="ADAL" clId="{06724261-09FD-48FC-BCB4-C9FBF772096A}" dt="2021-01-13T10:27:07.966" v="22" actId="2696"/>
        <pc:sldMkLst>
          <pc:docMk/>
          <pc:sldMk cId="1299451647" sldId="257"/>
        </pc:sldMkLst>
        <pc:spChg chg="add mod">
          <ac:chgData name="Berger,Bernard,CH-Lausanne" userId="e82bb347-e851-4db7-bca8-21df8a20dbf3" providerId="ADAL" clId="{06724261-09FD-48FC-BCB4-C9FBF772096A}" dt="2021-01-13T10:24:20.675" v="21" actId="1076"/>
          <ac:spMkLst>
            <pc:docMk/>
            <pc:sldMk cId="1299451647" sldId="257"/>
            <ac:spMk id="10" creationId="{903FF289-DCA0-4A47-B6D9-78E43BEC881D}"/>
          </ac:spMkLst>
        </pc:spChg>
      </pc:sldChg>
      <pc:sldChg chg="addCm modCm">
        <pc:chgData name="Berger,Bernard,CH-Lausanne" userId="e82bb347-e851-4db7-bca8-21df8a20dbf3" providerId="ADAL" clId="{06724261-09FD-48FC-BCB4-C9FBF772096A}" dt="2021-01-13T10:56:39.763" v="52"/>
        <pc:sldMkLst>
          <pc:docMk/>
          <pc:sldMk cId="3574380604" sldId="258"/>
        </pc:sldMkLst>
      </pc:sldChg>
      <pc:sldChg chg="addSp delSp modSp">
        <pc:chgData name="Berger,Bernard,CH-Lausanne" userId="e82bb347-e851-4db7-bca8-21df8a20dbf3" providerId="ADAL" clId="{06724261-09FD-48FC-BCB4-C9FBF772096A}" dt="2021-01-18T01:07:54.773" v="320"/>
        <pc:sldMkLst>
          <pc:docMk/>
          <pc:sldMk cId="1915425" sldId="265"/>
        </pc:sldMkLst>
        <pc:spChg chg="add del mod">
          <ac:chgData name="Berger,Bernard,CH-Lausanne" userId="e82bb347-e851-4db7-bca8-21df8a20dbf3" providerId="ADAL" clId="{06724261-09FD-48FC-BCB4-C9FBF772096A}" dt="2021-01-18T01:07:54.773" v="320"/>
          <ac:spMkLst>
            <pc:docMk/>
            <pc:sldMk cId="1915425" sldId="265"/>
            <ac:spMk id="7" creationId="{13A9F4D9-A384-487C-93E3-E564414D47EB}"/>
          </ac:spMkLst>
        </pc:spChg>
      </pc:sldChg>
      <pc:sldChg chg="addSp modSp">
        <pc:chgData name="Berger,Bernard,CH-Lausanne" userId="e82bb347-e851-4db7-bca8-21df8a20dbf3" providerId="ADAL" clId="{06724261-09FD-48FC-BCB4-C9FBF772096A}" dt="2021-01-13T10:29:45.834" v="50" actId="207"/>
        <pc:sldMkLst>
          <pc:docMk/>
          <pc:sldMk cId="1790202609" sldId="266"/>
        </pc:sldMkLst>
        <pc:spChg chg="add mod">
          <ac:chgData name="Berger,Bernard,CH-Lausanne" userId="e82bb347-e851-4db7-bca8-21df8a20dbf3" providerId="ADAL" clId="{06724261-09FD-48FC-BCB4-C9FBF772096A}" dt="2021-01-13T10:29:45.834" v="50" actId="207"/>
          <ac:spMkLst>
            <pc:docMk/>
            <pc:sldMk cId="1790202609" sldId="266"/>
            <ac:spMk id="5" creationId="{C3AD2FF4-3D11-4AD6-BA61-921067938663}"/>
          </ac:spMkLst>
        </pc:spChg>
      </pc:sldChg>
      <pc:sldChg chg="modSp">
        <pc:chgData name="Berger,Bernard,CH-Lausanne" userId="e82bb347-e851-4db7-bca8-21df8a20dbf3" providerId="ADAL" clId="{06724261-09FD-48FC-BCB4-C9FBF772096A}" dt="2021-01-15T08:45:46.275" v="75" actId="14100"/>
        <pc:sldMkLst>
          <pc:docMk/>
          <pc:sldMk cId="2425756050" sldId="271"/>
        </pc:sldMkLst>
        <pc:picChg chg="mod">
          <ac:chgData name="Berger,Bernard,CH-Lausanne" userId="e82bb347-e851-4db7-bca8-21df8a20dbf3" providerId="ADAL" clId="{06724261-09FD-48FC-BCB4-C9FBF772096A}" dt="2021-01-15T08:45:46.275" v="75" actId="14100"/>
          <ac:picMkLst>
            <pc:docMk/>
            <pc:sldMk cId="2425756050" sldId="271"/>
            <ac:picMk id="6" creationId="{9FF11B40-D4EE-4CCF-AEE0-DEF6742E7290}"/>
          </ac:picMkLst>
        </pc:picChg>
      </pc:sldChg>
      <pc:sldChg chg="addSp modSp add addCm">
        <pc:chgData name="Berger,Bernard,CH-Lausanne" userId="e82bb347-e851-4db7-bca8-21df8a20dbf3" providerId="ADAL" clId="{06724261-09FD-48FC-BCB4-C9FBF772096A}" dt="2021-01-18T15:58:25.120" v="369" actId="207"/>
        <pc:sldMkLst>
          <pc:docMk/>
          <pc:sldMk cId="4186082910" sldId="272"/>
        </pc:sldMkLst>
        <pc:spChg chg="add mod">
          <ac:chgData name="Berger,Bernard,CH-Lausanne" userId="e82bb347-e851-4db7-bca8-21df8a20dbf3" providerId="ADAL" clId="{06724261-09FD-48FC-BCB4-C9FBF772096A}" dt="2021-01-18T15:58:25.120" v="369" actId="207"/>
          <ac:spMkLst>
            <pc:docMk/>
            <pc:sldMk cId="4186082910" sldId="272"/>
            <ac:spMk id="10" creationId="{4A42DA60-A259-477F-A58E-B5B57DDF3658}"/>
          </ac:spMkLst>
        </pc:spChg>
      </pc:sldChg>
      <pc:sldChg chg="modSp add">
        <pc:chgData name="Berger,Bernard,CH-Lausanne" userId="e82bb347-e851-4db7-bca8-21df8a20dbf3" providerId="ADAL" clId="{06724261-09FD-48FC-BCB4-C9FBF772096A}" dt="2021-01-13T11:12:10.759" v="74" actId="20577"/>
        <pc:sldMkLst>
          <pc:docMk/>
          <pc:sldMk cId="2408093355" sldId="273"/>
        </pc:sldMkLst>
        <pc:spChg chg="mod">
          <ac:chgData name="Berger,Bernard,CH-Lausanne" userId="e82bb347-e851-4db7-bca8-21df8a20dbf3" providerId="ADAL" clId="{06724261-09FD-48FC-BCB4-C9FBF772096A}" dt="2021-01-13T11:12:10.759" v="74" actId="20577"/>
          <ac:spMkLst>
            <pc:docMk/>
            <pc:sldMk cId="2408093355" sldId="273"/>
            <ac:spMk id="2" creationId="{DF3B720B-BF09-4DA9-832C-7AF7B2826EDC}"/>
          </ac:spMkLst>
        </pc:spChg>
      </pc:sldChg>
      <pc:sldChg chg="addSp modSp add ord">
        <pc:chgData name="Berger,Bernard,CH-Lausanne" userId="e82bb347-e851-4db7-bca8-21df8a20dbf3" providerId="ADAL" clId="{06724261-09FD-48FC-BCB4-C9FBF772096A}" dt="2021-01-18T15:57:30.073" v="358" actId="1076"/>
        <pc:sldMkLst>
          <pc:docMk/>
          <pc:sldMk cId="4181099377" sldId="274"/>
        </pc:sldMkLst>
        <pc:spChg chg="mod">
          <ac:chgData name="Berger,Bernard,CH-Lausanne" userId="e82bb347-e851-4db7-bca8-21df8a20dbf3" providerId="ADAL" clId="{06724261-09FD-48FC-BCB4-C9FBF772096A}" dt="2021-01-18T15:57:09.048" v="350" actId="1076"/>
          <ac:spMkLst>
            <pc:docMk/>
            <pc:sldMk cId="4181099377" sldId="274"/>
            <ac:spMk id="6" creationId="{E2658BC6-E908-47F2-8D80-8075CE348F99}"/>
          </ac:spMkLst>
        </pc:spChg>
        <pc:spChg chg="mod">
          <ac:chgData name="Berger,Bernard,CH-Lausanne" userId="e82bb347-e851-4db7-bca8-21df8a20dbf3" providerId="ADAL" clId="{06724261-09FD-48FC-BCB4-C9FBF772096A}" dt="2021-01-18T15:57:15.224" v="352" actId="1076"/>
          <ac:spMkLst>
            <pc:docMk/>
            <pc:sldMk cId="4181099377" sldId="274"/>
            <ac:spMk id="7" creationId="{0C5D272F-2D94-4F8A-9994-F5CDA4B27394}"/>
          </ac:spMkLst>
        </pc:spChg>
        <pc:spChg chg="mod">
          <ac:chgData name="Berger,Bernard,CH-Lausanne" userId="e82bb347-e851-4db7-bca8-21df8a20dbf3" providerId="ADAL" clId="{06724261-09FD-48FC-BCB4-C9FBF772096A}" dt="2021-01-18T15:57:30.073" v="358" actId="1076"/>
          <ac:spMkLst>
            <pc:docMk/>
            <pc:sldMk cId="4181099377" sldId="274"/>
            <ac:spMk id="9" creationId="{27F0784C-44C8-447C-BD40-F972986CC706}"/>
          </ac:spMkLst>
        </pc:spChg>
        <pc:spChg chg="add mod">
          <ac:chgData name="Berger,Bernard,CH-Lausanne" userId="e82bb347-e851-4db7-bca8-21df8a20dbf3" providerId="ADAL" clId="{06724261-09FD-48FC-BCB4-C9FBF772096A}" dt="2021-01-18T00:11:26.477" v="218" actId="1076"/>
          <ac:spMkLst>
            <pc:docMk/>
            <pc:sldMk cId="4181099377" sldId="274"/>
            <ac:spMk id="10" creationId="{5FA22EB1-AB3C-420E-B24A-0C5100EC0B9F}"/>
          </ac:spMkLst>
        </pc:spChg>
        <pc:spChg chg="add mod">
          <ac:chgData name="Berger,Bernard,CH-Lausanne" userId="e82bb347-e851-4db7-bca8-21df8a20dbf3" providerId="ADAL" clId="{06724261-09FD-48FC-BCB4-C9FBF772096A}" dt="2021-01-18T00:08:51.008" v="188" actId="1076"/>
          <ac:spMkLst>
            <pc:docMk/>
            <pc:sldMk cId="4181099377" sldId="274"/>
            <ac:spMk id="13" creationId="{DC69C8CB-CB16-4A67-BD7F-0C6E879F7314}"/>
          </ac:spMkLst>
        </pc:spChg>
        <pc:spChg chg="add mod">
          <ac:chgData name="Berger,Bernard,CH-Lausanne" userId="e82bb347-e851-4db7-bca8-21df8a20dbf3" providerId="ADAL" clId="{06724261-09FD-48FC-BCB4-C9FBF772096A}" dt="2021-01-18T00:08:48.727" v="187" actId="1076"/>
          <ac:spMkLst>
            <pc:docMk/>
            <pc:sldMk cId="4181099377" sldId="274"/>
            <ac:spMk id="14" creationId="{BD8AF208-385D-4602-B5CB-51C6F5785B55}"/>
          </ac:spMkLst>
        </pc:spChg>
        <pc:spChg chg="add mod">
          <ac:chgData name="Berger,Bernard,CH-Lausanne" userId="e82bb347-e851-4db7-bca8-21df8a20dbf3" providerId="ADAL" clId="{06724261-09FD-48FC-BCB4-C9FBF772096A}" dt="2021-01-18T15:56:43.553" v="345" actId="20577"/>
          <ac:spMkLst>
            <pc:docMk/>
            <pc:sldMk cId="4181099377" sldId="274"/>
            <ac:spMk id="15" creationId="{A4FFF726-C6C5-407E-962B-9404C108370F}"/>
          </ac:spMkLst>
        </pc:spChg>
        <pc:graphicFrameChg chg="add mod">
          <ac:chgData name="Berger,Bernard,CH-Lausanne" userId="e82bb347-e851-4db7-bca8-21df8a20dbf3" providerId="ADAL" clId="{06724261-09FD-48FC-BCB4-C9FBF772096A}" dt="2021-01-18T15:56:24.177" v="322" actId="1076"/>
          <ac:graphicFrameMkLst>
            <pc:docMk/>
            <pc:sldMk cId="4181099377" sldId="274"/>
            <ac:graphicFrameMk id="11" creationId="{7A88A2FE-4192-4027-9541-32C9B32F6C74}"/>
          </ac:graphicFrameMkLst>
        </pc:graphicFrameChg>
        <pc:graphicFrameChg chg="add mod">
          <ac:chgData name="Berger,Bernard,CH-Lausanne" userId="e82bb347-e851-4db7-bca8-21df8a20dbf3" providerId="ADAL" clId="{06724261-09FD-48FC-BCB4-C9FBF772096A}" dt="2021-01-18T15:56:57.547" v="347" actId="1076"/>
          <ac:graphicFrameMkLst>
            <pc:docMk/>
            <pc:sldMk cId="4181099377" sldId="274"/>
            <ac:graphicFrameMk id="12" creationId="{24264916-EED1-4E0B-995F-D76D5EA2BAB6}"/>
          </ac:graphicFrameMkLst>
        </pc:graphicFrameChg>
        <pc:picChg chg="mod">
          <ac:chgData name="Berger,Bernard,CH-Lausanne" userId="e82bb347-e851-4db7-bca8-21df8a20dbf3" providerId="ADAL" clId="{06724261-09FD-48FC-BCB4-C9FBF772096A}" dt="2021-01-18T15:57:05.113" v="349" actId="1076"/>
          <ac:picMkLst>
            <pc:docMk/>
            <pc:sldMk cId="4181099377" sldId="274"/>
            <ac:picMk id="4" creationId="{07B678AA-EBCA-45B1-9B14-268888E0BE28}"/>
          </ac:picMkLst>
        </pc:picChg>
        <pc:picChg chg="mod">
          <ac:chgData name="Berger,Bernard,CH-Lausanne" userId="e82bb347-e851-4db7-bca8-21df8a20dbf3" providerId="ADAL" clId="{06724261-09FD-48FC-BCB4-C9FBF772096A}" dt="2021-01-18T15:57:23.193" v="356" actId="1076"/>
          <ac:picMkLst>
            <pc:docMk/>
            <pc:sldMk cId="4181099377" sldId="274"/>
            <ac:picMk id="5" creationId="{81702BDC-7DEB-448F-AFE4-8BF6F6171D74}"/>
          </ac:picMkLst>
        </pc:picChg>
        <pc:picChg chg="mod">
          <ac:chgData name="Berger,Bernard,CH-Lausanne" userId="e82bb347-e851-4db7-bca8-21df8a20dbf3" providerId="ADAL" clId="{06724261-09FD-48FC-BCB4-C9FBF772096A}" dt="2021-01-18T15:57:26.561" v="357" actId="1076"/>
          <ac:picMkLst>
            <pc:docMk/>
            <pc:sldMk cId="4181099377" sldId="274"/>
            <ac:picMk id="8" creationId="{0853C466-3925-4261-BE29-A30A1DAC2CC3}"/>
          </ac:picMkLst>
        </pc:picChg>
      </pc:sldChg>
      <pc:sldChg chg="addSp delSp modSp add ord">
        <pc:chgData name="Berger,Bernard,CH-Lausanne" userId="e82bb347-e851-4db7-bca8-21df8a20dbf3" providerId="ADAL" clId="{06724261-09FD-48FC-BCB4-C9FBF772096A}" dt="2021-01-18T01:07:30.628" v="304"/>
        <pc:sldMkLst>
          <pc:docMk/>
          <pc:sldMk cId="562436449" sldId="275"/>
        </pc:sldMkLst>
        <pc:spChg chg="del mod">
          <ac:chgData name="Berger,Bernard,CH-Lausanne" userId="e82bb347-e851-4db7-bca8-21df8a20dbf3" providerId="ADAL" clId="{06724261-09FD-48FC-BCB4-C9FBF772096A}" dt="2021-01-18T00:10:56.253" v="214" actId="478"/>
          <ac:spMkLst>
            <pc:docMk/>
            <pc:sldMk cId="562436449" sldId="275"/>
            <ac:spMk id="3" creationId="{00000000-0000-0000-0000-000000000000}"/>
          </ac:spMkLst>
        </pc:spChg>
        <pc:spChg chg="add del mod">
          <ac:chgData name="Berger,Bernard,CH-Lausanne" userId="e82bb347-e851-4db7-bca8-21df8a20dbf3" providerId="ADAL" clId="{06724261-09FD-48FC-BCB4-C9FBF772096A}" dt="2021-01-18T00:11:00.461" v="215" actId="478"/>
          <ac:spMkLst>
            <pc:docMk/>
            <pc:sldMk cId="562436449" sldId="275"/>
            <ac:spMk id="6" creationId="{20DB9B81-7915-48B4-8BF4-13879E48A81C}"/>
          </ac:spMkLst>
        </pc:spChg>
        <pc:spChg chg="add mod">
          <ac:chgData name="Berger,Bernard,CH-Lausanne" userId="e82bb347-e851-4db7-bca8-21df8a20dbf3" providerId="ADAL" clId="{06724261-09FD-48FC-BCB4-C9FBF772096A}" dt="2021-01-18T00:11:20.133" v="217" actId="1076"/>
          <ac:spMkLst>
            <pc:docMk/>
            <pc:sldMk cId="562436449" sldId="275"/>
            <ac:spMk id="15" creationId="{B276FD76-44D4-48DF-A52F-066CF3CDB601}"/>
          </ac:spMkLst>
        </pc:spChg>
        <pc:spChg chg="add mod">
          <ac:chgData name="Berger,Bernard,CH-Lausanne" userId="e82bb347-e851-4db7-bca8-21df8a20dbf3" providerId="ADAL" clId="{06724261-09FD-48FC-BCB4-C9FBF772096A}" dt="2021-01-18T00:16:08.667" v="302" actId="20577"/>
          <ac:spMkLst>
            <pc:docMk/>
            <pc:sldMk cId="562436449" sldId="275"/>
            <ac:spMk id="16" creationId="{FD99EC64-4D30-40BF-840B-F14700F2E217}"/>
          </ac:spMkLst>
        </pc:spChg>
        <pc:picChg chg="mod">
          <ac:chgData name="Berger,Bernard,CH-Lausanne" userId="e82bb347-e851-4db7-bca8-21df8a20dbf3" providerId="ADAL" clId="{06724261-09FD-48FC-BCB4-C9FBF772096A}" dt="2021-01-18T00:09:32.233" v="195" actId="14100"/>
          <ac:picMkLst>
            <pc:docMk/>
            <pc:sldMk cId="562436449" sldId="275"/>
            <ac:picMk id="7" creationId="{6FD4A128-53D0-44D5-8022-E6D66A8603CF}"/>
          </ac:picMkLst>
        </pc:picChg>
        <pc:picChg chg="mod">
          <ac:chgData name="Berger,Bernard,CH-Lausanne" userId="e82bb347-e851-4db7-bca8-21df8a20dbf3" providerId="ADAL" clId="{06724261-09FD-48FC-BCB4-C9FBF772096A}" dt="2021-01-18T00:09:36.081" v="197" actId="1076"/>
          <ac:picMkLst>
            <pc:docMk/>
            <pc:sldMk cId="562436449" sldId="275"/>
            <ac:picMk id="9" creationId="{752EDCCB-31CC-406D-B7A2-D86F31DD013B}"/>
          </ac:picMkLst>
        </pc:picChg>
        <pc:picChg chg="mod">
          <ac:chgData name="Berger,Bernard,CH-Lausanne" userId="e82bb347-e851-4db7-bca8-21df8a20dbf3" providerId="ADAL" clId="{06724261-09FD-48FC-BCB4-C9FBF772096A}" dt="2021-01-18T00:09:41.289" v="200" actId="14100"/>
          <ac:picMkLst>
            <pc:docMk/>
            <pc:sldMk cId="562436449" sldId="275"/>
            <ac:picMk id="10" creationId="{E1E211D5-9EA0-40CF-B930-E1D82F07F433}"/>
          </ac:picMkLst>
        </pc:picChg>
        <pc:picChg chg="add mod">
          <ac:chgData name="Berger,Bernard,CH-Lausanne" userId="e82bb347-e851-4db7-bca8-21df8a20dbf3" providerId="ADAL" clId="{06724261-09FD-48FC-BCB4-C9FBF772096A}" dt="2021-01-18T00:15:08.150" v="223" actId="1076"/>
          <ac:picMkLst>
            <pc:docMk/>
            <pc:sldMk cId="562436449" sldId="275"/>
            <ac:picMk id="13" creationId="{CF00B211-672D-494F-AD26-1949025262BA}"/>
          </ac:picMkLst>
        </pc:picChg>
        <pc:picChg chg="add del mod">
          <ac:chgData name="Berger,Bernard,CH-Lausanne" userId="e82bb347-e851-4db7-bca8-21df8a20dbf3" providerId="ADAL" clId="{06724261-09FD-48FC-BCB4-C9FBF772096A}" dt="2021-01-18T00:15:02.470" v="221" actId="478"/>
          <ac:picMkLst>
            <pc:docMk/>
            <pc:sldMk cId="562436449" sldId="275"/>
            <ac:picMk id="14" creationId="{03DC5D32-9287-4818-9D68-16666E0ABD57}"/>
          </ac:picMkLst>
        </pc:picChg>
      </pc:sldChg>
    </pc:docChg>
  </pc:docChgLst>
  <pc:docChgLst>
    <pc:chgData name="Kortman, Guus" userId="S::guus.kortman_nizo.com#ext#@nestle.onmicrosoft.com::5e79f0f8-9dfb-4e42-8e30-2c2bbc6868fd" providerId="AD" clId="Web-{9E213E4A-3342-45CA-B00D-DCE7DD26EA10}"/>
    <pc:docChg chg="addSld modSld">
      <pc:chgData name="Kortman, Guus" userId="S::guus.kortman_nizo.com#ext#@nestle.onmicrosoft.com::5e79f0f8-9dfb-4e42-8e30-2c2bbc6868fd" providerId="AD" clId="Web-{9E213E4A-3342-45CA-B00D-DCE7DD26EA10}" dt="2020-09-23T10:05:35.360" v="27" actId="20577"/>
      <pc:docMkLst>
        <pc:docMk/>
      </pc:docMkLst>
      <pc:sldChg chg="modSp">
        <pc:chgData name="Kortman, Guus" userId="S::guus.kortman_nizo.com#ext#@nestle.onmicrosoft.com::5e79f0f8-9dfb-4e42-8e30-2c2bbc6868fd" providerId="AD" clId="Web-{9E213E4A-3342-45CA-B00D-DCE7DD26EA10}" dt="2020-09-23T10:04:57.483" v="15" actId="1076"/>
        <pc:sldMkLst>
          <pc:docMk/>
          <pc:sldMk cId="109857222" sldId="256"/>
        </pc:sldMkLst>
        <pc:spChg chg="mod">
          <ac:chgData name="Kortman, Guus" userId="S::guus.kortman_nizo.com#ext#@nestle.onmicrosoft.com::5e79f0f8-9dfb-4e42-8e30-2c2bbc6868fd" providerId="AD" clId="Web-{9E213E4A-3342-45CA-B00D-DCE7DD26EA10}" dt="2020-09-23T10:04:57.483" v="15" actId="1076"/>
          <ac:spMkLst>
            <pc:docMk/>
            <pc:sldMk cId="109857222" sldId="256"/>
            <ac:spMk id="2" creationId="{00000000-0000-0000-0000-000000000000}"/>
          </ac:spMkLst>
        </pc:spChg>
        <pc:spChg chg="mod">
          <ac:chgData name="Kortman, Guus" userId="S::guus.kortman_nizo.com#ext#@nestle.onmicrosoft.com::5e79f0f8-9dfb-4e42-8e30-2c2bbc6868fd" providerId="AD" clId="Web-{9E213E4A-3342-45CA-B00D-DCE7DD26EA10}" dt="2020-09-23T10:04:31.170" v="0" actId="1076"/>
          <ac:spMkLst>
            <pc:docMk/>
            <pc:sldMk cId="109857222" sldId="256"/>
            <ac:spMk id="3" creationId="{00000000-0000-0000-0000-000000000000}"/>
          </ac:spMkLst>
        </pc:spChg>
      </pc:sldChg>
      <pc:sldChg chg="modSp add replId">
        <pc:chgData name="Kortman, Guus" userId="S::guus.kortman_nizo.com#ext#@nestle.onmicrosoft.com::5e79f0f8-9dfb-4e42-8e30-2c2bbc6868fd" providerId="AD" clId="Web-{9E213E4A-3342-45CA-B00D-DCE7DD26EA10}" dt="2020-09-23T10:05:16.531" v="22" actId="20577"/>
        <pc:sldMkLst>
          <pc:docMk/>
          <pc:sldMk cId="1299451647" sldId="257"/>
        </pc:sldMkLst>
        <pc:spChg chg="mod">
          <ac:chgData name="Kortman, Guus" userId="S::guus.kortman_nizo.com#ext#@nestle.onmicrosoft.com::5e79f0f8-9dfb-4e42-8e30-2c2bbc6868fd" providerId="AD" clId="Web-{9E213E4A-3342-45CA-B00D-DCE7DD26EA10}" dt="2020-09-23T10:05:16.531" v="22" actId="20577"/>
          <ac:spMkLst>
            <pc:docMk/>
            <pc:sldMk cId="1299451647" sldId="257"/>
            <ac:spMk id="2" creationId="{00000000-0000-0000-0000-000000000000}"/>
          </ac:spMkLst>
        </pc:spChg>
      </pc:sldChg>
      <pc:sldChg chg="modSp add replId">
        <pc:chgData name="Kortman, Guus" userId="S::guus.kortman_nizo.com#ext#@nestle.onmicrosoft.com::5e79f0f8-9dfb-4e42-8e30-2c2bbc6868fd" providerId="AD" clId="Web-{9E213E4A-3342-45CA-B00D-DCE7DD26EA10}" dt="2020-09-23T10:05:20.219" v="23" actId="20577"/>
        <pc:sldMkLst>
          <pc:docMk/>
          <pc:sldMk cId="3574380604" sldId="258"/>
        </pc:sldMkLst>
        <pc:spChg chg="mod">
          <ac:chgData name="Kortman, Guus" userId="S::guus.kortman_nizo.com#ext#@nestle.onmicrosoft.com::5e79f0f8-9dfb-4e42-8e30-2c2bbc6868fd" providerId="AD" clId="Web-{9E213E4A-3342-45CA-B00D-DCE7DD26EA10}" dt="2020-09-23T10:05:20.219" v="23" actId="20577"/>
          <ac:spMkLst>
            <pc:docMk/>
            <pc:sldMk cId="3574380604" sldId="258"/>
            <ac:spMk id="2" creationId="{00000000-0000-0000-0000-000000000000}"/>
          </ac:spMkLst>
        </pc:spChg>
      </pc:sldChg>
      <pc:sldChg chg="modSp add replId">
        <pc:chgData name="Kortman, Guus" userId="S::guus.kortman_nizo.com#ext#@nestle.onmicrosoft.com::5e79f0f8-9dfb-4e42-8e30-2c2bbc6868fd" providerId="AD" clId="Web-{9E213E4A-3342-45CA-B00D-DCE7DD26EA10}" dt="2020-09-23T10:05:23.031" v="24" actId="20577"/>
        <pc:sldMkLst>
          <pc:docMk/>
          <pc:sldMk cId="3481645440" sldId="259"/>
        </pc:sldMkLst>
        <pc:spChg chg="mod">
          <ac:chgData name="Kortman, Guus" userId="S::guus.kortman_nizo.com#ext#@nestle.onmicrosoft.com::5e79f0f8-9dfb-4e42-8e30-2c2bbc6868fd" providerId="AD" clId="Web-{9E213E4A-3342-45CA-B00D-DCE7DD26EA10}" dt="2020-09-23T10:05:23.031" v="24" actId="20577"/>
          <ac:spMkLst>
            <pc:docMk/>
            <pc:sldMk cId="3481645440" sldId="259"/>
            <ac:spMk id="2" creationId="{00000000-0000-0000-0000-000000000000}"/>
          </ac:spMkLst>
        </pc:spChg>
      </pc:sldChg>
      <pc:sldChg chg="modSp add replId">
        <pc:chgData name="Kortman, Guus" userId="S::guus.kortman_nizo.com#ext#@nestle.onmicrosoft.com::5e79f0f8-9dfb-4e42-8e30-2c2bbc6868fd" providerId="AD" clId="Web-{9E213E4A-3342-45CA-B00D-DCE7DD26EA10}" dt="2020-09-23T10:05:26.250" v="25" actId="20577"/>
        <pc:sldMkLst>
          <pc:docMk/>
          <pc:sldMk cId="3261540884" sldId="260"/>
        </pc:sldMkLst>
        <pc:spChg chg="mod">
          <ac:chgData name="Kortman, Guus" userId="S::guus.kortman_nizo.com#ext#@nestle.onmicrosoft.com::5e79f0f8-9dfb-4e42-8e30-2c2bbc6868fd" providerId="AD" clId="Web-{9E213E4A-3342-45CA-B00D-DCE7DD26EA10}" dt="2020-09-23T10:05:26.250" v="25" actId="20577"/>
          <ac:spMkLst>
            <pc:docMk/>
            <pc:sldMk cId="3261540884" sldId="260"/>
            <ac:spMk id="2" creationId="{00000000-0000-0000-0000-000000000000}"/>
          </ac:spMkLst>
        </pc:spChg>
      </pc:sldChg>
      <pc:sldChg chg="modSp add replId">
        <pc:chgData name="Kortman, Guus" userId="S::guus.kortman_nizo.com#ext#@nestle.onmicrosoft.com::5e79f0f8-9dfb-4e42-8e30-2c2bbc6868fd" providerId="AD" clId="Web-{9E213E4A-3342-45CA-B00D-DCE7DD26EA10}" dt="2020-09-23T10:05:29.969" v="26" actId="20577"/>
        <pc:sldMkLst>
          <pc:docMk/>
          <pc:sldMk cId="1876531822" sldId="261"/>
        </pc:sldMkLst>
        <pc:spChg chg="mod">
          <ac:chgData name="Kortman, Guus" userId="S::guus.kortman_nizo.com#ext#@nestle.onmicrosoft.com::5e79f0f8-9dfb-4e42-8e30-2c2bbc6868fd" providerId="AD" clId="Web-{9E213E4A-3342-45CA-B00D-DCE7DD26EA10}" dt="2020-09-23T10:05:29.969" v="26" actId="20577"/>
          <ac:spMkLst>
            <pc:docMk/>
            <pc:sldMk cId="1876531822" sldId="261"/>
            <ac:spMk id="2" creationId="{00000000-0000-0000-0000-000000000000}"/>
          </ac:spMkLst>
        </pc:spChg>
      </pc:sldChg>
      <pc:sldChg chg="modSp add replId">
        <pc:chgData name="Kortman, Guus" userId="S::guus.kortman_nizo.com#ext#@nestle.onmicrosoft.com::5e79f0f8-9dfb-4e42-8e30-2c2bbc6868fd" providerId="AD" clId="Web-{9E213E4A-3342-45CA-B00D-DCE7DD26EA10}" dt="2020-09-23T10:05:35.360" v="27" actId="20577"/>
        <pc:sldMkLst>
          <pc:docMk/>
          <pc:sldMk cId="907894339" sldId="262"/>
        </pc:sldMkLst>
        <pc:spChg chg="mod">
          <ac:chgData name="Kortman, Guus" userId="S::guus.kortman_nizo.com#ext#@nestle.onmicrosoft.com::5e79f0f8-9dfb-4e42-8e30-2c2bbc6868fd" providerId="AD" clId="Web-{9E213E4A-3342-45CA-B00D-DCE7DD26EA10}" dt="2020-09-23T10:05:35.360" v="27" actId="20577"/>
          <ac:spMkLst>
            <pc:docMk/>
            <pc:sldMk cId="907894339" sldId="262"/>
            <ac:spMk id="2" creationId="{00000000-0000-0000-0000-000000000000}"/>
          </ac:spMkLst>
        </pc:spChg>
      </pc:sldChg>
    </pc:docChg>
  </pc:docChgLst>
  <pc:docChgLst>
    <pc:chgData name="Cercamondi,Colin Ivano,CH-Vevey" userId="d25e694c-3ff8-4193-82fc-75dd469e9cee" providerId="ADAL" clId="{DC3C00A4-DD54-4E5B-8082-5EC85C00EEEC}"/>
    <pc:docChg chg="undo custSel modSld">
      <pc:chgData name="Cercamondi,Colin Ivano,CH-Vevey" userId="d25e694c-3ff8-4193-82fc-75dd469e9cee" providerId="ADAL" clId="{DC3C00A4-DD54-4E5B-8082-5EC85C00EEEC}" dt="2021-07-28T10:32:18.359" v="244" actId="20577"/>
      <pc:docMkLst>
        <pc:docMk/>
      </pc:docMkLst>
      <pc:sldChg chg="addSp delSp modSp mod">
        <pc:chgData name="Cercamondi,Colin Ivano,CH-Vevey" userId="d25e694c-3ff8-4193-82fc-75dd469e9cee" providerId="ADAL" clId="{DC3C00A4-DD54-4E5B-8082-5EC85C00EEEC}" dt="2021-07-28T10:32:18.359" v="244" actId="20577"/>
        <pc:sldMkLst>
          <pc:docMk/>
          <pc:sldMk cId="1153482099" sldId="267"/>
        </pc:sldMkLst>
        <pc:spChg chg="mod">
          <ac:chgData name="Cercamondi,Colin Ivano,CH-Vevey" userId="d25e694c-3ff8-4193-82fc-75dd469e9cee" providerId="ADAL" clId="{DC3C00A4-DD54-4E5B-8082-5EC85C00EEEC}" dt="2021-07-28T07:47:13.799" v="150" actId="20577"/>
          <ac:spMkLst>
            <pc:docMk/>
            <pc:sldMk cId="1153482099" sldId="267"/>
            <ac:spMk id="2" creationId="{00000000-0000-0000-0000-000000000000}"/>
          </ac:spMkLst>
        </pc:spChg>
        <pc:spChg chg="mod">
          <ac:chgData name="Cercamondi,Colin Ivano,CH-Vevey" userId="d25e694c-3ff8-4193-82fc-75dd469e9cee" providerId="ADAL" clId="{DC3C00A4-DD54-4E5B-8082-5EC85C00EEEC}" dt="2021-07-28T10:32:18.359" v="244" actId="20577"/>
          <ac:spMkLst>
            <pc:docMk/>
            <pc:sldMk cId="1153482099" sldId="267"/>
            <ac:spMk id="3" creationId="{00000000-0000-0000-0000-000000000000}"/>
          </ac:spMkLst>
        </pc:spChg>
        <pc:picChg chg="del mod">
          <ac:chgData name="Cercamondi,Colin Ivano,CH-Vevey" userId="d25e694c-3ff8-4193-82fc-75dd469e9cee" providerId="ADAL" clId="{DC3C00A4-DD54-4E5B-8082-5EC85C00EEEC}" dt="2021-07-28T07:50:43.726" v="219" actId="478"/>
          <ac:picMkLst>
            <pc:docMk/>
            <pc:sldMk cId="1153482099" sldId="267"/>
            <ac:picMk id="6" creationId="{767D1AEF-C759-401F-962D-6328A4D555A1}"/>
          </ac:picMkLst>
        </pc:picChg>
        <pc:picChg chg="add mod ord">
          <ac:chgData name="Cercamondi,Colin Ivano,CH-Vevey" userId="d25e694c-3ff8-4193-82fc-75dd469e9cee" providerId="ADAL" clId="{DC3C00A4-DD54-4E5B-8082-5EC85C00EEEC}" dt="2021-07-28T07:52:49.615" v="239" actId="1076"/>
          <ac:picMkLst>
            <pc:docMk/>
            <pc:sldMk cId="1153482099" sldId="267"/>
            <ac:picMk id="7" creationId="{30C8D721-3462-420D-9D66-3E61075996AF}"/>
          </ac:picMkLst>
        </pc:picChg>
      </pc:sldChg>
    </pc:docChg>
  </pc:docChgLst>
  <pc:docChgLst>
    <pc:chgData name="Cercamondi,Colin Ivano,CH-Vevey" userId="d25e694c-3ff8-4193-82fc-75dd469e9cee" providerId="ADAL" clId="{A585A20B-B85D-4B69-9B20-6AF4B26F24C3}"/>
    <pc:docChg chg="delSld">
      <pc:chgData name="Cercamondi,Colin Ivano,CH-Vevey" userId="d25e694c-3ff8-4193-82fc-75dd469e9cee" providerId="ADAL" clId="{A585A20B-B85D-4B69-9B20-6AF4B26F24C3}" dt="2021-04-16T14:50:41.550" v="0" actId="2696"/>
      <pc:docMkLst>
        <pc:docMk/>
      </pc:docMkLst>
      <pc:sldChg chg="del">
        <pc:chgData name="Cercamondi,Colin Ivano,CH-Vevey" userId="d25e694c-3ff8-4193-82fc-75dd469e9cee" providerId="ADAL" clId="{A585A20B-B85D-4B69-9B20-6AF4B26F24C3}" dt="2021-04-16T14:50:41.550" v="0" actId="2696"/>
        <pc:sldMkLst>
          <pc:docMk/>
          <pc:sldMk cId="4229023287" sldId="268"/>
        </pc:sldMkLst>
      </pc:sldChg>
    </pc:docChg>
  </pc:docChgLst>
  <pc:docChgLst>
    <pc:chgData name="Berger,Bernard,CH-Lausanne" userId="e82bb347-e851-4db7-bca8-21df8a20dbf3" providerId="ADAL" clId="{23785B14-8ACB-4544-A2AA-66B474134AC6}"/>
    <pc:docChg chg="custSel modSld">
      <pc:chgData name="Berger,Bernard,CH-Lausanne" userId="e82bb347-e851-4db7-bca8-21df8a20dbf3" providerId="ADAL" clId="{23785B14-8ACB-4544-A2AA-66B474134AC6}" dt="2021-07-28T16:50:12.975" v="92" actId="13926"/>
      <pc:docMkLst>
        <pc:docMk/>
      </pc:docMkLst>
      <pc:sldChg chg="addSp modSp mod">
        <pc:chgData name="Berger,Bernard,CH-Lausanne" userId="e82bb347-e851-4db7-bca8-21df8a20dbf3" providerId="ADAL" clId="{23785B14-8ACB-4544-A2AA-66B474134AC6}" dt="2021-07-28T16:50:12.975" v="92" actId="13926"/>
        <pc:sldMkLst>
          <pc:docMk/>
          <pc:sldMk cId="1153482099" sldId="267"/>
        </pc:sldMkLst>
        <pc:spChg chg="mod">
          <ac:chgData name="Berger,Bernard,CH-Lausanne" userId="e82bb347-e851-4db7-bca8-21df8a20dbf3" providerId="ADAL" clId="{23785B14-8ACB-4544-A2AA-66B474134AC6}" dt="2021-07-28T16:50:12.975" v="92" actId="13926"/>
          <ac:spMkLst>
            <pc:docMk/>
            <pc:sldMk cId="1153482099" sldId="267"/>
            <ac:spMk id="3" creationId="{00000000-0000-0000-0000-000000000000}"/>
          </ac:spMkLst>
        </pc:spChg>
        <pc:spChg chg="add mod">
          <ac:chgData name="Berger,Bernard,CH-Lausanne" userId="e82bb347-e851-4db7-bca8-21df8a20dbf3" providerId="ADAL" clId="{23785B14-8ACB-4544-A2AA-66B474134AC6}" dt="2021-07-28T14:35:47.986" v="5" actId="1076"/>
          <ac:spMkLst>
            <pc:docMk/>
            <pc:sldMk cId="1153482099" sldId="267"/>
            <ac:spMk id="23" creationId="{86599123-4989-4FC6-8418-34814D7EDFA6}"/>
          </ac:spMkLst>
        </pc:spChg>
        <pc:spChg chg="add mod">
          <ac:chgData name="Berger,Bernard,CH-Lausanne" userId="e82bb347-e851-4db7-bca8-21df8a20dbf3" providerId="ADAL" clId="{23785B14-8ACB-4544-A2AA-66B474134AC6}" dt="2021-07-28T14:35:07.677" v="2" actId="571"/>
          <ac:spMkLst>
            <pc:docMk/>
            <pc:sldMk cId="1153482099" sldId="267"/>
            <ac:spMk id="25" creationId="{B62F38A6-15AE-4F17-99BF-900A4DA9CDFC}"/>
          </ac:spMkLst>
        </pc:spChg>
        <pc:spChg chg="add mod">
          <ac:chgData name="Berger,Bernard,CH-Lausanne" userId="e82bb347-e851-4db7-bca8-21df8a20dbf3" providerId="ADAL" clId="{23785B14-8ACB-4544-A2AA-66B474134AC6}" dt="2021-07-28T14:35:18.315" v="3" actId="571"/>
          <ac:spMkLst>
            <pc:docMk/>
            <pc:sldMk cId="1153482099" sldId="267"/>
            <ac:spMk id="26" creationId="{E0815F5C-BA97-49B4-836F-6DE8CCA4DE27}"/>
          </ac:spMkLst>
        </pc:spChg>
        <pc:spChg chg="add mod">
          <ac:chgData name="Berger,Bernard,CH-Lausanne" userId="e82bb347-e851-4db7-bca8-21df8a20dbf3" providerId="ADAL" clId="{23785B14-8ACB-4544-A2AA-66B474134AC6}" dt="2021-07-28T14:35:22.501" v="4" actId="571"/>
          <ac:spMkLst>
            <pc:docMk/>
            <pc:sldMk cId="1153482099" sldId="267"/>
            <ac:spMk id="27" creationId="{8E7CED26-3B52-40CF-A90D-12BF1BF07EA6}"/>
          </ac:spMkLst>
        </pc:spChg>
        <pc:picChg chg="add mod">
          <ac:chgData name="Berger,Bernard,CH-Lausanne" userId="e82bb347-e851-4db7-bca8-21df8a20dbf3" providerId="ADAL" clId="{23785B14-8ACB-4544-A2AA-66B474134AC6}" dt="2021-07-28T14:35:07.677" v="2" actId="571"/>
          <ac:picMkLst>
            <pc:docMk/>
            <pc:sldMk cId="1153482099" sldId="267"/>
            <ac:picMk id="24" creationId="{0730D7F8-6DCF-4603-8837-E9F4E1C769D9}"/>
          </ac:picMkLst>
        </pc:picChg>
      </pc:sldChg>
    </pc:docChg>
  </pc:docChgLst>
  <pc:docChgLst>
    <pc:chgData name="Cercamondi,Colin Ivano,CH-Vevey" userId="d25e694c-3ff8-4193-82fc-75dd469e9cee" providerId="ADAL" clId="{FB197852-8253-4B1D-875B-C85F492A99F3}"/>
    <pc:docChg chg="modSld">
      <pc:chgData name="Cercamondi,Colin Ivano,CH-Vevey" userId="d25e694c-3ff8-4193-82fc-75dd469e9cee" providerId="ADAL" clId="{FB197852-8253-4B1D-875B-C85F492A99F3}" dt="2021-08-04T08:43:09.688" v="22" actId="20577"/>
      <pc:docMkLst>
        <pc:docMk/>
      </pc:docMkLst>
      <pc:sldChg chg="modSp mod">
        <pc:chgData name="Cercamondi,Colin Ivano,CH-Vevey" userId="d25e694c-3ff8-4193-82fc-75dd469e9cee" providerId="ADAL" clId="{FB197852-8253-4B1D-875B-C85F492A99F3}" dt="2021-08-04T08:43:09.688" v="22" actId="20577"/>
        <pc:sldMkLst>
          <pc:docMk/>
          <pc:sldMk cId="1153482099" sldId="267"/>
        </pc:sldMkLst>
        <pc:spChg chg="mod">
          <ac:chgData name="Cercamondi,Colin Ivano,CH-Vevey" userId="d25e694c-3ff8-4193-82fc-75dd469e9cee" providerId="ADAL" clId="{FB197852-8253-4B1D-875B-C85F492A99F3}" dt="2021-08-04T08:43:09.688" v="22" actId="20577"/>
          <ac:spMkLst>
            <pc:docMk/>
            <pc:sldMk cId="1153482099" sldId="267"/>
            <ac:spMk id="3" creationId="{00000000-0000-0000-0000-000000000000}"/>
          </ac:spMkLst>
        </pc:spChg>
      </pc:sldChg>
    </pc:docChg>
  </pc:docChgLst>
  <pc:docChgLst>
    <pc:chgData name="Cercamondi,Colin Ivano,CH-Vevey" userId="S::colinivano.cercamondi@nestle.com::d25e694c-3ff8-4193-82fc-75dd469e9cee" providerId="AD" clId="Web-{AD349A20-C998-1538-A84E-02CAEF4BE1FD}"/>
    <pc:docChg chg="modSld">
      <pc:chgData name="Cercamondi,Colin Ivano,CH-Vevey" userId="S::colinivano.cercamondi@nestle.com::d25e694c-3ff8-4193-82fc-75dd469e9cee" providerId="AD" clId="Web-{AD349A20-C998-1538-A84E-02CAEF4BE1FD}" dt="2020-10-05T15:26:55.825" v="3" actId="20577"/>
      <pc:docMkLst>
        <pc:docMk/>
      </pc:docMkLst>
      <pc:sldChg chg="modSp">
        <pc:chgData name="Cercamondi,Colin Ivano,CH-Vevey" userId="S::colinivano.cercamondi@nestle.com::d25e694c-3ff8-4193-82fc-75dd469e9cee" providerId="AD" clId="Web-{AD349A20-C998-1538-A84E-02CAEF4BE1FD}" dt="2020-10-05T15:26:55.825" v="2" actId="20577"/>
        <pc:sldMkLst>
          <pc:docMk/>
          <pc:sldMk cId="1299451647" sldId="257"/>
        </pc:sldMkLst>
        <pc:spChg chg="mod">
          <ac:chgData name="Cercamondi,Colin Ivano,CH-Vevey" userId="S::colinivano.cercamondi@nestle.com::d25e694c-3ff8-4193-82fc-75dd469e9cee" providerId="AD" clId="Web-{AD349A20-C998-1538-A84E-02CAEF4BE1FD}" dt="2020-10-05T15:26:55.825" v="2" actId="20577"/>
          <ac:spMkLst>
            <pc:docMk/>
            <pc:sldMk cId="1299451647" sldId="257"/>
            <ac:spMk id="3" creationId="{00000000-0000-0000-0000-000000000000}"/>
          </ac:spMkLst>
        </pc:spChg>
      </pc:sldChg>
    </pc:docChg>
  </pc:docChgLst>
  <pc:docChgLst>
    <pc:chgData name="Cercamondi,Colin Ivano,CH-Vevey" userId="d25e694c-3ff8-4193-82fc-75dd469e9cee" providerId="ADAL" clId="{7556EFC9-3E4B-4A98-97A3-718A1963B17F}"/>
    <pc:docChg chg="custSel modSld">
      <pc:chgData name="Cercamondi,Colin Ivano,CH-Vevey" userId="d25e694c-3ff8-4193-82fc-75dd469e9cee" providerId="ADAL" clId="{7556EFC9-3E4B-4A98-97A3-718A1963B17F}" dt="2021-09-23T21:26:50.983" v="2" actId="478"/>
      <pc:docMkLst>
        <pc:docMk/>
      </pc:docMkLst>
      <pc:sldChg chg="addSp delSp modSp mod">
        <pc:chgData name="Cercamondi,Colin Ivano,CH-Vevey" userId="d25e694c-3ff8-4193-82fc-75dd469e9cee" providerId="ADAL" clId="{7556EFC9-3E4B-4A98-97A3-718A1963B17F}" dt="2021-09-23T21:26:46.899" v="1" actId="478"/>
        <pc:sldMkLst>
          <pc:docMk/>
          <pc:sldMk cId="930360236" sldId="268"/>
        </pc:sldMkLst>
        <pc:spChg chg="add del mod">
          <ac:chgData name="Cercamondi,Colin Ivano,CH-Vevey" userId="d25e694c-3ff8-4193-82fc-75dd469e9cee" providerId="ADAL" clId="{7556EFC9-3E4B-4A98-97A3-718A1963B17F}" dt="2021-09-23T21:26:46.899" v="1" actId="478"/>
          <ac:spMkLst>
            <pc:docMk/>
            <pc:sldMk cId="930360236" sldId="268"/>
            <ac:spMk id="5" creationId="{15978F09-8086-486C-BA78-B08A5812C65E}"/>
          </ac:spMkLst>
        </pc:spChg>
        <pc:spChg chg="del">
          <ac:chgData name="Cercamondi,Colin Ivano,CH-Vevey" userId="d25e694c-3ff8-4193-82fc-75dd469e9cee" providerId="ADAL" clId="{7556EFC9-3E4B-4A98-97A3-718A1963B17F}" dt="2021-09-23T21:26:44.799" v="0" actId="478"/>
          <ac:spMkLst>
            <pc:docMk/>
            <pc:sldMk cId="930360236" sldId="268"/>
            <ac:spMk id="8" creationId="{7B982E0F-6EA6-41FF-9192-F503E669FB6C}"/>
          </ac:spMkLst>
        </pc:spChg>
      </pc:sldChg>
      <pc:sldChg chg="delSp mod">
        <pc:chgData name="Cercamondi,Colin Ivano,CH-Vevey" userId="d25e694c-3ff8-4193-82fc-75dd469e9cee" providerId="ADAL" clId="{7556EFC9-3E4B-4A98-97A3-718A1963B17F}" dt="2021-09-23T21:26:50.983" v="2" actId="478"/>
        <pc:sldMkLst>
          <pc:docMk/>
          <pc:sldMk cId="4229023287" sldId="271"/>
        </pc:sldMkLst>
        <pc:spChg chg="del">
          <ac:chgData name="Cercamondi,Colin Ivano,CH-Vevey" userId="d25e694c-3ff8-4193-82fc-75dd469e9cee" providerId="ADAL" clId="{7556EFC9-3E4B-4A98-97A3-718A1963B17F}" dt="2021-09-23T21:26:50.983" v="2" actId="478"/>
          <ac:spMkLst>
            <pc:docMk/>
            <pc:sldMk cId="4229023287" sldId="271"/>
            <ac:spMk id="7" creationId="{17F175C0-7928-44D5-B672-63EB5B37E480}"/>
          </ac:spMkLst>
        </pc:spChg>
      </pc:sldChg>
    </pc:docChg>
  </pc:docChgLst>
  <pc:docChgLst>
    <pc:chgData name="Kortman, Guus" userId="41e95c6d-0420-46db-8343-bb7e712699d8" providerId="ADAL" clId="{EB4D9AA7-9BE6-48E0-B268-99E8DC891A87}"/>
    <pc:docChg chg="undo custSel mod modSld">
      <pc:chgData name="Kortman, Guus" userId="41e95c6d-0420-46db-8343-bb7e712699d8" providerId="ADAL" clId="{EB4D9AA7-9BE6-48E0-B268-99E8DC891A87}" dt="2020-10-05T18:09:27.221" v="13" actId="1592"/>
      <pc:docMkLst>
        <pc:docMk/>
      </pc:docMkLst>
      <pc:sldChg chg="addSp delSp modSp delCm">
        <pc:chgData name="Kortman, Guus" userId="41e95c6d-0420-46db-8343-bb7e712699d8" providerId="ADAL" clId="{EB4D9AA7-9BE6-48E0-B268-99E8DC891A87}" dt="2020-10-05T15:34:46.996" v="6" actId="1076"/>
        <pc:sldMkLst>
          <pc:docMk/>
          <pc:sldMk cId="3481645440" sldId="259"/>
        </pc:sldMkLst>
        <pc:picChg chg="add mod">
          <ac:chgData name="Kortman, Guus" userId="41e95c6d-0420-46db-8343-bb7e712699d8" providerId="ADAL" clId="{EB4D9AA7-9BE6-48E0-B268-99E8DC891A87}" dt="2020-10-05T15:34:46.996" v="6" actId="1076"/>
          <ac:picMkLst>
            <pc:docMk/>
            <pc:sldMk cId="3481645440" sldId="259"/>
            <ac:picMk id="5" creationId="{0878DFAD-2D83-4878-AFCE-DC3701920568}"/>
          </ac:picMkLst>
        </pc:picChg>
        <pc:picChg chg="del">
          <ac:chgData name="Kortman, Guus" userId="41e95c6d-0420-46db-8343-bb7e712699d8" providerId="ADAL" clId="{EB4D9AA7-9BE6-48E0-B268-99E8DC891A87}" dt="2020-10-05T15:34:39.552" v="3" actId="478"/>
          <ac:picMkLst>
            <pc:docMk/>
            <pc:sldMk cId="3481645440" sldId="259"/>
            <ac:picMk id="6" creationId="{0819C97F-1F32-4E7A-A0F4-519AFDA91A7F}"/>
          </ac:picMkLst>
        </pc:picChg>
      </pc:sldChg>
      <pc:sldChg chg="addSp delSp modSp mod setBg delCm">
        <pc:chgData name="Kortman, Guus" userId="41e95c6d-0420-46db-8343-bb7e712699d8" providerId="ADAL" clId="{EB4D9AA7-9BE6-48E0-B268-99E8DC891A87}" dt="2020-10-05T18:09:27.221" v="13" actId="1592"/>
        <pc:sldMkLst>
          <pc:docMk/>
          <pc:sldMk cId="3249222257" sldId="263"/>
        </pc:sldMkLst>
        <pc:spChg chg="mod ord">
          <ac:chgData name="Kortman, Guus" userId="41e95c6d-0420-46db-8343-bb7e712699d8" providerId="ADAL" clId="{EB4D9AA7-9BE6-48E0-B268-99E8DC891A87}" dt="2020-10-05T18:09:22.121" v="12" actId="26606"/>
          <ac:spMkLst>
            <pc:docMk/>
            <pc:sldMk cId="3249222257" sldId="263"/>
            <ac:spMk id="2" creationId="{88105DD8-232D-46AA-98B2-E5ADEF8FA725}"/>
          </ac:spMkLst>
        </pc:spChg>
        <pc:spChg chg="add del">
          <ac:chgData name="Kortman, Guus" userId="41e95c6d-0420-46db-8343-bb7e712699d8" providerId="ADAL" clId="{EB4D9AA7-9BE6-48E0-B268-99E8DC891A87}" dt="2020-10-05T18:09:22.121" v="12" actId="26606"/>
          <ac:spMkLst>
            <pc:docMk/>
            <pc:sldMk cId="3249222257" sldId="263"/>
            <ac:spMk id="10" creationId="{4351DFE5-F63D-4BE0-BDA9-E3EB88F01AA5}"/>
          </ac:spMkLst>
        </pc:spChg>
        <pc:picChg chg="mod ord">
          <ac:chgData name="Kortman, Guus" userId="41e95c6d-0420-46db-8343-bb7e712699d8" providerId="ADAL" clId="{EB4D9AA7-9BE6-48E0-B268-99E8DC891A87}" dt="2020-10-05T18:09:22.121" v="12" actId="26606"/>
          <ac:picMkLst>
            <pc:docMk/>
            <pc:sldMk cId="3249222257" sldId="263"/>
            <ac:picMk id="3" creationId="{63572A93-E725-4C75-BF31-6E8A7DC4E859}"/>
          </ac:picMkLst>
        </pc:picChg>
        <pc:picChg chg="del">
          <ac:chgData name="Kortman, Guus" userId="41e95c6d-0420-46db-8343-bb7e712699d8" providerId="ADAL" clId="{EB4D9AA7-9BE6-48E0-B268-99E8DC891A87}" dt="2020-10-05T18:09:08.868" v="7" actId="478"/>
          <ac:picMkLst>
            <pc:docMk/>
            <pc:sldMk cId="3249222257" sldId="263"/>
            <ac:picMk id="4" creationId="{6B65013A-E1CE-424F-8F27-D492B616BC05}"/>
          </ac:picMkLst>
        </pc:picChg>
        <pc:picChg chg="add mod">
          <ac:chgData name="Kortman, Guus" userId="41e95c6d-0420-46db-8343-bb7e712699d8" providerId="ADAL" clId="{EB4D9AA7-9BE6-48E0-B268-99E8DC891A87}" dt="2020-10-05T18:09:22.121" v="12" actId="26606"/>
          <ac:picMkLst>
            <pc:docMk/>
            <pc:sldMk cId="3249222257" sldId="263"/>
            <ac:picMk id="5" creationId="{20D52804-70B5-48CB-BF98-BFAFF586588D}"/>
          </ac:picMkLst>
        </pc:picChg>
        <pc:picChg chg="add del">
          <ac:chgData name="Kortman, Guus" userId="41e95c6d-0420-46db-8343-bb7e712699d8" providerId="ADAL" clId="{EB4D9AA7-9BE6-48E0-B268-99E8DC891A87}" dt="2020-10-05T18:09:22.121" v="12" actId="26606"/>
          <ac:picMkLst>
            <pc:docMk/>
            <pc:sldMk cId="3249222257" sldId="263"/>
            <ac:picMk id="12" creationId="{02DD2BC0-6F29-4B4F-8D61-2DCF6D2E8E73}"/>
          </ac:picMkLst>
        </pc:picChg>
      </pc:sldChg>
      <pc:sldChg chg="addSp modSp">
        <pc:chgData name="Kortman, Guus" userId="41e95c6d-0420-46db-8343-bb7e712699d8" providerId="ADAL" clId="{EB4D9AA7-9BE6-48E0-B268-99E8DC891A87}" dt="2020-10-05T15:17:51.633" v="1" actId="1076"/>
        <pc:sldMkLst>
          <pc:docMk/>
          <pc:sldMk cId="1915425" sldId="265"/>
        </pc:sldMkLst>
        <pc:graphicFrameChg chg="add mod">
          <ac:chgData name="Kortman, Guus" userId="41e95c6d-0420-46db-8343-bb7e712699d8" providerId="ADAL" clId="{EB4D9AA7-9BE6-48E0-B268-99E8DC891A87}" dt="2020-10-05T15:17:51.633" v="1" actId="1076"/>
          <ac:graphicFrameMkLst>
            <pc:docMk/>
            <pc:sldMk cId="1915425" sldId="265"/>
            <ac:graphicFrameMk id="5" creationId="{0A7BE4EC-0AF0-41F5-81F2-EDC8962D0A27}"/>
          </ac:graphicFrameMkLst>
        </pc:graphicFrameChg>
      </pc:sldChg>
    </pc:docChg>
  </pc:docChgLst>
  <pc:docChgLst>
    <pc:chgData name="Cercamondi,Colin Ivano,CH-Vevey" userId="d25e694c-3ff8-4193-82fc-75dd469e9cee" providerId="ADAL" clId="{9803B14A-C731-4724-9458-B2A6C31E0D3F}"/>
    <pc:docChg chg="undo custSel mod modSld">
      <pc:chgData name="Cercamondi,Colin Ivano,CH-Vevey" userId="d25e694c-3ff8-4193-82fc-75dd469e9cee" providerId="ADAL" clId="{9803B14A-C731-4724-9458-B2A6C31E0D3F}" dt="2021-02-19T16:34:50.408" v="91" actId="1592"/>
      <pc:docMkLst>
        <pc:docMk/>
      </pc:docMkLst>
      <pc:sldChg chg="addSp delSp modSp mod setBg delCm">
        <pc:chgData name="Cercamondi,Colin Ivano,CH-Vevey" userId="d25e694c-3ff8-4193-82fc-75dd469e9cee" providerId="ADAL" clId="{9803B14A-C731-4724-9458-B2A6C31E0D3F}" dt="2021-02-19T13:01:29.448" v="90" actId="14100"/>
        <pc:sldMkLst>
          <pc:docMk/>
          <pc:sldMk cId="1210609011" sldId="264"/>
        </pc:sldMkLst>
        <pc:spChg chg="mod">
          <ac:chgData name="Cercamondi,Colin Ivano,CH-Vevey" userId="d25e694c-3ff8-4193-82fc-75dd469e9cee" providerId="ADAL" clId="{9803B14A-C731-4724-9458-B2A6C31E0D3F}" dt="2021-02-19T13:00:40.624" v="12" actId="26606"/>
          <ac:spMkLst>
            <pc:docMk/>
            <pc:sldMk cId="1210609011" sldId="264"/>
            <ac:spMk id="2" creationId="{00000000-0000-0000-0000-000000000000}"/>
          </ac:spMkLst>
        </pc:spChg>
        <pc:spChg chg="add del">
          <ac:chgData name="Cercamondi,Colin Ivano,CH-Vevey" userId="d25e694c-3ff8-4193-82fc-75dd469e9cee" providerId="ADAL" clId="{9803B14A-C731-4724-9458-B2A6C31E0D3F}" dt="2021-02-19T13:00:40.624" v="12" actId="26606"/>
          <ac:spMkLst>
            <pc:docMk/>
            <pc:sldMk cId="1210609011" sldId="264"/>
            <ac:spMk id="9" creationId="{A4AC5506-6312-4701-8D3C-40187889A947}"/>
          </ac:spMkLst>
        </pc:spChg>
        <pc:picChg chg="add mod">
          <ac:chgData name="Cercamondi,Colin Ivano,CH-Vevey" userId="d25e694c-3ff8-4193-82fc-75dd469e9cee" providerId="ADAL" clId="{9803B14A-C731-4724-9458-B2A6C31E0D3F}" dt="2021-02-19T13:01:29.448" v="90" actId="14100"/>
          <ac:picMkLst>
            <pc:docMk/>
            <pc:sldMk cId="1210609011" sldId="264"/>
            <ac:picMk id="4" creationId="{EB981D13-5830-4D2E-8BD9-836AE5B81F46}"/>
          </ac:picMkLst>
        </pc:picChg>
        <pc:picChg chg="del">
          <ac:chgData name="Cercamondi,Colin Ivano,CH-Vevey" userId="d25e694c-3ff8-4193-82fc-75dd469e9cee" providerId="ADAL" clId="{9803B14A-C731-4724-9458-B2A6C31E0D3F}" dt="2021-02-19T12:59:46.666" v="6" actId="478"/>
          <ac:picMkLst>
            <pc:docMk/>
            <pc:sldMk cId="1210609011" sldId="264"/>
            <ac:picMk id="5" creationId="{F17739DB-1853-4405-8DEA-20047D0726DE}"/>
          </ac:picMkLst>
        </pc:picChg>
      </pc:sldChg>
      <pc:sldChg chg="delCm">
        <pc:chgData name="Cercamondi,Colin Ivano,CH-Vevey" userId="d25e694c-3ff8-4193-82fc-75dd469e9cee" providerId="ADAL" clId="{9803B14A-C731-4724-9458-B2A6C31E0D3F}" dt="2021-02-19T12:41:04.194" v="5" actId="1592"/>
        <pc:sldMkLst>
          <pc:docMk/>
          <pc:sldMk cId="4229023287" sldId="268"/>
        </pc:sldMkLst>
      </pc:sldChg>
      <pc:sldChg chg="addCm delCm modCm">
        <pc:chgData name="Cercamondi,Colin Ivano,CH-Vevey" userId="d25e694c-3ff8-4193-82fc-75dd469e9cee" providerId="ADAL" clId="{9803B14A-C731-4724-9458-B2A6C31E0D3F}" dt="2021-02-19T16:34:50.408" v="91" actId="1592"/>
        <pc:sldMkLst>
          <pc:docMk/>
          <pc:sldMk cId="4181099377" sldId="274"/>
        </pc:sldMkLst>
      </pc:sldChg>
    </pc:docChg>
  </pc:docChgLst>
  <pc:docChgLst>
    <pc:chgData name="Kortman, Guus" userId="41e95c6d-0420-46db-8343-bb7e712699d8" providerId="ADAL" clId="{CB1AEFFD-7B4B-4A11-9476-CFAED6D7EA43}"/>
    <pc:docChg chg="custSel modSld">
      <pc:chgData name="Kortman, Guus" userId="41e95c6d-0420-46db-8343-bb7e712699d8" providerId="ADAL" clId="{CB1AEFFD-7B4B-4A11-9476-CFAED6D7EA43}" dt="2020-10-05T15:12:57.642" v="29" actId="478"/>
      <pc:docMkLst>
        <pc:docMk/>
      </pc:docMkLst>
      <pc:sldChg chg="addSp delSp modSp delCm">
        <pc:chgData name="Kortman, Guus" userId="41e95c6d-0420-46db-8343-bb7e712699d8" providerId="ADAL" clId="{CB1AEFFD-7B4B-4A11-9476-CFAED6D7EA43}" dt="2020-10-05T14:58:04.931" v="12" actId="1076"/>
        <pc:sldMkLst>
          <pc:docMk/>
          <pc:sldMk cId="1299451647" sldId="257"/>
        </pc:sldMkLst>
        <pc:picChg chg="add mod">
          <ac:chgData name="Kortman, Guus" userId="41e95c6d-0420-46db-8343-bb7e712699d8" providerId="ADAL" clId="{CB1AEFFD-7B4B-4A11-9476-CFAED6D7EA43}" dt="2020-10-05T14:57:17.830" v="6" actId="1076"/>
          <ac:picMkLst>
            <pc:docMk/>
            <pc:sldMk cId="1299451647" sldId="257"/>
            <ac:picMk id="4" creationId="{07B678AA-EBCA-45B1-9B14-268888E0BE28}"/>
          </ac:picMkLst>
        </pc:picChg>
        <pc:picChg chg="add mod">
          <ac:chgData name="Kortman, Guus" userId="41e95c6d-0420-46db-8343-bb7e712699d8" providerId="ADAL" clId="{CB1AEFFD-7B4B-4A11-9476-CFAED6D7EA43}" dt="2020-10-05T14:58:04.931" v="12" actId="1076"/>
          <ac:picMkLst>
            <pc:docMk/>
            <pc:sldMk cId="1299451647" sldId="257"/>
            <ac:picMk id="5" creationId="{81702BDC-7DEB-448F-AFE4-8BF6F6171D74}"/>
          </ac:picMkLst>
        </pc:picChg>
        <pc:picChg chg="del">
          <ac:chgData name="Kortman, Guus" userId="41e95c6d-0420-46db-8343-bb7e712699d8" providerId="ADAL" clId="{CB1AEFFD-7B4B-4A11-9476-CFAED6D7EA43}" dt="2020-10-05T14:57:10.177" v="3" actId="478"/>
          <ac:picMkLst>
            <pc:docMk/>
            <pc:sldMk cId="1299451647" sldId="257"/>
            <ac:picMk id="6" creationId="{49AE908C-8BE3-484D-8DF6-D3C2682A8E41}"/>
          </ac:picMkLst>
        </pc:picChg>
        <pc:picChg chg="del">
          <ac:chgData name="Kortman, Guus" userId="41e95c6d-0420-46db-8343-bb7e712699d8" providerId="ADAL" clId="{CB1AEFFD-7B4B-4A11-9476-CFAED6D7EA43}" dt="2020-10-05T14:57:23.859" v="8" actId="478"/>
          <ac:picMkLst>
            <pc:docMk/>
            <pc:sldMk cId="1299451647" sldId="257"/>
            <ac:picMk id="7" creationId="{5F80410C-8B9E-4299-8B2D-E24C85DA702C}"/>
          </ac:picMkLst>
        </pc:picChg>
      </pc:sldChg>
      <pc:sldChg chg="addCm modCm">
        <pc:chgData name="Kortman, Guus" userId="41e95c6d-0420-46db-8343-bb7e712699d8" providerId="ADAL" clId="{CB1AEFFD-7B4B-4A11-9476-CFAED6D7EA43}" dt="2020-09-29T14:26:21.787" v="2" actId="5900"/>
        <pc:sldMkLst>
          <pc:docMk/>
          <pc:sldMk cId="3481645440" sldId="259"/>
        </pc:sldMkLst>
      </pc:sldChg>
      <pc:sldChg chg="addSp delSp modSp">
        <pc:chgData name="Kortman, Guus" userId="41e95c6d-0420-46db-8343-bb7e712699d8" providerId="ADAL" clId="{CB1AEFFD-7B4B-4A11-9476-CFAED6D7EA43}" dt="2020-10-05T15:03:21.849" v="22" actId="1076"/>
        <pc:sldMkLst>
          <pc:docMk/>
          <pc:sldMk cId="3249222257" sldId="263"/>
        </pc:sldMkLst>
        <pc:picChg chg="add mod">
          <ac:chgData name="Kortman, Guus" userId="41e95c6d-0420-46db-8343-bb7e712699d8" providerId="ADAL" clId="{CB1AEFFD-7B4B-4A11-9476-CFAED6D7EA43}" dt="2020-10-05T15:03:21.849" v="22" actId="1076"/>
          <ac:picMkLst>
            <pc:docMk/>
            <pc:sldMk cId="3249222257" sldId="263"/>
            <ac:picMk id="3" creationId="{63572A93-E725-4C75-BF31-6E8A7DC4E859}"/>
          </ac:picMkLst>
        </pc:picChg>
        <pc:picChg chg="del">
          <ac:chgData name="Kortman, Guus" userId="41e95c6d-0420-46db-8343-bb7e712699d8" providerId="ADAL" clId="{CB1AEFFD-7B4B-4A11-9476-CFAED6D7EA43}" dt="2020-10-05T15:03:15.853" v="20" actId="478"/>
          <ac:picMkLst>
            <pc:docMk/>
            <pc:sldMk cId="3249222257" sldId="263"/>
            <ac:picMk id="5" creationId="{D4CDA747-8074-448C-98A7-87E3E693A247}"/>
          </ac:picMkLst>
        </pc:picChg>
      </pc:sldChg>
      <pc:sldChg chg="addSp delSp modSp delCm">
        <pc:chgData name="Kortman, Guus" userId="41e95c6d-0420-46db-8343-bb7e712699d8" providerId="ADAL" clId="{CB1AEFFD-7B4B-4A11-9476-CFAED6D7EA43}" dt="2020-10-05T15:12:57.642" v="29" actId="478"/>
        <pc:sldMkLst>
          <pc:docMk/>
          <pc:sldMk cId="1915425" sldId="265"/>
        </pc:sldMkLst>
        <pc:graphicFrameChg chg="add del mod">
          <ac:chgData name="Kortman, Guus" userId="41e95c6d-0420-46db-8343-bb7e712699d8" providerId="ADAL" clId="{CB1AEFFD-7B4B-4A11-9476-CFAED6D7EA43}" dt="2020-10-05T15:12:57.642" v="29" actId="478"/>
          <ac:graphicFrameMkLst>
            <pc:docMk/>
            <pc:sldMk cId="1915425" sldId="265"/>
            <ac:graphicFrameMk id="5" creationId="{A605F5E8-0D9A-4757-AF66-6BADC8E67A0F}"/>
          </ac:graphicFrameMkLst>
        </pc:graphicFrameChg>
        <pc:graphicFrameChg chg="del">
          <ac:chgData name="Kortman, Guus" userId="41e95c6d-0420-46db-8343-bb7e712699d8" providerId="ADAL" clId="{CB1AEFFD-7B4B-4A11-9476-CFAED6D7EA43}" dt="2020-10-05T15:11:02.665" v="23" actId="478"/>
          <ac:graphicFrameMkLst>
            <pc:docMk/>
            <pc:sldMk cId="1915425" sldId="265"/>
            <ac:graphicFrameMk id="6" creationId="{327C24CF-8A97-4264-8AA8-8A8BE5230C3D}"/>
          </ac:graphicFrameMkLst>
        </pc:graphicFrameChg>
      </pc:sldChg>
      <pc:sldChg chg="addSp delSp modSp delCm">
        <pc:chgData name="Kortman, Guus" userId="41e95c6d-0420-46db-8343-bb7e712699d8" providerId="ADAL" clId="{CB1AEFFD-7B4B-4A11-9476-CFAED6D7EA43}" dt="2020-10-05T14:59:05.850" v="19" actId="1592"/>
        <pc:sldMkLst>
          <pc:docMk/>
          <pc:sldMk cId="1790202609" sldId="266"/>
        </pc:sldMkLst>
        <pc:picChg chg="del">
          <ac:chgData name="Kortman, Guus" userId="41e95c6d-0420-46db-8343-bb7e712699d8" providerId="ADAL" clId="{CB1AEFFD-7B4B-4A11-9476-CFAED6D7EA43}" dt="2020-10-05T14:58:30.389" v="13" actId="478"/>
          <ac:picMkLst>
            <pc:docMk/>
            <pc:sldMk cId="1790202609" sldId="266"/>
            <ac:picMk id="5" creationId="{F1E1E3DC-862D-4B91-AAE7-7B00BB685165}"/>
          </ac:picMkLst>
        </pc:picChg>
        <pc:picChg chg="add mod">
          <ac:chgData name="Kortman, Guus" userId="41e95c6d-0420-46db-8343-bb7e712699d8" providerId="ADAL" clId="{CB1AEFFD-7B4B-4A11-9476-CFAED6D7EA43}" dt="2020-10-05T14:59:02.429" v="18" actId="1076"/>
          <ac:picMkLst>
            <pc:docMk/>
            <pc:sldMk cId="1790202609" sldId="266"/>
            <ac:picMk id="6" creationId="{6FED7408-CDED-4F4C-932A-DA0B386B3F4E}"/>
          </ac:picMkLst>
        </pc:picChg>
      </pc:sldChg>
    </pc:docChg>
  </pc:docChgLst>
  <pc:docChgLst>
    <pc:chgData name="Kortman, Guus" userId="41e95c6d-0420-46db-8343-bb7e712699d8" providerId="ADAL" clId="{90D702C7-6408-4DA9-B7B1-965883B51AFD}"/>
    <pc:docChg chg="undo custSel modSld">
      <pc:chgData name="Kortman, Guus" userId="41e95c6d-0420-46db-8343-bb7e712699d8" providerId="ADAL" clId="{90D702C7-6408-4DA9-B7B1-965883B51AFD}" dt="2020-09-28T10:34:42.779" v="1461" actId="20577"/>
      <pc:docMkLst>
        <pc:docMk/>
      </pc:docMkLst>
      <pc:sldChg chg="addSp delSp modSp">
        <pc:chgData name="Kortman, Guus" userId="41e95c6d-0420-46db-8343-bb7e712699d8" providerId="ADAL" clId="{90D702C7-6408-4DA9-B7B1-965883B51AFD}" dt="2020-09-28T09:58:00.310" v="975" actId="20577"/>
        <pc:sldMkLst>
          <pc:docMk/>
          <pc:sldMk cId="1299451647" sldId="257"/>
        </pc:sldMkLst>
        <pc:spChg chg="mod">
          <ac:chgData name="Kortman, Guus" userId="41e95c6d-0420-46db-8343-bb7e712699d8" providerId="ADAL" clId="{90D702C7-6408-4DA9-B7B1-965883B51AFD}" dt="2020-09-28T09:58:00.310" v="975" actId="20577"/>
          <ac:spMkLst>
            <pc:docMk/>
            <pc:sldMk cId="1299451647" sldId="257"/>
            <ac:spMk id="3" creationId="{00000000-0000-0000-0000-000000000000}"/>
          </ac:spMkLst>
        </pc:spChg>
        <pc:picChg chg="add del">
          <ac:chgData name="Kortman, Guus" userId="41e95c6d-0420-46db-8343-bb7e712699d8" providerId="ADAL" clId="{90D702C7-6408-4DA9-B7B1-965883B51AFD}" dt="2020-09-28T09:37:45.650" v="864" actId="478"/>
          <ac:picMkLst>
            <pc:docMk/>
            <pc:sldMk cId="1299451647" sldId="257"/>
            <ac:picMk id="4" creationId="{D16E0238-7CCD-4037-92F9-C584AD562906}"/>
          </ac:picMkLst>
        </pc:picChg>
        <pc:picChg chg="del">
          <ac:chgData name="Kortman, Guus" userId="41e95c6d-0420-46db-8343-bb7e712699d8" providerId="ADAL" clId="{90D702C7-6408-4DA9-B7B1-965883B51AFD}" dt="2020-09-28T09:28:04.033" v="856" actId="478"/>
          <ac:picMkLst>
            <pc:docMk/>
            <pc:sldMk cId="1299451647" sldId="257"/>
            <ac:picMk id="5" creationId="{F275F451-16F7-4A31-AEB5-47A6FEF1D6D1}"/>
          </ac:picMkLst>
        </pc:picChg>
        <pc:picChg chg="add mod">
          <ac:chgData name="Kortman, Guus" userId="41e95c6d-0420-46db-8343-bb7e712699d8" providerId="ADAL" clId="{90D702C7-6408-4DA9-B7B1-965883B51AFD}" dt="2020-09-28T09:28:17.444" v="861" actId="1076"/>
          <ac:picMkLst>
            <pc:docMk/>
            <pc:sldMk cId="1299451647" sldId="257"/>
            <ac:picMk id="6" creationId="{49AE908C-8BE3-484D-8DF6-D3C2682A8E41}"/>
          </ac:picMkLst>
        </pc:picChg>
        <pc:picChg chg="add mod">
          <ac:chgData name="Kortman, Guus" userId="41e95c6d-0420-46db-8343-bb7e712699d8" providerId="ADAL" clId="{90D702C7-6408-4DA9-B7B1-965883B51AFD}" dt="2020-09-28T09:37:57.277" v="869" actId="1076"/>
          <ac:picMkLst>
            <pc:docMk/>
            <pc:sldMk cId="1299451647" sldId="257"/>
            <ac:picMk id="7" creationId="{5F80410C-8B9E-4299-8B2D-E24C85DA702C}"/>
          </ac:picMkLst>
        </pc:picChg>
      </pc:sldChg>
      <pc:sldChg chg="modSp">
        <pc:chgData name="Kortman, Guus" userId="41e95c6d-0420-46db-8343-bb7e712699d8" providerId="ADAL" clId="{90D702C7-6408-4DA9-B7B1-965883B51AFD}" dt="2020-09-28T10:07:36.641" v="1162" actId="207"/>
        <pc:sldMkLst>
          <pc:docMk/>
          <pc:sldMk cId="3574380604" sldId="258"/>
        </pc:sldMkLst>
        <pc:spChg chg="mod">
          <ac:chgData name="Kortman, Guus" userId="41e95c6d-0420-46db-8343-bb7e712699d8" providerId="ADAL" clId="{90D702C7-6408-4DA9-B7B1-965883B51AFD}" dt="2020-09-28T10:07:36.641" v="1162" actId="207"/>
          <ac:spMkLst>
            <pc:docMk/>
            <pc:sldMk cId="3574380604" sldId="258"/>
            <ac:spMk id="3" creationId="{00000000-0000-0000-0000-000000000000}"/>
          </ac:spMkLst>
        </pc:spChg>
      </pc:sldChg>
      <pc:sldChg chg="modSp">
        <pc:chgData name="Kortman, Guus" userId="41e95c6d-0420-46db-8343-bb7e712699d8" providerId="ADAL" clId="{90D702C7-6408-4DA9-B7B1-965883B51AFD}" dt="2020-09-28T10:06:23.835" v="1161" actId="20577"/>
        <pc:sldMkLst>
          <pc:docMk/>
          <pc:sldMk cId="3481645440" sldId="259"/>
        </pc:sldMkLst>
        <pc:spChg chg="mod">
          <ac:chgData name="Kortman, Guus" userId="41e95c6d-0420-46db-8343-bb7e712699d8" providerId="ADAL" clId="{90D702C7-6408-4DA9-B7B1-965883B51AFD}" dt="2020-09-28T10:06:23.835" v="1161" actId="20577"/>
          <ac:spMkLst>
            <pc:docMk/>
            <pc:sldMk cId="3481645440" sldId="259"/>
            <ac:spMk id="3" creationId="{00000000-0000-0000-0000-000000000000}"/>
          </ac:spMkLst>
        </pc:spChg>
      </pc:sldChg>
      <pc:sldChg chg="addSp delSp modSp">
        <pc:chgData name="Kortman, Guus" userId="41e95c6d-0420-46db-8343-bb7e712699d8" providerId="ADAL" clId="{90D702C7-6408-4DA9-B7B1-965883B51AFD}" dt="2020-09-28T10:34:42.779" v="1461" actId="20577"/>
        <pc:sldMkLst>
          <pc:docMk/>
          <pc:sldMk cId="3261540884" sldId="260"/>
        </pc:sldMkLst>
        <pc:spChg chg="mod">
          <ac:chgData name="Kortman, Guus" userId="41e95c6d-0420-46db-8343-bb7e712699d8" providerId="ADAL" clId="{90D702C7-6408-4DA9-B7B1-965883B51AFD}" dt="2020-09-28T10:34:42.779" v="1461" actId="20577"/>
          <ac:spMkLst>
            <pc:docMk/>
            <pc:sldMk cId="3261540884" sldId="260"/>
            <ac:spMk id="3" creationId="{00000000-0000-0000-0000-000000000000}"/>
          </ac:spMkLst>
        </pc:spChg>
        <pc:picChg chg="del">
          <ac:chgData name="Kortman, Guus" userId="41e95c6d-0420-46db-8343-bb7e712699d8" providerId="ADAL" clId="{90D702C7-6408-4DA9-B7B1-965883B51AFD}" dt="2020-09-28T10:11:06.597" v="1169" actId="478"/>
          <ac:picMkLst>
            <pc:docMk/>
            <pc:sldMk cId="3261540884" sldId="260"/>
            <ac:picMk id="4" creationId="{68D51F3A-36FD-4657-9FC1-A2437CBEE3E3}"/>
          </ac:picMkLst>
        </pc:picChg>
        <pc:picChg chg="del">
          <ac:chgData name="Kortman, Guus" userId="41e95c6d-0420-46db-8343-bb7e712699d8" providerId="ADAL" clId="{90D702C7-6408-4DA9-B7B1-965883B51AFD}" dt="2020-09-28T10:13:18.856" v="1174" actId="478"/>
          <ac:picMkLst>
            <pc:docMk/>
            <pc:sldMk cId="3261540884" sldId="260"/>
            <ac:picMk id="5" creationId="{633892B0-5E85-492C-8A6C-5C66B7776321}"/>
          </ac:picMkLst>
        </pc:picChg>
        <pc:picChg chg="del">
          <ac:chgData name="Kortman, Guus" userId="41e95c6d-0420-46db-8343-bb7e712699d8" providerId="ADAL" clId="{90D702C7-6408-4DA9-B7B1-965883B51AFD}" dt="2020-09-28T10:25:53.051" v="1185" actId="478"/>
          <ac:picMkLst>
            <pc:docMk/>
            <pc:sldMk cId="3261540884" sldId="260"/>
            <ac:picMk id="6" creationId="{C7B81B08-93DA-4687-B79C-B13BDB3059CE}"/>
          </ac:picMkLst>
        </pc:picChg>
        <pc:picChg chg="add mod">
          <ac:chgData name="Kortman, Guus" userId="41e95c6d-0420-46db-8343-bb7e712699d8" providerId="ADAL" clId="{90D702C7-6408-4DA9-B7B1-965883B51AFD}" dt="2020-09-28T10:11:14.556" v="1173" actId="1076"/>
          <ac:picMkLst>
            <pc:docMk/>
            <pc:sldMk cId="3261540884" sldId="260"/>
            <ac:picMk id="7" creationId="{6FD4A128-53D0-44D5-8022-E6D66A8603CF}"/>
          </ac:picMkLst>
        </pc:picChg>
        <pc:picChg chg="add del mod">
          <ac:chgData name="Kortman, Guus" userId="41e95c6d-0420-46db-8343-bb7e712699d8" providerId="ADAL" clId="{90D702C7-6408-4DA9-B7B1-965883B51AFD}" dt="2020-09-28T10:24:00.818" v="1180" actId="478"/>
          <ac:picMkLst>
            <pc:docMk/>
            <pc:sldMk cId="3261540884" sldId="260"/>
            <ac:picMk id="8" creationId="{09634895-3ECF-4DA6-A8C9-FEB35400334E}"/>
          </ac:picMkLst>
        </pc:picChg>
        <pc:picChg chg="add mod">
          <ac:chgData name="Kortman, Guus" userId="41e95c6d-0420-46db-8343-bb7e712699d8" providerId="ADAL" clId="{90D702C7-6408-4DA9-B7B1-965883B51AFD}" dt="2020-09-28T10:24:09.580" v="1184" actId="14100"/>
          <ac:picMkLst>
            <pc:docMk/>
            <pc:sldMk cId="3261540884" sldId="260"/>
            <ac:picMk id="9" creationId="{752EDCCB-31CC-406D-B7A2-D86F31DD013B}"/>
          </ac:picMkLst>
        </pc:picChg>
        <pc:picChg chg="add mod">
          <ac:chgData name="Kortman, Guus" userId="41e95c6d-0420-46db-8343-bb7e712699d8" providerId="ADAL" clId="{90D702C7-6408-4DA9-B7B1-965883B51AFD}" dt="2020-09-28T10:26:03.868" v="1189" actId="14100"/>
          <ac:picMkLst>
            <pc:docMk/>
            <pc:sldMk cId="3261540884" sldId="260"/>
            <ac:picMk id="10" creationId="{E1E211D5-9EA0-40CF-B930-E1D82F07F433}"/>
          </ac:picMkLst>
        </pc:picChg>
      </pc:sldChg>
      <pc:sldChg chg="modSp addCm modCm">
        <pc:chgData name="Kortman, Guus" userId="41e95c6d-0420-46db-8343-bb7e712699d8" providerId="ADAL" clId="{90D702C7-6408-4DA9-B7B1-965883B51AFD}" dt="2020-09-28T10:09:14.383" v="1168"/>
        <pc:sldMkLst>
          <pc:docMk/>
          <pc:sldMk cId="1876531822" sldId="261"/>
        </pc:sldMkLst>
        <pc:spChg chg="mod">
          <ac:chgData name="Kortman, Guus" userId="41e95c6d-0420-46db-8343-bb7e712699d8" providerId="ADAL" clId="{90D702C7-6408-4DA9-B7B1-965883B51AFD}" dt="2020-09-28T10:04:13.703" v="1071" actId="20577"/>
          <ac:spMkLst>
            <pc:docMk/>
            <pc:sldMk cId="1876531822" sldId="261"/>
            <ac:spMk id="3" creationId="{00000000-0000-0000-0000-000000000000}"/>
          </ac:spMkLst>
        </pc:spChg>
      </pc:sldChg>
      <pc:sldChg chg="addSp modSp">
        <pc:chgData name="Kortman, Guus" userId="41e95c6d-0420-46db-8343-bb7e712699d8" providerId="ADAL" clId="{90D702C7-6408-4DA9-B7B1-965883B51AFD}" dt="2020-09-28T09:15:59.806" v="855" actId="20577"/>
        <pc:sldMkLst>
          <pc:docMk/>
          <pc:sldMk cId="907894339" sldId="262"/>
        </pc:sldMkLst>
        <pc:spChg chg="mod">
          <ac:chgData name="Kortman, Guus" userId="41e95c6d-0420-46db-8343-bb7e712699d8" providerId="ADAL" clId="{90D702C7-6408-4DA9-B7B1-965883B51AFD}" dt="2020-09-28T09:15:59.806" v="855" actId="20577"/>
          <ac:spMkLst>
            <pc:docMk/>
            <pc:sldMk cId="907894339" sldId="262"/>
            <ac:spMk id="3" creationId="{00000000-0000-0000-0000-000000000000}"/>
          </ac:spMkLst>
        </pc:spChg>
        <pc:spChg chg="add mod">
          <ac:chgData name="Kortman, Guus" userId="41e95c6d-0420-46db-8343-bb7e712699d8" providerId="ADAL" clId="{90D702C7-6408-4DA9-B7B1-965883B51AFD}" dt="2020-09-28T09:13:08.940" v="651" actId="1035"/>
          <ac:spMkLst>
            <pc:docMk/>
            <pc:sldMk cId="907894339" sldId="262"/>
            <ac:spMk id="6" creationId="{92CAFDC8-999F-4800-B85F-F60D7E98E0E1}"/>
          </ac:spMkLst>
        </pc:spChg>
        <pc:spChg chg="add mod">
          <ac:chgData name="Kortman, Guus" userId="41e95c6d-0420-46db-8343-bb7e712699d8" providerId="ADAL" clId="{90D702C7-6408-4DA9-B7B1-965883B51AFD}" dt="2020-09-28T09:13:08.940" v="651" actId="1035"/>
          <ac:spMkLst>
            <pc:docMk/>
            <pc:sldMk cId="907894339" sldId="262"/>
            <ac:spMk id="7" creationId="{353B68AC-5DB7-4784-9867-3FDC9D74DE6E}"/>
          </ac:spMkLst>
        </pc:spChg>
        <pc:picChg chg="add mod">
          <ac:chgData name="Kortman, Guus" userId="41e95c6d-0420-46db-8343-bb7e712699d8" providerId="ADAL" clId="{90D702C7-6408-4DA9-B7B1-965883B51AFD}" dt="2020-09-28T09:13:08.940" v="651" actId="1035"/>
          <ac:picMkLst>
            <pc:docMk/>
            <pc:sldMk cId="907894339" sldId="262"/>
            <ac:picMk id="4" creationId="{54DA59D2-506D-4A60-B0C2-BD0B056E9695}"/>
          </ac:picMkLst>
        </pc:picChg>
        <pc:picChg chg="add mod">
          <ac:chgData name="Kortman, Guus" userId="41e95c6d-0420-46db-8343-bb7e712699d8" providerId="ADAL" clId="{90D702C7-6408-4DA9-B7B1-965883B51AFD}" dt="2020-09-28T09:13:08.940" v="651" actId="1035"/>
          <ac:picMkLst>
            <pc:docMk/>
            <pc:sldMk cId="907894339" sldId="262"/>
            <ac:picMk id="5" creationId="{07526367-45CF-498E-BCB5-826D54DE1044}"/>
          </ac:picMkLst>
        </pc:picChg>
      </pc:sldChg>
      <pc:sldChg chg="addCm modCm">
        <pc:chgData name="Kortman, Guus" userId="41e95c6d-0420-46db-8343-bb7e712699d8" providerId="ADAL" clId="{90D702C7-6408-4DA9-B7B1-965883B51AFD}" dt="2020-09-28T09:49:01.027" v="877"/>
        <pc:sldMkLst>
          <pc:docMk/>
          <pc:sldMk cId="1210609011" sldId="264"/>
        </pc:sldMkLst>
      </pc:sldChg>
      <pc:sldChg chg="modSp">
        <pc:chgData name="Kortman, Guus" userId="41e95c6d-0420-46db-8343-bb7e712699d8" providerId="ADAL" clId="{90D702C7-6408-4DA9-B7B1-965883B51AFD}" dt="2020-09-28T09:55:31.055" v="947" actId="6549"/>
        <pc:sldMkLst>
          <pc:docMk/>
          <pc:sldMk cId="1915425" sldId="265"/>
        </pc:sldMkLst>
        <pc:spChg chg="mod">
          <ac:chgData name="Kortman, Guus" userId="41e95c6d-0420-46db-8343-bb7e712699d8" providerId="ADAL" clId="{90D702C7-6408-4DA9-B7B1-965883B51AFD}" dt="2020-09-28T09:55:31.055" v="947" actId="6549"/>
          <ac:spMkLst>
            <pc:docMk/>
            <pc:sldMk cId="1915425" sldId="265"/>
            <ac:spMk id="3" creationId="{00000000-0000-0000-0000-000000000000}"/>
          </ac:spMkLst>
        </pc:spChg>
      </pc:sldChg>
      <pc:sldChg chg="addSp delSp modSp">
        <pc:chgData name="Kortman, Guus" userId="41e95c6d-0420-46db-8343-bb7e712699d8" providerId="ADAL" clId="{90D702C7-6408-4DA9-B7B1-965883B51AFD}" dt="2020-09-28T09:59:08.921" v="981" actId="20578"/>
        <pc:sldMkLst>
          <pc:docMk/>
          <pc:sldMk cId="1790202609" sldId="266"/>
        </pc:sldMkLst>
        <pc:spChg chg="mod">
          <ac:chgData name="Kortman, Guus" userId="41e95c6d-0420-46db-8343-bb7e712699d8" providerId="ADAL" clId="{90D702C7-6408-4DA9-B7B1-965883B51AFD}" dt="2020-09-28T09:59:08.921" v="981" actId="20578"/>
          <ac:spMkLst>
            <pc:docMk/>
            <pc:sldMk cId="1790202609" sldId="266"/>
            <ac:spMk id="3" creationId="{00000000-0000-0000-0000-000000000000}"/>
          </ac:spMkLst>
        </pc:spChg>
        <pc:picChg chg="add mod">
          <ac:chgData name="Kortman, Guus" userId="41e95c6d-0420-46db-8343-bb7e712699d8" providerId="ADAL" clId="{90D702C7-6408-4DA9-B7B1-965883B51AFD}" dt="2020-09-28T09:46:56.426" v="873" actId="1076"/>
          <ac:picMkLst>
            <pc:docMk/>
            <pc:sldMk cId="1790202609" sldId="266"/>
            <ac:picMk id="5" creationId="{F1E1E3DC-862D-4B91-AAE7-7B00BB685165}"/>
          </ac:picMkLst>
        </pc:picChg>
        <pc:picChg chg="del">
          <ac:chgData name="Kortman, Guus" userId="41e95c6d-0420-46db-8343-bb7e712699d8" providerId="ADAL" clId="{90D702C7-6408-4DA9-B7B1-965883B51AFD}" dt="2020-09-28T09:46:48.895" v="870" actId="478"/>
          <ac:picMkLst>
            <pc:docMk/>
            <pc:sldMk cId="1790202609" sldId="266"/>
            <ac:picMk id="7" creationId="{97CA63F0-CA31-4BD5-AA14-0F3D5766EE4A}"/>
          </ac:picMkLst>
        </pc:picChg>
      </pc:sldChg>
    </pc:docChg>
  </pc:docChgLst>
  <pc:docChgLst>
    <pc:chgData name="Cercamondi,Colin Ivano,VEVEY,Clinical Research" userId="S::colinivano.cercamondi@nestle.com::d25e694c-3ff8-4193-82fc-75dd469e9cee" providerId="AD" clId="Web-{24164FF3-F1AF-60A5-73EC-A35550BAB122}"/>
    <pc:docChg chg="">
      <pc:chgData name="Cercamondi,Colin Ivano,VEVEY,Clinical Research" userId="S::colinivano.cercamondi@nestle.com::d25e694c-3ff8-4193-82fc-75dd469e9cee" providerId="AD" clId="Web-{24164FF3-F1AF-60A5-73EC-A35550BAB122}" dt="2020-09-29T12:42:14.071" v="3"/>
      <pc:docMkLst>
        <pc:docMk/>
      </pc:docMkLst>
      <pc:sldChg chg="addCm">
        <pc:chgData name="Cercamondi,Colin Ivano,VEVEY,Clinical Research" userId="S::colinivano.cercamondi@nestle.com::d25e694c-3ff8-4193-82fc-75dd469e9cee" providerId="AD" clId="Web-{24164FF3-F1AF-60A5-73EC-A35550BAB122}" dt="2020-09-29T12:39:47.523" v="1"/>
        <pc:sldMkLst>
          <pc:docMk/>
          <pc:sldMk cId="1299451647" sldId="257"/>
        </pc:sldMkLst>
      </pc:sldChg>
      <pc:sldChg chg="addCm modCm">
        <pc:chgData name="Cercamondi,Colin Ivano,VEVEY,Clinical Research" userId="S::colinivano.cercamondi@nestle.com::d25e694c-3ff8-4193-82fc-75dd469e9cee" providerId="AD" clId="Web-{24164FF3-F1AF-60A5-73EC-A35550BAB122}" dt="2020-09-29T12:41:26.165" v="2"/>
        <pc:sldMkLst>
          <pc:docMk/>
          <pc:sldMk cId="1210609011" sldId="264"/>
        </pc:sldMkLst>
      </pc:sldChg>
      <pc:sldChg chg="addCm">
        <pc:chgData name="Cercamondi,Colin Ivano,VEVEY,Clinical Research" userId="S::colinivano.cercamondi@nestle.com::d25e694c-3ff8-4193-82fc-75dd469e9cee" providerId="AD" clId="Web-{24164FF3-F1AF-60A5-73EC-A35550BAB122}" dt="2020-09-29T12:42:14.071" v="3"/>
        <pc:sldMkLst>
          <pc:docMk/>
          <pc:sldMk cId="1790202609" sldId="266"/>
        </pc:sldMkLst>
      </pc:sldChg>
    </pc:docChg>
  </pc:docChgLst>
  <pc:docChgLst>
    <pc:chgData name="Cercamondi,Colin Ivano,CH-Vevey" userId="d25e694c-3ff8-4193-82fc-75dd469e9cee" providerId="ADAL" clId="{C54C5B99-9445-4BCE-AC27-C2BE398CE5C3}"/>
    <pc:docChg chg="undo custSel modSld">
      <pc:chgData name="Cercamondi,Colin Ivano,CH-Vevey" userId="d25e694c-3ff8-4193-82fc-75dd469e9cee" providerId="ADAL" clId="{C54C5B99-9445-4BCE-AC27-C2BE398CE5C3}" dt="2021-07-30T12:41:43.766" v="245" actId="20577"/>
      <pc:docMkLst>
        <pc:docMk/>
      </pc:docMkLst>
      <pc:sldChg chg="addSp delSp modSp mod">
        <pc:chgData name="Cercamondi,Colin Ivano,CH-Vevey" userId="d25e694c-3ff8-4193-82fc-75dd469e9cee" providerId="ADAL" clId="{C54C5B99-9445-4BCE-AC27-C2BE398CE5C3}" dt="2021-07-30T12:41:43.766" v="245" actId="20577"/>
        <pc:sldMkLst>
          <pc:docMk/>
          <pc:sldMk cId="1153482099" sldId="267"/>
        </pc:sldMkLst>
        <pc:spChg chg="del mod">
          <ac:chgData name="Cercamondi,Colin Ivano,CH-Vevey" userId="d25e694c-3ff8-4193-82fc-75dd469e9cee" providerId="ADAL" clId="{C54C5B99-9445-4BCE-AC27-C2BE398CE5C3}" dt="2021-07-30T09:06:16.584" v="126" actId="478"/>
          <ac:spMkLst>
            <pc:docMk/>
            <pc:sldMk cId="1153482099" sldId="267"/>
            <ac:spMk id="2" creationId="{00000000-0000-0000-0000-000000000000}"/>
          </ac:spMkLst>
        </pc:spChg>
        <pc:spChg chg="mod">
          <ac:chgData name="Cercamondi,Colin Ivano,CH-Vevey" userId="d25e694c-3ff8-4193-82fc-75dd469e9cee" providerId="ADAL" clId="{C54C5B99-9445-4BCE-AC27-C2BE398CE5C3}" dt="2021-07-30T09:11:13.375" v="228" actId="20577"/>
          <ac:spMkLst>
            <pc:docMk/>
            <pc:sldMk cId="1153482099" sldId="267"/>
            <ac:spMk id="3" creationId="{00000000-0000-0000-0000-000000000000}"/>
          </ac:spMkLst>
        </pc:spChg>
        <pc:spChg chg="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4" creationId="{2C7295EC-FEE4-42D6-976E-0B19C0C83971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5" creationId="{AB569975-78BE-4414-BD6E-3975ACE52851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9" creationId="{9B516649-4854-446A-86B1-BFB135BB0B6E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10" creationId="{E0A7B104-4E83-41AD-B804-0C44F3B4A0E9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11" creationId="{12CDF8A1-6A84-48F9-BE4D-78DB8758E00A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12" creationId="{BB1DC154-5CF0-4D97-92D2-1B095CCA31E3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13" creationId="{421ABD72-E34D-465C-A9AB-A3DE66633B89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14" creationId="{3E0A05CC-9874-45FB-8D44-C4E70D3A403E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15" creationId="{1D53EEC9-29D5-4951-8914-F14283BA6BD1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16" creationId="{6E1B40B7-4C7D-4AA9-B9FD-D72A113EEE33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17" creationId="{EFA816E7-F249-462F-BB03-51BB25A6AD73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18" creationId="{75B7C79B-AB55-4CB2-A177-1EC3E57EDF39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19" creationId="{A2B58D1C-2F51-418B-B224-579A815DEF17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20" creationId="{69CEA797-62CB-469B-9F1A-722364B5ECA4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21" creationId="{07B1688B-A1BA-4388-962F-9EBE476AB1E7}"/>
          </ac:spMkLst>
        </pc:spChg>
        <pc:spChg chg="add 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22" creationId="{29FC799C-EE05-48F0-A24A-D522495E962F}"/>
          </ac:spMkLst>
        </pc:spChg>
        <pc:spChg chg="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23" creationId="{86599123-4989-4FC6-8418-34814D7EDFA6}"/>
          </ac:spMkLst>
        </pc:spChg>
        <pc:spChg chg="add del mod">
          <ac:chgData name="Cercamondi,Colin Ivano,CH-Vevey" userId="d25e694c-3ff8-4193-82fc-75dd469e9cee" providerId="ADAL" clId="{C54C5B99-9445-4BCE-AC27-C2BE398CE5C3}" dt="2021-07-30T09:06:22.141" v="128" actId="478"/>
          <ac:spMkLst>
            <pc:docMk/>
            <pc:sldMk cId="1153482099" sldId="267"/>
            <ac:spMk id="24" creationId="{A975FC66-7D14-4A5D-A012-1807DE5E7757}"/>
          </ac:spMkLst>
        </pc:spChg>
        <pc:spChg chg="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26" creationId="{E0815F5C-BA97-49B4-836F-6DE8CCA4DE27}"/>
          </ac:spMkLst>
        </pc:spChg>
        <pc:spChg chg="mod">
          <ac:chgData name="Cercamondi,Colin Ivano,CH-Vevey" userId="d25e694c-3ff8-4193-82fc-75dd469e9cee" providerId="ADAL" clId="{C54C5B99-9445-4BCE-AC27-C2BE398CE5C3}" dt="2021-07-30T09:10:29.655" v="227" actId="1035"/>
          <ac:spMkLst>
            <pc:docMk/>
            <pc:sldMk cId="1153482099" sldId="267"/>
            <ac:spMk id="27" creationId="{8E7CED26-3B52-40CF-A90D-12BF1BF07EA6}"/>
          </ac:spMkLst>
        </pc:spChg>
        <pc:spChg chg="add mod">
          <ac:chgData name="Cercamondi,Colin Ivano,CH-Vevey" userId="d25e694c-3ff8-4193-82fc-75dd469e9cee" providerId="ADAL" clId="{C54C5B99-9445-4BCE-AC27-C2BE398CE5C3}" dt="2021-07-30T12:41:43.766" v="245" actId="20577"/>
          <ac:spMkLst>
            <pc:docMk/>
            <pc:sldMk cId="1153482099" sldId="267"/>
            <ac:spMk id="28" creationId="{C7D1DC8E-D1FE-407F-8875-1D0A88C5E219}"/>
          </ac:spMkLst>
        </pc:spChg>
        <pc:grpChg chg="add mod">
          <ac:chgData name="Cercamondi,Colin Ivano,CH-Vevey" userId="d25e694c-3ff8-4193-82fc-75dd469e9cee" providerId="ADAL" clId="{C54C5B99-9445-4BCE-AC27-C2BE398CE5C3}" dt="2021-07-30T09:10:29.655" v="227" actId="1035"/>
          <ac:grpSpMkLst>
            <pc:docMk/>
            <pc:sldMk cId="1153482099" sldId="267"/>
            <ac:grpSpMk id="25" creationId="{F172A2FE-3EE1-454B-8978-86A96DB253D4}"/>
          </ac:grpSpMkLst>
        </pc:grpChg>
        <pc:picChg chg="add mod ord">
          <ac:chgData name="Cercamondi,Colin Ivano,CH-Vevey" userId="d25e694c-3ff8-4193-82fc-75dd469e9cee" providerId="ADAL" clId="{C54C5B99-9445-4BCE-AC27-C2BE398CE5C3}" dt="2021-07-30T09:10:29.655" v="227" actId="1035"/>
          <ac:picMkLst>
            <pc:docMk/>
            <pc:sldMk cId="1153482099" sldId="267"/>
            <ac:picMk id="6" creationId="{8CFEDCC0-5700-4915-8B30-57EFD484495F}"/>
          </ac:picMkLst>
        </pc:picChg>
        <pc:picChg chg="del">
          <ac:chgData name="Cercamondi,Colin Ivano,CH-Vevey" userId="d25e694c-3ff8-4193-82fc-75dd469e9cee" providerId="ADAL" clId="{C54C5B99-9445-4BCE-AC27-C2BE398CE5C3}" dt="2021-07-28T13:46:29.859" v="0" actId="478"/>
          <ac:picMkLst>
            <pc:docMk/>
            <pc:sldMk cId="1153482099" sldId="267"/>
            <ac:picMk id="7" creationId="{30C8D721-3462-420D-9D66-3E61075996AF}"/>
          </ac:picMkLst>
        </pc:picChg>
        <pc:picChg chg="add mod ord">
          <ac:chgData name="Cercamondi,Colin Ivano,CH-Vevey" userId="d25e694c-3ff8-4193-82fc-75dd469e9cee" providerId="ADAL" clId="{C54C5B99-9445-4BCE-AC27-C2BE398CE5C3}" dt="2021-07-30T09:10:29.655" v="227" actId="1035"/>
          <ac:picMkLst>
            <pc:docMk/>
            <pc:sldMk cId="1153482099" sldId="267"/>
            <ac:picMk id="8" creationId="{16C06EE6-8BCF-440C-B1F2-9E6870FF8ED3}"/>
          </ac:picMkLst>
        </pc:picChg>
        <pc:cxnChg chg="add del">
          <ac:chgData name="Cercamondi,Colin Ivano,CH-Vevey" userId="d25e694c-3ff8-4193-82fc-75dd469e9cee" providerId="ADAL" clId="{C54C5B99-9445-4BCE-AC27-C2BE398CE5C3}" dt="2021-07-28T17:06:08.583" v="74" actId="478"/>
          <ac:cxnSpMkLst>
            <pc:docMk/>
            <pc:sldMk cId="1153482099" sldId="267"/>
            <ac:cxnSpMk id="29" creationId="{2C805E29-770A-44F4-9CC0-CB6CD6533082}"/>
          </ac:cxnSpMkLst>
        </pc:cxnChg>
      </pc:sldChg>
    </pc:docChg>
  </pc:docChgLst>
  <pc:docChgLst>
    <pc:chgData name="Kortman, Guus" userId="41e95c6d-0420-46db-8343-bb7e712699d8" providerId="ADAL" clId="{70676CEE-5614-4E07-AA84-36CF976D34ED}"/>
    <pc:docChg chg="custSel modSld">
      <pc:chgData name="Kortman, Guus" userId="41e95c6d-0420-46db-8343-bb7e712699d8" providerId="ADAL" clId="{70676CEE-5614-4E07-AA84-36CF976D34ED}" dt="2021-01-19T15:11:10.030" v="33" actId="22"/>
      <pc:docMkLst>
        <pc:docMk/>
      </pc:docMkLst>
      <pc:sldChg chg="addSp delSp mod">
        <pc:chgData name="Kortman, Guus" userId="41e95c6d-0420-46db-8343-bb7e712699d8" providerId="ADAL" clId="{70676CEE-5614-4E07-AA84-36CF976D34ED}" dt="2021-01-19T15:11:10.030" v="33" actId="22"/>
        <pc:sldMkLst>
          <pc:docMk/>
          <pc:sldMk cId="3481645440" sldId="259"/>
        </pc:sldMkLst>
        <pc:picChg chg="del">
          <ac:chgData name="Kortman, Guus" userId="41e95c6d-0420-46db-8343-bb7e712699d8" providerId="ADAL" clId="{70676CEE-5614-4E07-AA84-36CF976D34ED}" dt="2021-01-19T15:11:08.908" v="32" actId="478"/>
          <ac:picMkLst>
            <pc:docMk/>
            <pc:sldMk cId="3481645440" sldId="259"/>
            <ac:picMk id="5" creationId="{DE64BB77-7C35-4F18-8417-05617E8DD58B}"/>
          </ac:picMkLst>
        </pc:picChg>
        <pc:picChg chg="add">
          <ac:chgData name="Kortman, Guus" userId="41e95c6d-0420-46db-8343-bb7e712699d8" providerId="ADAL" clId="{70676CEE-5614-4E07-AA84-36CF976D34ED}" dt="2021-01-19T15:11:10.030" v="33" actId="22"/>
          <ac:picMkLst>
            <pc:docMk/>
            <pc:sldMk cId="3481645440" sldId="259"/>
            <ac:picMk id="8" creationId="{F4618F31-D737-4257-805B-770E7328A3C3}"/>
          </ac:picMkLst>
        </pc:picChg>
      </pc:sldChg>
      <pc:sldChg chg="addSp delSp modSp mod modCm">
        <pc:chgData name="Kortman, Guus" userId="41e95c6d-0420-46db-8343-bb7e712699d8" providerId="ADAL" clId="{70676CEE-5614-4E07-AA84-36CF976D34ED}" dt="2021-01-19T15:03:51.284" v="16" actId="1076"/>
        <pc:sldMkLst>
          <pc:docMk/>
          <pc:sldMk cId="4181099377" sldId="274"/>
        </pc:sldMkLst>
        <pc:spChg chg="mod">
          <ac:chgData name="Kortman, Guus" userId="41e95c6d-0420-46db-8343-bb7e712699d8" providerId="ADAL" clId="{70676CEE-5614-4E07-AA84-36CF976D34ED}" dt="2021-01-19T15:00:57.763" v="0" actId="1076"/>
          <ac:spMkLst>
            <pc:docMk/>
            <pc:sldMk cId="4181099377" sldId="274"/>
            <ac:spMk id="15" creationId="{A4FFF726-C6C5-407E-962B-9404C108370F}"/>
          </ac:spMkLst>
        </pc:spChg>
        <pc:graphicFrameChg chg="del">
          <ac:chgData name="Kortman, Guus" userId="41e95c6d-0420-46db-8343-bb7e712699d8" providerId="ADAL" clId="{70676CEE-5614-4E07-AA84-36CF976D34ED}" dt="2021-01-19T15:01:14.463" v="5" actId="478"/>
          <ac:graphicFrameMkLst>
            <pc:docMk/>
            <pc:sldMk cId="4181099377" sldId="274"/>
            <ac:graphicFrameMk id="11" creationId="{7A88A2FE-4192-4027-9541-32C9B32F6C74}"/>
          </ac:graphicFrameMkLst>
        </pc:graphicFrameChg>
        <pc:picChg chg="add mod">
          <ac:chgData name="Kortman, Guus" userId="41e95c6d-0420-46db-8343-bb7e712699d8" providerId="ADAL" clId="{70676CEE-5614-4E07-AA84-36CF976D34ED}" dt="2021-01-19T15:01:45.727" v="12" actId="1035"/>
          <ac:picMkLst>
            <pc:docMk/>
            <pc:sldMk cId="4181099377" sldId="274"/>
            <ac:picMk id="10" creationId="{788648E9-5DA0-418F-9385-CF4D262ED6A3}"/>
          </ac:picMkLst>
        </pc:picChg>
        <pc:picChg chg="add mod">
          <ac:chgData name="Kortman, Guus" userId="41e95c6d-0420-46db-8343-bb7e712699d8" providerId="ADAL" clId="{70676CEE-5614-4E07-AA84-36CF976D34ED}" dt="2021-01-19T15:03:51.284" v="16" actId="1076"/>
          <ac:picMkLst>
            <pc:docMk/>
            <pc:sldMk cId="4181099377" sldId="274"/>
            <ac:picMk id="14" creationId="{9E39A15E-3F3B-4537-B3E5-1F95A6512CF0}"/>
          </ac:picMkLst>
        </pc:picChg>
      </pc:sldChg>
      <pc:sldChg chg="addSp delSp modSp mod delCm">
        <pc:chgData name="Kortman, Guus" userId="41e95c6d-0420-46db-8343-bb7e712699d8" providerId="ADAL" clId="{70676CEE-5614-4E07-AA84-36CF976D34ED}" dt="2021-01-19T15:06:55.451" v="31" actId="1076"/>
        <pc:sldMkLst>
          <pc:docMk/>
          <pc:sldMk cId="562436449" sldId="275"/>
        </pc:sldMkLst>
        <pc:picChg chg="add del mod">
          <ac:chgData name="Kortman, Guus" userId="41e95c6d-0420-46db-8343-bb7e712699d8" providerId="ADAL" clId="{70676CEE-5614-4E07-AA84-36CF976D34ED}" dt="2021-01-19T15:06:44.341" v="25" actId="478"/>
          <ac:picMkLst>
            <pc:docMk/>
            <pc:sldMk cId="562436449" sldId="275"/>
            <ac:picMk id="5" creationId="{5EAC34DC-E221-47E9-B06B-D90F55224A40}"/>
          </ac:picMkLst>
        </pc:picChg>
        <pc:picChg chg="del">
          <ac:chgData name="Kortman, Guus" userId="41e95c6d-0420-46db-8343-bb7e712699d8" providerId="ADAL" clId="{70676CEE-5614-4E07-AA84-36CF976D34ED}" dt="2021-01-19T15:04:55.831" v="17" actId="478"/>
          <ac:picMkLst>
            <pc:docMk/>
            <pc:sldMk cId="562436449" sldId="275"/>
            <ac:picMk id="13" creationId="{CF00B211-672D-494F-AD26-1949025262BA}"/>
          </ac:picMkLst>
        </pc:picChg>
        <pc:picChg chg="add mod">
          <ac:chgData name="Kortman, Guus" userId="41e95c6d-0420-46db-8343-bb7e712699d8" providerId="ADAL" clId="{70676CEE-5614-4E07-AA84-36CF976D34ED}" dt="2021-01-19T15:06:55.451" v="31" actId="1076"/>
          <ac:picMkLst>
            <pc:docMk/>
            <pc:sldMk cId="562436449" sldId="275"/>
            <ac:picMk id="14" creationId="{E25289A2-BBC0-4BC6-836A-5E4C073CFBA1}"/>
          </ac:picMkLst>
        </pc:picChg>
      </pc:sldChg>
    </pc:docChg>
  </pc:docChgLst>
  <pc:docChgLst>
    <pc:chgData name="Kortman, Guus" userId="41e95c6d-0420-46db-8343-bb7e712699d8" providerId="ADAL" clId="{0D98DF9F-4DB0-4281-9CAD-F25F2C906ED4}"/>
    <pc:docChg chg="custSel modSld">
      <pc:chgData name="Kortman, Guus" userId="41e95c6d-0420-46db-8343-bb7e712699d8" providerId="ADAL" clId="{0D98DF9F-4DB0-4281-9CAD-F25F2C906ED4}" dt="2021-02-19T16:42:16.725" v="10" actId="1076"/>
      <pc:docMkLst>
        <pc:docMk/>
      </pc:docMkLst>
      <pc:sldChg chg="addSp delSp modSp mod">
        <pc:chgData name="Kortman, Guus" userId="41e95c6d-0420-46db-8343-bb7e712699d8" providerId="ADAL" clId="{0D98DF9F-4DB0-4281-9CAD-F25F2C906ED4}" dt="2021-02-19T16:42:16.725" v="10" actId="1076"/>
        <pc:sldMkLst>
          <pc:docMk/>
          <pc:sldMk cId="562436449" sldId="275"/>
        </pc:sldMkLst>
        <pc:picChg chg="del mod">
          <ac:chgData name="Kortman, Guus" userId="41e95c6d-0420-46db-8343-bb7e712699d8" providerId="ADAL" clId="{0D98DF9F-4DB0-4281-9CAD-F25F2C906ED4}" dt="2021-02-19T16:41:56.953" v="4" actId="478"/>
          <ac:picMkLst>
            <pc:docMk/>
            <pc:sldMk cId="562436449" sldId="275"/>
            <ac:picMk id="5" creationId="{54C9BE2D-738D-41DF-BBEE-9FF5F1C40DAA}"/>
          </ac:picMkLst>
        </pc:picChg>
        <pc:picChg chg="add mod ord">
          <ac:chgData name="Kortman, Guus" userId="41e95c6d-0420-46db-8343-bb7e712699d8" providerId="ADAL" clId="{0D98DF9F-4DB0-4281-9CAD-F25F2C906ED4}" dt="2021-02-19T16:42:16.725" v="10" actId="1076"/>
          <ac:picMkLst>
            <pc:docMk/>
            <pc:sldMk cId="562436449" sldId="275"/>
            <ac:picMk id="6" creationId="{DE55BF76-D57B-44C5-9F15-717A44053618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66BEEB-EB84-427B-9340-AF6C42907C6B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F9F4C8-D18A-469A-A04D-534747DE34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0363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F9F4C8-D18A-469A-A04D-534747DE34F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7779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F9F4C8-D18A-469A-A04D-534747DE34F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7779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22" indent="0" algn="ctr">
              <a:buNone/>
              <a:defRPr sz="2000"/>
            </a:lvl2pPr>
            <a:lvl3pPr marL="914447" indent="0" algn="ctr">
              <a:buNone/>
              <a:defRPr sz="1801"/>
            </a:lvl3pPr>
            <a:lvl4pPr marL="1371669" indent="0" algn="ctr">
              <a:buNone/>
              <a:defRPr sz="1600"/>
            </a:lvl4pPr>
            <a:lvl5pPr marL="1828892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9" indent="0" algn="ctr">
              <a:buNone/>
              <a:defRPr sz="1600"/>
            </a:lvl7pPr>
            <a:lvl8pPr marL="3200561" indent="0" algn="ctr">
              <a:buNone/>
              <a:defRPr sz="1600"/>
            </a:lvl8pPr>
            <a:lvl9pPr marL="3657783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3" y="1709741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3" y="4589467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2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47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6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1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33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5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78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8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1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22" indent="0">
              <a:buNone/>
              <a:defRPr sz="2000" b="1"/>
            </a:lvl2pPr>
            <a:lvl3pPr marL="914447" indent="0">
              <a:buNone/>
              <a:defRPr sz="1801" b="1"/>
            </a:lvl3pPr>
            <a:lvl4pPr marL="1371669" indent="0">
              <a:buNone/>
              <a:defRPr sz="1600" b="1"/>
            </a:lvl4pPr>
            <a:lvl5pPr marL="1828892" indent="0">
              <a:buNone/>
              <a:defRPr sz="1600" b="1"/>
            </a:lvl5pPr>
            <a:lvl6pPr marL="2286114" indent="0">
              <a:buNone/>
              <a:defRPr sz="1600" b="1"/>
            </a:lvl6pPr>
            <a:lvl7pPr marL="2743339" indent="0">
              <a:buNone/>
              <a:defRPr sz="1600" b="1"/>
            </a:lvl7pPr>
            <a:lvl8pPr marL="3200561" indent="0">
              <a:buNone/>
              <a:defRPr sz="1600" b="1"/>
            </a:lvl8pPr>
            <a:lvl9pPr marL="365778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1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3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22" indent="0">
              <a:buNone/>
              <a:defRPr sz="2000" b="1"/>
            </a:lvl2pPr>
            <a:lvl3pPr marL="914447" indent="0">
              <a:buNone/>
              <a:defRPr sz="1801" b="1"/>
            </a:lvl3pPr>
            <a:lvl4pPr marL="1371669" indent="0">
              <a:buNone/>
              <a:defRPr sz="1600" b="1"/>
            </a:lvl4pPr>
            <a:lvl5pPr marL="1828892" indent="0">
              <a:buNone/>
              <a:defRPr sz="1600" b="1"/>
            </a:lvl5pPr>
            <a:lvl6pPr marL="2286114" indent="0">
              <a:buNone/>
              <a:defRPr sz="1600" b="1"/>
            </a:lvl6pPr>
            <a:lvl7pPr marL="2743339" indent="0">
              <a:buNone/>
              <a:defRPr sz="1600" b="1"/>
            </a:lvl7pPr>
            <a:lvl8pPr marL="3200561" indent="0">
              <a:buNone/>
              <a:defRPr sz="1600" b="1"/>
            </a:lvl8pPr>
            <a:lvl9pPr marL="365778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92" y="987429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22" indent="0">
              <a:buNone/>
              <a:defRPr sz="1401"/>
            </a:lvl2pPr>
            <a:lvl3pPr marL="914447" indent="0">
              <a:buNone/>
              <a:defRPr sz="1200"/>
            </a:lvl3pPr>
            <a:lvl4pPr marL="1371669" indent="0">
              <a:buNone/>
              <a:defRPr sz="1001"/>
            </a:lvl4pPr>
            <a:lvl5pPr marL="1828892" indent="0">
              <a:buNone/>
              <a:defRPr sz="1001"/>
            </a:lvl5pPr>
            <a:lvl6pPr marL="2286114" indent="0">
              <a:buNone/>
              <a:defRPr sz="1001"/>
            </a:lvl6pPr>
            <a:lvl7pPr marL="2743339" indent="0">
              <a:buNone/>
              <a:defRPr sz="1001"/>
            </a:lvl7pPr>
            <a:lvl8pPr marL="3200561" indent="0">
              <a:buNone/>
              <a:defRPr sz="1001"/>
            </a:lvl8pPr>
            <a:lvl9pPr marL="3657783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92" y="987429"/>
            <a:ext cx="617220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22" indent="0">
              <a:buNone/>
              <a:defRPr sz="2800"/>
            </a:lvl2pPr>
            <a:lvl3pPr marL="914447" indent="0">
              <a:buNone/>
              <a:defRPr sz="2400"/>
            </a:lvl3pPr>
            <a:lvl4pPr marL="1371669" indent="0">
              <a:buNone/>
              <a:defRPr sz="2000"/>
            </a:lvl4pPr>
            <a:lvl5pPr marL="1828892" indent="0">
              <a:buNone/>
              <a:defRPr sz="2000"/>
            </a:lvl5pPr>
            <a:lvl6pPr marL="2286114" indent="0">
              <a:buNone/>
              <a:defRPr sz="2000"/>
            </a:lvl6pPr>
            <a:lvl7pPr marL="2743339" indent="0">
              <a:buNone/>
              <a:defRPr sz="2000"/>
            </a:lvl7pPr>
            <a:lvl8pPr marL="3200561" indent="0">
              <a:buNone/>
              <a:defRPr sz="2000"/>
            </a:lvl8pPr>
            <a:lvl9pPr marL="3657783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22" indent="0">
              <a:buNone/>
              <a:defRPr sz="1401"/>
            </a:lvl2pPr>
            <a:lvl3pPr marL="914447" indent="0">
              <a:buNone/>
              <a:defRPr sz="1200"/>
            </a:lvl3pPr>
            <a:lvl4pPr marL="1371669" indent="0">
              <a:buNone/>
              <a:defRPr sz="1001"/>
            </a:lvl4pPr>
            <a:lvl5pPr marL="1828892" indent="0">
              <a:buNone/>
              <a:defRPr sz="1001"/>
            </a:lvl5pPr>
            <a:lvl6pPr marL="2286114" indent="0">
              <a:buNone/>
              <a:defRPr sz="1001"/>
            </a:lvl6pPr>
            <a:lvl7pPr marL="2743339" indent="0">
              <a:buNone/>
              <a:defRPr sz="1001"/>
            </a:lvl7pPr>
            <a:lvl8pPr marL="3200561" indent="0">
              <a:buNone/>
              <a:defRPr sz="1001"/>
            </a:lvl8pPr>
            <a:lvl9pPr marL="3657783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4" y="365128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4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9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4" y="6356354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4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13" indent="-228613" algn="l" defTabSz="914447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36" indent="-228613" algn="l" defTabSz="91444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58" indent="-228613" algn="l" defTabSz="91444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81" indent="-228613" algn="l" defTabSz="91444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503" indent="-228613" algn="l" defTabSz="91444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727" indent="-228613" algn="l" defTabSz="91444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950" indent="-228613" algn="l" defTabSz="91444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172" indent="-228613" algn="l" defTabSz="91444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395" indent="-228613" algn="l" defTabSz="91444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47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22" algn="l" defTabSz="914447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47" algn="l" defTabSz="914447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69" algn="l" defTabSz="914447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92" algn="l" defTabSz="914447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114" algn="l" defTabSz="914447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339" algn="l" defTabSz="914447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561" algn="l" defTabSz="914447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783" algn="l" defTabSz="914447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" y="4888813"/>
            <a:ext cx="12191999" cy="1965666"/>
          </a:xfrm>
        </p:spPr>
        <p:txBody>
          <a:bodyPr>
            <a:spAutoFit/>
          </a:bodyPr>
          <a:lstStyle/>
          <a:p>
            <a:pPr algn="just"/>
            <a:r>
              <a:rPr lang="en-US" sz="1800" b="1" dirty="0"/>
              <a:t>Supplementary figure 1: Comparison of alpha diversity between feeding groups using observed species and Shannon diversity indexes.</a:t>
            </a:r>
          </a:p>
          <a:p>
            <a:pPr algn="just"/>
            <a:r>
              <a:rPr lang="en-US" sz="1800" dirty="0"/>
              <a:t>Box plots show the median and 25th and 75th percentiles with Tukey whiskers and outliers as individual data points. Feeding groups were compared by </a:t>
            </a:r>
            <a:r>
              <a:rPr lang="en-US" sz="1800"/>
              <a:t>Kruskal-Wallis test </a:t>
            </a:r>
            <a:r>
              <a:rPr lang="en-US" sz="1800" dirty="0"/>
              <a:t>followed by pairwise comparisons with Dunn’s </a:t>
            </a:r>
            <a:r>
              <a:rPr lang="en-US" sz="1800" dirty="0" err="1"/>
              <a:t>posthoc</a:t>
            </a:r>
            <a:r>
              <a:rPr lang="en-US" sz="1800" dirty="0"/>
              <a:t> test. Box plots without a common superscript letter are significantly different from each other (p&lt;0.05 based on Dunn’s </a:t>
            </a:r>
            <a:r>
              <a:rPr lang="en-US" sz="1800" dirty="0" err="1"/>
              <a:t>posthoc</a:t>
            </a:r>
            <a:r>
              <a:rPr lang="en-US" sz="1800" dirty="0"/>
              <a:t> test).</a:t>
            </a:r>
            <a:r>
              <a:rPr lang="en-GB" sz="1800" dirty="0"/>
              <a:t> CG, n=112; EG, n=114; HFI, n=70 except at 2.5  months of age where CG and EG, n=75; HFI, n=72. </a:t>
            </a:r>
            <a:r>
              <a:rPr lang="en-US" sz="1800" dirty="0"/>
              <a:t>CG, control group; EG, experimental group; HFI, human milk-fed infants.</a:t>
            </a:r>
            <a:endParaRPr lang="en-GB" sz="1800" dirty="0"/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F172A2FE-3EE1-454B-8978-86A96DB253D4}"/>
              </a:ext>
            </a:extLst>
          </p:cNvPr>
          <p:cNvGrpSpPr/>
          <p:nvPr/>
        </p:nvGrpSpPr>
        <p:grpSpPr>
          <a:xfrm>
            <a:off x="1484853" y="1040461"/>
            <a:ext cx="9222292" cy="3888000"/>
            <a:chOff x="1583922" y="1455942"/>
            <a:chExt cx="9222292" cy="3888000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CFEDCC0-5700-4915-8B30-57EFD484495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83922" y="1509666"/>
              <a:ext cx="4512077" cy="38160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16C06EE6-8BCF-440C-B1F2-9E6870FF8ED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95998" y="1455942"/>
              <a:ext cx="4710216" cy="3888000"/>
            </a:xfrm>
            <a:prstGeom prst="rect">
              <a:avLst/>
            </a:prstGeom>
          </p:spPr>
        </p:pic>
        <p:sp>
          <p:nvSpPr>
            <p:cNvPr id="4" name="Rectangle 2">
              <a:extLst>
                <a:ext uri="{FF2B5EF4-FFF2-40B4-BE49-F238E27FC236}">
                  <a16:creationId xmlns:a16="http://schemas.microsoft.com/office/drawing/2014/main" id="{2C7295EC-FEE4-42D6-976E-0B19C0C839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9823" y="1478610"/>
              <a:ext cx="184731" cy="3694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1" rIns="91440" bIns="45721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nl-NL" sz="1801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B569975-78BE-4414-BD6E-3975ACE52851}"/>
                </a:ext>
              </a:extLst>
            </p:cNvPr>
            <p:cNvSpPr txBox="1"/>
            <p:nvPr/>
          </p:nvSpPr>
          <p:spPr>
            <a:xfrm>
              <a:off x="3634451" y="1907002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B516649-4854-446A-86B1-BFB135BB0B6E}"/>
                </a:ext>
              </a:extLst>
            </p:cNvPr>
            <p:cNvSpPr txBox="1"/>
            <p:nvPr/>
          </p:nvSpPr>
          <p:spPr>
            <a:xfrm>
              <a:off x="4026866" y="2004076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0A7B104-4E83-41AD-B804-0C44F3B4A0E9}"/>
                </a:ext>
              </a:extLst>
            </p:cNvPr>
            <p:cNvSpPr txBox="1"/>
            <p:nvPr/>
          </p:nvSpPr>
          <p:spPr>
            <a:xfrm>
              <a:off x="4406005" y="2310634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2CDF8A1-6A84-48F9-BE4D-78DB8758E00A}"/>
                </a:ext>
              </a:extLst>
            </p:cNvPr>
            <p:cNvSpPr txBox="1"/>
            <p:nvPr/>
          </p:nvSpPr>
          <p:spPr>
            <a:xfrm>
              <a:off x="5288634" y="2119851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B1DC154-5CF0-4D97-92D2-1B095CCA31E3}"/>
                </a:ext>
              </a:extLst>
            </p:cNvPr>
            <p:cNvSpPr txBox="1"/>
            <p:nvPr/>
          </p:nvSpPr>
          <p:spPr>
            <a:xfrm>
              <a:off x="4917129" y="1573064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21ABD72-E34D-465C-A9AB-A3DE66633B89}"/>
                </a:ext>
              </a:extLst>
            </p:cNvPr>
            <p:cNvSpPr txBox="1"/>
            <p:nvPr/>
          </p:nvSpPr>
          <p:spPr>
            <a:xfrm>
              <a:off x="5667773" y="2216850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E0A05CC-9874-45FB-8D44-C4E70D3A403E}"/>
                </a:ext>
              </a:extLst>
            </p:cNvPr>
            <p:cNvSpPr txBox="1"/>
            <p:nvPr/>
          </p:nvSpPr>
          <p:spPr>
            <a:xfrm>
              <a:off x="7044880" y="1786428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D53EEC9-29D5-4951-8914-F14283BA6BD1}"/>
                </a:ext>
              </a:extLst>
            </p:cNvPr>
            <p:cNvSpPr txBox="1"/>
            <p:nvPr/>
          </p:nvSpPr>
          <p:spPr>
            <a:xfrm>
              <a:off x="7458608" y="1911960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E1B40B7-4C7D-4AA9-B9FD-D72A113EEE33}"/>
                </a:ext>
              </a:extLst>
            </p:cNvPr>
            <p:cNvSpPr txBox="1"/>
            <p:nvPr/>
          </p:nvSpPr>
          <p:spPr>
            <a:xfrm>
              <a:off x="7808457" y="2037218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FA816E7-F249-462F-BB03-51BB25A6AD73}"/>
                </a:ext>
              </a:extLst>
            </p:cNvPr>
            <p:cNvSpPr txBox="1"/>
            <p:nvPr/>
          </p:nvSpPr>
          <p:spPr>
            <a:xfrm>
              <a:off x="8373311" y="1757730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5B7C79B-AB55-4CB2-A177-1EC3E57EDF39}"/>
                </a:ext>
              </a:extLst>
            </p:cNvPr>
            <p:cNvSpPr txBox="1"/>
            <p:nvPr/>
          </p:nvSpPr>
          <p:spPr>
            <a:xfrm>
              <a:off x="8724657" y="1737376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2B58D1C-2F51-418B-B224-579A815DEF17}"/>
                </a:ext>
              </a:extLst>
            </p:cNvPr>
            <p:cNvSpPr txBox="1"/>
            <p:nvPr/>
          </p:nvSpPr>
          <p:spPr>
            <a:xfrm>
              <a:off x="9134649" y="2118283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9CEA797-62CB-469B-9F1A-722364B5ECA4}"/>
                </a:ext>
              </a:extLst>
            </p:cNvPr>
            <p:cNvSpPr txBox="1"/>
            <p:nvPr/>
          </p:nvSpPr>
          <p:spPr>
            <a:xfrm>
              <a:off x="9658037" y="1876986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7B1688B-A1BA-4388-962F-9EBE476AB1E7}"/>
                </a:ext>
              </a:extLst>
            </p:cNvPr>
            <p:cNvSpPr txBox="1"/>
            <p:nvPr/>
          </p:nvSpPr>
          <p:spPr>
            <a:xfrm>
              <a:off x="10038706" y="2038876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9FC799C-EE05-48F0-A24A-D522495E962F}"/>
                </a:ext>
              </a:extLst>
            </p:cNvPr>
            <p:cNvSpPr txBox="1"/>
            <p:nvPr/>
          </p:nvSpPr>
          <p:spPr>
            <a:xfrm>
              <a:off x="10435392" y="2155760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6599123-4989-4FC6-8418-34814D7EDFA6}"/>
                </a:ext>
              </a:extLst>
            </p:cNvPr>
            <p:cNvSpPr txBox="1"/>
            <p:nvPr/>
          </p:nvSpPr>
          <p:spPr>
            <a:xfrm>
              <a:off x="2367374" y="2188742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0815F5C-BA97-49B4-836F-6DE8CCA4DE27}"/>
                </a:ext>
              </a:extLst>
            </p:cNvPr>
            <p:cNvSpPr txBox="1"/>
            <p:nvPr/>
          </p:nvSpPr>
          <p:spPr>
            <a:xfrm>
              <a:off x="2746956" y="1947249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/>
                <a:t>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E7CED26-3B52-40CF-A90D-12BF1BF07EA6}"/>
                </a:ext>
              </a:extLst>
            </p:cNvPr>
            <p:cNvSpPr txBox="1"/>
            <p:nvPr/>
          </p:nvSpPr>
          <p:spPr>
            <a:xfrm>
              <a:off x="3098745" y="2188742"/>
              <a:ext cx="3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/>
                <a:t>a</a:t>
              </a:r>
            </a:p>
          </p:txBody>
        </p:sp>
      </p:grpSp>
      <p:sp>
        <p:nvSpPr>
          <p:cNvPr id="28" name="Title 1">
            <a:extLst>
              <a:ext uri="{FF2B5EF4-FFF2-40B4-BE49-F238E27FC236}">
                <a16:creationId xmlns:a16="http://schemas.microsoft.com/office/drawing/2014/main" id="{C7D1DC8E-D1FE-407F-8875-1D0A88C5E219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2192000" cy="124881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47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  <a:spcAft>
                <a:spcPts val="1200"/>
              </a:spcAft>
            </a:pPr>
            <a:r>
              <a:rPr lang="en-US" sz="1800" b="1" dirty="0">
                <a:cs typeface="Calibri Light"/>
              </a:rPr>
              <a:t>Term infant formula supplemented with milk-derived oligosaccharides shifts the gut microbiota closer to that of </a:t>
            </a:r>
            <a:r>
              <a:rPr lang="en-US" sz="1800" b="1">
                <a:cs typeface="Calibri Light"/>
              </a:rPr>
              <a:t>human milk-fed infants </a:t>
            </a:r>
            <a:r>
              <a:rPr lang="en-US" sz="1800" b="1" dirty="0">
                <a:cs typeface="Calibri Light"/>
              </a:rPr>
              <a:t>and improves intestinal immune defense: A randomized controlled trial</a:t>
            </a:r>
            <a:br>
              <a:rPr lang="en-US" sz="1800" b="1" dirty="0">
                <a:cs typeface="Calibri Light"/>
              </a:rPr>
            </a:br>
            <a:r>
              <a:rPr lang="en-US" sz="1800" i="1" dirty="0">
                <a:cs typeface="Calibri Light"/>
              </a:rPr>
              <a:t>Elvira Estorninos et al.</a:t>
            </a:r>
            <a:br>
              <a:rPr lang="en-US" sz="1800" i="1" dirty="0">
                <a:cs typeface="Calibri Light"/>
              </a:rPr>
            </a:br>
            <a:r>
              <a:rPr lang="en-US" sz="1800" b="1" dirty="0">
                <a:cs typeface="Calibri Light"/>
              </a:rPr>
              <a:t>Online supplementary material</a:t>
            </a:r>
            <a:endParaRPr lang="en-US" sz="1800" b="1" i="1" dirty="0"/>
          </a:p>
        </p:txBody>
      </p:sp>
    </p:spTree>
    <p:extLst>
      <p:ext uri="{BB962C8B-B14F-4D97-AF65-F5344CB8AC3E}">
        <p14:creationId xmlns:p14="http://schemas.microsoft.com/office/powerpoint/2010/main" val="11534820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Chart, box and whisker chart&#10;&#10;Description automatically generated">
            <a:extLst>
              <a:ext uri="{FF2B5EF4-FFF2-40B4-BE49-F238E27FC236}">
                <a16:creationId xmlns:a16="http://schemas.microsoft.com/office/drawing/2014/main" id="{30C8D721-3462-420D-9D66-3E61075996A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9228" y="763059"/>
            <a:ext cx="6480000" cy="4568330"/>
          </a:xfrm>
          <a:prstGeom prst="rect">
            <a:avLst/>
          </a:prstGeom>
        </p:spPr>
      </p:pic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0" y="5139160"/>
            <a:ext cx="12191999" cy="1718840"/>
          </a:xfrm>
        </p:spPr>
        <p:txBody>
          <a:bodyPr>
            <a:noAutofit/>
          </a:bodyPr>
          <a:lstStyle/>
          <a:p>
            <a:pPr algn="just"/>
            <a:r>
              <a:rPr lang="en-US" sz="1800" b="1" dirty="0"/>
              <a:t>Supplementary figure 2: Relative abundance of genus Bifidobacterium at 2.5 months of age in the three feeding groups.</a:t>
            </a:r>
          </a:p>
          <a:p>
            <a:pPr algn="just"/>
            <a:r>
              <a:rPr lang="en-US" sz="1800" dirty="0"/>
              <a:t>Box plots show the median and 25th and 75th percentiles with Tukey whiskers and outliers as individual data points. Feeding groups were compared by Kruskal-Wallis test and false discovery rate correction for multiple testing, followed by pairwise comparisons with Dunn’s </a:t>
            </a:r>
            <a:r>
              <a:rPr lang="en-US" sz="1800" dirty="0" err="1"/>
              <a:t>posthoc</a:t>
            </a:r>
            <a:r>
              <a:rPr lang="en-US" sz="1800" dirty="0"/>
              <a:t> test. Box plots without a common superscript letter are significantly different from each other (p&lt;0.05 based on Dunn’s </a:t>
            </a:r>
            <a:r>
              <a:rPr lang="en-US" sz="1800" dirty="0" err="1"/>
              <a:t>posthoc</a:t>
            </a:r>
            <a:r>
              <a:rPr lang="en-US" sz="1800" dirty="0"/>
              <a:t> test).</a:t>
            </a:r>
            <a:r>
              <a:rPr lang="en-GB" sz="1800" dirty="0"/>
              <a:t> CG and EG, n=75; HFI, n=72. </a:t>
            </a:r>
            <a:r>
              <a:rPr lang="en-US" sz="1800" dirty="0"/>
              <a:t>CG, control group; EG, experimental group; HFI, human milk-fed infants.</a:t>
            </a:r>
            <a:endParaRPr lang="en-GB" sz="1800" dirty="0"/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2C7295EC-FEE4-42D6-976E-0B19C0C839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9823" y="1478610"/>
            <a:ext cx="184731" cy="3694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1" rIns="91440" bIns="45721" numCol="1" anchor="ctr" anchorCtr="0" compatLnSpc="1">
            <a:prstTxWarp prst="textNoShape">
              <a:avLst/>
            </a:prstTxWarp>
            <a:spAutoFit/>
          </a:bodyPr>
          <a:lstStyle/>
          <a:p>
            <a:endParaRPr lang="nl-NL" sz="1801"/>
          </a:p>
        </p:txBody>
      </p:sp>
    </p:spTree>
    <p:extLst>
      <p:ext uri="{BB962C8B-B14F-4D97-AF65-F5344CB8AC3E}">
        <p14:creationId xmlns:p14="http://schemas.microsoft.com/office/powerpoint/2010/main" val="9303602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ubtitle 2">
            <a:extLst>
              <a:ext uri="{FF2B5EF4-FFF2-40B4-BE49-F238E27FC236}">
                <a16:creationId xmlns:a16="http://schemas.microsoft.com/office/drawing/2014/main" id="{81FA4653-DC30-4403-B45C-5C347BD53527}"/>
              </a:ext>
            </a:extLst>
          </p:cNvPr>
          <p:cNvSpPr txBox="1">
            <a:spLocks/>
          </p:cNvSpPr>
          <p:nvPr/>
        </p:nvSpPr>
        <p:spPr>
          <a:xfrm>
            <a:off x="5950781" y="2364302"/>
            <a:ext cx="6096000" cy="3710761"/>
          </a:xfrm>
          <a:prstGeom prst="rect">
            <a:avLst/>
          </a:prstGeom>
        </p:spPr>
        <p:txBody>
          <a:bodyPr vert="horz" wrap="square" lIns="91440" tIns="45721" rIns="91440" bIns="45721" rtlCol="0">
            <a:spAutoFit/>
          </a:bodyPr>
          <a:lstStyle>
            <a:lvl1pPr marL="228609" indent="-228609" algn="l" defTabSz="914435" rtl="0" eaLnBrk="1" latinLnBrk="0" hangingPunct="1">
              <a:lnSpc>
                <a:spcPct val="90000"/>
              </a:lnSpc>
              <a:spcBef>
                <a:spcPts val="1001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27" indent="-228609" algn="l" defTabSz="914435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44" indent="-228609" algn="l" defTabSz="914435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62" indent="-228609" algn="l" defTabSz="914435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78" indent="-228609" algn="l" defTabSz="914435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95" indent="-228609" algn="l" defTabSz="914435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913" indent="-228609" algn="l" defTabSz="914435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129" indent="-228609" algn="l" defTabSz="914435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347" indent="-228609" algn="l" defTabSz="914435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US" sz="1800" b="1" dirty="0"/>
              <a:t>Supplementary figure 3: Relative abundance of genus Bifidobacterium at 2.5 and 4 months of age in the three feeding groups stratified by delivery mode.</a:t>
            </a:r>
          </a:p>
          <a:p>
            <a:pPr marL="0" indent="0" algn="just">
              <a:buNone/>
            </a:pPr>
            <a:r>
              <a:rPr lang="en-US" sz="1800" dirty="0"/>
              <a:t>Box plots show the median and 25th and 75th percentiles with Tukey whiskers and outliers as individual data points. Feeding groups were compared by Kruskal-Wallis test and </a:t>
            </a:r>
            <a:r>
              <a:rPr lang="en-US" sz="1800"/>
              <a:t>false discovery rate </a:t>
            </a:r>
            <a:r>
              <a:rPr lang="en-US" sz="1800" dirty="0"/>
              <a:t>correction for multiple testing, followed by pairwise comparisons with Dunn’s </a:t>
            </a:r>
            <a:r>
              <a:rPr lang="en-US" sz="1800" dirty="0" err="1"/>
              <a:t>posthoc</a:t>
            </a:r>
            <a:r>
              <a:rPr lang="en-US" sz="1800" dirty="0"/>
              <a:t> test. Box plots without a common superscript letter are significantly different from each other (p&lt;0.05 based on Dunn’s </a:t>
            </a:r>
            <a:r>
              <a:rPr lang="en-US" sz="1800" dirty="0" err="1"/>
              <a:t>posthoc</a:t>
            </a:r>
            <a:r>
              <a:rPr lang="en-US" sz="1800" dirty="0"/>
              <a:t> test). </a:t>
            </a:r>
            <a:r>
              <a:rPr lang="en-GB" sz="1800" dirty="0"/>
              <a:t>For detailed statistical outcomes, see supplementary table 3. CG, n=112; EG, n=114; HFI, n=70 except at 2.5 months of age where CG and EG, n=75; HFI, n=72. </a:t>
            </a:r>
            <a:r>
              <a:rPr lang="en-US" sz="1800" dirty="0"/>
              <a:t>CG, control group; EG, experimental group; HFI, human milk-fed infants.</a:t>
            </a:r>
          </a:p>
        </p:txBody>
      </p:sp>
      <p:pic>
        <p:nvPicPr>
          <p:cNvPr id="10" name="Picture 9" descr="Chart&#10;&#10;Description automatically generated">
            <a:extLst>
              <a:ext uri="{FF2B5EF4-FFF2-40B4-BE49-F238E27FC236}">
                <a16:creationId xmlns:a16="http://schemas.microsoft.com/office/drawing/2014/main" id="{329F94AA-CD5E-4589-A33C-2EA27EECEB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219" y="1427902"/>
            <a:ext cx="5760000" cy="52642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9023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9D8F4455137414A9D839F57BF755B84" ma:contentTypeVersion="6" ma:contentTypeDescription="Crée un document." ma:contentTypeScope="" ma:versionID="8215ab35b6543a888b99bf9cce5f27c3">
  <xsd:schema xmlns:xsd="http://www.w3.org/2001/XMLSchema" xmlns:xs="http://www.w3.org/2001/XMLSchema" xmlns:p="http://schemas.microsoft.com/office/2006/metadata/properties" xmlns:ns2="39c9e4bf-332d-4a34-8cdb-cabb2adf4921" xmlns:ns3="cf1341a6-96a7-49bb-bb82-17c9b9518abe" targetNamespace="http://schemas.microsoft.com/office/2006/metadata/properties" ma:root="true" ma:fieldsID="c28869f9b77ff73e7619c5bfeca552fc" ns2:_="" ns3:_="">
    <xsd:import namespace="39c9e4bf-332d-4a34-8cdb-cabb2adf4921"/>
    <xsd:import namespace="cf1341a6-96a7-49bb-bb82-17c9b9518ab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9c9e4bf-332d-4a34-8cdb-cabb2adf492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f1341a6-96a7-49bb-bb82-17c9b9518abe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0512B581-7FF3-453E-AAA3-94A650909DD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9c9e4bf-332d-4a34-8cdb-cabb2adf4921"/>
    <ds:schemaRef ds:uri="cf1341a6-96a7-49bb-bb82-17c9b9518ab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2F4B88E-E4A9-4A64-AF34-736D2E3EB61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5F0894F-AAC2-4E19-93C3-1215CF0218C0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9</TotalTime>
  <Words>466</Words>
  <Application>Microsoft Office PowerPoint</Application>
  <PresentationFormat>Widescreen</PresentationFormat>
  <Paragraphs>27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Cercamondi,Colin Ivano,CH-Vevey</cp:lastModifiedBy>
  <cp:revision>1</cp:revision>
  <dcterms:created xsi:type="dcterms:W3CDTF">2020-09-23T10:03:49Z</dcterms:created>
  <dcterms:modified xsi:type="dcterms:W3CDTF">2021-09-23T21:26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9D8F4455137414A9D839F57BF755B84</vt:lpwstr>
  </property>
  <property fmtid="{D5CDD505-2E9C-101B-9397-08002B2CF9AE}" pid="3" name="MSIP_Label_1ada0a2f-b917-4d51-b0d0-d418a10c8b23_Enabled">
    <vt:lpwstr>true</vt:lpwstr>
  </property>
  <property fmtid="{D5CDD505-2E9C-101B-9397-08002B2CF9AE}" pid="4" name="MSIP_Label_1ada0a2f-b917-4d51-b0d0-d418a10c8b23_SetDate">
    <vt:lpwstr>2020-11-12T09:02:40Z</vt:lpwstr>
  </property>
  <property fmtid="{D5CDD505-2E9C-101B-9397-08002B2CF9AE}" pid="5" name="MSIP_Label_1ada0a2f-b917-4d51-b0d0-d418a10c8b23_Method">
    <vt:lpwstr>Standard</vt:lpwstr>
  </property>
  <property fmtid="{D5CDD505-2E9C-101B-9397-08002B2CF9AE}" pid="6" name="MSIP_Label_1ada0a2f-b917-4d51-b0d0-d418a10c8b23_Name">
    <vt:lpwstr>1ada0a2f-b917-4d51-b0d0-d418a10c8b23</vt:lpwstr>
  </property>
  <property fmtid="{D5CDD505-2E9C-101B-9397-08002B2CF9AE}" pid="7" name="MSIP_Label_1ada0a2f-b917-4d51-b0d0-d418a10c8b23_SiteId">
    <vt:lpwstr>12a3af23-a769-4654-847f-958f3d479f4a</vt:lpwstr>
  </property>
  <property fmtid="{D5CDD505-2E9C-101B-9397-08002B2CF9AE}" pid="8" name="MSIP_Label_1ada0a2f-b917-4d51-b0d0-d418a10c8b23_ActionId">
    <vt:lpwstr>5ce6f6ac-5e2c-48da-bb18-3ddd54b04b86</vt:lpwstr>
  </property>
  <property fmtid="{D5CDD505-2E9C-101B-9397-08002B2CF9AE}" pid="9" name="MSIP_Label_1ada0a2f-b917-4d51-b0d0-d418a10c8b23_ContentBits">
    <vt:lpwstr>0</vt:lpwstr>
  </property>
</Properties>
</file>